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018" r:id="rId2"/>
    <p:sldId id="2124" r:id="rId3"/>
    <p:sldId id="301" r:id="rId4"/>
    <p:sldId id="2123" r:id="rId5"/>
    <p:sldId id="2090" r:id="rId6"/>
    <p:sldId id="2120" r:id="rId7"/>
    <p:sldId id="2114" r:id="rId8"/>
    <p:sldId id="2091" r:id="rId9"/>
    <p:sldId id="2063" r:id="rId10"/>
    <p:sldId id="2070" r:id="rId11"/>
    <p:sldId id="2081" r:id="rId12"/>
    <p:sldId id="2080" r:id="rId13"/>
    <p:sldId id="2071" r:id="rId14"/>
    <p:sldId id="2100" r:id="rId15"/>
    <p:sldId id="2121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1C1"/>
    <a:srgbClr val="C3E56D"/>
    <a:srgbClr val="BAE18F"/>
    <a:srgbClr val="AFDC7E"/>
    <a:srgbClr val="CC00CC"/>
    <a:srgbClr val="A3EAFB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2923" autoAdjust="0"/>
  </p:normalViewPr>
  <p:slideViewPr>
    <p:cSldViewPr snapToGrid="0">
      <p:cViewPr>
        <p:scale>
          <a:sx n="64" d="100"/>
          <a:sy n="64" d="100"/>
        </p:scale>
        <p:origin x="748" y="-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3" d="100"/>
        <a:sy n="9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ADFE2B-9585-4CCE-AB42-2CA000B2A90E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DF26E0-AE71-4E16-BE84-5BC0C2DD5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503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DF26E0-AE71-4E16-BE84-5BC0C2DD543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49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98D81-67D9-4F63-9EC6-BBF5B54961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E121CE-F31E-4FE4-B9A9-2253A67B48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0EA3E4-B81A-4A28-A6D4-326C7C32F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3B3C1D-71A1-4828-AFCA-0F352CB2C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81F3F-DD21-4704-B879-2004939AD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330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2B25D7-B7EB-4E85-BC32-E98C9F8B1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69F682-FC24-41FD-B4D2-785C5EE787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C1C33-91D6-40D3-9DD6-C099C3B9A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BE708-2624-4486-AFD6-A7398D153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F007C6-A398-47BF-96AB-D2E13E465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887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9327F3-A150-4F38-97B6-2F6BC4A733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8CA4B7-822E-487C-AA0D-305EFF4E33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B03AA6-16D1-4DA3-8825-AEFEB35B1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AEE3B-0E1A-4B7F-9B11-B0D4ACA09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03A2D-06D5-449C-9370-CBAA01EE2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71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DA83F-E783-434D-B975-6CB580489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ED35CA-D702-4953-A8FF-52734A44D3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65A0D-41B3-4171-87E6-6636AD37A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03FF49-AF8C-4B72-B073-2C107D6CC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0920C1-45F0-4B53-BD9B-5ACF1ED59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551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D9C6A-9C0E-4928-99EC-37153D904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15D5BE-551E-4817-8561-80B702CEE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9A9D1-E372-4D6B-98CD-2213C17A9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9F4DA-7A09-49F5-8DD2-945CCA990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692CA7-5833-4559-8AB1-9D9C61048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567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7D42A-6870-41DD-BBE5-A2C82C868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F74B1C-D424-443D-9BB8-5AFE910074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1EBE15-4FCD-4C58-A82A-0A4A48CB8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BDF19B-F2A0-4F73-BD46-56D2CA2D4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937991-7670-445D-8AF4-4C68E0411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EAA50-ED50-4736-92A4-669DC0C7D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765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DFDE51-1427-481D-8AA0-7BABBABDD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D763C2-8103-4558-A52A-1CBD6E90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475AA2-67A4-446B-A989-745B132E9A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E37FCE-1F61-4FD4-8DA8-1B02526AE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E340CF-D4C4-46C5-AB79-C3CE74AF6C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B8EA5E-F9D9-4EB8-A0C7-E174BD721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2C07F3-0B8A-433B-B352-75DBDCDDE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B05716-0EF1-4F2D-9409-D9BC0E243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01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F29F2-5EAC-4EF5-96B0-2B8038814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EE928F-5C47-4A90-B427-10D6CB627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9BC2F0-43BB-4E52-8886-A11877B9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63A699-D270-4B99-81D4-18CFD56CD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56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09F3F2-187B-4B84-9248-587058FB9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E134FF-5B41-4437-A7C8-BD2F9EDEC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8C8AAF-10A7-4C24-8704-EC12BFDED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922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C5A6B-7910-4B66-882B-D0F20270AD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3CD0-1ECB-4CC8-8FF4-1F4B1470A9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76679E-F910-47CF-8069-0B451676FC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BFB112-8134-4278-97AE-AA7A8F924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BAD415-36E8-4962-A662-A9EFEA8DC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ADCEA3-5288-4AD4-9C73-90C449D0E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331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BF3C5-0325-4D49-A2B4-C2104B1BB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880CAF-F94C-4CA1-9FA7-DC91C76984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6B37D-69EA-4ECA-A2FE-A4655DF63E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F33D5C-072D-43B8-A5E1-A86EDB5D5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296ECA-F46B-49D8-A8EA-C35B23F49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517718-B361-4B61-9354-7465ACD32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7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326541-8F91-4382-A53E-27C605AA4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622BD-4F31-4471-A88C-0F68253121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67B1D-788E-4738-B097-18410CF253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5E1C3-708A-477A-ACE1-75D95F64C175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3B1A0B-AF9E-43A5-98FC-4B312C39C6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4F5E5-8B71-4F25-B525-3F5F754515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98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8.bin"/><Relationship Id="rId13" Type="http://schemas.openxmlformats.org/officeDocument/2006/relationships/image" Target="../media/image110.emf"/><Relationship Id="rId3" Type="http://schemas.openxmlformats.org/officeDocument/2006/relationships/image" Target="../media/image105.emf"/><Relationship Id="rId7" Type="http://schemas.openxmlformats.org/officeDocument/2006/relationships/image" Target="../media/image107.emf"/><Relationship Id="rId12" Type="http://schemas.openxmlformats.org/officeDocument/2006/relationships/oleObject" Target="../embeddings/oleObject110.bin"/><Relationship Id="rId17" Type="http://schemas.openxmlformats.org/officeDocument/2006/relationships/image" Target="../media/image112.emf"/><Relationship Id="rId2" Type="http://schemas.openxmlformats.org/officeDocument/2006/relationships/oleObject" Target="../embeddings/oleObject105.bin"/><Relationship Id="rId16" Type="http://schemas.openxmlformats.org/officeDocument/2006/relationships/oleObject" Target="../embeddings/oleObject11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7.bin"/><Relationship Id="rId11" Type="http://schemas.openxmlformats.org/officeDocument/2006/relationships/image" Target="../media/image109.emf"/><Relationship Id="rId5" Type="http://schemas.openxmlformats.org/officeDocument/2006/relationships/image" Target="../media/image106.emf"/><Relationship Id="rId15" Type="http://schemas.openxmlformats.org/officeDocument/2006/relationships/image" Target="../media/image111.emf"/><Relationship Id="rId10" Type="http://schemas.openxmlformats.org/officeDocument/2006/relationships/oleObject" Target="../embeddings/oleObject109.bin"/><Relationship Id="rId4" Type="http://schemas.openxmlformats.org/officeDocument/2006/relationships/oleObject" Target="../embeddings/oleObject106.bin"/><Relationship Id="rId9" Type="http://schemas.openxmlformats.org/officeDocument/2006/relationships/image" Target="../media/image108.emf"/><Relationship Id="rId14" Type="http://schemas.openxmlformats.org/officeDocument/2006/relationships/oleObject" Target="../embeddings/oleObject111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6.bin"/><Relationship Id="rId13" Type="http://schemas.openxmlformats.org/officeDocument/2006/relationships/image" Target="../media/image118.emf"/><Relationship Id="rId3" Type="http://schemas.openxmlformats.org/officeDocument/2006/relationships/image" Target="../media/image113.emf"/><Relationship Id="rId7" Type="http://schemas.openxmlformats.org/officeDocument/2006/relationships/image" Target="../media/image115.emf"/><Relationship Id="rId12" Type="http://schemas.openxmlformats.org/officeDocument/2006/relationships/oleObject" Target="../embeddings/oleObject118.bin"/><Relationship Id="rId17" Type="http://schemas.openxmlformats.org/officeDocument/2006/relationships/image" Target="../media/image120.emf"/><Relationship Id="rId2" Type="http://schemas.openxmlformats.org/officeDocument/2006/relationships/oleObject" Target="../embeddings/oleObject113.bin"/><Relationship Id="rId16" Type="http://schemas.openxmlformats.org/officeDocument/2006/relationships/oleObject" Target="../embeddings/oleObject12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5.bin"/><Relationship Id="rId11" Type="http://schemas.openxmlformats.org/officeDocument/2006/relationships/image" Target="../media/image117.emf"/><Relationship Id="rId5" Type="http://schemas.openxmlformats.org/officeDocument/2006/relationships/image" Target="../media/image114.emf"/><Relationship Id="rId15" Type="http://schemas.openxmlformats.org/officeDocument/2006/relationships/image" Target="../media/image119.emf"/><Relationship Id="rId10" Type="http://schemas.openxmlformats.org/officeDocument/2006/relationships/oleObject" Target="../embeddings/oleObject117.bin"/><Relationship Id="rId4" Type="http://schemas.openxmlformats.org/officeDocument/2006/relationships/oleObject" Target="../embeddings/oleObject114.bin"/><Relationship Id="rId9" Type="http://schemas.openxmlformats.org/officeDocument/2006/relationships/image" Target="../media/image116.emf"/><Relationship Id="rId14" Type="http://schemas.openxmlformats.org/officeDocument/2006/relationships/oleObject" Target="../embeddings/oleObject119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4.bin"/><Relationship Id="rId13" Type="http://schemas.openxmlformats.org/officeDocument/2006/relationships/image" Target="../media/image126.emf"/><Relationship Id="rId3" Type="http://schemas.openxmlformats.org/officeDocument/2006/relationships/image" Target="../media/image121.emf"/><Relationship Id="rId7" Type="http://schemas.openxmlformats.org/officeDocument/2006/relationships/image" Target="../media/image123.emf"/><Relationship Id="rId12" Type="http://schemas.openxmlformats.org/officeDocument/2006/relationships/oleObject" Target="../embeddings/oleObject126.bin"/><Relationship Id="rId17" Type="http://schemas.openxmlformats.org/officeDocument/2006/relationships/image" Target="../media/image128.emf"/><Relationship Id="rId2" Type="http://schemas.openxmlformats.org/officeDocument/2006/relationships/oleObject" Target="../embeddings/oleObject121.bin"/><Relationship Id="rId16" Type="http://schemas.openxmlformats.org/officeDocument/2006/relationships/oleObject" Target="../embeddings/oleObject12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23.bin"/><Relationship Id="rId11" Type="http://schemas.openxmlformats.org/officeDocument/2006/relationships/image" Target="../media/image125.emf"/><Relationship Id="rId5" Type="http://schemas.openxmlformats.org/officeDocument/2006/relationships/image" Target="../media/image122.emf"/><Relationship Id="rId15" Type="http://schemas.openxmlformats.org/officeDocument/2006/relationships/image" Target="../media/image127.emf"/><Relationship Id="rId10" Type="http://schemas.openxmlformats.org/officeDocument/2006/relationships/oleObject" Target="../embeddings/oleObject125.bin"/><Relationship Id="rId4" Type="http://schemas.openxmlformats.org/officeDocument/2006/relationships/oleObject" Target="../embeddings/oleObject122.bin"/><Relationship Id="rId9" Type="http://schemas.openxmlformats.org/officeDocument/2006/relationships/image" Target="../media/image124.emf"/><Relationship Id="rId14" Type="http://schemas.openxmlformats.org/officeDocument/2006/relationships/oleObject" Target="../embeddings/oleObject127.bin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2.bin"/><Relationship Id="rId13" Type="http://schemas.openxmlformats.org/officeDocument/2006/relationships/image" Target="../media/image134.emf"/><Relationship Id="rId3" Type="http://schemas.openxmlformats.org/officeDocument/2006/relationships/image" Target="../media/image129.emf"/><Relationship Id="rId7" Type="http://schemas.openxmlformats.org/officeDocument/2006/relationships/image" Target="../media/image131.emf"/><Relationship Id="rId12" Type="http://schemas.openxmlformats.org/officeDocument/2006/relationships/oleObject" Target="../embeddings/oleObject134.bin"/><Relationship Id="rId17" Type="http://schemas.openxmlformats.org/officeDocument/2006/relationships/image" Target="../media/image136.emf"/><Relationship Id="rId2" Type="http://schemas.openxmlformats.org/officeDocument/2006/relationships/oleObject" Target="../embeddings/oleObject129.bin"/><Relationship Id="rId16" Type="http://schemas.openxmlformats.org/officeDocument/2006/relationships/oleObject" Target="../embeddings/oleObject13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31.bin"/><Relationship Id="rId11" Type="http://schemas.openxmlformats.org/officeDocument/2006/relationships/image" Target="../media/image133.emf"/><Relationship Id="rId5" Type="http://schemas.openxmlformats.org/officeDocument/2006/relationships/image" Target="../media/image130.emf"/><Relationship Id="rId15" Type="http://schemas.openxmlformats.org/officeDocument/2006/relationships/image" Target="../media/image135.emf"/><Relationship Id="rId10" Type="http://schemas.openxmlformats.org/officeDocument/2006/relationships/oleObject" Target="../embeddings/oleObject133.bin"/><Relationship Id="rId4" Type="http://schemas.openxmlformats.org/officeDocument/2006/relationships/oleObject" Target="../embeddings/oleObject130.bin"/><Relationship Id="rId9" Type="http://schemas.openxmlformats.org/officeDocument/2006/relationships/image" Target="../media/image132.emf"/><Relationship Id="rId14" Type="http://schemas.openxmlformats.org/officeDocument/2006/relationships/oleObject" Target="../embeddings/oleObject135.bin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9.emf"/><Relationship Id="rId13" Type="http://schemas.openxmlformats.org/officeDocument/2006/relationships/oleObject" Target="../embeddings/oleObject142.bin"/><Relationship Id="rId3" Type="http://schemas.openxmlformats.org/officeDocument/2006/relationships/oleObject" Target="../embeddings/oleObject137.bin"/><Relationship Id="rId7" Type="http://schemas.openxmlformats.org/officeDocument/2006/relationships/oleObject" Target="../embeddings/oleObject139.bin"/><Relationship Id="rId12" Type="http://schemas.openxmlformats.org/officeDocument/2006/relationships/image" Target="../media/image14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8.emf"/><Relationship Id="rId11" Type="http://schemas.openxmlformats.org/officeDocument/2006/relationships/oleObject" Target="../embeddings/oleObject141.bin"/><Relationship Id="rId5" Type="http://schemas.openxmlformats.org/officeDocument/2006/relationships/oleObject" Target="../embeddings/oleObject138.bin"/><Relationship Id="rId10" Type="http://schemas.openxmlformats.org/officeDocument/2006/relationships/image" Target="../media/image140.emf"/><Relationship Id="rId4" Type="http://schemas.openxmlformats.org/officeDocument/2006/relationships/image" Target="../media/image137.emf"/><Relationship Id="rId9" Type="http://schemas.openxmlformats.org/officeDocument/2006/relationships/oleObject" Target="../embeddings/oleObject140.bin"/><Relationship Id="rId14" Type="http://schemas.openxmlformats.org/officeDocument/2006/relationships/image" Target="../media/image142.em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6.bin"/><Relationship Id="rId13" Type="http://schemas.openxmlformats.org/officeDocument/2006/relationships/image" Target="../media/image148.emf"/><Relationship Id="rId18" Type="http://schemas.openxmlformats.org/officeDocument/2006/relationships/oleObject" Target="../embeddings/oleObject151.bin"/><Relationship Id="rId3" Type="http://schemas.openxmlformats.org/officeDocument/2006/relationships/image" Target="../media/image143.emf"/><Relationship Id="rId7" Type="http://schemas.openxmlformats.org/officeDocument/2006/relationships/image" Target="../media/image145.emf"/><Relationship Id="rId12" Type="http://schemas.openxmlformats.org/officeDocument/2006/relationships/oleObject" Target="../embeddings/oleObject148.bin"/><Relationship Id="rId17" Type="http://schemas.openxmlformats.org/officeDocument/2006/relationships/image" Target="../media/image150.emf"/><Relationship Id="rId2" Type="http://schemas.openxmlformats.org/officeDocument/2006/relationships/oleObject" Target="../embeddings/oleObject143.bin"/><Relationship Id="rId16" Type="http://schemas.openxmlformats.org/officeDocument/2006/relationships/oleObject" Target="../embeddings/oleObject15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45.bin"/><Relationship Id="rId11" Type="http://schemas.openxmlformats.org/officeDocument/2006/relationships/image" Target="../media/image147.emf"/><Relationship Id="rId5" Type="http://schemas.openxmlformats.org/officeDocument/2006/relationships/image" Target="../media/image144.emf"/><Relationship Id="rId15" Type="http://schemas.openxmlformats.org/officeDocument/2006/relationships/image" Target="../media/image149.emf"/><Relationship Id="rId10" Type="http://schemas.openxmlformats.org/officeDocument/2006/relationships/oleObject" Target="../embeddings/oleObject147.bin"/><Relationship Id="rId19" Type="http://schemas.openxmlformats.org/officeDocument/2006/relationships/image" Target="../media/image151.emf"/><Relationship Id="rId4" Type="http://schemas.openxmlformats.org/officeDocument/2006/relationships/oleObject" Target="../embeddings/oleObject144.bin"/><Relationship Id="rId9" Type="http://schemas.openxmlformats.org/officeDocument/2006/relationships/image" Target="../media/image146.emf"/><Relationship Id="rId14" Type="http://schemas.openxmlformats.org/officeDocument/2006/relationships/oleObject" Target="../embeddings/oleObject149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image" Target="../media/image6.emf"/><Relationship Id="rId7" Type="http://schemas.openxmlformats.org/officeDocument/2006/relationships/image" Target="../media/image8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8.bin"/><Relationship Id="rId11" Type="http://schemas.openxmlformats.org/officeDocument/2006/relationships/image" Target="../media/image10.emf"/><Relationship Id="rId5" Type="http://schemas.openxmlformats.org/officeDocument/2006/relationships/image" Target="../media/image7.emf"/><Relationship Id="rId10" Type="http://schemas.openxmlformats.org/officeDocument/2006/relationships/oleObject" Target="../embeddings/oleObject10.bin"/><Relationship Id="rId4" Type="http://schemas.openxmlformats.org/officeDocument/2006/relationships/oleObject" Target="../embeddings/oleObject7.bin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13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3.emf"/><Relationship Id="rId12" Type="http://schemas.openxmlformats.org/officeDocument/2006/relationships/oleObject" Target="../embeddings/oleObject16.bin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3.bin"/><Relationship Id="rId11" Type="http://schemas.openxmlformats.org/officeDocument/2006/relationships/image" Target="../media/image15.emf"/><Relationship Id="rId5" Type="http://schemas.openxmlformats.org/officeDocument/2006/relationships/image" Target="../media/image12.emf"/><Relationship Id="rId10" Type="http://schemas.openxmlformats.org/officeDocument/2006/relationships/oleObject" Target="../embeddings/oleObject15.bin"/><Relationship Id="rId4" Type="http://schemas.openxmlformats.org/officeDocument/2006/relationships/oleObject" Target="../embeddings/oleObject12.bin"/><Relationship Id="rId9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0.bin"/><Relationship Id="rId13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22.bin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9.bin"/><Relationship Id="rId11" Type="http://schemas.openxmlformats.org/officeDocument/2006/relationships/image" Target="../media/image21.emf"/><Relationship Id="rId5" Type="http://schemas.openxmlformats.org/officeDocument/2006/relationships/image" Target="../media/image18.emf"/><Relationship Id="rId10" Type="http://schemas.openxmlformats.org/officeDocument/2006/relationships/oleObject" Target="../embeddings/oleObject21.bin"/><Relationship Id="rId4" Type="http://schemas.openxmlformats.org/officeDocument/2006/relationships/oleObject" Target="../embeddings/oleObject18.bin"/><Relationship Id="rId9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8.emf"/><Relationship Id="rId18" Type="http://schemas.openxmlformats.org/officeDocument/2006/relationships/oleObject" Target="../embeddings/oleObject31.bin"/><Relationship Id="rId26" Type="http://schemas.openxmlformats.org/officeDocument/2006/relationships/oleObject" Target="../embeddings/oleObject35.bin"/><Relationship Id="rId39" Type="http://schemas.openxmlformats.org/officeDocument/2006/relationships/image" Target="../media/image41.emf"/><Relationship Id="rId3" Type="http://schemas.openxmlformats.org/officeDocument/2006/relationships/image" Target="../media/image23.emf"/><Relationship Id="rId21" Type="http://schemas.openxmlformats.org/officeDocument/2006/relationships/image" Target="../media/image32.emf"/><Relationship Id="rId34" Type="http://schemas.openxmlformats.org/officeDocument/2006/relationships/oleObject" Target="../embeddings/oleObject39.bin"/><Relationship Id="rId42" Type="http://schemas.openxmlformats.org/officeDocument/2006/relationships/oleObject" Target="../embeddings/oleObject43.bin"/><Relationship Id="rId47" Type="http://schemas.openxmlformats.org/officeDocument/2006/relationships/image" Target="../media/image45.emf"/><Relationship Id="rId50" Type="http://schemas.openxmlformats.org/officeDocument/2006/relationships/oleObject" Target="../embeddings/oleObject47.bin"/><Relationship Id="rId7" Type="http://schemas.openxmlformats.org/officeDocument/2006/relationships/image" Target="../media/image25.emf"/><Relationship Id="rId12" Type="http://schemas.openxmlformats.org/officeDocument/2006/relationships/oleObject" Target="../embeddings/oleObject28.bin"/><Relationship Id="rId17" Type="http://schemas.openxmlformats.org/officeDocument/2006/relationships/image" Target="../media/image30.emf"/><Relationship Id="rId25" Type="http://schemas.openxmlformats.org/officeDocument/2006/relationships/image" Target="../media/image34.emf"/><Relationship Id="rId33" Type="http://schemas.openxmlformats.org/officeDocument/2006/relationships/image" Target="../media/image38.emf"/><Relationship Id="rId38" Type="http://schemas.openxmlformats.org/officeDocument/2006/relationships/oleObject" Target="../embeddings/oleObject41.bin"/><Relationship Id="rId46" Type="http://schemas.openxmlformats.org/officeDocument/2006/relationships/oleObject" Target="../embeddings/oleObject45.bin"/><Relationship Id="rId2" Type="http://schemas.openxmlformats.org/officeDocument/2006/relationships/oleObject" Target="../embeddings/oleObject23.bin"/><Relationship Id="rId16" Type="http://schemas.openxmlformats.org/officeDocument/2006/relationships/oleObject" Target="../embeddings/oleObject30.bin"/><Relationship Id="rId20" Type="http://schemas.openxmlformats.org/officeDocument/2006/relationships/oleObject" Target="../embeddings/oleObject32.bin"/><Relationship Id="rId29" Type="http://schemas.openxmlformats.org/officeDocument/2006/relationships/image" Target="../media/image36.emf"/><Relationship Id="rId41" Type="http://schemas.openxmlformats.org/officeDocument/2006/relationships/image" Target="../media/image42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5.bin"/><Relationship Id="rId11" Type="http://schemas.openxmlformats.org/officeDocument/2006/relationships/image" Target="../media/image27.emf"/><Relationship Id="rId24" Type="http://schemas.openxmlformats.org/officeDocument/2006/relationships/oleObject" Target="../embeddings/oleObject34.bin"/><Relationship Id="rId32" Type="http://schemas.openxmlformats.org/officeDocument/2006/relationships/oleObject" Target="../embeddings/oleObject38.bin"/><Relationship Id="rId37" Type="http://schemas.openxmlformats.org/officeDocument/2006/relationships/image" Target="../media/image40.emf"/><Relationship Id="rId40" Type="http://schemas.openxmlformats.org/officeDocument/2006/relationships/oleObject" Target="../embeddings/oleObject42.bin"/><Relationship Id="rId45" Type="http://schemas.openxmlformats.org/officeDocument/2006/relationships/image" Target="../media/image44.emf"/><Relationship Id="rId53" Type="http://schemas.openxmlformats.org/officeDocument/2006/relationships/image" Target="../media/image48.emf"/><Relationship Id="rId5" Type="http://schemas.openxmlformats.org/officeDocument/2006/relationships/image" Target="../media/image24.emf"/><Relationship Id="rId15" Type="http://schemas.openxmlformats.org/officeDocument/2006/relationships/image" Target="../media/image29.emf"/><Relationship Id="rId23" Type="http://schemas.openxmlformats.org/officeDocument/2006/relationships/image" Target="../media/image33.emf"/><Relationship Id="rId28" Type="http://schemas.openxmlformats.org/officeDocument/2006/relationships/oleObject" Target="../embeddings/oleObject36.bin"/><Relationship Id="rId36" Type="http://schemas.openxmlformats.org/officeDocument/2006/relationships/oleObject" Target="../embeddings/oleObject40.bin"/><Relationship Id="rId49" Type="http://schemas.openxmlformats.org/officeDocument/2006/relationships/image" Target="../media/image46.emf"/><Relationship Id="rId10" Type="http://schemas.openxmlformats.org/officeDocument/2006/relationships/oleObject" Target="../embeddings/oleObject27.bin"/><Relationship Id="rId19" Type="http://schemas.openxmlformats.org/officeDocument/2006/relationships/image" Target="../media/image31.emf"/><Relationship Id="rId31" Type="http://schemas.openxmlformats.org/officeDocument/2006/relationships/image" Target="../media/image37.emf"/><Relationship Id="rId44" Type="http://schemas.openxmlformats.org/officeDocument/2006/relationships/oleObject" Target="../embeddings/oleObject44.bin"/><Relationship Id="rId52" Type="http://schemas.openxmlformats.org/officeDocument/2006/relationships/oleObject" Target="../embeddings/oleObject48.bin"/><Relationship Id="rId4" Type="http://schemas.openxmlformats.org/officeDocument/2006/relationships/oleObject" Target="../embeddings/oleObject24.bin"/><Relationship Id="rId9" Type="http://schemas.openxmlformats.org/officeDocument/2006/relationships/image" Target="../media/image26.emf"/><Relationship Id="rId14" Type="http://schemas.openxmlformats.org/officeDocument/2006/relationships/oleObject" Target="../embeddings/oleObject29.bin"/><Relationship Id="rId22" Type="http://schemas.openxmlformats.org/officeDocument/2006/relationships/oleObject" Target="../embeddings/oleObject33.bin"/><Relationship Id="rId27" Type="http://schemas.openxmlformats.org/officeDocument/2006/relationships/image" Target="../media/image35.emf"/><Relationship Id="rId30" Type="http://schemas.openxmlformats.org/officeDocument/2006/relationships/oleObject" Target="../embeddings/oleObject37.bin"/><Relationship Id="rId35" Type="http://schemas.openxmlformats.org/officeDocument/2006/relationships/image" Target="../media/image39.emf"/><Relationship Id="rId43" Type="http://schemas.openxmlformats.org/officeDocument/2006/relationships/image" Target="../media/image43.emf"/><Relationship Id="rId48" Type="http://schemas.openxmlformats.org/officeDocument/2006/relationships/oleObject" Target="../embeddings/oleObject46.bin"/><Relationship Id="rId8" Type="http://schemas.openxmlformats.org/officeDocument/2006/relationships/oleObject" Target="../embeddings/oleObject26.bin"/><Relationship Id="rId51" Type="http://schemas.openxmlformats.org/officeDocument/2006/relationships/image" Target="../media/image4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2.bin"/><Relationship Id="rId13" Type="http://schemas.openxmlformats.org/officeDocument/2006/relationships/image" Target="../media/image54.emf"/><Relationship Id="rId18" Type="http://schemas.openxmlformats.org/officeDocument/2006/relationships/oleObject" Target="../embeddings/oleObject57.bin"/><Relationship Id="rId26" Type="http://schemas.openxmlformats.org/officeDocument/2006/relationships/oleObject" Target="../embeddings/oleObject61.bin"/><Relationship Id="rId39" Type="http://schemas.openxmlformats.org/officeDocument/2006/relationships/image" Target="../media/image67.emf"/><Relationship Id="rId3" Type="http://schemas.openxmlformats.org/officeDocument/2006/relationships/image" Target="../media/image49.emf"/><Relationship Id="rId21" Type="http://schemas.openxmlformats.org/officeDocument/2006/relationships/image" Target="../media/image58.emf"/><Relationship Id="rId34" Type="http://schemas.openxmlformats.org/officeDocument/2006/relationships/oleObject" Target="../embeddings/oleObject65.bin"/><Relationship Id="rId7" Type="http://schemas.openxmlformats.org/officeDocument/2006/relationships/image" Target="../media/image51.emf"/><Relationship Id="rId12" Type="http://schemas.openxmlformats.org/officeDocument/2006/relationships/oleObject" Target="../embeddings/oleObject54.bin"/><Relationship Id="rId17" Type="http://schemas.openxmlformats.org/officeDocument/2006/relationships/image" Target="../media/image56.emf"/><Relationship Id="rId25" Type="http://schemas.openxmlformats.org/officeDocument/2006/relationships/image" Target="../media/image60.emf"/><Relationship Id="rId33" Type="http://schemas.openxmlformats.org/officeDocument/2006/relationships/image" Target="../media/image64.emf"/><Relationship Id="rId38" Type="http://schemas.openxmlformats.org/officeDocument/2006/relationships/oleObject" Target="../embeddings/oleObject67.bin"/><Relationship Id="rId2" Type="http://schemas.openxmlformats.org/officeDocument/2006/relationships/oleObject" Target="../embeddings/oleObject49.bin"/><Relationship Id="rId16" Type="http://schemas.openxmlformats.org/officeDocument/2006/relationships/oleObject" Target="../embeddings/oleObject56.bin"/><Relationship Id="rId20" Type="http://schemas.openxmlformats.org/officeDocument/2006/relationships/oleObject" Target="../embeddings/oleObject58.bin"/><Relationship Id="rId29" Type="http://schemas.openxmlformats.org/officeDocument/2006/relationships/image" Target="../media/image62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1.bin"/><Relationship Id="rId11" Type="http://schemas.openxmlformats.org/officeDocument/2006/relationships/image" Target="../media/image53.emf"/><Relationship Id="rId24" Type="http://schemas.openxmlformats.org/officeDocument/2006/relationships/oleObject" Target="../embeddings/oleObject60.bin"/><Relationship Id="rId32" Type="http://schemas.openxmlformats.org/officeDocument/2006/relationships/oleObject" Target="../embeddings/oleObject64.bin"/><Relationship Id="rId37" Type="http://schemas.openxmlformats.org/officeDocument/2006/relationships/image" Target="../media/image66.emf"/><Relationship Id="rId5" Type="http://schemas.openxmlformats.org/officeDocument/2006/relationships/image" Target="../media/image50.emf"/><Relationship Id="rId15" Type="http://schemas.openxmlformats.org/officeDocument/2006/relationships/image" Target="../media/image55.emf"/><Relationship Id="rId23" Type="http://schemas.openxmlformats.org/officeDocument/2006/relationships/image" Target="../media/image59.emf"/><Relationship Id="rId28" Type="http://schemas.openxmlformats.org/officeDocument/2006/relationships/oleObject" Target="../embeddings/oleObject62.bin"/><Relationship Id="rId36" Type="http://schemas.openxmlformats.org/officeDocument/2006/relationships/oleObject" Target="../embeddings/oleObject66.bin"/><Relationship Id="rId10" Type="http://schemas.openxmlformats.org/officeDocument/2006/relationships/oleObject" Target="../embeddings/oleObject53.bin"/><Relationship Id="rId19" Type="http://schemas.openxmlformats.org/officeDocument/2006/relationships/image" Target="../media/image57.emf"/><Relationship Id="rId31" Type="http://schemas.openxmlformats.org/officeDocument/2006/relationships/image" Target="../media/image63.emf"/><Relationship Id="rId4" Type="http://schemas.openxmlformats.org/officeDocument/2006/relationships/oleObject" Target="../embeddings/oleObject50.bin"/><Relationship Id="rId9" Type="http://schemas.openxmlformats.org/officeDocument/2006/relationships/image" Target="../media/image52.emf"/><Relationship Id="rId14" Type="http://schemas.openxmlformats.org/officeDocument/2006/relationships/oleObject" Target="../embeddings/oleObject55.bin"/><Relationship Id="rId22" Type="http://schemas.openxmlformats.org/officeDocument/2006/relationships/oleObject" Target="../embeddings/oleObject59.bin"/><Relationship Id="rId27" Type="http://schemas.openxmlformats.org/officeDocument/2006/relationships/image" Target="../media/image61.emf"/><Relationship Id="rId30" Type="http://schemas.openxmlformats.org/officeDocument/2006/relationships/oleObject" Target="../embeddings/oleObject63.bin"/><Relationship Id="rId35" Type="http://schemas.openxmlformats.org/officeDocument/2006/relationships/image" Target="../media/image65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1.bin"/><Relationship Id="rId13" Type="http://schemas.openxmlformats.org/officeDocument/2006/relationships/image" Target="../media/image73.emf"/><Relationship Id="rId18" Type="http://schemas.openxmlformats.org/officeDocument/2006/relationships/oleObject" Target="../embeddings/oleObject76.bin"/><Relationship Id="rId26" Type="http://schemas.openxmlformats.org/officeDocument/2006/relationships/oleObject" Target="../embeddings/oleObject80.bin"/><Relationship Id="rId39" Type="http://schemas.openxmlformats.org/officeDocument/2006/relationships/image" Target="../media/image86.emf"/><Relationship Id="rId3" Type="http://schemas.openxmlformats.org/officeDocument/2006/relationships/image" Target="../media/image68.emf"/><Relationship Id="rId21" Type="http://schemas.openxmlformats.org/officeDocument/2006/relationships/image" Target="../media/image77.emf"/><Relationship Id="rId34" Type="http://schemas.openxmlformats.org/officeDocument/2006/relationships/oleObject" Target="../embeddings/oleObject84.bin"/><Relationship Id="rId42" Type="http://schemas.openxmlformats.org/officeDocument/2006/relationships/oleObject" Target="../embeddings/oleObject88.bin"/><Relationship Id="rId7" Type="http://schemas.openxmlformats.org/officeDocument/2006/relationships/image" Target="../media/image70.emf"/><Relationship Id="rId12" Type="http://schemas.openxmlformats.org/officeDocument/2006/relationships/oleObject" Target="../embeddings/oleObject73.bin"/><Relationship Id="rId17" Type="http://schemas.openxmlformats.org/officeDocument/2006/relationships/image" Target="../media/image75.emf"/><Relationship Id="rId25" Type="http://schemas.openxmlformats.org/officeDocument/2006/relationships/image" Target="../media/image79.emf"/><Relationship Id="rId33" Type="http://schemas.openxmlformats.org/officeDocument/2006/relationships/image" Target="../media/image83.emf"/><Relationship Id="rId38" Type="http://schemas.openxmlformats.org/officeDocument/2006/relationships/oleObject" Target="../embeddings/oleObject86.bin"/><Relationship Id="rId2" Type="http://schemas.openxmlformats.org/officeDocument/2006/relationships/oleObject" Target="../embeddings/oleObject68.bin"/><Relationship Id="rId16" Type="http://schemas.openxmlformats.org/officeDocument/2006/relationships/oleObject" Target="../embeddings/oleObject75.bin"/><Relationship Id="rId20" Type="http://schemas.openxmlformats.org/officeDocument/2006/relationships/oleObject" Target="../embeddings/oleObject77.bin"/><Relationship Id="rId29" Type="http://schemas.openxmlformats.org/officeDocument/2006/relationships/image" Target="../media/image81.emf"/><Relationship Id="rId41" Type="http://schemas.openxmlformats.org/officeDocument/2006/relationships/image" Target="../media/image87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0.bin"/><Relationship Id="rId11" Type="http://schemas.openxmlformats.org/officeDocument/2006/relationships/image" Target="../media/image72.emf"/><Relationship Id="rId24" Type="http://schemas.openxmlformats.org/officeDocument/2006/relationships/oleObject" Target="../embeddings/oleObject79.bin"/><Relationship Id="rId32" Type="http://schemas.openxmlformats.org/officeDocument/2006/relationships/oleObject" Target="../embeddings/oleObject83.bin"/><Relationship Id="rId37" Type="http://schemas.openxmlformats.org/officeDocument/2006/relationships/image" Target="../media/image85.emf"/><Relationship Id="rId40" Type="http://schemas.openxmlformats.org/officeDocument/2006/relationships/oleObject" Target="../embeddings/oleObject87.bin"/><Relationship Id="rId5" Type="http://schemas.openxmlformats.org/officeDocument/2006/relationships/image" Target="../media/image69.emf"/><Relationship Id="rId15" Type="http://schemas.openxmlformats.org/officeDocument/2006/relationships/image" Target="../media/image74.emf"/><Relationship Id="rId23" Type="http://schemas.openxmlformats.org/officeDocument/2006/relationships/image" Target="../media/image78.emf"/><Relationship Id="rId28" Type="http://schemas.openxmlformats.org/officeDocument/2006/relationships/oleObject" Target="../embeddings/oleObject81.bin"/><Relationship Id="rId36" Type="http://schemas.openxmlformats.org/officeDocument/2006/relationships/oleObject" Target="../embeddings/oleObject85.bin"/><Relationship Id="rId10" Type="http://schemas.openxmlformats.org/officeDocument/2006/relationships/oleObject" Target="../embeddings/oleObject72.bin"/><Relationship Id="rId19" Type="http://schemas.openxmlformats.org/officeDocument/2006/relationships/image" Target="../media/image76.emf"/><Relationship Id="rId31" Type="http://schemas.openxmlformats.org/officeDocument/2006/relationships/image" Target="../media/image82.emf"/><Relationship Id="rId4" Type="http://schemas.openxmlformats.org/officeDocument/2006/relationships/oleObject" Target="../embeddings/oleObject69.bin"/><Relationship Id="rId9" Type="http://schemas.openxmlformats.org/officeDocument/2006/relationships/image" Target="../media/image71.emf"/><Relationship Id="rId14" Type="http://schemas.openxmlformats.org/officeDocument/2006/relationships/oleObject" Target="../embeddings/oleObject74.bin"/><Relationship Id="rId22" Type="http://schemas.openxmlformats.org/officeDocument/2006/relationships/oleObject" Target="../embeddings/oleObject78.bin"/><Relationship Id="rId27" Type="http://schemas.openxmlformats.org/officeDocument/2006/relationships/image" Target="../media/image80.emf"/><Relationship Id="rId30" Type="http://schemas.openxmlformats.org/officeDocument/2006/relationships/oleObject" Target="../embeddings/oleObject82.bin"/><Relationship Id="rId35" Type="http://schemas.openxmlformats.org/officeDocument/2006/relationships/image" Target="../media/image84.emf"/><Relationship Id="rId43" Type="http://schemas.openxmlformats.org/officeDocument/2006/relationships/image" Target="../media/image88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2.bin"/><Relationship Id="rId13" Type="http://schemas.openxmlformats.org/officeDocument/2006/relationships/image" Target="../media/image94.emf"/><Relationship Id="rId18" Type="http://schemas.openxmlformats.org/officeDocument/2006/relationships/oleObject" Target="../embeddings/oleObject97.bin"/><Relationship Id="rId3" Type="http://schemas.openxmlformats.org/officeDocument/2006/relationships/image" Target="../media/image89.emf"/><Relationship Id="rId21" Type="http://schemas.openxmlformats.org/officeDocument/2006/relationships/image" Target="../media/image98.emf"/><Relationship Id="rId7" Type="http://schemas.openxmlformats.org/officeDocument/2006/relationships/image" Target="../media/image91.emf"/><Relationship Id="rId12" Type="http://schemas.openxmlformats.org/officeDocument/2006/relationships/oleObject" Target="../embeddings/oleObject94.bin"/><Relationship Id="rId17" Type="http://schemas.openxmlformats.org/officeDocument/2006/relationships/image" Target="../media/image96.emf"/><Relationship Id="rId2" Type="http://schemas.openxmlformats.org/officeDocument/2006/relationships/oleObject" Target="../embeddings/oleObject89.bin"/><Relationship Id="rId16" Type="http://schemas.openxmlformats.org/officeDocument/2006/relationships/oleObject" Target="../embeddings/oleObject96.bin"/><Relationship Id="rId20" Type="http://schemas.openxmlformats.org/officeDocument/2006/relationships/oleObject" Target="../embeddings/oleObject9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91.bin"/><Relationship Id="rId11" Type="http://schemas.openxmlformats.org/officeDocument/2006/relationships/image" Target="../media/image93.emf"/><Relationship Id="rId5" Type="http://schemas.openxmlformats.org/officeDocument/2006/relationships/image" Target="../media/image90.emf"/><Relationship Id="rId15" Type="http://schemas.openxmlformats.org/officeDocument/2006/relationships/image" Target="../media/image95.emf"/><Relationship Id="rId10" Type="http://schemas.openxmlformats.org/officeDocument/2006/relationships/oleObject" Target="../embeddings/oleObject93.bin"/><Relationship Id="rId19" Type="http://schemas.openxmlformats.org/officeDocument/2006/relationships/image" Target="../media/image97.emf"/><Relationship Id="rId4" Type="http://schemas.openxmlformats.org/officeDocument/2006/relationships/oleObject" Target="../embeddings/oleObject90.bin"/><Relationship Id="rId9" Type="http://schemas.openxmlformats.org/officeDocument/2006/relationships/image" Target="../media/image92.emf"/><Relationship Id="rId14" Type="http://schemas.openxmlformats.org/officeDocument/2006/relationships/oleObject" Target="../embeddings/oleObject95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2.bin"/><Relationship Id="rId13" Type="http://schemas.openxmlformats.org/officeDocument/2006/relationships/image" Target="../media/image104.emf"/><Relationship Id="rId3" Type="http://schemas.openxmlformats.org/officeDocument/2006/relationships/image" Target="../media/image99.emf"/><Relationship Id="rId7" Type="http://schemas.openxmlformats.org/officeDocument/2006/relationships/image" Target="../media/image101.emf"/><Relationship Id="rId12" Type="http://schemas.openxmlformats.org/officeDocument/2006/relationships/oleObject" Target="../embeddings/oleObject104.bin"/><Relationship Id="rId2" Type="http://schemas.openxmlformats.org/officeDocument/2006/relationships/oleObject" Target="../embeddings/oleObject9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1.bin"/><Relationship Id="rId11" Type="http://schemas.openxmlformats.org/officeDocument/2006/relationships/image" Target="../media/image103.emf"/><Relationship Id="rId5" Type="http://schemas.openxmlformats.org/officeDocument/2006/relationships/image" Target="../media/image100.emf"/><Relationship Id="rId10" Type="http://schemas.openxmlformats.org/officeDocument/2006/relationships/oleObject" Target="../embeddings/oleObject103.bin"/><Relationship Id="rId4" Type="http://schemas.openxmlformats.org/officeDocument/2006/relationships/oleObject" Target="../embeddings/oleObject100.bin"/><Relationship Id="rId9" Type="http://schemas.openxmlformats.org/officeDocument/2006/relationships/image" Target="../media/image10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6343C00F-CB02-F7C9-C6AB-01C0E4B53BCE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E223173-D721-64D1-CCE4-8F933FCC0041}"/>
              </a:ext>
            </a:extLst>
          </p:cNvPr>
          <p:cNvGrpSpPr/>
          <p:nvPr/>
        </p:nvGrpSpPr>
        <p:grpSpPr>
          <a:xfrm>
            <a:off x="1658163" y="1673271"/>
            <a:ext cx="9248662" cy="2258649"/>
            <a:chOff x="1059424" y="4646613"/>
            <a:chExt cx="9055136" cy="2211387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480A534A-C0E3-7B1E-C797-1B79BA13558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574321" y="4646613"/>
            <a:ext cx="1741487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1742079" imgH="2211296" progId="SigmaPlotGraphicObject.12">
                    <p:embed/>
                  </p:oleObj>
                </mc:Choice>
                <mc:Fallback>
                  <p:oleObj name="SPW 13.0 Graph" r:id="rId2" imgW="1742079" imgH="2211296" progId="SigmaPlotGraphicObject.12">
                    <p:embed/>
                    <p:pic>
                      <p:nvPicPr>
                        <p:cNvPr id="49" name="Object 48">
                          <a:extLst>
                            <a:ext uri="{FF2B5EF4-FFF2-40B4-BE49-F238E27FC236}">
                              <a16:creationId xmlns:a16="http://schemas.microsoft.com/office/drawing/2014/main" id="{16AFFD73-D0E0-D1DB-D311-448AF3218D0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574321" y="4646613"/>
                          <a:ext cx="1741487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27D8A5BE-447F-609A-5560-8A01142E327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988051" y="4646613"/>
            <a:ext cx="1730375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1729814" imgH="2211296" progId="SigmaPlotGraphicObject.12">
                    <p:embed/>
                  </p:oleObj>
                </mc:Choice>
                <mc:Fallback>
                  <p:oleObj name="SPW 13.0 Graph" r:id="rId4" imgW="1729814" imgH="2211296" progId="SigmaPlotGraphicObject.12">
                    <p:embed/>
                    <p:pic>
                      <p:nvPicPr>
                        <p:cNvPr id="50" name="Object 49">
                          <a:extLst>
                            <a:ext uri="{FF2B5EF4-FFF2-40B4-BE49-F238E27FC236}">
                              <a16:creationId xmlns:a16="http://schemas.microsoft.com/office/drawing/2014/main" id="{B0F31C40-485F-16C6-D506-B278C4581C8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988051" y="4646613"/>
                          <a:ext cx="1730375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6" name="Object 45">
              <a:extLst>
                <a:ext uri="{FF2B5EF4-FFF2-40B4-BE49-F238E27FC236}">
                  <a16:creationId xmlns:a16="http://schemas.microsoft.com/office/drawing/2014/main" id="{D4E49726-1E1E-2980-E579-75810DC235C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028700" y="4646613"/>
            <a:ext cx="1876425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1875919" imgH="2211296" progId="SigmaPlotGraphicObject.12">
                    <p:embed/>
                  </p:oleObj>
                </mc:Choice>
                <mc:Fallback>
                  <p:oleObj name="SPW 13.0 Graph" r:id="rId6" imgW="1875919" imgH="2211296" progId="SigmaPlotGraphicObject.12">
                    <p:embed/>
                    <p:pic>
                      <p:nvPicPr>
                        <p:cNvPr id="51" name="Object 50">
                          <a:extLst>
                            <a:ext uri="{FF2B5EF4-FFF2-40B4-BE49-F238E27FC236}">
                              <a16:creationId xmlns:a16="http://schemas.microsoft.com/office/drawing/2014/main" id="{FFB7DFE7-FFD7-F052-8F37-1A56201EC43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028700" y="4646613"/>
                          <a:ext cx="1876425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ED8F6A6-E55C-040C-0C1E-DD48DF15C520}"/>
                </a:ext>
              </a:extLst>
            </p:cNvPr>
            <p:cNvSpPr txBox="1"/>
            <p:nvPr/>
          </p:nvSpPr>
          <p:spPr>
            <a:xfrm>
              <a:off x="8262340" y="5958426"/>
              <a:ext cx="185222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H2S, NQ, GSH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H2S, NQ, GSH, SOD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H2S, NQ, GSH, Cat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H2S, NQ, GSH, SOD, Cat</a:t>
              </a:r>
            </a:p>
          </p:txBody>
        </p:sp>
        <p:graphicFrame>
          <p:nvGraphicFramePr>
            <p:cNvPr id="75" name="Object 74">
              <a:extLst>
                <a:ext uri="{FF2B5EF4-FFF2-40B4-BE49-F238E27FC236}">
                  <a16:creationId xmlns:a16="http://schemas.microsoft.com/office/drawing/2014/main" id="{DBD284F5-F52B-2AD3-C008-AF0F2BD57D5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52823" y="4646613"/>
            <a:ext cx="180340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8" imgW="1803047" imgH="2211296" progId="SigmaPlotGraphicObject.12">
                    <p:embed/>
                  </p:oleObj>
                </mc:Choice>
                <mc:Fallback>
                  <p:oleObj name="SPW 13.0 Graph" r:id="rId8" imgW="1803047" imgH="2211296" progId="SigmaPlotGraphicObject.12">
                    <p:embed/>
                    <p:pic>
                      <p:nvPicPr>
                        <p:cNvPr id="53" name="Object 52">
                          <a:extLst>
                            <a:ext uri="{FF2B5EF4-FFF2-40B4-BE49-F238E27FC236}">
                              <a16:creationId xmlns:a16="http://schemas.microsoft.com/office/drawing/2014/main" id="{D9378312-E773-B1B1-F6E3-E158FC70D94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552823" y="4646613"/>
                          <a:ext cx="180340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6" name="Object 75">
              <a:extLst>
                <a:ext uri="{FF2B5EF4-FFF2-40B4-BE49-F238E27FC236}">
                  <a16:creationId xmlns:a16="http://schemas.microsoft.com/office/drawing/2014/main" id="{42690676-D96C-F9E0-DF6A-52A80DF72FB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59424" y="4646613"/>
            <a:ext cx="1806575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1805933" imgH="2211296" progId="SigmaPlotGraphicObject.12">
                    <p:embed/>
                  </p:oleObj>
                </mc:Choice>
                <mc:Fallback>
                  <p:oleObj name="SPW 13.0 Graph" r:id="rId10" imgW="1805933" imgH="2211296" progId="SigmaPlotGraphicObject.12">
                    <p:embed/>
                    <p:pic>
                      <p:nvPicPr>
                        <p:cNvPr id="54" name="Object 53">
                          <a:extLst>
                            <a:ext uri="{FF2B5EF4-FFF2-40B4-BE49-F238E27FC236}">
                              <a16:creationId xmlns:a16="http://schemas.microsoft.com/office/drawing/2014/main" id="{515338AA-1237-4310-22F9-D6D445BE25B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059424" y="4646613"/>
                          <a:ext cx="1806575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DD17853-BD89-8B24-D26D-9ABDBDC9FE86}"/>
                </a:ext>
              </a:extLst>
            </p:cNvPr>
            <p:cNvSpPr txBox="1"/>
            <p:nvPr/>
          </p:nvSpPr>
          <p:spPr>
            <a:xfrm>
              <a:off x="1827282" y="4932468"/>
              <a:ext cx="502447" cy="25099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en-US" sz="1000" dirty="0"/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C2FC950-831E-E0FA-417C-79FE48469540}"/>
                </a:ext>
              </a:extLst>
            </p:cNvPr>
            <p:cNvSpPr txBox="1"/>
            <p:nvPr/>
          </p:nvSpPr>
          <p:spPr>
            <a:xfrm>
              <a:off x="3315503" y="4932468"/>
              <a:ext cx="50244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93DC055-3D96-465D-8090-D3FB762C5D8D}"/>
                </a:ext>
              </a:extLst>
            </p:cNvPr>
            <p:cNvSpPr txBox="1"/>
            <p:nvPr/>
          </p:nvSpPr>
          <p:spPr>
            <a:xfrm>
              <a:off x="4805476" y="4937238"/>
              <a:ext cx="53528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H</a:t>
              </a:r>
              <a:endParaRPr lang="en-US" sz="1000" dirty="0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4ADE8990-B208-F9BD-F340-7F634B5CC751}"/>
                </a:ext>
              </a:extLst>
            </p:cNvPr>
            <p:cNvSpPr txBox="1"/>
            <p:nvPr/>
          </p:nvSpPr>
          <p:spPr>
            <a:xfrm>
              <a:off x="6331701" y="4937238"/>
              <a:ext cx="70652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SH</a:t>
              </a:r>
              <a:endParaRPr lang="en-US" sz="1000" dirty="0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A07E6A40-F7D8-F5DF-88EF-49AC6EEC8482}"/>
                </a:ext>
              </a:extLst>
            </p:cNvPr>
            <p:cNvSpPr txBox="1"/>
            <p:nvPr/>
          </p:nvSpPr>
          <p:spPr>
            <a:xfrm>
              <a:off x="7641606" y="4937238"/>
              <a:ext cx="70652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SSH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4675817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6786A0F-E111-53EE-C3F0-CF0F21F3414F}"/>
              </a:ext>
            </a:extLst>
          </p:cNvPr>
          <p:cNvSpPr txBox="1"/>
          <p:nvPr/>
        </p:nvSpPr>
        <p:spPr>
          <a:xfrm>
            <a:off x="1622280" y="4376768"/>
            <a:ext cx="9678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385CD218-751B-00F1-1D98-90F7D4832694}"/>
              </a:ext>
            </a:extLst>
          </p:cNvPr>
          <p:cNvGrpSpPr/>
          <p:nvPr/>
        </p:nvGrpSpPr>
        <p:grpSpPr>
          <a:xfrm>
            <a:off x="2377504" y="1482078"/>
            <a:ext cx="2339661" cy="2211387"/>
            <a:chOff x="3263496" y="-150683"/>
            <a:chExt cx="2339661" cy="2211387"/>
          </a:xfrm>
        </p:grpSpPr>
        <p:graphicFrame>
          <p:nvGraphicFramePr>
            <p:cNvPr id="54" name="Object 53">
              <a:extLst>
                <a:ext uri="{FF2B5EF4-FFF2-40B4-BE49-F238E27FC236}">
                  <a16:creationId xmlns:a16="http://schemas.microsoft.com/office/drawing/2014/main" id="{76C1772D-3818-7C45-021A-810877B33DD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263496" y="-150683"/>
            <a:ext cx="1538287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1537893" imgH="2211296" progId="SigmaPlotGraphicObject.12">
                    <p:embed/>
                  </p:oleObj>
                </mc:Choice>
                <mc:Fallback>
                  <p:oleObj name="SPW 13.0 Graph" r:id="rId2" imgW="1537893" imgH="2211296" progId="SigmaPlotGraphicObject.12">
                    <p:embed/>
                    <p:pic>
                      <p:nvPicPr>
                        <p:cNvPr id="54" name="Object 53">
                          <a:extLst>
                            <a:ext uri="{FF2B5EF4-FFF2-40B4-BE49-F238E27FC236}">
                              <a16:creationId xmlns:a16="http://schemas.microsoft.com/office/drawing/2014/main" id="{76C1772D-3818-7C45-021A-810877B33DD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263496" y="-150683"/>
                          <a:ext cx="1538287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BDD2B86-0629-A46A-280C-FF81E7270568}"/>
                </a:ext>
              </a:extLst>
            </p:cNvPr>
            <p:cNvSpPr txBox="1"/>
            <p:nvPr/>
          </p:nvSpPr>
          <p:spPr>
            <a:xfrm>
              <a:off x="4495339" y="1164412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6116F46-5445-56D5-ACC8-333F686C50D7}"/>
                </a:ext>
              </a:extLst>
            </p:cNvPr>
            <p:cNvSpPr txBox="1"/>
            <p:nvPr/>
          </p:nvSpPr>
          <p:spPr>
            <a:xfrm>
              <a:off x="3949064" y="446430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D369BB7-991E-C197-84D4-D027F68562DE}"/>
                </a:ext>
              </a:extLst>
            </p:cNvPr>
            <p:cNvSpPr txBox="1"/>
            <p:nvPr/>
          </p:nvSpPr>
          <p:spPr>
            <a:xfrm>
              <a:off x="4311011" y="249657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502CA861-67E4-A6BE-6C72-2DA216354D64}"/>
              </a:ext>
            </a:extLst>
          </p:cNvPr>
          <p:cNvSpPr txBox="1"/>
          <p:nvPr/>
        </p:nvSpPr>
        <p:spPr>
          <a:xfrm>
            <a:off x="1572483" y="2526454"/>
            <a:ext cx="9678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12EC23ED-1332-82FA-0564-EBF1D56BB684}"/>
              </a:ext>
            </a:extLst>
          </p:cNvPr>
          <p:cNvGrpSpPr/>
          <p:nvPr/>
        </p:nvGrpSpPr>
        <p:grpSpPr>
          <a:xfrm>
            <a:off x="4719518" y="1463265"/>
            <a:ext cx="2350855" cy="2211387"/>
            <a:chOff x="5595884" y="-227252"/>
            <a:chExt cx="2350855" cy="2211387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B665045-8AD3-4D76-8CBC-042DF6294123}"/>
                </a:ext>
              </a:extLst>
            </p:cNvPr>
            <p:cNvSpPr txBox="1"/>
            <p:nvPr/>
          </p:nvSpPr>
          <p:spPr>
            <a:xfrm>
              <a:off x="6838921" y="1119034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55" name="Object 54">
              <a:extLst>
                <a:ext uri="{FF2B5EF4-FFF2-40B4-BE49-F238E27FC236}">
                  <a16:creationId xmlns:a16="http://schemas.microsoft.com/office/drawing/2014/main" id="{D7562A92-E4F7-EC9B-3978-44B95B4973E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595884" y="-227252"/>
            <a:ext cx="1538287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1537893" imgH="2211296" progId="SigmaPlotGraphicObject.12">
                    <p:embed/>
                  </p:oleObj>
                </mc:Choice>
                <mc:Fallback>
                  <p:oleObj name="SPW 13.0 Graph" r:id="rId4" imgW="1537893" imgH="2211296" progId="SigmaPlotGraphicObject.12">
                    <p:embed/>
                    <p:pic>
                      <p:nvPicPr>
                        <p:cNvPr id="55" name="Object 54">
                          <a:extLst>
                            <a:ext uri="{FF2B5EF4-FFF2-40B4-BE49-F238E27FC236}">
                              <a16:creationId xmlns:a16="http://schemas.microsoft.com/office/drawing/2014/main" id="{D7562A92-E4F7-EC9B-3978-44B95B4973E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595884" y="-227252"/>
                          <a:ext cx="1538287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340C9ED6-FA78-B50A-10EE-47B8182EF019}"/>
              </a:ext>
            </a:extLst>
          </p:cNvPr>
          <p:cNvGrpSpPr/>
          <p:nvPr/>
        </p:nvGrpSpPr>
        <p:grpSpPr>
          <a:xfrm>
            <a:off x="7126151" y="1470609"/>
            <a:ext cx="2333988" cy="2211387"/>
            <a:chOff x="4951309" y="1190197"/>
            <a:chExt cx="2333988" cy="2211387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030F951-7305-B54C-9942-C321EF5A7630}"/>
                </a:ext>
              </a:extLst>
            </p:cNvPr>
            <p:cNvSpPr txBox="1"/>
            <p:nvPr/>
          </p:nvSpPr>
          <p:spPr>
            <a:xfrm>
              <a:off x="6177479" y="2510758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58" name="Object 57">
              <a:extLst>
                <a:ext uri="{FF2B5EF4-FFF2-40B4-BE49-F238E27FC236}">
                  <a16:creationId xmlns:a16="http://schemas.microsoft.com/office/drawing/2014/main" id="{ADB29AA0-C66F-BB21-FB22-3ED7E04B6C5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951309" y="1190197"/>
            <a:ext cx="1538287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1537893" imgH="2211296" progId="SigmaPlotGraphicObject.12">
                    <p:embed/>
                  </p:oleObj>
                </mc:Choice>
                <mc:Fallback>
                  <p:oleObj name="SPW 13.0 Graph" r:id="rId6" imgW="1537893" imgH="2211296" progId="SigmaPlotGraphicObject.12">
                    <p:embed/>
                    <p:pic>
                      <p:nvPicPr>
                        <p:cNvPr id="58" name="Object 57">
                          <a:extLst>
                            <a:ext uri="{FF2B5EF4-FFF2-40B4-BE49-F238E27FC236}">
                              <a16:creationId xmlns:a16="http://schemas.microsoft.com/office/drawing/2014/main" id="{ADB29AA0-C66F-BB21-FB22-3ED7E04B6C5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951309" y="1190197"/>
                          <a:ext cx="1538287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F7736D70-02FF-2AB0-5CCD-2BB8A52E38EF}"/>
              </a:ext>
            </a:extLst>
          </p:cNvPr>
          <p:cNvGrpSpPr/>
          <p:nvPr/>
        </p:nvGrpSpPr>
        <p:grpSpPr>
          <a:xfrm>
            <a:off x="2447875" y="3412207"/>
            <a:ext cx="2265096" cy="2211387"/>
            <a:chOff x="2301741" y="2717149"/>
            <a:chExt cx="2265096" cy="2211387"/>
          </a:xfrm>
        </p:grpSpPr>
        <p:graphicFrame>
          <p:nvGraphicFramePr>
            <p:cNvPr id="60" name="Object 59">
              <a:extLst>
                <a:ext uri="{FF2B5EF4-FFF2-40B4-BE49-F238E27FC236}">
                  <a16:creationId xmlns:a16="http://schemas.microsoft.com/office/drawing/2014/main" id="{6A4BF3F2-6986-7ED4-C258-9016292DE45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01741" y="2717149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8" imgW="1467546" imgH="2211296" progId="SigmaPlotGraphicObject.12">
                    <p:embed/>
                  </p:oleObj>
                </mc:Choice>
                <mc:Fallback>
                  <p:oleObj name="SPW 13.0 Graph" r:id="rId8" imgW="1467546" imgH="2211296" progId="SigmaPlotGraphicObject.12">
                    <p:embed/>
                    <p:pic>
                      <p:nvPicPr>
                        <p:cNvPr id="60" name="Object 59">
                          <a:extLst>
                            <a:ext uri="{FF2B5EF4-FFF2-40B4-BE49-F238E27FC236}">
                              <a16:creationId xmlns:a16="http://schemas.microsoft.com/office/drawing/2014/main" id="{6A4BF3F2-6986-7ED4-C258-9016292DE45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301741" y="2717149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AD65E85-4C9E-97B1-D543-2B93BEE117EE}"/>
                </a:ext>
              </a:extLst>
            </p:cNvPr>
            <p:cNvSpPr txBox="1"/>
            <p:nvPr/>
          </p:nvSpPr>
          <p:spPr>
            <a:xfrm>
              <a:off x="2930607" y="3483237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D604A8E-E971-1C92-57FC-9699A5BF8F5C}"/>
                </a:ext>
              </a:extLst>
            </p:cNvPr>
            <p:cNvSpPr txBox="1"/>
            <p:nvPr/>
          </p:nvSpPr>
          <p:spPr>
            <a:xfrm>
              <a:off x="3286278" y="3072996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4CC393E-86E6-CCBC-2F20-AB7EBFDFF517}"/>
                </a:ext>
              </a:extLst>
            </p:cNvPr>
            <p:cNvSpPr txBox="1"/>
            <p:nvPr/>
          </p:nvSpPr>
          <p:spPr>
            <a:xfrm>
              <a:off x="3459019" y="4035942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B539F104-251B-8EF6-37B0-8D9C60EDA2A3}"/>
              </a:ext>
            </a:extLst>
          </p:cNvPr>
          <p:cNvGrpSpPr/>
          <p:nvPr/>
        </p:nvGrpSpPr>
        <p:grpSpPr>
          <a:xfrm>
            <a:off x="4793600" y="3414697"/>
            <a:ext cx="2253192" cy="2211387"/>
            <a:chOff x="5642905" y="1693863"/>
            <a:chExt cx="2253192" cy="2211387"/>
          </a:xfrm>
        </p:grpSpPr>
        <p:graphicFrame>
          <p:nvGraphicFramePr>
            <p:cNvPr id="63" name="Object 62">
              <a:extLst>
                <a:ext uri="{FF2B5EF4-FFF2-40B4-BE49-F238E27FC236}">
                  <a16:creationId xmlns:a16="http://schemas.microsoft.com/office/drawing/2014/main" id="{904F65E0-69A6-A9FB-80D5-C861B20C9A9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642905" y="1693863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1467546" imgH="2211296" progId="SigmaPlotGraphicObject.12">
                    <p:embed/>
                  </p:oleObj>
                </mc:Choice>
                <mc:Fallback>
                  <p:oleObj name="SPW 13.0 Graph" r:id="rId10" imgW="1467546" imgH="2211296" progId="SigmaPlotGraphicObject.12">
                    <p:embed/>
                    <p:pic>
                      <p:nvPicPr>
                        <p:cNvPr id="63" name="Object 62">
                          <a:extLst>
                            <a:ext uri="{FF2B5EF4-FFF2-40B4-BE49-F238E27FC236}">
                              <a16:creationId xmlns:a16="http://schemas.microsoft.com/office/drawing/2014/main" id="{904F65E0-69A6-A9FB-80D5-C861B20C9A9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642905" y="1693863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81E1597-7DCB-C594-9497-1BFC422EFC76}"/>
                </a:ext>
              </a:extLst>
            </p:cNvPr>
            <p:cNvSpPr txBox="1"/>
            <p:nvPr/>
          </p:nvSpPr>
          <p:spPr>
            <a:xfrm>
              <a:off x="6788279" y="3008889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7F5CCDD2-9513-42F1-16D4-8120922532B5}"/>
              </a:ext>
            </a:extLst>
          </p:cNvPr>
          <p:cNvGrpSpPr/>
          <p:nvPr/>
        </p:nvGrpSpPr>
        <p:grpSpPr>
          <a:xfrm>
            <a:off x="7187551" y="3417429"/>
            <a:ext cx="2283874" cy="2211387"/>
            <a:chOff x="8311184" y="1653278"/>
            <a:chExt cx="2283874" cy="2211387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66D1AD2-C017-7900-91E7-74A02E0DDAA3}"/>
                </a:ext>
              </a:extLst>
            </p:cNvPr>
            <p:cNvSpPr txBox="1"/>
            <p:nvPr/>
          </p:nvSpPr>
          <p:spPr>
            <a:xfrm>
              <a:off x="9293678" y="3178209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graphicFrame>
          <p:nvGraphicFramePr>
            <p:cNvPr id="66" name="Object 65">
              <a:extLst>
                <a:ext uri="{FF2B5EF4-FFF2-40B4-BE49-F238E27FC236}">
                  <a16:creationId xmlns:a16="http://schemas.microsoft.com/office/drawing/2014/main" id="{D116847C-495D-0985-1A95-C429C3C03E3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311184" y="1653278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2" imgW="1467546" imgH="2211296" progId="SigmaPlotGraphicObject.12">
                    <p:embed/>
                  </p:oleObj>
                </mc:Choice>
                <mc:Fallback>
                  <p:oleObj name="SPW 13.0 Graph" r:id="rId12" imgW="1467546" imgH="2211296" progId="SigmaPlotGraphicObject.12">
                    <p:embed/>
                    <p:pic>
                      <p:nvPicPr>
                        <p:cNvPr id="66" name="Object 65">
                          <a:extLst>
                            <a:ext uri="{FF2B5EF4-FFF2-40B4-BE49-F238E27FC236}">
                              <a16:creationId xmlns:a16="http://schemas.microsoft.com/office/drawing/2014/main" id="{D116847C-495D-0985-1A95-C429C3C03E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311184" y="1653278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FD5DF64-9100-EDA2-C2AF-4736064A70D9}"/>
                </a:ext>
              </a:extLst>
            </p:cNvPr>
            <p:cNvSpPr txBox="1"/>
            <p:nvPr/>
          </p:nvSpPr>
          <p:spPr>
            <a:xfrm>
              <a:off x="9487240" y="2976130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Jug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Jug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10" name="TextBox 109">
            <a:extLst>
              <a:ext uri="{FF2B5EF4-FFF2-40B4-BE49-F238E27FC236}">
                <a16:creationId xmlns:a16="http://schemas.microsoft.com/office/drawing/2014/main" id="{BB8B670C-117F-331A-C312-16ACBA04A56F}"/>
              </a:ext>
            </a:extLst>
          </p:cNvPr>
          <p:cNvSpPr txBox="1"/>
          <p:nvPr/>
        </p:nvSpPr>
        <p:spPr>
          <a:xfrm>
            <a:off x="2323500" y="1653082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3C11007-3DEC-88D9-BE97-534C270D33A8}"/>
              </a:ext>
            </a:extLst>
          </p:cNvPr>
          <p:cNvSpPr txBox="1"/>
          <p:nvPr/>
        </p:nvSpPr>
        <p:spPr>
          <a:xfrm>
            <a:off x="4736319" y="1651148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18D44FD-D2A7-04BC-41B6-0C76BE951590}"/>
              </a:ext>
            </a:extLst>
          </p:cNvPr>
          <p:cNvSpPr txBox="1"/>
          <p:nvPr/>
        </p:nvSpPr>
        <p:spPr>
          <a:xfrm>
            <a:off x="7047075" y="1644616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AB91899-356F-60A0-E53C-DD86E0ADCF85}"/>
              </a:ext>
            </a:extLst>
          </p:cNvPr>
          <p:cNvSpPr txBox="1"/>
          <p:nvPr/>
        </p:nvSpPr>
        <p:spPr>
          <a:xfrm>
            <a:off x="2320180" y="356729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8F23E1F-7760-0D64-B684-6D9A96FF9AE8}"/>
              </a:ext>
            </a:extLst>
          </p:cNvPr>
          <p:cNvSpPr txBox="1"/>
          <p:nvPr/>
        </p:nvSpPr>
        <p:spPr>
          <a:xfrm>
            <a:off x="7067196" y="3572052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DD868E1-F461-EFC4-7283-0C046D517B77}"/>
              </a:ext>
            </a:extLst>
          </p:cNvPr>
          <p:cNvSpPr txBox="1"/>
          <p:nvPr/>
        </p:nvSpPr>
        <p:spPr>
          <a:xfrm>
            <a:off x="4738864" y="356358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DE2CE867-F3CA-C47F-E017-60AB6175BB3A}"/>
              </a:ext>
            </a:extLst>
          </p:cNvPr>
          <p:cNvSpPr txBox="1"/>
          <p:nvPr/>
        </p:nvSpPr>
        <p:spPr>
          <a:xfrm>
            <a:off x="2983720" y="1592928"/>
            <a:ext cx="9678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GSH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C08BFA1-2533-497C-CC8C-DAB3DB71BC8D}"/>
              </a:ext>
            </a:extLst>
          </p:cNvPr>
          <p:cNvSpPr txBox="1"/>
          <p:nvPr/>
        </p:nvSpPr>
        <p:spPr>
          <a:xfrm>
            <a:off x="5480309" y="1592006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96CFC4E-5F90-2C42-411D-8E6296077786}"/>
              </a:ext>
            </a:extLst>
          </p:cNvPr>
          <p:cNvSpPr txBox="1"/>
          <p:nvPr/>
        </p:nvSpPr>
        <p:spPr>
          <a:xfrm>
            <a:off x="7841653" y="1605052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530CBF1-BE1F-0ED3-9112-ABA6B695CB60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5F72695-142C-74D5-5F49-A0814B66B93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510037" y="1467135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4" imgW="1467546" imgH="2211296" progId="SigmaPlotGraphicObject.12">
                  <p:embed/>
                </p:oleObj>
              </mc:Choice>
              <mc:Fallback>
                <p:oleObj name="SPW 13.0 Graph" r:id="rId14" imgW="1467546" imgH="2211296" progId="SigmaPlotGraphicObject.12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5F72695-142C-74D5-5F49-A0814B66B9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510037" y="1467135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EE26C6AB-2EF8-CDE1-2C5D-A928EC12E412}"/>
              </a:ext>
            </a:extLst>
          </p:cNvPr>
          <p:cNvSpPr txBox="1"/>
          <p:nvPr/>
        </p:nvSpPr>
        <p:spPr>
          <a:xfrm>
            <a:off x="10166823" y="1651319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2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E169FB3-B183-A1AB-AAA3-C870AF25E07C}"/>
              </a:ext>
            </a:extLst>
          </p:cNvPr>
          <p:cNvSpPr txBox="1"/>
          <p:nvPr/>
        </p:nvSpPr>
        <p:spPr>
          <a:xfrm>
            <a:off x="10680864" y="2791274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Jug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Jug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Jug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 +Jug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9D93E21-F846-E21C-6182-2397CFD868FF}"/>
              </a:ext>
            </a:extLst>
          </p:cNvPr>
          <p:cNvSpPr txBox="1"/>
          <p:nvPr/>
        </p:nvSpPr>
        <p:spPr>
          <a:xfrm>
            <a:off x="10141816" y="2448703"/>
            <a:ext cx="33309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b="1" dirty="0"/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BC085273-5D39-533B-3A5D-348537AB44F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506252" y="3419792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6" imgW="1467546" imgH="2211296" progId="SigmaPlotGraphicObject.12">
                  <p:embed/>
                </p:oleObj>
              </mc:Choice>
              <mc:Fallback>
                <p:oleObj name="SPW 13.0 Graph" r:id="rId16" imgW="1467546" imgH="2211296" progId="SigmaPlotGraphicObject.12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BC085273-5D39-533B-3A5D-348537AB44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506252" y="3419792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75501F2-0195-3725-ADC6-715F10308E70}"/>
              </a:ext>
            </a:extLst>
          </p:cNvPr>
          <p:cNvSpPr txBox="1"/>
          <p:nvPr/>
        </p:nvSpPr>
        <p:spPr>
          <a:xfrm>
            <a:off x="10669635" y="4733975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Jug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Jug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Jug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 +Jug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5FE8599-0FC6-C9F4-4CD7-30FEBB917F29}"/>
              </a:ext>
            </a:extLst>
          </p:cNvPr>
          <p:cNvSpPr txBox="1"/>
          <p:nvPr/>
        </p:nvSpPr>
        <p:spPr>
          <a:xfrm>
            <a:off x="10135396" y="4145950"/>
            <a:ext cx="33309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460A9F-91F6-8280-71B2-B62FD17D1E50}"/>
              </a:ext>
            </a:extLst>
          </p:cNvPr>
          <p:cNvSpPr txBox="1"/>
          <p:nvPr/>
        </p:nvSpPr>
        <p:spPr>
          <a:xfrm>
            <a:off x="10485115" y="4279098"/>
            <a:ext cx="33309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AC5CBF5-50A5-5AB1-3279-209FF3593539}"/>
              </a:ext>
            </a:extLst>
          </p:cNvPr>
          <p:cNvSpPr txBox="1"/>
          <p:nvPr/>
        </p:nvSpPr>
        <p:spPr>
          <a:xfrm>
            <a:off x="9463568" y="164151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6B5BF9B-527E-7717-E589-45E3F2DC4587}"/>
              </a:ext>
            </a:extLst>
          </p:cNvPr>
          <p:cNvSpPr txBox="1"/>
          <p:nvPr/>
        </p:nvSpPr>
        <p:spPr>
          <a:xfrm>
            <a:off x="9430315" y="357837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39110121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0CBFE4C-8995-73FD-0092-C09438EDAA4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22901" y="1475893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2" imgW="1467546" imgH="2211296" progId="SigmaPlotGraphicObject.12">
                  <p:embed/>
                </p:oleObj>
              </mc:Choice>
              <mc:Fallback>
                <p:oleObj name="SPW 13.0 Graph" r:id="rId2" imgW="1467546" imgH="2211296" progId="SigmaPlotGraphicObject.12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0CBFE4C-8995-73FD-0092-C09438EDAA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22901" y="1475893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BAFEBB8-A410-3549-2962-3F1CD1B49C3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679029" y="1476575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4" imgW="1467546" imgH="2211296" progId="SigmaPlotGraphicObject.12">
                  <p:embed/>
                </p:oleObj>
              </mc:Choice>
              <mc:Fallback>
                <p:oleObj name="SPW 13.0 Graph" r:id="rId4" imgW="1467546" imgH="2211296" progId="SigmaPlotGraphicObject.12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BAFEBB8-A410-3549-2962-3F1CD1B49C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79029" y="1476575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E01A2228-1193-C53E-5B8C-3D6286B4465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24131" y="3420281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6" imgW="1467546" imgH="2211296" progId="SigmaPlotGraphicObject.12">
                  <p:embed/>
                </p:oleObj>
              </mc:Choice>
              <mc:Fallback>
                <p:oleObj name="SPW 13.0 Graph" r:id="rId6" imgW="1467546" imgH="2211296" progId="SigmaPlotGraphicObject.12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E01A2228-1193-C53E-5B8C-3D6286B446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24131" y="3420281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B86D6CE0-65F1-BF2F-2E27-0746DF5CBC0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91695" y="3417840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8" imgW="1467546" imgH="2211296" progId="SigmaPlotGraphicObject.12">
                  <p:embed/>
                </p:oleObj>
              </mc:Choice>
              <mc:Fallback>
                <p:oleObj name="SPW 13.0 Graph" r:id="rId8" imgW="1467546" imgH="2211296" progId="SigmaPlotGraphicObject.12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B86D6CE0-65F1-BF2F-2E27-0746DF5CBC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091695" y="3417840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3A479E2-34E5-88C7-9FEA-08F32C6F447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86257" y="1477509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0" imgW="1467546" imgH="2211296" progId="SigmaPlotGraphicObject.12">
                  <p:embed/>
                </p:oleObj>
              </mc:Choice>
              <mc:Fallback>
                <p:oleObj name="SPW 13.0 Graph" r:id="rId10" imgW="1467546" imgH="2211296" progId="SigmaPlotGraphicObjec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3A479E2-34E5-88C7-9FEA-08F32C6F44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086257" y="1477509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TextBox 69">
            <a:extLst>
              <a:ext uri="{FF2B5EF4-FFF2-40B4-BE49-F238E27FC236}">
                <a16:creationId xmlns:a16="http://schemas.microsoft.com/office/drawing/2014/main" id="{C44999DF-A49B-3096-0CA1-B4636AFAC2F4}"/>
              </a:ext>
            </a:extLst>
          </p:cNvPr>
          <p:cNvSpPr txBox="1"/>
          <p:nvPr/>
        </p:nvSpPr>
        <p:spPr>
          <a:xfrm>
            <a:off x="2845292" y="2810909"/>
            <a:ext cx="121530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GSH+PB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GSH+PB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469C703-2603-CBB6-93D4-33CB2EB025AD}"/>
              </a:ext>
            </a:extLst>
          </p:cNvPr>
          <p:cNvSpPr txBox="1"/>
          <p:nvPr/>
        </p:nvSpPr>
        <p:spPr>
          <a:xfrm>
            <a:off x="7596047" y="4735021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PA+PB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PA+PB)</a:t>
            </a:r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5E4C0F1C-4E3D-2ACF-46D2-70CD2066030D}"/>
              </a:ext>
            </a:extLst>
          </p:cNvPr>
          <p:cNvGrpSpPr/>
          <p:nvPr/>
        </p:nvGrpSpPr>
        <p:grpSpPr>
          <a:xfrm>
            <a:off x="2290500" y="2051710"/>
            <a:ext cx="4067412" cy="1279781"/>
            <a:chOff x="3861743" y="4112473"/>
            <a:chExt cx="4067412" cy="1279781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08AB59D-D107-22A7-2281-4BA32A5FA5CF}"/>
                </a:ext>
              </a:extLst>
            </p:cNvPr>
            <p:cNvSpPr txBox="1"/>
            <p:nvPr/>
          </p:nvSpPr>
          <p:spPr>
            <a:xfrm>
              <a:off x="6821337" y="4869034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P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P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D1B5EBA-4DE8-1880-D1F6-C6CC664DEA33}"/>
                </a:ext>
              </a:extLst>
            </p:cNvPr>
            <p:cNvSpPr txBox="1"/>
            <p:nvPr/>
          </p:nvSpPr>
          <p:spPr>
            <a:xfrm>
              <a:off x="3861743" y="4112473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5C27DA4-D2BC-4501-DF3A-30C247CE16DB}"/>
                </a:ext>
              </a:extLst>
            </p:cNvPr>
            <p:cNvSpPr txBox="1"/>
            <p:nvPr/>
          </p:nvSpPr>
          <p:spPr>
            <a:xfrm>
              <a:off x="6630742" y="5051650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D52FFBAB-8952-7CA9-4423-D819BB9FE82D}"/>
              </a:ext>
            </a:extLst>
          </p:cNvPr>
          <p:cNvGrpSpPr/>
          <p:nvPr/>
        </p:nvGrpSpPr>
        <p:grpSpPr>
          <a:xfrm>
            <a:off x="2293665" y="3853262"/>
            <a:ext cx="1780462" cy="1420017"/>
            <a:chOff x="4120486" y="5334716"/>
            <a:chExt cx="1780462" cy="1420017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0583EC1-3AE9-6194-E88F-4D23CC36772D}"/>
                </a:ext>
              </a:extLst>
            </p:cNvPr>
            <p:cNvSpPr txBox="1"/>
            <p:nvPr/>
          </p:nvSpPr>
          <p:spPr>
            <a:xfrm>
              <a:off x="4120486" y="5334716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16C1BB28-1986-82EF-9CD2-C400B02A3CC6}"/>
                </a:ext>
              </a:extLst>
            </p:cNvPr>
            <p:cNvSpPr txBox="1"/>
            <p:nvPr/>
          </p:nvSpPr>
          <p:spPr>
            <a:xfrm>
              <a:off x="4685642" y="6231513"/>
              <a:ext cx="1215306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GSH+PB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GSH+PB)</a:t>
              </a:r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2F91D9BD-F4F0-802A-55D9-CECAB393255A}"/>
              </a:ext>
            </a:extLst>
          </p:cNvPr>
          <p:cNvGrpSpPr/>
          <p:nvPr/>
        </p:nvGrpSpPr>
        <p:grpSpPr>
          <a:xfrm>
            <a:off x="5075899" y="4650410"/>
            <a:ext cx="2308912" cy="615245"/>
            <a:chOff x="6811848" y="6330646"/>
            <a:chExt cx="2308912" cy="615245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1AEC2D2-5F1F-66E6-E1A0-807E8B985A14}"/>
                </a:ext>
              </a:extLst>
            </p:cNvPr>
            <p:cNvSpPr txBox="1"/>
            <p:nvPr/>
          </p:nvSpPr>
          <p:spPr>
            <a:xfrm>
              <a:off x="6811848" y="6684335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63FB7F77-BC49-30E0-F103-9E6BEB6E9D30}"/>
                </a:ext>
              </a:extLst>
            </p:cNvPr>
            <p:cNvSpPr txBox="1"/>
            <p:nvPr/>
          </p:nvSpPr>
          <p:spPr>
            <a:xfrm>
              <a:off x="6992459" y="6422671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P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PB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P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4FA77496-C181-F922-739E-F165A6199471}"/>
                </a:ext>
              </a:extLst>
            </p:cNvPr>
            <p:cNvSpPr txBox="1"/>
            <p:nvPr/>
          </p:nvSpPr>
          <p:spPr>
            <a:xfrm>
              <a:off x="8787661" y="6330646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/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A73B2427-5F77-D151-229B-3677AEB3F610}"/>
              </a:ext>
            </a:extLst>
          </p:cNvPr>
          <p:cNvSpPr txBox="1"/>
          <p:nvPr/>
        </p:nvSpPr>
        <p:spPr>
          <a:xfrm>
            <a:off x="7591630" y="2797324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PA+PB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PA+PB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D89AB8D-C4BE-17FA-371D-2EEC5AAB03FD}"/>
              </a:ext>
            </a:extLst>
          </p:cNvPr>
          <p:cNvSpPr txBox="1"/>
          <p:nvPr/>
        </p:nvSpPr>
        <p:spPr>
          <a:xfrm>
            <a:off x="854791" y="4394784"/>
            <a:ext cx="9678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69E462A-0E9B-35D4-D31F-ABEE77B3F686}"/>
              </a:ext>
            </a:extLst>
          </p:cNvPr>
          <p:cNvSpPr txBox="1"/>
          <p:nvPr/>
        </p:nvSpPr>
        <p:spPr>
          <a:xfrm>
            <a:off x="804994" y="2544470"/>
            <a:ext cx="9678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2F74926-FBD5-C3B8-D15D-9127187815E7}"/>
              </a:ext>
            </a:extLst>
          </p:cNvPr>
          <p:cNvSpPr txBox="1"/>
          <p:nvPr/>
        </p:nvSpPr>
        <p:spPr>
          <a:xfrm>
            <a:off x="2449093" y="1610944"/>
            <a:ext cx="58385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S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D319129-B4C4-E631-F7C8-A8B6846C6B03}"/>
              </a:ext>
            </a:extLst>
          </p:cNvPr>
          <p:cNvSpPr txBox="1"/>
          <p:nvPr/>
        </p:nvSpPr>
        <p:spPr>
          <a:xfrm>
            <a:off x="4712820" y="1610022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5AE51A-FF39-F87D-5A49-CE03EA9806D6}"/>
              </a:ext>
            </a:extLst>
          </p:cNvPr>
          <p:cNvSpPr txBox="1"/>
          <p:nvPr/>
        </p:nvSpPr>
        <p:spPr>
          <a:xfrm>
            <a:off x="7074164" y="1623068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7ADC504-4544-7F9F-B5D8-9580D2A33288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1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0A7BF0C4-492C-765F-9160-384ED69A91C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678557" y="3420283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2" imgW="1467546" imgH="2211296" progId="SigmaPlotGraphicObject.12">
                  <p:embed/>
                </p:oleObj>
              </mc:Choice>
              <mc:Fallback>
                <p:oleObj name="SPW 13.0 Graph" r:id="rId12" imgW="1467546" imgH="2211296" progId="SigmaPlotGraphicObject.12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A7BF0C4-492C-765F-9160-384ED69A91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678557" y="3420283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F967CB66-8479-5B5A-8941-9FB1793942A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27369" y="1471954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4" imgW="1467546" imgH="2211296" progId="SigmaPlotGraphicObject.12">
                  <p:embed/>
                </p:oleObj>
              </mc:Choice>
              <mc:Fallback>
                <p:oleObj name="SPW 13.0 Graph" r:id="rId14" imgW="1467546" imgH="2211296" progId="SigmaPlotGraphicObject.12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F967CB66-8479-5B5A-8941-9FB1793942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627369" y="1471954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EF64615E-EC39-32B4-3CA1-9DDEEB530593}"/>
              </a:ext>
            </a:extLst>
          </p:cNvPr>
          <p:cNvSpPr txBox="1"/>
          <p:nvPr/>
        </p:nvSpPr>
        <p:spPr>
          <a:xfrm>
            <a:off x="9236504" y="2120396"/>
            <a:ext cx="33309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84679F-1E61-8B59-46BE-0E305717EDB9}"/>
              </a:ext>
            </a:extLst>
          </p:cNvPr>
          <p:cNvSpPr txBox="1"/>
          <p:nvPr/>
        </p:nvSpPr>
        <p:spPr>
          <a:xfrm>
            <a:off x="9790606" y="2796672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PB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PB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188479-04BD-B5D0-875C-0A316A7A7846}"/>
              </a:ext>
            </a:extLst>
          </p:cNvPr>
          <p:cNvSpPr txBox="1"/>
          <p:nvPr/>
        </p:nvSpPr>
        <p:spPr>
          <a:xfrm>
            <a:off x="9793874" y="4738626"/>
            <a:ext cx="11078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 +1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PB)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B</a:t>
            </a:r>
          </a:p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 +3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+PB)</a:t>
            </a:r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6671F9F0-93DD-5405-EFB9-D68DF0DD363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31612" y="3417429"/>
          <a:ext cx="146685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6" imgW="1467546" imgH="2211296" progId="SigmaPlotGraphicObject.12">
                  <p:embed/>
                </p:oleObj>
              </mc:Choice>
              <mc:Fallback>
                <p:oleObj name="SPW 13.0 Graph" r:id="rId16" imgW="1467546" imgH="2211296" progId="SigmaPlotGraphicObject.12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6671F9F0-93DD-5405-EFB9-D68DF0DD36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631612" y="3417429"/>
                        <a:ext cx="146685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DCB1EA8C-16E8-EAFB-C8C9-7BE5257776D6}"/>
              </a:ext>
            </a:extLst>
          </p:cNvPr>
          <p:cNvSpPr txBox="1"/>
          <p:nvPr/>
        </p:nvSpPr>
        <p:spPr>
          <a:xfrm>
            <a:off x="9241573" y="3777748"/>
            <a:ext cx="33309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89A7800-CDF6-DEDE-1C2B-42A4BBA631DD}"/>
              </a:ext>
            </a:extLst>
          </p:cNvPr>
          <p:cNvSpPr txBox="1"/>
          <p:nvPr/>
        </p:nvSpPr>
        <p:spPr>
          <a:xfrm>
            <a:off x="9316006" y="1636923"/>
            <a:ext cx="430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9239AB3-CBCF-51C6-0D17-E8A8FCC411CA}"/>
              </a:ext>
            </a:extLst>
          </p:cNvPr>
          <p:cNvSpPr txBox="1"/>
          <p:nvPr/>
        </p:nvSpPr>
        <p:spPr>
          <a:xfrm>
            <a:off x="1625230" y="1653082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C17A8E9-03F9-C9F2-3806-5A9EA5ED7D26}"/>
              </a:ext>
            </a:extLst>
          </p:cNvPr>
          <p:cNvSpPr txBox="1"/>
          <p:nvPr/>
        </p:nvSpPr>
        <p:spPr>
          <a:xfrm>
            <a:off x="4038049" y="1651148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2302E85-13BB-CC5B-E341-2275E0F8385B}"/>
              </a:ext>
            </a:extLst>
          </p:cNvPr>
          <p:cNvSpPr txBox="1"/>
          <p:nvPr/>
        </p:nvSpPr>
        <p:spPr>
          <a:xfrm>
            <a:off x="6348805" y="1644616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BE410EC-89B6-7796-B627-1E24C70BD0A3}"/>
              </a:ext>
            </a:extLst>
          </p:cNvPr>
          <p:cNvSpPr txBox="1"/>
          <p:nvPr/>
        </p:nvSpPr>
        <p:spPr>
          <a:xfrm>
            <a:off x="1621910" y="356729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EF5E0C5-1C59-AB26-97CD-F8A7F093A991}"/>
              </a:ext>
            </a:extLst>
          </p:cNvPr>
          <p:cNvSpPr txBox="1"/>
          <p:nvPr/>
        </p:nvSpPr>
        <p:spPr>
          <a:xfrm>
            <a:off x="6368926" y="3572052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0E64B50-7126-3616-75CF-3AFA9E91EB28}"/>
              </a:ext>
            </a:extLst>
          </p:cNvPr>
          <p:cNvSpPr txBox="1"/>
          <p:nvPr/>
        </p:nvSpPr>
        <p:spPr>
          <a:xfrm>
            <a:off x="4040594" y="356358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5145E5E-E16B-07ED-4E31-F871F9A10671}"/>
              </a:ext>
            </a:extLst>
          </p:cNvPr>
          <p:cNvSpPr txBox="1"/>
          <p:nvPr/>
        </p:nvSpPr>
        <p:spPr>
          <a:xfrm>
            <a:off x="8574104" y="164151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32FEF2A-ADA3-C8A5-5336-0B96EDCAE9C3}"/>
              </a:ext>
            </a:extLst>
          </p:cNvPr>
          <p:cNvSpPr txBox="1"/>
          <p:nvPr/>
        </p:nvSpPr>
        <p:spPr>
          <a:xfrm>
            <a:off x="8540851" y="3578379"/>
            <a:ext cx="2954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42168883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ADC504-4544-7F9F-B5D8-9580D2A33288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2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A7F68DD-C383-7166-F270-6692F40B5824}"/>
              </a:ext>
            </a:extLst>
          </p:cNvPr>
          <p:cNvGrpSpPr/>
          <p:nvPr/>
        </p:nvGrpSpPr>
        <p:grpSpPr>
          <a:xfrm>
            <a:off x="1282325" y="1443739"/>
            <a:ext cx="10435542" cy="4193363"/>
            <a:chOff x="1282325" y="1443739"/>
            <a:chExt cx="10435542" cy="4193363"/>
          </a:xfrm>
        </p:grpSpPr>
        <p:graphicFrame>
          <p:nvGraphicFramePr>
            <p:cNvPr id="40" name="Object 39">
              <a:extLst>
                <a:ext uri="{FF2B5EF4-FFF2-40B4-BE49-F238E27FC236}">
                  <a16:creationId xmlns:a16="http://schemas.microsoft.com/office/drawing/2014/main" id="{E20B131B-7755-36C6-A5D9-E71CAADCBD7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245807" y="1443739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1467546" imgH="2211296" progId="SigmaPlotGraphicObject.12">
                    <p:embed/>
                  </p:oleObj>
                </mc:Choice>
                <mc:Fallback>
                  <p:oleObj name="SPW 13.0 Graph" r:id="rId2" imgW="1467546" imgH="2211296" progId="SigmaPlotGraphicObject.12">
                    <p:embed/>
                    <p:pic>
                      <p:nvPicPr>
                        <p:cNvPr id="40" name="Object 39">
                          <a:extLst>
                            <a:ext uri="{FF2B5EF4-FFF2-40B4-BE49-F238E27FC236}">
                              <a16:creationId xmlns:a16="http://schemas.microsoft.com/office/drawing/2014/main" id="{E20B131B-7755-36C6-A5D9-E71CAADCBD7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9245807" y="1443739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678A5681-F8CB-B928-DA14-04AAF7706D6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885913" y="1467571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1467546" imgH="2211296" progId="SigmaPlotGraphicObject.12">
                    <p:embed/>
                  </p:oleObj>
                </mc:Choice>
                <mc:Fallback>
                  <p:oleObj name="SPW 13.0 Graph" r:id="rId4" imgW="1467546" imgH="2211296" progId="SigmaPlotGraphicObject.12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678A5681-F8CB-B928-DA14-04AAF7706D6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885913" y="1467571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3440E100-6D18-D05A-D297-AEBBDE334B7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566605" y="3420787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1467546" imgH="2211296" progId="SigmaPlotGraphicObject.12">
                    <p:embed/>
                  </p:oleObj>
                </mc:Choice>
                <mc:Fallback>
                  <p:oleObj name="SPW 13.0 Graph" r:id="rId6" imgW="1467546" imgH="2211296" progId="SigmaPlotGraphicObject.12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3440E100-6D18-D05A-D297-AEBBDE334B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566605" y="3420787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2EEB04C2-6EE4-E43E-6C8F-A334088CBA1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564949" y="1477386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8" imgW="1467546" imgH="2211296" progId="SigmaPlotGraphicObject.12">
                    <p:embed/>
                  </p:oleObj>
                </mc:Choice>
                <mc:Fallback>
                  <p:oleObj name="SPW 13.0 Graph" r:id="rId8" imgW="1467546" imgH="2211296" progId="SigmaPlotGraphicObject.12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2EEB04C2-6EE4-E43E-6C8F-A334088CBA1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564949" y="1477386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id="{FB4ABB51-98F7-61FA-CE9E-585C85876EA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164299" y="1475225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1467546" imgH="2211296" progId="SigmaPlotGraphicObject.12">
                    <p:embed/>
                  </p:oleObj>
                </mc:Choice>
                <mc:Fallback>
                  <p:oleObj name="SPW 13.0 Graph" r:id="rId10" imgW="1467546" imgH="2211296" progId="SigmaPlotGraphicObject.12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FB4ABB51-98F7-61FA-CE9E-585C85876E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164299" y="1475225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235F1EE-9703-A2F8-38F3-5187A6F08F67}"/>
                </a:ext>
              </a:extLst>
            </p:cNvPr>
            <p:cNvSpPr txBox="1"/>
            <p:nvPr/>
          </p:nvSpPr>
          <p:spPr>
            <a:xfrm>
              <a:off x="2103578" y="1694069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BFB516E-E786-BD45-07AC-9A9588AE5418}"/>
                </a:ext>
              </a:extLst>
            </p:cNvPr>
            <p:cNvSpPr txBox="1"/>
            <p:nvPr/>
          </p:nvSpPr>
          <p:spPr>
            <a:xfrm>
              <a:off x="4516397" y="1692135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55B7F8E-7CAF-5EA7-5EA1-A9CEC4F47940}"/>
                </a:ext>
              </a:extLst>
            </p:cNvPr>
            <p:cNvSpPr txBox="1"/>
            <p:nvPr/>
          </p:nvSpPr>
          <p:spPr>
            <a:xfrm>
              <a:off x="6827153" y="1685603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44999DF-A49B-3096-0CA1-B4636AFAC2F4}"/>
                </a:ext>
              </a:extLst>
            </p:cNvPr>
            <p:cNvSpPr txBox="1"/>
            <p:nvPr/>
          </p:nvSpPr>
          <p:spPr>
            <a:xfrm>
              <a:off x="3322623" y="2810909"/>
              <a:ext cx="1215306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469C703-2603-CBB6-93D4-33CB2EB025AD}"/>
                </a:ext>
              </a:extLst>
            </p:cNvPr>
            <p:cNvSpPr txBox="1"/>
            <p:nvPr/>
          </p:nvSpPr>
          <p:spPr>
            <a:xfrm>
              <a:off x="8073378" y="4735021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5E4C0F1C-4E3D-2ACF-46D2-70CD2066030D}"/>
                </a:ext>
              </a:extLst>
            </p:cNvPr>
            <p:cNvGrpSpPr/>
            <p:nvPr/>
          </p:nvGrpSpPr>
          <p:grpSpPr>
            <a:xfrm>
              <a:off x="5180997" y="2808271"/>
              <a:ext cx="1654246" cy="523220"/>
              <a:chOff x="6274909" y="4869034"/>
              <a:chExt cx="1654246" cy="523220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608AB59D-D107-22A7-2281-4BA32A5FA5CF}"/>
                  </a:ext>
                </a:extLst>
              </p:cNvPr>
              <p:cNvSpPr txBox="1"/>
              <p:nvPr/>
            </p:nvSpPr>
            <p:spPr>
              <a:xfrm>
                <a:off x="6821337" y="4869034"/>
                <a:ext cx="1107818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ED1B5EBA-4DE8-1880-D1F6-C6CC664DEA33}"/>
                  </a:ext>
                </a:extLst>
              </p:cNvPr>
              <p:cNvSpPr txBox="1"/>
              <p:nvPr/>
            </p:nvSpPr>
            <p:spPr>
              <a:xfrm>
                <a:off x="6274909" y="5050129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b="1" dirty="0"/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D52FFBAB-8952-7CA9-4423-D819BB9FE82D}"/>
                </a:ext>
              </a:extLst>
            </p:cNvPr>
            <p:cNvGrpSpPr/>
            <p:nvPr/>
          </p:nvGrpSpPr>
          <p:grpSpPr>
            <a:xfrm>
              <a:off x="3181742" y="4740768"/>
              <a:ext cx="1369716" cy="532511"/>
              <a:chOff x="4531232" y="6222222"/>
              <a:chExt cx="1369716" cy="532511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00583EC1-3AE9-6194-E88F-4D23CC36772D}"/>
                  </a:ext>
                </a:extLst>
              </p:cNvPr>
              <p:cNvSpPr txBox="1"/>
              <p:nvPr/>
            </p:nvSpPr>
            <p:spPr>
              <a:xfrm>
                <a:off x="4531232" y="6222222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/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6C1BB28-1986-82EF-9CD2-C400B02A3CC6}"/>
                  </a:ext>
                </a:extLst>
              </p:cNvPr>
              <p:cNvSpPr txBox="1"/>
              <p:nvPr/>
            </p:nvSpPr>
            <p:spPr>
              <a:xfrm>
                <a:off x="4685642" y="6231513"/>
                <a:ext cx="1215306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SH+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SH+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2F91D9BD-F4F0-802A-55D9-CECAB393255A}"/>
                </a:ext>
              </a:extLst>
            </p:cNvPr>
            <p:cNvGrpSpPr/>
            <p:nvPr/>
          </p:nvGrpSpPr>
          <p:grpSpPr>
            <a:xfrm>
              <a:off x="2777394" y="4337488"/>
              <a:ext cx="4064265" cy="928167"/>
              <a:chOff x="4036012" y="6017724"/>
              <a:chExt cx="4064265" cy="928167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1AEC2D2-5F1F-66E6-E1A0-807E8B985A14}"/>
                  </a:ext>
                </a:extLst>
              </p:cNvPr>
              <p:cNvSpPr txBox="1"/>
              <p:nvPr/>
            </p:nvSpPr>
            <p:spPr>
              <a:xfrm>
                <a:off x="4036012" y="6017724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b="1" dirty="0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63FB7F77-BC49-30E0-F103-9E6BEB6E9D30}"/>
                  </a:ext>
                </a:extLst>
              </p:cNvPr>
              <p:cNvSpPr txBox="1"/>
              <p:nvPr/>
            </p:nvSpPr>
            <p:spPr>
              <a:xfrm>
                <a:off x="6992459" y="6422671"/>
                <a:ext cx="1107818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 +1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. +3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M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4FA77496-C181-F922-739E-F165A6199471}"/>
                  </a:ext>
                </a:extLst>
              </p:cNvPr>
              <p:cNvSpPr txBox="1"/>
              <p:nvPr/>
            </p:nvSpPr>
            <p:spPr>
              <a:xfrm>
                <a:off x="6474401" y="6646945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/>
              </a:p>
            </p:txBody>
          </p: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73B2427-5F77-D151-229B-3677AEB3F610}"/>
                </a:ext>
              </a:extLst>
            </p:cNvPr>
            <p:cNvSpPr txBox="1"/>
            <p:nvPr/>
          </p:nvSpPr>
          <p:spPr>
            <a:xfrm>
              <a:off x="8068961" y="2797324"/>
              <a:ext cx="11078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+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D89AB8D-C4BE-17FA-371D-2EEC5AAB03FD}"/>
                </a:ext>
              </a:extLst>
            </p:cNvPr>
            <p:cNvSpPr txBox="1"/>
            <p:nvPr/>
          </p:nvSpPr>
          <p:spPr>
            <a:xfrm>
              <a:off x="1332122" y="4394784"/>
              <a:ext cx="96788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0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69E462A-0E9B-35D4-D31F-ABEE77B3F686}"/>
                </a:ext>
              </a:extLst>
            </p:cNvPr>
            <p:cNvSpPr txBox="1"/>
            <p:nvPr/>
          </p:nvSpPr>
          <p:spPr>
            <a:xfrm>
              <a:off x="1282325" y="2544470"/>
              <a:ext cx="96788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2F74926-FBD5-C3B8-D15D-9127187815E7}"/>
                </a:ext>
              </a:extLst>
            </p:cNvPr>
            <p:cNvSpPr txBox="1"/>
            <p:nvPr/>
          </p:nvSpPr>
          <p:spPr>
            <a:xfrm>
              <a:off x="2773074" y="1610944"/>
              <a:ext cx="58385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H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D319129-B4C4-E631-F7C8-A8B6846C6B03}"/>
                </a:ext>
              </a:extLst>
            </p:cNvPr>
            <p:cNvSpPr txBox="1"/>
            <p:nvPr/>
          </p:nvSpPr>
          <p:spPr>
            <a:xfrm>
              <a:off x="5190151" y="1610022"/>
              <a:ext cx="43001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y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25AE51A-FF39-F87D-5A49-CE03EA9806D6}"/>
                </a:ext>
              </a:extLst>
            </p:cNvPr>
            <p:cNvSpPr txBox="1"/>
            <p:nvPr/>
          </p:nvSpPr>
          <p:spPr>
            <a:xfrm>
              <a:off x="7551495" y="1623068"/>
              <a:ext cx="43001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AA430FD-CA9A-867D-9AD1-C9F9E7D2AD49}"/>
                </a:ext>
              </a:extLst>
            </p:cNvPr>
            <p:cNvSpPr txBox="1"/>
            <p:nvPr/>
          </p:nvSpPr>
          <p:spPr>
            <a:xfrm>
              <a:off x="2776144" y="2270787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FB515A1-8D83-06C4-0057-57A0DE359B46}"/>
                </a:ext>
              </a:extLst>
            </p:cNvPr>
            <p:cNvSpPr txBox="1"/>
            <p:nvPr/>
          </p:nvSpPr>
          <p:spPr>
            <a:xfrm>
              <a:off x="3139823" y="1834983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9349C362-4261-9476-EBE5-5E81B6BE73F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162527" y="3425715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2" imgW="1467546" imgH="2211296" progId="SigmaPlotGraphicObject.12">
                    <p:embed/>
                  </p:oleObj>
                </mc:Choice>
                <mc:Fallback>
                  <p:oleObj name="SPW 13.0 Graph" r:id="rId12" imgW="1467546" imgH="2211296" progId="SigmaPlotGraphicObject.12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9349C362-4261-9476-EBE5-5E81B6BE73F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162527" y="3425715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7B9ED01-3CA7-DE2F-FA71-C121C5083516}"/>
                </a:ext>
              </a:extLst>
            </p:cNvPr>
            <p:cNvSpPr txBox="1"/>
            <p:nvPr/>
          </p:nvSpPr>
          <p:spPr>
            <a:xfrm>
              <a:off x="3138518" y="3888564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F471B46-F051-8324-EC63-2697CA6353B2}"/>
                </a:ext>
              </a:extLst>
            </p:cNvPr>
            <p:cNvSpPr txBox="1"/>
            <p:nvPr/>
          </p:nvSpPr>
          <p:spPr>
            <a:xfrm>
              <a:off x="5398003" y="4806023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/>
            </a:p>
          </p:txBody>
        </p:sp>
        <p:graphicFrame>
          <p:nvGraphicFramePr>
            <p:cNvPr id="38" name="Object 37">
              <a:extLst>
                <a:ext uri="{FF2B5EF4-FFF2-40B4-BE49-F238E27FC236}">
                  <a16:creationId xmlns:a16="http://schemas.microsoft.com/office/drawing/2014/main" id="{E5714E62-769A-C610-A8B9-C0EA3607EBC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902140" y="3418756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4" imgW="1467546" imgH="2211296" progId="SigmaPlotGraphicObject.12">
                    <p:embed/>
                  </p:oleObj>
                </mc:Choice>
                <mc:Fallback>
                  <p:oleObj name="SPW 13.0 Graph" r:id="rId14" imgW="1467546" imgH="2211296" progId="SigmaPlotGraphicObject.12">
                    <p:embed/>
                    <p:pic>
                      <p:nvPicPr>
                        <p:cNvPr id="38" name="Object 37">
                          <a:extLst>
                            <a:ext uri="{FF2B5EF4-FFF2-40B4-BE49-F238E27FC236}">
                              <a16:creationId xmlns:a16="http://schemas.microsoft.com/office/drawing/2014/main" id="{E5714E62-769A-C610-A8B9-C0EA3607EB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6902140" y="3418756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1FCC934-28E2-E897-D6A9-2CFBDF05B1B6}"/>
                </a:ext>
              </a:extLst>
            </p:cNvPr>
            <p:cNvSpPr txBox="1"/>
            <p:nvPr/>
          </p:nvSpPr>
          <p:spPr>
            <a:xfrm>
              <a:off x="9826625" y="1673869"/>
              <a:ext cx="48895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729FB0F-F8AE-6A18-A2B9-91A177B789D2}"/>
                </a:ext>
              </a:extLst>
            </p:cNvPr>
            <p:cNvSpPr txBox="1"/>
            <p:nvPr/>
          </p:nvSpPr>
          <p:spPr>
            <a:xfrm>
              <a:off x="9854376" y="2711487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2C28776-82D0-951B-4B3D-B5CA020F9510}"/>
                </a:ext>
              </a:extLst>
            </p:cNvPr>
            <p:cNvSpPr txBox="1"/>
            <p:nvPr/>
          </p:nvSpPr>
          <p:spPr>
            <a:xfrm>
              <a:off x="10222676" y="2447962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graphicFrame>
          <p:nvGraphicFramePr>
            <p:cNvPr id="52" name="Object 51">
              <a:extLst>
                <a:ext uri="{FF2B5EF4-FFF2-40B4-BE49-F238E27FC236}">
                  <a16:creationId xmlns:a16="http://schemas.microsoft.com/office/drawing/2014/main" id="{E2DDE3BC-0C9B-621A-50AE-CFF1F3C86CA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245600" y="3411538"/>
            <a:ext cx="1466850" cy="2211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6" imgW="1467546" imgH="2211296" progId="SigmaPlotGraphicObject.12">
                    <p:embed/>
                  </p:oleObj>
                </mc:Choice>
                <mc:Fallback>
                  <p:oleObj name="SPW 13.0 Graph" r:id="rId16" imgW="1467546" imgH="2211296" progId="SigmaPlotGraphicObject.12">
                    <p:embed/>
                    <p:pic>
                      <p:nvPicPr>
                        <p:cNvPr id="52" name="Object 51">
                          <a:extLst>
                            <a:ext uri="{FF2B5EF4-FFF2-40B4-BE49-F238E27FC236}">
                              <a16:creationId xmlns:a16="http://schemas.microsoft.com/office/drawing/2014/main" id="{E2DDE3BC-0C9B-621A-50AE-CFF1F3C86C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9245600" y="3411538"/>
                          <a:ext cx="1466850" cy="2211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D1E2149-01D0-1310-29B5-7CF9E1FA3828}"/>
                </a:ext>
              </a:extLst>
            </p:cNvPr>
            <p:cNvSpPr txBox="1"/>
            <p:nvPr/>
          </p:nvSpPr>
          <p:spPr>
            <a:xfrm>
              <a:off x="9860726" y="4492662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35E5680-EE07-8BB9-79FA-FA6147881FFB}"/>
                </a:ext>
              </a:extLst>
            </p:cNvPr>
            <p:cNvSpPr txBox="1"/>
            <p:nvPr/>
          </p:nvSpPr>
          <p:spPr>
            <a:xfrm>
              <a:off x="10219501" y="3813212"/>
              <a:ext cx="33309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b="1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FEB2FD2-584C-30B2-4B5C-EB923FB329C8}"/>
                </a:ext>
              </a:extLst>
            </p:cNvPr>
            <p:cNvSpPr txBox="1"/>
            <p:nvPr/>
          </p:nvSpPr>
          <p:spPr>
            <a:xfrm>
              <a:off x="2104044" y="3592238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A20163B-5FDE-10FB-D7BB-2EEF31CBDC1F}"/>
                </a:ext>
              </a:extLst>
            </p:cNvPr>
            <p:cNvSpPr txBox="1"/>
            <p:nvPr/>
          </p:nvSpPr>
          <p:spPr>
            <a:xfrm>
              <a:off x="6851060" y="3596991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174413D-0217-A5D5-D8C1-DFBA31E42984}"/>
                </a:ext>
              </a:extLst>
            </p:cNvPr>
            <p:cNvSpPr txBox="1"/>
            <p:nvPr/>
          </p:nvSpPr>
          <p:spPr>
            <a:xfrm>
              <a:off x="4522728" y="3588528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0D31470-FE6C-F26C-CD99-2A18161E75FB}"/>
                </a:ext>
              </a:extLst>
            </p:cNvPr>
            <p:cNvSpPr txBox="1"/>
            <p:nvPr/>
          </p:nvSpPr>
          <p:spPr>
            <a:xfrm>
              <a:off x="9205866" y="1666458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E8749F3-8765-EF16-6844-23E10410AA8B}"/>
                </a:ext>
              </a:extLst>
            </p:cNvPr>
            <p:cNvSpPr txBox="1"/>
            <p:nvPr/>
          </p:nvSpPr>
          <p:spPr>
            <a:xfrm>
              <a:off x="9172613" y="3603318"/>
              <a:ext cx="2954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C6CC046-1787-70AF-6C1D-C0AEF0AE98F6}"/>
                </a:ext>
              </a:extLst>
            </p:cNvPr>
            <p:cNvSpPr txBox="1"/>
            <p:nvPr/>
          </p:nvSpPr>
          <p:spPr>
            <a:xfrm>
              <a:off x="10419145" y="2761219"/>
              <a:ext cx="1298722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+Mnd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 +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9B4DD09-9F8A-6F13-E246-FF3F83AC37F7}"/>
                </a:ext>
              </a:extLst>
            </p:cNvPr>
            <p:cNvSpPr txBox="1"/>
            <p:nvPr/>
          </p:nvSpPr>
          <p:spPr>
            <a:xfrm>
              <a:off x="10410027" y="4729395"/>
              <a:ext cx="1298722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+Mnd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 +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606267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ADC504-4544-7F9F-B5D8-9580D2A33288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3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C1A0F780-20ED-E0D3-CFE2-EBDFD7A6B7D1}"/>
              </a:ext>
            </a:extLst>
          </p:cNvPr>
          <p:cNvGrpSpPr/>
          <p:nvPr/>
        </p:nvGrpSpPr>
        <p:grpSpPr>
          <a:xfrm>
            <a:off x="775029" y="1435735"/>
            <a:ext cx="10415183" cy="4165065"/>
            <a:chOff x="775029" y="1435735"/>
            <a:chExt cx="10415183" cy="4165065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C86E0F28-DA01-380F-F136-709BF8DB2B56}"/>
                </a:ext>
              </a:extLst>
            </p:cNvPr>
            <p:cNvGrpSpPr/>
            <p:nvPr/>
          </p:nvGrpSpPr>
          <p:grpSpPr>
            <a:xfrm>
              <a:off x="775029" y="1435735"/>
              <a:ext cx="9419333" cy="4165065"/>
              <a:chOff x="85916" y="1475491"/>
              <a:chExt cx="9419333" cy="4165065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D89AB8D-C4BE-17FA-371D-2EEC5AAB03FD}"/>
                  </a:ext>
                </a:extLst>
              </p:cNvPr>
              <p:cNvSpPr txBox="1"/>
              <p:nvPr/>
            </p:nvSpPr>
            <p:spPr>
              <a:xfrm>
                <a:off x="135713" y="4394784"/>
                <a:ext cx="967886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69E462A-0E9B-35D4-D31F-ABEE77B3F686}"/>
                  </a:ext>
                </a:extLst>
              </p:cNvPr>
              <p:cNvSpPr txBox="1"/>
              <p:nvPr/>
            </p:nvSpPr>
            <p:spPr>
              <a:xfrm>
                <a:off x="85916" y="2544470"/>
                <a:ext cx="967886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235F1EE-9703-A2F8-38F3-5187A6F08F67}"/>
                  </a:ext>
                </a:extLst>
              </p:cNvPr>
              <p:cNvSpPr txBox="1"/>
              <p:nvPr/>
            </p:nvSpPr>
            <p:spPr>
              <a:xfrm>
                <a:off x="907169" y="1694069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BFB516E-E786-BD45-07AC-9A9588AE5418}"/>
                  </a:ext>
                </a:extLst>
              </p:cNvPr>
              <p:cNvSpPr txBox="1"/>
              <p:nvPr/>
            </p:nvSpPr>
            <p:spPr>
              <a:xfrm>
                <a:off x="3319988" y="1692135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55B7F8E-7CAF-5EA7-5EA1-A9CEC4F47940}"/>
                  </a:ext>
                </a:extLst>
              </p:cNvPr>
              <p:cNvSpPr txBox="1"/>
              <p:nvPr/>
            </p:nvSpPr>
            <p:spPr>
              <a:xfrm>
                <a:off x="5630744" y="1685603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3D11FD33-E94F-57CC-AB39-03FD1D4AD851}"/>
                  </a:ext>
                </a:extLst>
              </p:cNvPr>
              <p:cNvGrpSpPr/>
              <p:nvPr/>
            </p:nvGrpSpPr>
            <p:grpSpPr>
              <a:xfrm>
                <a:off x="967582" y="1491660"/>
                <a:ext cx="2373938" cy="2211387"/>
                <a:chOff x="3371492" y="3524028"/>
                <a:chExt cx="2373938" cy="2211387"/>
              </a:xfrm>
            </p:grpSpPr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C44999DF-A49B-3096-0CA1-B4636AFAC2F4}"/>
                    </a:ext>
                  </a:extLst>
                </p:cNvPr>
                <p:cNvSpPr txBox="1"/>
                <p:nvPr/>
              </p:nvSpPr>
              <p:spPr>
                <a:xfrm>
                  <a:off x="4530124" y="4843277"/>
                  <a:ext cx="1215306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GSH+MNQ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GSH+MNQ)</a:t>
                  </a:r>
                </a:p>
              </p:txBody>
            </p:sp>
            <p:graphicFrame>
              <p:nvGraphicFramePr>
                <p:cNvPr id="79" name="Object 78">
                  <a:extLst>
                    <a:ext uri="{FF2B5EF4-FFF2-40B4-BE49-F238E27FC236}">
                      <a16:creationId xmlns:a16="http://schemas.microsoft.com/office/drawing/2014/main" id="{CF8DB428-5E9F-29BA-3A1C-8B809C996E8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371492" y="3524028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1467546" imgH="2211296" progId="SigmaPlotGraphicObject.12">
                        <p:embed/>
                      </p:oleObj>
                    </mc:Choice>
                    <mc:Fallback>
                      <p:oleObj name="SPW 13.0 Graph" r:id="rId2" imgW="1467546" imgH="2211296" progId="SigmaPlotGraphicObject.12">
                        <p:embed/>
                        <p:pic>
                          <p:nvPicPr>
                            <p:cNvPr id="79" name="Object 78">
                              <a:extLst>
                                <a:ext uri="{FF2B5EF4-FFF2-40B4-BE49-F238E27FC236}">
                                  <a16:creationId xmlns:a16="http://schemas.microsoft.com/office/drawing/2014/main" id="{CF8DB428-5E9F-29BA-3A1C-8B809C996E8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371492" y="3524028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84DA9C30-F8A5-B762-91CB-45D24C88EFC9}"/>
                  </a:ext>
                </a:extLst>
              </p:cNvPr>
              <p:cNvGrpSpPr/>
              <p:nvPr/>
            </p:nvGrpSpPr>
            <p:grpSpPr>
              <a:xfrm>
                <a:off x="5711828" y="3416062"/>
                <a:ext cx="2272959" cy="2211387"/>
                <a:chOff x="8070296" y="1784154"/>
                <a:chExt cx="2272959" cy="2211387"/>
              </a:xfrm>
            </p:grpSpPr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4469C703-2603-CBB6-93D4-33CB2EB025AD}"/>
                    </a:ext>
                  </a:extLst>
                </p:cNvPr>
                <p:cNvSpPr txBox="1"/>
                <p:nvPr/>
              </p:nvSpPr>
              <p:spPr>
                <a:xfrm>
                  <a:off x="9235437" y="3103113"/>
                  <a:ext cx="1107818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A+MNQ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A+MNQ)</a:t>
                  </a:r>
                </a:p>
              </p:txBody>
            </p:sp>
            <p:graphicFrame>
              <p:nvGraphicFramePr>
                <p:cNvPr id="81" name="Object 80">
                  <a:extLst>
                    <a:ext uri="{FF2B5EF4-FFF2-40B4-BE49-F238E27FC236}">
                      <a16:creationId xmlns:a16="http://schemas.microsoft.com/office/drawing/2014/main" id="{6F100390-BEA9-E333-484F-35789E8B6843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8070296" y="1784154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1467546" imgH="2211296" progId="SigmaPlotGraphicObject.12">
                        <p:embed/>
                      </p:oleObj>
                    </mc:Choice>
                    <mc:Fallback>
                      <p:oleObj name="SPW 13.0 Graph" r:id="rId4" imgW="1467546" imgH="2211296" progId="SigmaPlotGraphicObject.12">
                        <p:embed/>
                        <p:pic>
                          <p:nvPicPr>
                            <p:cNvPr id="81" name="Object 80">
                              <a:extLst>
                                <a:ext uri="{FF2B5EF4-FFF2-40B4-BE49-F238E27FC236}">
                                  <a16:creationId xmlns:a16="http://schemas.microsoft.com/office/drawing/2014/main" id="{6F100390-BEA9-E333-484F-35789E8B684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070296" y="1784154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5E4C0F1C-4E3D-2ACF-46D2-70CD2066030D}"/>
                  </a:ext>
                </a:extLst>
              </p:cNvPr>
              <p:cNvGrpSpPr/>
              <p:nvPr/>
            </p:nvGrpSpPr>
            <p:grpSpPr>
              <a:xfrm>
                <a:off x="3374974" y="1491352"/>
                <a:ext cx="2263860" cy="2211387"/>
                <a:chOff x="5665295" y="3552115"/>
                <a:chExt cx="2263860" cy="2211387"/>
              </a:xfrm>
            </p:grpSpPr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608AB59D-D107-22A7-2281-4BA32A5FA5CF}"/>
                    </a:ext>
                  </a:extLst>
                </p:cNvPr>
                <p:cNvSpPr txBox="1"/>
                <p:nvPr/>
              </p:nvSpPr>
              <p:spPr>
                <a:xfrm>
                  <a:off x="6821337" y="4869034"/>
                  <a:ext cx="1107818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+MNQ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+MNQ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graphicFrame>
              <p:nvGraphicFramePr>
                <p:cNvPr id="77" name="Object 76">
                  <a:extLst>
                    <a:ext uri="{FF2B5EF4-FFF2-40B4-BE49-F238E27FC236}">
                      <a16:creationId xmlns:a16="http://schemas.microsoft.com/office/drawing/2014/main" id="{0AAEA00F-3EB9-8281-8EB8-D62E9A630930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665295" y="3552115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1467546" imgH="2211296" progId="SigmaPlotGraphicObject.12">
                        <p:embed/>
                      </p:oleObj>
                    </mc:Choice>
                    <mc:Fallback>
                      <p:oleObj name="SPW 13.0 Graph" r:id="rId6" imgW="1467546" imgH="2211296" progId="SigmaPlotGraphicObject.12">
                        <p:embed/>
                        <p:pic>
                          <p:nvPicPr>
                            <p:cNvPr id="77" name="Object 76">
                              <a:extLst>
                                <a:ext uri="{FF2B5EF4-FFF2-40B4-BE49-F238E27FC236}">
                                  <a16:creationId xmlns:a16="http://schemas.microsoft.com/office/drawing/2014/main" id="{0AAEA00F-3EB9-8281-8EB8-D62E9A63093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665295" y="3552115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ED1B5EBA-4DE8-1880-D1F6-C6CC664DEA33}"/>
                    </a:ext>
                  </a:extLst>
                </p:cNvPr>
                <p:cNvSpPr txBox="1"/>
                <p:nvPr/>
              </p:nvSpPr>
              <p:spPr>
                <a:xfrm>
                  <a:off x="6278372" y="4243102"/>
                  <a:ext cx="33309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45C27DA4-D2BC-4501-DF3A-30C247CE16DB}"/>
                    </a:ext>
                  </a:extLst>
                </p:cNvPr>
                <p:cNvSpPr txBox="1"/>
                <p:nvPr/>
              </p:nvSpPr>
              <p:spPr>
                <a:xfrm>
                  <a:off x="6642988" y="3908650"/>
                  <a:ext cx="33309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</p:grpSp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id="{D52FFBAB-8952-7CA9-4423-D819BB9FE82D}"/>
                  </a:ext>
                </a:extLst>
              </p:cNvPr>
              <p:cNvGrpSpPr/>
              <p:nvPr/>
            </p:nvGrpSpPr>
            <p:grpSpPr>
              <a:xfrm>
                <a:off x="969151" y="3425098"/>
                <a:ext cx="2385898" cy="2211387"/>
                <a:chOff x="3515050" y="4906552"/>
                <a:chExt cx="2385898" cy="2211387"/>
              </a:xfrm>
            </p:grpSpPr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00583EC1-3AE9-6194-E88F-4D23CC36772D}"/>
                    </a:ext>
                  </a:extLst>
                </p:cNvPr>
                <p:cNvSpPr txBox="1"/>
                <p:nvPr/>
              </p:nvSpPr>
              <p:spPr>
                <a:xfrm>
                  <a:off x="4531232" y="6222222"/>
                  <a:ext cx="33309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b="1" dirty="0"/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16C1BB28-1986-82EF-9CD2-C400B02A3CC6}"/>
                    </a:ext>
                  </a:extLst>
                </p:cNvPr>
                <p:cNvSpPr txBox="1"/>
                <p:nvPr/>
              </p:nvSpPr>
              <p:spPr>
                <a:xfrm>
                  <a:off x="4685642" y="6231513"/>
                  <a:ext cx="1215306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GSH+MNQ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GSH+MNQ)</a:t>
                  </a:r>
                </a:p>
              </p:txBody>
            </p:sp>
            <p:graphicFrame>
              <p:nvGraphicFramePr>
                <p:cNvPr id="85" name="Object 84">
                  <a:extLst>
                    <a:ext uri="{FF2B5EF4-FFF2-40B4-BE49-F238E27FC236}">
                      <a16:creationId xmlns:a16="http://schemas.microsoft.com/office/drawing/2014/main" id="{E30C5DE4-C3C2-6839-0093-20E7CCAEE2C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515050" y="4906552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1467546" imgH="2211296" progId="SigmaPlotGraphicObject.12">
                        <p:embed/>
                      </p:oleObj>
                    </mc:Choice>
                    <mc:Fallback>
                      <p:oleObj name="SPW 13.0 Graph" r:id="rId8" imgW="1467546" imgH="2211296" progId="SigmaPlotGraphicObject.12">
                        <p:embed/>
                        <p:pic>
                          <p:nvPicPr>
                            <p:cNvPr id="85" name="Object 84">
                              <a:extLst>
                                <a:ext uri="{FF2B5EF4-FFF2-40B4-BE49-F238E27FC236}">
                                  <a16:creationId xmlns:a16="http://schemas.microsoft.com/office/drawing/2014/main" id="{E30C5DE4-C3C2-6839-0093-20E7CCAEE2C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515050" y="4906552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2F91D9BD-F4F0-802A-55D9-CECAB393255A}"/>
                  </a:ext>
                </a:extLst>
              </p:cNvPr>
              <p:cNvGrpSpPr/>
              <p:nvPr/>
            </p:nvGrpSpPr>
            <p:grpSpPr>
              <a:xfrm>
                <a:off x="3372549" y="3429169"/>
                <a:ext cx="2272701" cy="2211387"/>
                <a:chOff x="5827576" y="5109405"/>
                <a:chExt cx="2272701" cy="2211387"/>
              </a:xfrm>
            </p:grpSpPr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51AEC2D2-5F1F-66E6-E1A0-807E8B985A14}"/>
                    </a:ext>
                  </a:extLst>
                </p:cNvPr>
                <p:cNvSpPr txBox="1"/>
                <p:nvPr/>
              </p:nvSpPr>
              <p:spPr>
                <a:xfrm>
                  <a:off x="6437775" y="5901960"/>
                  <a:ext cx="33309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63FB7F77-BC49-30E0-F103-9E6BEB6E9D30}"/>
                    </a:ext>
                  </a:extLst>
                </p:cNvPr>
                <p:cNvSpPr txBox="1"/>
                <p:nvPr/>
              </p:nvSpPr>
              <p:spPr>
                <a:xfrm>
                  <a:off x="6992459" y="6422671"/>
                  <a:ext cx="1107818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+MNQ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+MNQ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graphicFrame>
              <p:nvGraphicFramePr>
                <p:cNvPr id="87" name="Object 86">
                  <a:extLst>
                    <a:ext uri="{FF2B5EF4-FFF2-40B4-BE49-F238E27FC236}">
                      <a16:creationId xmlns:a16="http://schemas.microsoft.com/office/drawing/2014/main" id="{EC5C9EF6-DD64-36FA-B3C3-0B34DCD3D17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827576" y="5109405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1467546" imgH="2211296" progId="SigmaPlotGraphicObject.12">
                        <p:embed/>
                      </p:oleObj>
                    </mc:Choice>
                    <mc:Fallback>
                      <p:oleObj name="SPW 13.0 Graph" r:id="rId10" imgW="1467546" imgH="2211296" progId="SigmaPlotGraphicObject.12">
                        <p:embed/>
                        <p:pic>
                          <p:nvPicPr>
                            <p:cNvPr id="87" name="Object 86">
                              <a:extLst>
                                <a:ext uri="{FF2B5EF4-FFF2-40B4-BE49-F238E27FC236}">
                                  <a16:creationId xmlns:a16="http://schemas.microsoft.com/office/drawing/2014/main" id="{EC5C9EF6-DD64-36FA-B3C3-0B34DCD3D17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827576" y="5109405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4FA77496-C181-F922-739E-F165A6199471}"/>
                    </a:ext>
                  </a:extLst>
                </p:cNvPr>
                <p:cNvSpPr txBox="1"/>
                <p:nvPr/>
              </p:nvSpPr>
              <p:spPr>
                <a:xfrm>
                  <a:off x="6802392" y="5523823"/>
                  <a:ext cx="33309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</p:grp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55726986-3DF1-0DD7-12E2-AC16E3BFB458}"/>
                  </a:ext>
                </a:extLst>
              </p:cNvPr>
              <p:cNvGrpSpPr/>
              <p:nvPr/>
            </p:nvGrpSpPr>
            <p:grpSpPr>
              <a:xfrm>
                <a:off x="5712901" y="1477975"/>
                <a:ext cx="2267469" cy="2211387"/>
                <a:chOff x="9048248" y="3277481"/>
                <a:chExt cx="2267469" cy="2211387"/>
              </a:xfrm>
            </p:grpSpPr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A73B2427-5F77-D151-229B-3677AEB3F610}"/>
                    </a:ext>
                  </a:extLst>
                </p:cNvPr>
                <p:cNvSpPr txBox="1"/>
                <p:nvPr/>
              </p:nvSpPr>
              <p:spPr>
                <a:xfrm>
                  <a:off x="10207899" y="4596830"/>
                  <a:ext cx="1107818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A+MNQ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3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A+MNQ)</a:t>
                  </a:r>
                </a:p>
              </p:txBody>
            </p:sp>
            <p:graphicFrame>
              <p:nvGraphicFramePr>
                <p:cNvPr id="90" name="Object 89">
                  <a:extLst>
                    <a:ext uri="{FF2B5EF4-FFF2-40B4-BE49-F238E27FC236}">
                      <a16:creationId xmlns:a16="http://schemas.microsoft.com/office/drawing/2014/main" id="{664ADFCF-9089-0BC8-9F1C-4DBF3F2C6194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9048248" y="3277481"/>
                <a:ext cx="146685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1467546" imgH="2211296" progId="SigmaPlotGraphicObject.12">
                        <p:embed/>
                      </p:oleObj>
                    </mc:Choice>
                    <mc:Fallback>
                      <p:oleObj name="SPW 13.0 Graph" r:id="rId12" imgW="1467546" imgH="2211296" progId="SigmaPlotGraphicObject.12">
                        <p:embed/>
                        <p:pic>
                          <p:nvPicPr>
                            <p:cNvPr id="90" name="Object 89">
                              <a:extLst>
                                <a:ext uri="{FF2B5EF4-FFF2-40B4-BE49-F238E27FC236}">
                                  <a16:creationId xmlns:a16="http://schemas.microsoft.com/office/drawing/2014/main" id="{664ADFCF-9089-0BC8-9F1C-4DBF3F2C619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048248" y="3277481"/>
                              <a:ext cx="146685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2F74926-FBD5-C3B8-D15D-9127187815E7}"/>
                  </a:ext>
                </a:extLst>
              </p:cNvPr>
              <p:cNvSpPr txBox="1"/>
              <p:nvPr/>
            </p:nvSpPr>
            <p:spPr>
              <a:xfrm>
                <a:off x="1576665" y="1610944"/>
                <a:ext cx="58385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GSH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D319129-B4C4-E631-F7C8-A8B6846C6B03}"/>
                  </a:ext>
                </a:extLst>
              </p:cNvPr>
              <p:cNvSpPr txBox="1"/>
              <p:nvPr/>
            </p:nvSpPr>
            <p:spPr>
              <a:xfrm>
                <a:off x="3993742" y="1610022"/>
                <a:ext cx="43001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25AE51A-FF39-F87D-5A49-CE03EA9806D6}"/>
                  </a:ext>
                </a:extLst>
              </p:cNvPr>
              <p:cNvSpPr txBox="1"/>
              <p:nvPr/>
            </p:nvSpPr>
            <p:spPr>
              <a:xfrm>
                <a:off x="6355086" y="1623068"/>
                <a:ext cx="43001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</a:p>
            </p:txBody>
          </p:sp>
          <p:graphicFrame>
            <p:nvGraphicFramePr>
              <p:cNvPr id="11" name="Object 10">
                <a:extLst>
                  <a:ext uri="{FF2B5EF4-FFF2-40B4-BE49-F238E27FC236}">
                    <a16:creationId xmlns:a16="http://schemas.microsoft.com/office/drawing/2014/main" id="{6AE51ACE-6281-7DB3-6BEE-E7A9DB54BFCF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038398" y="1475491"/>
              <a:ext cx="1466850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4" imgW="1467546" imgH="2211296" progId="SigmaPlotGraphicObject.12">
                      <p:embed/>
                    </p:oleObj>
                  </mc:Choice>
                  <mc:Fallback>
                    <p:oleObj name="SPW 13.0 Graph" r:id="rId14" imgW="1467546" imgH="2211296" progId="SigmaPlotGraphicObject.12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6AE51ACE-6281-7DB3-6BEE-E7A9DB54BFC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8038398" y="1475491"/>
                            <a:ext cx="1466850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6" name="Object 15">
                <a:extLst>
                  <a:ext uri="{FF2B5EF4-FFF2-40B4-BE49-F238E27FC236}">
                    <a16:creationId xmlns:a16="http://schemas.microsoft.com/office/drawing/2014/main" id="{92AA2784-D124-D8B6-40D4-21506CCF42B0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038399" y="3400542"/>
              <a:ext cx="1466850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6" imgW="1467546" imgH="2211296" progId="SigmaPlotGraphicObject.12">
                      <p:embed/>
                    </p:oleObj>
                  </mc:Choice>
                  <mc:Fallback>
                    <p:oleObj name="SPW 13.0 Graph" r:id="rId16" imgW="1467546" imgH="2211296" progId="SigmaPlotGraphicObject.12">
                      <p:embed/>
                      <p:pic>
                        <p:nvPicPr>
                          <p:cNvPr id="16" name="Object 15">
                            <a:extLst>
                              <a:ext uri="{FF2B5EF4-FFF2-40B4-BE49-F238E27FC236}">
                                <a16:creationId xmlns:a16="http://schemas.microsoft.com/office/drawing/2014/main" id="{92AA2784-D124-D8B6-40D4-21506CCF42B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8038399" y="3400542"/>
                            <a:ext cx="1466850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79EDE7F-EC94-DE4D-D398-5DF569A97E72}"/>
                  </a:ext>
                </a:extLst>
              </p:cNvPr>
              <p:cNvSpPr txBox="1"/>
              <p:nvPr/>
            </p:nvSpPr>
            <p:spPr>
              <a:xfrm>
                <a:off x="9000074" y="2115787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b="1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791671E-0EA3-60A2-C08B-BFA10C64C861}"/>
                  </a:ext>
                </a:extLst>
              </p:cNvPr>
              <p:cNvSpPr txBox="1"/>
              <p:nvPr/>
            </p:nvSpPr>
            <p:spPr>
              <a:xfrm>
                <a:off x="8686296" y="4704288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2951B25-B210-0272-FB81-820EDF8E327D}"/>
                  </a:ext>
                </a:extLst>
              </p:cNvPr>
              <p:cNvSpPr txBox="1"/>
              <p:nvPr/>
            </p:nvSpPr>
            <p:spPr>
              <a:xfrm>
                <a:off x="9047961" y="3987775"/>
                <a:ext cx="333099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AF2550E-33DD-EF4D-C4AE-08E5038B7325}"/>
                  </a:ext>
                </a:extLst>
              </p:cNvPr>
              <p:cNvSpPr txBox="1"/>
              <p:nvPr/>
            </p:nvSpPr>
            <p:spPr>
              <a:xfrm>
                <a:off x="923642" y="3567299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2CE5B8E-2AD1-55DD-31FA-96DFEACFC037}"/>
                  </a:ext>
                </a:extLst>
              </p:cNvPr>
              <p:cNvSpPr txBox="1"/>
              <p:nvPr/>
            </p:nvSpPr>
            <p:spPr>
              <a:xfrm>
                <a:off x="5670658" y="3572052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732B63A-63B8-CA60-61D2-689E25A6B50D}"/>
                  </a:ext>
                </a:extLst>
              </p:cNvPr>
              <p:cNvSpPr txBox="1"/>
              <p:nvPr/>
            </p:nvSpPr>
            <p:spPr>
              <a:xfrm>
                <a:off x="3342326" y="3563589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3DFD105-DF38-B716-882B-93D9621AF4F5}"/>
                  </a:ext>
                </a:extLst>
              </p:cNvPr>
              <p:cNvSpPr txBox="1"/>
              <p:nvPr/>
            </p:nvSpPr>
            <p:spPr>
              <a:xfrm>
                <a:off x="7992216" y="1641519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1AD6598-2CEC-2A6C-131D-459C643564B8}"/>
                  </a:ext>
                </a:extLst>
              </p:cNvPr>
              <p:cNvSpPr txBox="1"/>
              <p:nvPr/>
            </p:nvSpPr>
            <p:spPr>
              <a:xfrm>
                <a:off x="7958963" y="3578379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B786DFC-706F-785B-44C5-75A9988F81B1}"/>
                  </a:ext>
                </a:extLst>
              </p:cNvPr>
              <p:cNvSpPr txBox="1"/>
              <p:nvPr/>
            </p:nvSpPr>
            <p:spPr>
              <a:xfrm>
                <a:off x="8696094" y="1657242"/>
                <a:ext cx="48895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EB8D907-B1A9-0219-647D-6768484254BE}"/>
                </a:ext>
              </a:extLst>
            </p:cNvPr>
            <p:cNvSpPr txBox="1"/>
            <p:nvPr/>
          </p:nvSpPr>
          <p:spPr>
            <a:xfrm>
              <a:off x="9891490" y="2752225"/>
              <a:ext cx="1298722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MNQ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+MNQ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MNQ 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 +MNQ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E330DBE-DFDB-02DF-8E3B-CCB887B7FCFA}"/>
                </a:ext>
              </a:extLst>
            </p:cNvPr>
            <p:cNvSpPr txBox="1"/>
            <p:nvPr/>
          </p:nvSpPr>
          <p:spPr>
            <a:xfrm>
              <a:off x="9890209" y="4678832"/>
              <a:ext cx="1298722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MNQ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 +1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+MNQ)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MNQ 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 +3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(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 +MNQ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60385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413EDC-DAA0-F6CF-7479-D248FE2081F0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4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D07056C5-D93B-B289-87C9-30520DED0052}"/>
              </a:ext>
            </a:extLst>
          </p:cNvPr>
          <p:cNvGrpSpPr/>
          <p:nvPr/>
        </p:nvGrpSpPr>
        <p:grpSpPr>
          <a:xfrm>
            <a:off x="2002706" y="370683"/>
            <a:ext cx="7079929" cy="6365215"/>
            <a:chOff x="1959844" y="440620"/>
            <a:chExt cx="7079929" cy="6365215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7C0A46D4-BC9A-FB09-DDD7-4AC136CAE492}"/>
                </a:ext>
              </a:extLst>
            </p:cNvPr>
            <p:cNvGrpSpPr/>
            <p:nvPr/>
          </p:nvGrpSpPr>
          <p:grpSpPr>
            <a:xfrm>
              <a:off x="1959844" y="440620"/>
              <a:ext cx="7079929" cy="4334945"/>
              <a:chOff x="2586567" y="1383248"/>
              <a:chExt cx="7079929" cy="4334945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D6CF097A-C670-4024-BEC5-1A8D6630C399}"/>
                  </a:ext>
                </a:extLst>
              </p:cNvPr>
              <p:cNvGrpSpPr/>
              <p:nvPr/>
            </p:nvGrpSpPr>
            <p:grpSpPr>
              <a:xfrm>
                <a:off x="2592806" y="1383248"/>
                <a:ext cx="7073690" cy="4334945"/>
                <a:chOff x="2592806" y="1383248"/>
                <a:chExt cx="7073690" cy="4334945"/>
              </a:xfrm>
            </p:grpSpPr>
            <p:graphicFrame>
              <p:nvGraphicFramePr>
                <p:cNvPr id="2" name="Object 1">
                  <a:extLst>
                    <a:ext uri="{FF2B5EF4-FFF2-40B4-BE49-F238E27FC236}">
                      <a16:creationId xmlns:a16="http://schemas.microsoft.com/office/drawing/2014/main" id="{56ABEA7E-DCC9-B9AB-3471-014E37C2EC3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46651713"/>
                    </p:ext>
                  </p:extLst>
                </p:nvPr>
              </p:nvGraphicFramePr>
              <p:xfrm>
                <a:off x="5885702" y="1408112"/>
                <a:ext cx="2792413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" imgW="2791872" imgH="2211296" progId="SigmaPlotGraphicObject.12">
                        <p:embed/>
                      </p:oleObj>
                    </mc:Choice>
                    <mc:Fallback>
                      <p:oleObj name="SPW 13.0 Graph" r:id="rId3" imgW="2791872" imgH="2211296" progId="SigmaPlotGraphicObject.12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56ABEA7E-DCC9-B9AB-3471-014E37C2EC3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885702" y="1408112"/>
                              <a:ext cx="2792413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DD8686D0-307B-6678-8532-C562FAAE2DF2}"/>
                    </a:ext>
                  </a:extLst>
                </p:cNvPr>
                <p:cNvSpPr txBox="1"/>
                <p:nvPr/>
              </p:nvSpPr>
              <p:spPr>
                <a:xfrm>
                  <a:off x="6824829" y="1876649"/>
                  <a:ext cx="333277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800" b="1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C96178C7-8B12-09B1-95EE-B74CA809B2E3}"/>
                    </a:ext>
                  </a:extLst>
                </p:cNvPr>
                <p:cNvSpPr txBox="1"/>
                <p:nvPr/>
              </p:nvSpPr>
              <p:spPr>
                <a:xfrm>
                  <a:off x="7857400" y="2916556"/>
                  <a:ext cx="333277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800" b="1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3A90B6E6-B11A-2C34-9863-9F9CA7D2247A}"/>
                    </a:ext>
                  </a:extLst>
                </p:cNvPr>
                <p:cNvGrpSpPr/>
                <p:nvPr/>
              </p:nvGrpSpPr>
              <p:grpSpPr>
                <a:xfrm>
                  <a:off x="5881016" y="3422711"/>
                  <a:ext cx="2792413" cy="2211387"/>
                  <a:chOff x="5637151" y="1467490"/>
                  <a:chExt cx="2792413" cy="2211387"/>
                </a:xfrm>
              </p:grpSpPr>
              <p:graphicFrame>
                <p:nvGraphicFramePr>
                  <p:cNvPr id="3" name="Object 2">
                    <a:extLst>
                      <a:ext uri="{FF2B5EF4-FFF2-40B4-BE49-F238E27FC236}">
                        <a16:creationId xmlns:a16="http://schemas.microsoft.com/office/drawing/2014/main" id="{8CD94CEE-5525-E264-8335-D558ED5DB3D7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5637151" y="1467490"/>
                  <a:ext cx="2792413" cy="2211387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5" imgW="2791872" imgH="2211296" progId="SigmaPlotGraphicObject.12">
                          <p:embed/>
                        </p:oleObj>
                      </mc:Choice>
                      <mc:Fallback>
                        <p:oleObj name="SPW 13.0 Graph" r:id="rId5" imgW="2791872" imgH="2211296" progId="SigmaPlotGraphicObject.12">
                          <p:embed/>
                          <p:pic>
                            <p:nvPicPr>
                              <p:cNvPr id="3" name="Object 2">
                                <a:extLst>
                                  <a:ext uri="{FF2B5EF4-FFF2-40B4-BE49-F238E27FC236}">
                                    <a16:creationId xmlns:a16="http://schemas.microsoft.com/office/drawing/2014/main" id="{8CD94CEE-5525-E264-8335-D558ED5DB3D7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637151" y="1467490"/>
                                <a:ext cx="2792413" cy="2211387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170F3C04-0EE3-1998-1EC7-08D40A84E7F3}"/>
                      </a:ext>
                    </a:extLst>
                  </p:cNvPr>
                  <p:cNvSpPr txBox="1"/>
                  <p:nvPr/>
                </p:nvSpPr>
                <p:spPr>
                  <a:xfrm>
                    <a:off x="6583848" y="1848947"/>
                    <a:ext cx="333277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pt-BR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***</a:t>
                    </a:r>
                    <a:endParaRPr lang="en-US" b="1" dirty="0"/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73E262FC-2BB6-B0A4-3FD7-96CD4583A2D8}"/>
                      </a:ext>
                    </a:extLst>
                  </p:cNvPr>
                  <p:cNvSpPr txBox="1"/>
                  <p:nvPr/>
                </p:nvSpPr>
                <p:spPr>
                  <a:xfrm>
                    <a:off x="6939177" y="2262956"/>
                    <a:ext cx="333277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pt-BR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**</a:t>
                    </a:r>
                    <a:endParaRPr lang="en-US" b="1" dirty="0"/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1EAC8962-70B8-5124-5432-F8C9277F74FB}"/>
                      </a:ext>
                    </a:extLst>
                  </p:cNvPr>
                  <p:cNvSpPr txBox="1"/>
                  <p:nvPr/>
                </p:nvSpPr>
                <p:spPr>
                  <a:xfrm>
                    <a:off x="7264352" y="2275181"/>
                    <a:ext cx="333277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pt-BR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***</a:t>
                    </a:r>
                    <a:endParaRPr lang="en-US" b="1" dirty="0"/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37B72C1C-B1A7-D2E5-7F0B-1F390074D7C1}"/>
                      </a:ext>
                    </a:extLst>
                  </p:cNvPr>
                  <p:cNvSpPr txBox="1"/>
                  <p:nvPr/>
                </p:nvSpPr>
                <p:spPr>
                  <a:xfrm>
                    <a:off x="7600127" y="3048591"/>
                    <a:ext cx="333277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pt-BR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***</a:t>
                    </a:r>
                    <a:endParaRPr lang="en-US" b="1" dirty="0"/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B9D64F23-7C07-0219-15DE-2A49692DFD90}"/>
                      </a:ext>
                    </a:extLst>
                  </p:cNvPr>
                  <p:cNvSpPr txBox="1"/>
                  <p:nvPr/>
                </p:nvSpPr>
                <p:spPr>
                  <a:xfrm>
                    <a:off x="7984801" y="3073851"/>
                    <a:ext cx="333277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pt-BR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*</a:t>
                    </a:r>
                    <a:endParaRPr lang="en-US" b="1" dirty="0"/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A6AD7F92-7888-644D-8884-ED786CA8F689}"/>
                    </a:ext>
                  </a:extLst>
                </p:cNvPr>
                <p:cNvSpPr txBox="1"/>
                <p:nvPr/>
              </p:nvSpPr>
              <p:spPr>
                <a:xfrm>
                  <a:off x="2596365" y="2426306"/>
                  <a:ext cx="470180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GSH</a:t>
                  </a:r>
                  <a:endParaRPr lang="en-US" sz="1000" dirty="0"/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2749A49A-6728-972F-20E9-262F13FBCFDD}"/>
                    </a:ext>
                  </a:extLst>
                </p:cNvPr>
                <p:cNvSpPr txBox="1"/>
                <p:nvPr/>
              </p:nvSpPr>
              <p:spPr>
                <a:xfrm>
                  <a:off x="2592806" y="4462002"/>
                  <a:ext cx="470180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Cys</a:t>
                  </a:r>
                  <a:endParaRPr lang="en-US" sz="1000" dirty="0"/>
                </a:p>
              </p:txBody>
            </p:sp>
            <p:graphicFrame>
              <p:nvGraphicFramePr>
                <p:cNvPr id="22" name="Object 21">
                  <a:extLst>
                    <a:ext uri="{FF2B5EF4-FFF2-40B4-BE49-F238E27FC236}">
                      <a16:creationId xmlns:a16="http://schemas.microsoft.com/office/drawing/2014/main" id="{F76BBC2F-9EEB-C8F6-D066-590723F1541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57466623"/>
                    </p:ext>
                  </p:extLst>
                </p:nvPr>
              </p:nvGraphicFramePr>
              <p:xfrm>
                <a:off x="2905246" y="3409968"/>
                <a:ext cx="3052763" cy="23082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7" imgW="3052697" imgH="2308832" progId="SigmaPlotGraphicObject.12">
                        <p:embed/>
                      </p:oleObj>
                    </mc:Choice>
                    <mc:Fallback>
                      <p:oleObj name="SPW 13.0 Graph" r:id="rId7" imgW="3052697" imgH="2308832" progId="SigmaPlotGraphicObject.12">
                        <p:embed/>
                        <p:pic>
                          <p:nvPicPr>
                            <p:cNvPr id="22" name="Object 21">
                              <a:extLst>
                                <a:ext uri="{FF2B5EF4-FFF2-40B4-BE49-F238E27FC236}">
                                  <a16:creationId xmlns:a16="http://schemas.microsoft.com/office/drawing/2014/main" id="{F76BBC2F-9EEB-C8F6-D066-590723F1541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05246" y="3409968"/>
                              <a:ext cx="3052763" cy="23082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9" name="Object 28">
                  <a:extLst>
                    <a:ext uri="{FF2B5EF4-FFF2-40B4-BE49-F238E27FC236}">
                      <a16:creationId xmlns:a16="http://schemas.microsoft.com/office/drawing/2014/main" id="{B60DA845-0E6F-B543-EE92-1A1C6D3225C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706348609"/>
                    </p:ext>
                  </p:extLst>
                </p:nvPr>
              </p:nvGraphicFramePr>
              <p:xfrm>
                <a:off x="2917630" y="1383248"/>
                <a:ext cx="3082925" cy="22971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9" imgW="3083000" imgH="2296595" progId="SigmaPlotGraphicObject.12">
                        <p:embed/>
                      </p:oleObj>
                    </mc:Choice>
                    <mc:Fallback>
                      <p:oleObj name="SPW 13.0 Graph" r:id="rId9" imgW="3083000" imgH="2296595" progId="SigmaPlotGraphicObject.12">
                        <p:embed/>
                        <p:pic>
                          <p:nvPicPr>
                            <p:cNvPr id="29" name="Object 28">
                              <a:extLst>
                                <a:ext uri="{FF2B5EF4-FFF2-40B4-BE49-F238E27FC236}">
                                  <a16:creationId xmlns:a16="http://schemas.microsoft.com/office/drawing/2014/main" id="{B60DA845-0E6F-B543-EE92-1A1C6D3225C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630" y="1383248"/>
                              <a:ext cx="3082925" cy="22971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993D76F6-94F8-8BFC-907C-E05B00C754DB}"/>
                    </a:ext>
                  </a:extLst>
                </p:cNvPr>
                <p:cNvSpPr txBox="1"/>
                <p:nvPr/>
              </p:nvSpPr>
              <p:spPr>
                <a:xfrm>
                  <a:off x="8382150" y="3887681"/>
                  <a:ext cx="1280514" cy="138499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</a:t>
                  </a:r>
                  <a:r>
                    <a:rPr lang="pt-BR" sz="7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Cys</a:t>
                  </a:r>
                  <a:endParaRPr lang="pt-BR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3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4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+Cys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5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Jug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6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Jug+Cys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7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PB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8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PB+Cys</a:t>
                  </a:r>
                </a:p>
                <a:p>
                  <a:r>
                    <a:rPr lang="pt-BR" sz="7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9.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enad</a:t>
                  </a:r>
                  <a:endPara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0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enad+Cys</a:t>
                  </a:r>
                </a:p>
                <a:p>
                  <a:r>
                    <a:rPr lang="pt-BR" sz="7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1.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NQ</a:t>
                  </a:r>
                  <a:endPara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2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NQ+Cys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394C6D6D-69CC-5C75-D9B7-DB8ACE2FFF88}"/>
                    </a:ext>
                  </a:extLst>
                </p:cNvPr>
                <p:cNvSpPr txBox="1"/>
                <p:nvPr/>
              </p:nvSpPr>
              <p:spPr>
                <a:xfrm>
                  <a:off x="8385982" y="1867718"/>
                  <a:ext cx="1280514" cy="138499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GSH</a:t>
                  </a:r>
                </a:p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3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4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+GSH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5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Jug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6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Jug+GSH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7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PB</a:t>
                  </a: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8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PB+GSH</a:t>
                  </a:r>
                </a:p>
                <a:p>
                  <a:r>
                    <a:rPr lang="pt-BR" sz="7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9.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enad</a:t>
                  </a:r>
                  <a:endPara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0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enad+GSH</a:t>
                  </a:r>
                </a:p>
                <a:p>
                  <a:r>
                    <a:rPr lang="pt-BR" sz="7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1.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NQ</a:t>
                  </a:r>
                  <a:endPara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12. 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pt-BR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MNQ+GSH</a:t>
                  </a:r>
                </a:p>
              </p:txBody>
            </p:sp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E0F0A5C-444D-ABB3-5B46-F9B026F2A852}"/>
                  </a:ext>
                </a:extLst>
              </p:cNvPr>
              <p:cNvSpPr txBox="1"/>
              <p:nvPr/>
            </p:nvSpPr>
            <p:spPr>
              <a:xfrm>
                <a:off x="2601756" y="1646960"/>
                <a:ext cx="31785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12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A</a:t>
                </a:r>
                <a:endParaRPr lang="en-US" sz="1200" b="1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2E78354-6D0B-86C8-3F39-C0794C2561E1}"/>
                  </a:ext>
                </a:extLst>
              </p:cNvPr>
              <p:cNvSpPr txBox="1"/>
              <p:nvPr/>
            </p:nvSpPr>
            <p:spPr>
              <a:xfrm>
                <a:off x="2586567" y="3654629"/>
                <a:ext cx="31785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12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B</a:t>
                </a:r>
                <a:endParaRPr lang="en-US" sz="1200" b="1" dirty="0"/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C5D566E8-8116-2264-2B4A-937D817CE92A}"/>
                </a:ext>
              </a:extLst>
            </p:cNvPr>
            <p:cNvGrpSpPr/>
            <p:nvPr/>
          </p:nvGrpSpPr>
          <p:grpSpPr>
            <a:xfrm>
              <a:off x="2032344" y="4520467"/>
              <a:ext cx="6030308" cy="2285368"/>
              <a:chOff x="2032344" y="4520467"/>
              <a:chExt cx="6030308" cy="2285368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CEB820A7-4C72-CE1F-E195-76DEAA83DF40}"/>
                  </a:ext>
                </a:extLst>
              </p:cNvPr>
              <p:cNvSpPr txBox="1"/>
              <p:nvPr/>
            </p:nvSpPr>
            <p:spPr>
              <a:xfrm>
                <a:off x="2893445" y="4911404"/>
                <a:ext cx="119282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Menadione</a:t>
                </a:r>
              </a:p>
            </p:txBody>
          </p:sp>
          <p:graphicFrame>
            <p:nvGraphicFramePr>
              <p:cNvPr id="48" name="Object 47">
                <a:extLst>
                  <a:ext uri="{FF2B5EF4-FFF2-40B4-BE49-F238E27FC236}">
                    <a16:creationId xmlns:a16="http://schemas.microsoft.com/office/drawing/2014/main" id="{0345E0B9-B51F-298C-54EF-1BE9B9DAAD0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23192177"/>
                  </p:ext>
                </p:extLst>
              </p:nvPr>
            </p:nvGraphicFramePr>
            <p:xfrm>
              <a:off x="2258260" y="4520467"/>
              <a:ext cx="2890837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1" imgW="2891080" imgH="2282918" progId="SigmaPlotGraphicObject.12">
                      <p:embed/>
                    </p:oleObj>
                  </mc:Choice>
                  <mc:Fallback>
                    <p:oleObj name="SPW 13.0 Graph" r:id="rId11" imgW="2891080" imgH="2282918" progId="SigmaPlotGraphicObject.12">
                      <p:embed/>
                      <p:pic>
                        <p:nvPicPr>
                          <p:cNvPr id="48" name="Object 47">
                            <a:extLst>
                              <a:ext uri="{FF2B5EF4-FFF2-40B4-BE49-F238E27FC236}">
                                <a16:creationId xmlns:a16="http://schemas.microsoft.com/office/drawing/2014/main" id="{0345E0B9-B51F-298C-54EF-1BE9B9DAAD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2258260" y="4520467"/>
                            <a:ext cx="2890837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1" name="Object 40">
                <a:extLst>
                  <a:ext uri="{FF2B5EF4-FFF2-40B4-BE49-F238E27FC236}">
                    <a16:creationId xmlns:a16="http://schemas.microsoft.com/office/drawing/2014/main" id="{B7E27F1D-C457-A792-BD18-B51FE3E792D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01254774"/>
                  </p:ext>
                </p:extLst>
              </p:nvPr>
            </p:nvGraphicFramePr>
            <p:xfrm>
              <a:off x="5241665" y="4523010"/>
              <a:ext cx="2820987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3" imgW="2821093" imgH="2282918" progId="SigmaPlotGraphicObject.12">
                      <p:embed/>
                    </p:oleObj>
                  </mc:Choice>
                  <mc:Fallback>
                    <p:oleObj name="SPW 13.0 Graph" r:id="rId13" imgW="2821093" imgH="2282918" progId="SigmaPlotGraphicObject.12">
                      <p:embed/>
                      <p:pic>
                        <p:nvPicPr>
                          <p:cNvPr id="41" name="Object 40">
                            <a:extLst>
                              <a:ext uri="{FF2B5EF4-FFF2-40B4-BE49-F238E27FC236}">
                                <a16:creationId xmlns:a16="http://schemas.microsoft.com/office/drawing/2014/main" id="{B7E27F1D-C457-A792-BD18-B51FE3E792D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5241665" y="4523010"/>
                            <a:ext cx="2820987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E85225F-D7C3-01CE-1254-3F1642E63116}"/>
                  </a:ext>
                </a:extLst>
              </p:cNvPr>
              <p:cNvSpPr txBox="1"/>
              <p:nvPr/>
            </p:nvSpPr>
            <p:spPr>
              <a:xfrm>
                <a:off x="5756634" y="4890069"/>
                <a:ext cx="131925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2-MNQ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53625F3-2EEA-C4F9-3216-12CABDBCE5B6}"/>
                  </a:ext>
                </a:extLst>
              </p:cNvPr>
              <p:cNvSpPr txBox="1"/>
              <p:nvPr/>
            </p:nvSpPr>
            <p:spPr>
              <a:xfrm>
                <a:off x="2032344" y="4755346"/>
                <a:ext cx="31785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12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</a:t>
                </a:r>
                <a:endParaRPr lang="en-US" sz="1200" b="1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A88452C-67D9-7549-C341-A0299C361EC7}"/>
                  </a:ext>
                </a:extLst>
              </p:cNvPr>
              <p:cNvSpPr txBox="1"/>
              <p:nvPr/>
            </p:nvSpPr>
            <p:spPr>
              <a:xfrm>
                <a:off x="5038189" y="4758591"/>
                <a:ext cx="31785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12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D</a:t>
                </a:r>
                <a:endParaRPr lang="en-US" sz="12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1916535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>
            <a:extLst>
              <a:ext uri="{FF2B5EF4-FFF2-40B4-BE49-F238E27FC236}">
                <a16:creationId xmlns:a16="http://schemas.microsoft.com/office/drawing/2014/main" id="{18B2131D-898B-0E7F-69FA-F21CD1AE0028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5</a:t>
            </a:r>
          </a:p>
        </p:txBody>
      </p: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B727C5D5-4693-B13B-6A5E-6C6BE5F23430}"/>
              </a:ext>
            </a:extLst>
          </p:cNvPr>
          <p:cNvGrpSpPr/>
          <p:nvPr/>
        </p:nvGrpSpPr>
        <p:grpSpPr>
          <a:xfrm>
            <a:off x="1877318" y="1160458"/>
            <a:ext cx="8389585" cy="4813379"/>
            <a:chOff x="1877318" y="1160458"/>
            <a:chExt cx="8389585" cy="4813379"/>
          </a:xfrm>
        </p:grpSpPr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D02DB2A6-0B79-32FE-396F-487F71CC591B}"/>
                </a:ext>
              </a:extLst>
            </p:cNvPr>
            <p:cNvGrpSpPr/>
            <p:nvPr/>
          </p:nvGrpSpPr>
          <p:grpSpPr>
            <a:xfrm>
              <a:off x="1894545" y="1341835"/>
              <a:ext cx="6230735" cy="2311438"/>
              <a:chOff x="1633290" y="653066"/>
              <a:chExt cx="6230735" cy="2311438"/>
            </a:xfrm>
          </p:grpSpPr>
          <p:graphicFrame>
            <p:nvGraphicFramePr>
              <p:cNvPr id="6" name="Object 5">
                <a:extLst>
                  <a:ext uri="{FF2B5EF4-FFF2-40B4-BE49-F238E27FC236}">
                    <a16:creationId xmlns:a16="http://schemas.microsoft.com/office/drawing/2014/main" id="{7EC1405E-AF08-EE95-C632-6D2FD8D7EDE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51750574"/>
                  </p:ext>
                </p:extLst>
              </p:nvPr>
            </p:nvGraphicFramePr>
            <p:xfrm>
              <a:off x="1698503" y="656279"/>
              <a:ext cx="2009775" cy="2308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" imgW="2010119" imgH="2308832" progId="SigmaPlotGraphicObject.12">
                      <p:embed/>
                    </p:oleObj>
                  </mc:Choice>
                  <mc:Fallback>
                    <p:oleObj name="SPW 13.0 Graph" r:id="rId2" imgW="2010119" imgH="2308832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698503" y="656279"/>
                            <a:ext cx="2009775" cy="2308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34E7E17E-4195-2104-BC7C-4CC8E4D39286}"/>
                  </a:ext>
                </a:extLst>
              </p:cNvPr>
              <p:cNvGrpSpPr/>
              <p:nvPr/>
            </p:nvGrpSpPr>
            <p:grpSpPr>
              <a:xfrm>
                <a:off x="5676450" y="653564"/>
                <a:ext cx="2187575" cy="2308225"/>
                <a:chOff x="5563457" y="3688078"/>
                <a:chExt cx="2187575" cy="2308225"/>
              </a:xfrm>
            </p:grpSpPr>
            <p:graphicFrame>
              <p:nvGraphicFramePr>
                <p:cNvPr id="81" name="Object 80">
                  <a:extLst>
                    <a:ext uri="{FF2B5EF4-FFF2-40B4-BE49-F238E27FC236}">
                      <a16:creationId xmlns:a16="http://schemas.microsoft.com/office/drawing/2014/main" id="{ABF33A93-4678-0FA4-8DCD-8C9C22A05CC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610015013"/>
                    </p:ext>
                  </p:extLst>
                </p:nvPr>
              </p:nvGraphicFramePr>
              <p:xfrm>
                <a:off x="5563457" y="3688078"/>
                <a:ext cx="2187575" cy="23082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186888" imgH="2308832" progId="SigmaPlotGraphicObject.12">
                        <p:embed/>
                      </p:oleObj>
                    </mc:Choice>
                    <mc:Fallback>
                      <p:oleObj name="SPW 13.0 Graph" r:id="rId4" imgW="2186888" imgH="2308832" progId="SigmaPlotGraphicObject.12">
                        <p:embed/>
                        <p:pic>
                          <p:nvPicPr>
                            <p:cNvPr id="78" name="Object 77">
                              <a:extLst>
                                <a:ext uri="{FF2B5EF4-FFF2-40B4-BE49-F238E27FC236}">
                                  <a16:creationId xmlns:a16="http://schemas.microsoft.com/office/drawing/2014/main" id="{9F56F550-4612-A3BA-B1B5-21693B87961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563457" y="3688078"/>
                              <a:ext cx="2187575" cy="23082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964EFC52-2BA2-D4D0-3BE0-7850881D94DA}"/>
                    </a:ext>
                  </a:extLst>
                </p:cNvPr>
                <p:cNvGrpSpPr/>
                <p:nvPr/>
              </p:nvGrpSpPr>
              <p:grpSpPr>
                <a:xfrm>
                  <a:off x="6070299" y="4864458"/>
                  <a:ext cx="850321" cy="353096"/>
                  <a:chOff x="3859759" y="2662796"/>
                  <a:chExt cx="850321" cy="353096"/>
                </a:xfrm>
              </p:grpSpPr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154843E5-89EC-5E71-884C-D055E4CBAAAB}"/>
                      </a:ext>
                    </a:extLst>
                  </p:cNvPr>
                  <p:cNvSpPr txBox="1"/>
                  <p:nvPr/>
                </p:nvSpPr>
                <p:spPr>
                  <a:xfrm>
                    <a:off x="4376334" y="2662796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8</a:t>
                    </a:r>
                  </a:p>
                </p:txBody>
              </p:sp>
              <p:cxnSp>
                <p:nvCxnSpPr>
                  <p:cNvPr id="20" name="Straight Arrow Connector 19">
                    <a:extLst>
                      <a:ext uri="{FF2B5EF4-FFF2-40B4-BE49-F238E27FC236}">
                        <a16:creationId xmlns:a16="http://schemas.microsoft.com/office/drawing/2014/main" id="{FC0D006A-9453-94A3-5F1E-D42EE7AB7A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427908" y="2819108"/>
                    <a:ext cx="72408" cy="14782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>
                    <a:extLst>
                      <a:ext uri="{FF2B5EF4-FFF2-40B4-BE49-F238E27FC236}">
                        <a16:creationId xmlns:a16="http://schemas.microsoft.com/office/drawing/2014/main" id="{67FCEEAC-84B4-4D94-67BE-B91683280A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035365" y="2665780"/>
                    <a:ext cx="43332" cy="19745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849297D8-AACE-D095-3A71-4F55D9DDA85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759" y="2815837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38</a:t>
                    </a:r>
                  </a:p>
                </p:txBody>
              </p:sp>
            </p:grp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156BF1F9-0EE6-6576-086F-0A1B284D508C}"/>
                  </a:ext>
                </a:extLst>
              </p:cNvPr>
              <p:cNvGrpSpPr/>
              <p:nvPr/>
            </p:nvGrpSpPr>
            <p:grpSpPr>
              <a:xfrm>
                <a:off x="3598315" y="653066"/>
                <a:ext cx="2116137" cy="2308225"/>
                <a:chOff x="5791882" y="1351643"/>
                <a:chExt cx="2116137" cy="2308225"/>
              </a:xfrm>
            </p:grpSpPr>
            <p:graphicFrame>
              <p:nvGraphicFramePr>
                <p:cNvPr id="24" name="Object 23">
                  <a:extLst>
                    <a:ext uri="{FF2B5EF4-FFF2-40B4-BE49-F238E27FC236}">
                      <a16:creationId xmlns:a16="http://schemas.microsoft.com/office/drawing/2014/main" id="{231ECC4F-DDC1-5336-A644-91763C23F65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5454646"/>
                    </p:ext>
                  </p:extLst>
                </p:nvPr>
              </p:nvGraphicFramePr>
              <p:xfrm>
                <a:off x="5791882" y="1351643"/>
                <a:ext cx="2116137" cy="23082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115459" imgH="2308832" progId="SigmaPlotGraphicObject.12">
                        <p:embed/>
                      </p:oleObj>
                    </mc:Choice>
                    <mc:Fallback>
                      <p:oleObj name="SPW 13.0 Graph" r:id="rId6" imgW="2115459" imgH="2308832" progId="SigmaPlotGraphicObject.12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791882" y="1351643"/>
                              <a:ext cx="2116137" cy="23082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4B35698D-48DB-7BEB-94B4-89B546A9AF5A}"/>
                    </a:ext>
                  </a:extLst>
                </p:cNvPr>
                <p:cNvSpPr txBox="1"/>
                <p:nvPr/>
              </p:nvSpPr>
              <p:spPr>
                <a:xfrm>
                  <a:off x="6945142" y="2020066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2</a:t>
                  </a:r>
                </a:p>
              </p:txBody>
            </p:sp>
            <p:cxnSp>
              <p:nvCxnSpPr>
                <p:cNvPr id="26" name="Straight Arrow Connector 25">
                  <a:extLst>
                    <a:ext uri="{FF2B5EF4-FFF2-40B4-BE49-F238E27FC236}">
                      <a16:creationId xmlns:a16="http://schemas.microsoft.com/office/drawing/2014/main" id="{10FB0DB3-3A2A-523D-8A02-F56BA75A2D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7238003" y="2630417"/>
                  <a:ext cx="38361" cy="19751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Arrow Connector 26">
                  <a:extLst>
                    <a:ext uri="{FF2B5EF4-FFF2-40B4-BE49-F238E27FC236}">
                      <a16:creationId xmlns:a16="http://schemas.microsoft.com/office/drawing/2014/main" id="{3DA53397-5F17-2178-9433-323FC3F3B5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050917" y="2203034"/>
                  <a:ext cx="31270" cy="30953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C138498-4FAE-8C80-B5E9-9D4F2AE64F10}"/>
                    </a:ext>
                  </a:extLst>
                </p:cNvPr>
                <p:cNvSpPr txBox="1"/>
                <p:nvPr/>
              </p:nvSpPr>
              <p:spPr>
                <a:xfrm>
                  <a:off x="7470634" y="1715516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78</a:t>
                  </a:r>
                </a:p>
              </p:txBody>
            </p:sp>
            <p:cxnSp>
              <p:nvCxnSpPr>
                <p:cNvPr id="29" name="Straight Arrow Connector 28">
                  <a:extLst>
                    <a:ext uri="{FF2B5EF4-FFF2-40B4-BE49-F238E27FC236}">
                      <a16:creationId xmlns:a16="http://schemas.microsoft.com/office/drawing/2014/main" id="{0F5EA611-D66A-B7D2-B5ED-7BCB3F0BD4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399884" y="1823986"/>
                  <a:ext cx="117137" cy="8040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6D0D733C-8020-C3C1-2667-0A5DFEC0038D}"/>
                    </a:ext>
                  </a:extLst>
                </p:cNvPr>
                <p:cNvSpPr txBox="1"/>
                <p:nvPr/>
              </p:nvSpPr>
              <p:spPr>
                <a:xfrm>
                  <a:off x="7125233" y="2796438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6</a:t>
                  </a:r>
                </a:p>
              </p:txBody>
            </p:sp>
          </p:grp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70E01B6C-2EB6-446C-B2D3-50ACF979E61C}"/>
                  </a:ext>
                </a:extLst>
              </p:cNvPr>
              <p:cNvSpPr txBox="1"/>
              <p:nvPr/>
            </p:nvSpPr>
            <p:spPr>
              <a:xfrm>
                <a:off x="1633290" y="803598"/>
                <a:ext cx="3291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A3E15B52-7EAC-1BE7-529E-1D0EABC69F77}"/>
                  </a:ext>
                </a:extLst>
              </p:cNvPr>
              <p:cNvSpPr txBox="1"/>
              <p:nvPr/>
            </p:nvSpPr>
            <p:spPr>
              <a:xfrm>
                <a:off x="5614305" y="780634"/>
                <a:ext cx="3291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4D82AFA0-25B0-4A45-D38B-6F383E67EDF4}"/>
                  </a:ext>
                </a:extLst>
              </p:cNvPr>
              <p:cNvSpPr txBox="1"/>
              <p:nvPr/>
            </p:nvSpPr>
            <p:spPr>
              <a:xfrm>
                <a:off x="3556895" y="789102"/>
                <a:ext cx="3291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180" name="Group 179">
              <a:extLst>
                <a:ext uri="{FF2B5EF4-FFF2-40B4-BE49-F238E27FC236}">
                  <a16:creationId xmlns:a16="http://schemas.microsoft.com/office/drawing/2014/main" id="{33027F51-B69D-323C-2CD2-E462CD053B5E}"/>
                </a:ext>
              </a:extLst>
            </p:cNvPr>
            <p:cNvGrpSpPr/>
            <p:nvPr/>
          </p:nvGrpSpPr>
          <p:grpSpPr>
            <a:xfrm>
              <a:off x="7324939" y="1160458"/>
              <a:ext cx="2941964" cy="2594191"/>
              <a:chOff x="7063684" y="471689"/>
              <a:chExt cx="2941964" cy="2594191"/>
            </a:xfrm>
          </p:grpSpPr>
          <p:graphicFrame>
            <p:nvGraphicFramePr>
              <p:cNvPr id="40" name="Object 39">
                <a:extLst>
                  <a:ext uri="{FF2B5EF4-FFF2-40B4-BE49-F238E27FC236}">
                    <a16:creationId xmlns:a16="http://schemas.microsoft.com/office/drawing/2014/main" id="{87950412-95C4-B644-32A2-A9526B5F536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5381051"/>
                  </p:ext>
                </p:extLst>
              </p:nvPr>
            </p:nvGraphicFramePr>
            <p:xfrm>
              <a:off x="7063684" y="471689"/>
              <a:ext cx="2860675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8" imgW="2860415" imgH="1819712" progId="SigmaPlotGraphicObject.12">
                      <p:embed/>
                    </p:oleObj>
                  </mc:Choice>
                  <mc:Fallback>
                    <p:oleObj name="SPW 13.0 Graph" r:id="rId8" imgW="2860415" imgH="1819712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7063684" y="471689"/>
                            <a:ext cx="2860675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2" name="Object 41">
                <a:extLst>
                  <a:ext uri="{FF2B5EF4-FFF2-40B4-BE49-F238E27FC236}">
                    <a16:creationId xmlns:a16="http://schemas.microsoft.com/office/drawing/2014/main" id="{45F4303C-0FCC-D2DA-9F0F-9256B80B52A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611582279"/>
                  </p:ext>
                </p:extLst>
              </p:nvPr>
            </p:nvGraphicFramePr>
            <p:xfrm>
              <a:off x="7176259" y="1246605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0" imgW="2755436" imgH="1819712" progId="SigmaPlotGraphicObject.12">
                      <p:embed/>
                    </p:oleObj>
                  </mc:Choice>
                  <mc:Fallback>
                    <p:oleObj name="SPW 13.0 Graph" r:id="rId10" imgW="2755436" imgH="1819712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7176259" y="1246605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1C729AE-BB72-37B6-EFBC-EC888E30B00B}"/>
                  </a:ext>
                </a:extLst>
              </p:cNvPr>
              <p:cNvSpPr txBox="1"/>
              <p:nvPr/>
            </p:nvSpPr>
            <p:spPr>
              <a:xfrm>
                <a:off x="8104735" y="1136080"/>
                <a:ext cx="52457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606468C4-A612-D1D5-9910-A4A5C3F839BC}"/>
                  </a:ext>
                </a:extLst>
              </p:cNvPr>
              <p:cNvSpPr txBox="1"/>
              <p:nvPr/>
            </p:nvSpPr>
            <p:spPr>
              <a:xfrm>
                <a:off x="8142573" y="1877171"/>
                <a:ext cx="44262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b</a:t>
                </a:r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ED043B92-B4B3-502A-D023-0F62AD857CAA}"/>
                  </a:ext>
                </a:extLst>
              </p:cNvPr>
              <p:cNvSpPr txBox="1"/>
              <p:nvPr/>
            </p:nvSpPr>
            <p:spPr>
              <a:xfrm>
                <a:off x="7671708" y="797567"/>
                <a:ext cx="3291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pSp>
            <p:nvGrpSpPr>
              <p:cNvPr id="163" name="Group 162">
                <a:extLst>
                  <a:ext uri="{FF2B5EF4-FFF2-40B4-BE49-F238E27FC236}">
                    <a16:creationId xmlns:a16="http://schemas.microsoft.com/office/drawing/2014/main" id="{7C793FED-CCCC-D1CE-35A3-CC9E02850311}"/>
                  </a:ext>
                </a:extLst>
              </p:cNvPr>
              <p:cNvGrpSpPr/>
              <p:nvPr/>
            </p:nvGrpSpPr>
            <p:grpSpPr>
              <a:xfrm>
                <a:off x="7709225" y="2512521"/>
                <a:ext cx="2296423" cy="400453"/>
                <a:chOff x="8334036" y="5393250"/>
                <a:chExt cx="2296423" cy="400453"/>
              </a:xfrm>
            </p:grpSpPr>
            <p:sp>
              <p:nvSpPr>
                <p:cNvPr id="164" name="TextBox 163">
                  <a:extLst>
                    <a:ext uri="{FF2B5EF4-FFF2-40B4-BE49-F238E27FC236}">
                      <a16:creationId xmlns:a16="http://schemas.microsoft.com/office/drawing/2014/main" id="{101886E9-77A5-2FEF-658D-32262DDF120D}"/>
                    </a:ext>
                  </a:extLst>
                </p:cNvPr>
                <p:cNvSpPr txBox="1"/>
                <p:nvPr/>
              </p:nvSpPr>
              <p:spPr>
                <a:xfrm>
                  <a:off x="8334036" y="5393250"/>
                  <a:ext cx="4667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315</a:t>
                  </a:r>
                </a:p>
              </p:txBody>
            </p:sp>
            <p:sp>
              <p:nvSpPr>
                <p:cNvPr id="165" name="TextBox 164">
                  <a:extLst>
                    <a:ext uri="{FF2B5EF4-FFF2-40B4-BE49-F238E27FC236}">
                      <a16:creationId xmlns:a16="http://schemas.microsoft.com/office/drawing/2014/main" id="{E0735978-E4AD-B535-1F9D-548C9F1D3BA3}"/>
                    </a:ext>
                  </a:extLst>
                </p:cNvPr>
                <p:cNvSpPr txBox="1"/>
                <p:nvPr/>
              </p:nvSpPr>
              <p:spPr>
                <a:xfrm>
                  <a:off x="9201235" y="5547482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uss</a:t>
                  </a:r>
                </a:p>
              </p:txBody>
            </p:sp>
            <p:sp>
              <p:nvSpPr>
                <p:cNvPr id="166" name="TextBox 165">
                  <a:extLst>
                    <a:ext uri="{FF2B5EF4-FFF2-40B4-BE49-F238E27FC236}">
                      <a16:creationId xmlns:a16="http://schemas.microsoft.com/office/drawing/2014/main" id="{3F9CD3B8-0262-D6C1-9912-085F38A2A69C}"/>
                    </a:ext>
                  </a:extLst>
                </p:cNvPr>
                <p:cNvSpPr txBox="1"/>
                <p:nvPr/>
              </p:nvSpPr>
              <p:spPr>
                <a:xfrm>
                  <a:off x="8792064" y="5393250"/>
                  <a:ext cx="4667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320</a:t>
                  </a:r>
                </a:p>
              </p:txBody>
            </p:sp>
            <p:sp>
              <p:nvSpPr>
                <p:cNvPr id="167" name="TextBox 166">
                  <a:extLst>
                    <a:ext uri="{FF2B5EF4-FFF2-40B4-BE49-F238E27FC236}">
                      <a16:creationId xmlns:a16="http://schemas.microsoft.com/office/drawing/2014/main" id="{243095A3-DC98-658B-AA38-27D7C628DF26}"/>
                    </a:ext>
                  </a:extLst>
                </p:cNvPr>
                <p:cNvSpPr txBox="1"/>
                <p:nvPr/>
              </p:nvSpPr>
              <p:spPr>
                <a:xfrm>
                  <a:off x="9252578" y="5393250"/>
                  <a:ext cx="4667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325</a:t>
                  </a:r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5C4585FE-B28A-982C-7426-940CF7236C7A}"/>
                    </a:ext>
                  </a:extLst>
                </p:cNvPr>
                <p:cNvSpPr txBox="1"/>
                <p:nvPr/>
              </p:nvSpPr>
              <p:spPr>
                <a:xfrm>
                  <a:off x="9705637" y="5393250"/>
                  <a:ext cx="4667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330</a:t>
                  </a:r>
                </a:p>
              </p:txBody>
            </p:sp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07A27EFE-517B-82DF-79DA-D47B8545A76E}"/>
                    </a:ext>
                  </a:extLst>
                </p:cNvPr>
                <p:cNvSpPr txBox="1"/>
                <p:nvPr/>
              </p:nvSpPr>
              <p:spPr>
                <a:xfrm>
                  <a:off x="10163665" y="5393250"/>
                  <a:ext cx="4667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335</a:t>
                  </a:r>
                </a:p>
              </p:txBody>
            </p:sp>
            <p:grpSp>
              <p:nvGrpSpPr>
                <p:cNvPr id="170" name="Group 169">
                  <a:extLst>
                    <a:ext uri="{FF2B5EF4-FFF2-40B4-BE49-F238E27FC236}">
                      <a16:creationId xmlns:a16="http://schemas.microsoft.com/office/drawing/2014/main" id="{386E651C-513A-F11D-BCDA-63A22F86864C}"/>
                    </a:ext>
                  </a:extLst>
                </p:cNvPr>
                <p:cNvGrpSpPr/>
                <p:nvPr/>
              </p:nvGrpSpPr>
              <p:grpSpPr>
                <a:xfrm>
                  <a:off x="8567531" y="5394463"/>
                  <a:ext cx="1826315" cy="49693"/>
                  <a:chOff x="8073059" y="5173317"/>
                  <a:chExt cx="1826315" cy="49693"/>
                </a:xfrm>
              </p:grpSpPr>
              <p:cxnSp>
                <p:nvCxnSpPr>
                  <p:cNvPr id="171" name="Straight Connector 170">
                    <a:extLst>
                      <a:ext uri="{FF2B5EF4-FFF2-40B4-BE49-F238E27FC236}">
                        <a16:creationId xmlns:a16="http://schemas.microsoft.com/office/drawing/2014/main" id="{E95C1A76-1EC9-C904-2BCA-E30A6E8696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8073059" y="5173317"/>
                    <a:ext cx="1826315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72" name="Group 171">
                    <a:extLst>
                      <a:ext uri="{FF2B5EF4-FFF2-40B4-BE49-F238E27FC236}">
                        <a16:creationId xmlns:a16="http://schemas.microsoft.com/office/drawing/2014/main" id="{39A81F92-7FB2-0E9E-BFA2-2949325BE3C9}"/>
                      </a:ext>
                    </a:extLst>
                  </p:cNvPr>
                  <p:cNvGrpSpPr/>
                  <p:nvPr/>
                </p:nvGrpSpPr>
                <p:grpSpPr>
                  <a:xfrm>
                    <a:off x="8073059" y="5174143"/>
                    <a:ext cx="1826315" cy="48867"/>
                    <a:chOff x="8073059" y="5034997"/>
                    <a:chExt cx="1826315" cy="129209"/>
                  </a:xfrm>
                </p:grpSpPr>
                <p:cxnSp>
                  <p:nvCxnSpPr>
                    <p:cNvPr id="173" name="Straight Connector 172">
                      <a:extLst>
                        <a:ext uri="{FF2B5EF4-FFF2-40B4-BE49-F238E27FC236}">
                          <a16:creationId xmlns:a16="http://schemas.microsoft.com/office/drawing/2014/main" id="{70934DA0-4A45-74FE-F6A8-CC9A93AC46D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529638" y="5034997"/>
                      <a:ext cx="0" cy="12920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4" name="Straight Connector 173">
                      <a:extLst>
                        <a:ext uri="{FF2B5EF4-FFF2-40B4-BE49-F238E27FC236}">
                          <a16:creationId xmlns:a16="http://schemas.microsoft.com/office/drawing/2014/main" id="{5E3DE741-DE6E-84FC-C8F0-830858EE90C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986217" y="5034997"/>
                      <a:ext cx="0" cy="12920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5" name="Straight Connector 174">
                      <a:extLst>
                        <a:ext uri="{FF2B5EF4-FFF2-40B4-BE49-F238E27FC236}">
                          <a16:creationId xmlns:a16="http://schemas.microsoft.com/office/drawing/2014/main" id="{91CDFDFB-A1EF-77ED-664F-C9634F794EA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442796" y="5034997"/>
                      <a:ext cx="0" cy="12920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6" name="Straight Connector 175">
                      <a:extLst>
                        <a:ext uri="{FF2B5EF4-FFF2-40B4-BE49-F238E27FC236}">
                          <a16:creationId xmlns:a16="http://schemas.microsoft.com/office/drawing/2014/main" id="{2F167DB1-8F40-39BB-43A7-1147318F09E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073059" y="5034997"/>
                      <a:ext cx="0" cy="12920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7" name="Straight Connector 176">
                      <a:extLst>
                        <a:ext uri="{FF2B5EF4-FFF2-40B4-BE49-F238E27FC236}">
                          <a16:creationId xmlns:a16="http://schemas.microsoft.com/office/drawing/2014/main" id="{C837F9FB-28D8-F6C2-93B5-62E98EF0CD7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899374" y="5034997"/>
                      <a:ext cx="0" cy="12920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4BA91F33-9F7B-1BE1-B56F-59D447FFD9B2}"/>
                </a:ext>
              </a:extLst>
            </p:cNvPr>
            <p:cNvSpPr txBox="1"/>
            <p:nvPr/>
          </p:nvSpPr>
          <p:spPr>
            <a:xfrm>
              <a:off x="3921845" y="3777394"/>
              <a:ext cx="3291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F1E2B3C-5598-B0DD-2DFF-4A860C9A78F5}"/>
                </a:ext>
              </a:extLst>
            </p:cNvPr>
            <p:cNvSpPr txBox="1"/>
            <p:nvPr/>
          </p:nvSpPr>
          <p:spPr>
            <a:xfrm>
              <a:off x="1877318" y="3777394"/>
              <a:ext cx="3291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0AC3EC64-9072-AEAF-8032-ABF57F5AFD77}"/>
                </a:ext>
              </a:extLst>
            </p:cNvPr>
            <p:cNvGrpSpPr/>
            <p:nvPr/>
          </p:nvGrpSpPr>
          <p:grpSpPr>
            <a:xfrm>
              <a:off x="1992981" y="3761018"/>
              <a:ext cx="1875774" cy="2211387"/>
              <a:chOff x="1706326" y="683638"/>
              <a:chExt cx="1875774" cy="2211387"/>
            </a:xfrm>
          </p:grpSpPr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4FECBC9B-F369-5CF0-BCB9-70EC7AFE4E05}"/>
                  </a:ext>
                </a:extLst>
              </p:cNvPr>
              <p:cNvSpPr txBox="1"/>
              <p:nvPr/>
            </p:nvSpPr>
            <p:spPr>
              <a:xfrm>
                <a:off x="2315062" y="900492"/>
                <a:ext cx="8114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SSP4</a:t>
                </a:r>
              </a:p>
            </p:txBody>
          </p:sp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id="{FB21B355-B0AF-364C-E4C8-D0AE43F8ED0F}"/>
                  </a:ext>
                </a:extLst>
              </p:cNvPr>
              <p:cNvSpPr/>
              <p:nvPr/>
            </p:nvSpPr>
            <p:spPr>
              <a:xfrm>
                <a:off x="2776109" y="1544617"/>
                <a:ext cx="45719" cy="985010"/>
              </a:xfrm>
              <a:prstGeom prst="rect">
                <a:avLst/>
              </a:prstGeom>
              <a:solidFill>
                <a:srgbClr val="FFC1C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aphicFrame>
            <p:nvGraphicFramePr>
              <p:cNvPr id="126" name="Object 125">
                <a:extLst>
                  <a:ext uri="{FF2B5EF4-FFF2-40B4-BE49-F238E27FC236}">
                    <a16:creationId xmlns:a16="http://schemas.microsoft.com/office/drawing/2014/main" id="{082AA08F-4E2C-BDC7-9316-5ECACF2674C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06637884"/>
                  </p:ext>
                </p:extLst>
              </p:nvPr>
            </p:nvGraphicFramePr>
            <p:xfrm>
              <a:off x="1706326" y="683638"/>
              <a:ext cx="1651000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2" imgW="1650448" imgH="2211296" progId="SigmaPlotGraphicObject.12">
                      <p:embed/>
                    </p:oleObj>
                  </mc:Choice>
                  <mc:Fallback>
                    <p:oleObj name="SPW 13.0 Graph" r:id="rId12" imgW="1650448" imgH="2211296" progId="SigmaPlotGraphicObject.12">
                      <p:embed/>
                      <p:pic>
                        <p:nvPicPr>
                          <p:cNvPr id="97" name="Object 96">
                            <a:extLst>
                              <a:ext uri="{FF2B5EF4-FFF2-40B4-BE49-F238E27FC236}">
                                <a16:creationId xmlns:a16="http://schemas.microsoft.com/office/drawing/2014/main" id="{CE780D89-025B-8656-E6A4-2BA489534C8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1706326" y="683638"/>
                            <a:ext cx="1651000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D435C081-BC26-C9C0-C50A-BC2CF98BB4DE}"/>
                  </a:ext>
                </a:extLst>
              </p:cNvPr>
              <p:cNvSpPr txBox="1"/>
              <p:nvPr/>
            </p:nvSpPr>
            <p:spPr>
              <a:xfrm>
                <a:off x="3004465" y="1656993"/>
                <a:ext cx="577635" cy="73866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SA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 0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 1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. 10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. 100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. 1000</a:t>
                </a:r>
              </a:p>
            </p:txBody>
          </p:sp>
        </p:grp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6309C4C5-7113-AD0C-4AD3-F9808360F4BD}"/>
                </a:ext>
              </a:extLst>
            </p:cNvPr>
            <p:cNvGrpSpPr/>
            <p:nvPr/>
          </p:nvGrpSpPr>
          <p:grpSpPr>
            <a:xfrm>
              <a:off x="4001606" y="3762450"/>
              <a:ext cx="1912816" cy="2211387"/>
              <a:chOff x="8950618" y="836767"/>
              <a:chExt cx="1912816" cy="2211387"/>
            </a:xfrm>
          </p:grpSpPr>
          <p:graphicFrame>
            <p:nvGraphicFramePr>
              <p:cNvPr id="148" name="Object 147">
                <a:extLst>
                  <a:ext uri="{FF2B5EF4-FFF2-40B4-BE49-F238E27FC236}">
                    <a16:creationId xmlns:a16="http://schemas.microsoft.com/office/drawing/2014/main" id="{89E11F33-A864-D2A1-A52C-B801499699C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20864887"/>
                  </p:ext>
                </p:extLst>
              </p:nvPr>
            </p:nvGraphicFramePr>
            <p:xfrm>
              <a:off x="8950618" y="836767"/>
              <a:ext cx="1616075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4" imgW="1615455" imgH="2211296" progId="SigmaPlotGraphicObject.12">
                      <p:embed/>
                    </p:oleObj>
                  </mc:Choice>
                  <mc:Fallback>
                    <p:oleObj name="SPW 13.0 Graph" r:id="rId14" imgW="1615455" imgH="2211296" progId="SigmaPlotGraphicObject.12">
                      <p:embed/>
                      <p:pic>
                        <p:nvPicPr>
                          <p:cNvPr id="138" name="Object 137">
                            <a:extLst>
                              <a:ext uri="{FF2B5EF4-FFF2-40B4-BE49-F238E27FC236}">
                                <a16:creationId xmlns:a16="http://schemas.microsoft.com/office/drawing/2014/main" id="{FEE6BD66-C8F0-B29C-876F-8EF4B0ABE38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8950618" y="836767"/>
                            <a:ext cx="1616075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64ECF9EF-363C-D3C6-EC10-F16D51BB8C59}"/>
                  </a:ext>
                </a:extLst>
              </p:cNvPr>
              <p:cNvGrpSpPr/>
              <p:nvPr/>
            </p:nvGrpSpPr>
            <p:grpSpPr>
              <a:xfrm>
                <a:off x="9457410" y="1069354"/>
                <a:ext cx="1406024" cy="1481078"/>
                <a:chOff x="9226859" y="1119883"/>
                <a:chExt cx="1406024" cy="1481078"/>
              </a:xfrm>
            </p:grpSpPr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E3C13C30-4DD1-F6D0-A00A-72057A0CB05A}"/>
                    </a:ext>
                  </a:extLst>
                </p:cNvPr>
                <p:cNvSpPr txBox="1"/>
                <p:nvPr/>
              </p:nvSpPr>
              <p:spPr>
                <a:xfrm>
                  <a:off x="9226859" y="1119883"/>
                  <a:ext cx="7954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/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zMC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id="{258D5A53-7979-DC71-4522-CD1EA9E1A5BB}"/>
                    </a:ext>
                  </a:extLst>
                </p:cNvPr>
                <p:cNvSpPr txBox="1"/>
                <p:nvPr/>
              </p:nvSpPr>
              <p:spPr>
                <a:xfrm>
                  <a:off x="10055248" y="1862297"/>
                  <a:ext cx="577635" cy="73866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SA (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0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1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10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100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 1000</a:t>
                  </a:r>
                </a:p>
              </p:txBody>
            </p:sp>
          </p:grp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A8D2924C-99E5-7B21-BE62-F28E53E77E0E}"/>
                  </a:ext>
                </a:extLst>
              </p:cNvPr>
              <p:cNvSpPr txBox="1"/>
              <p:nvPr/>
            </p:nvSpPr>
            <p:spPr>
              <a:xfrm>
                <a:off x="9891434" y="1283373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74A0EFEA-FA45-C0A2-5865-A8CC6833E073}"/>
                  </a:ext>
                </a:extLst>
              </p:cNvPr>
              <p:cNvSpPr txBox="1"/>
              <p:nvPr/>
            </p:nvSpPr>
            <p:spPr>
              <a:xfrm>
                <a:off x="10072234" y="1421573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3A3E28A4-DC5D-3C7D-FAE3-97F4203C86BE}"/>
                  </a:ext>
                </a:extLst>
              </p:cNvPr>
              <p:cNvSpPr txBox="1"/>
              <p:nvPr/>
            </p:nvSpPr>
            <p:spPr>
              <a:xfrm>
                <a:off x="9750366" y="1318395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36D90C13-7AC7-5382-A1DA-978C053288D2}"/>
                </a:ext>
              </a:extLst>
            </p:cNvPr>
            <p:cNvSpPr txBox="1"/>
            <p:nvPr/>
          </p:nvSpPr>
          <p:spPr>
            <a:xfrm>
              <a:off x="2611791" y="4733815"/>
              <a:ext cx="3127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CD0D6C1B-EE3C-F824-588D-953E84D7345F}"/>
                </a:ext>
              </a:extLst>
            </p:cNvPr>
            <p:cNvSpPr txBox="1"/>
            <p:nvPr/>
          </p:nvSpPr>
          <p:spPr>
            <a:xfrm>
              <a:off x="2792437" y="5006259"/>
              <a:ext cx="3127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F09F5F70-9FEC-3620-82B3-45A59A1E4D7D}"/>
                </a:ext>
              </a:extLst>
            </p:cNvPr>
            <p:cNvSpPr txBox="1"/>
            <p:nvPr/>
          </p:nvSpPr>
          <p:spPr>
            <a:xfrm>
              <a:off x="2971728" y="5176313"/>
              <a:ext cx="3127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E043BE99-7325-548A-BF73-6C6E5BC8DCE3}"/>
                </a:ext>
              </a:extLst>
            </p:cNvPr>
            <p:cNvSpPr txBox="1"/>
            <p:nvPr/>
          </p:nvSpPr>
          <p:spPr>
            <a:xfrm>
              <a:off x="3161612" y="5363545"/>
              <a:ext cx="3127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grpSp>
          <p:nvGrpSpPr>
            <p:cNvPr id="196" name="Group 195">
              <a:extLst>
                <a:ext uri="{FF2B5EF4-FFF2-40B4-BE49-F238E27FC236}">
                  <a16:creationId xmlns:a16="http://schemas.microsoft.com/office/drawing/2014/main" id="{796CB1D7-F0D2-B8B6-4883-5E9BA45B45A7}"/>
                </a:ext>
              </a:extLst>
            </p:cNvPr>
            <p:cNvGrpSpPr/>
            <p:nvPr/>
          </p:nvGrpSpPr>
          <p:grpSpPr>
            <a:xfrm>
              <a:off x="5912418" y="3752619"/>
              <a:ext cx="2562186" cy="2211387"/>
              <a:chOff x="5912418" y="3752619"/>
              <a:chExt cx="2562186" cy="2211387"/>
            </a:xfrm>
          </p:grpSpPr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EABB2637-DFC1-B594-2000-83EF4D89BEFE}"/>
                  </a:ext>
                </a:extLst>
              </p:cNvPr>
              <p:cNvSpPr txBox="1"/>
              <p:nvPr/>
            </p:nvSpPr>
            <p:spPr>
              <a:xfrm>
                <a:off x="5912418" y="3777394"/>
                <a:ext cx="3291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4EE0C408-1C7E-B9FA-9D48-28F9F9FDF722}"/>
                  </a:ext>
                </a:extLst>
              </p:cNvPr>
              <p:cNvSpPr txBox="1"/>
              <p:nvPr/>
            </p:nvSpPr>
            <p:spPr>
              <a:xfrm>
                <a:off x="7295428" y="4965354"/>
                <a:ext cx="1179176" cy="63094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zMC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 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. 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+Alb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. 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+1,4-NQ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. 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+Alb+1,4-NQ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C78BD39E-E6B6-534A-5489-F2897912C51E}"/>
                  </a:ext>
                </a:extLst>
              </p:cNvPr>
              <p:cNvSpPr txBox="1"/>
              <p:nvPr/>
            </p:nvSpPr>
            <p:spPr>
              <a:xfrm>
                <a:off x="7112900" y="4604243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4241E3CB-CCDF-BC6D-3DDD-331F38527AB7}"/>
                  </a:ext>
                </a:extLst>
              </p:cNvPr>
              <p:cNvSpPr txBox="1"/>
              <p:nvPr/>
            </p:nvSpPr>
            <p:spPr>
              <a:xfrm>
                <a:off x="6929009" y="4754312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C89F8D2D-4AE6-6561-EC90-5FD6808EFCB1}"/>
                  </a:ext>
                </a:extLst>
              </p:cNvPr>
              <p:cNvSpPr txBox="1"/>
              <p:nvPr/>
            </p:nvSpPr>
            <p:spPr>
              <a:xfrm>
                <a:off x="6751446" y="4110860"/>
                <a:ext cx="3127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graphicFrame>
            <p:nvGraphicFramePr>
              <p:cNvPr id="195" name="Object 194">
                <a:extLst>
                  <a:ext uri="{FF2B5EF4-FFF2-40B4-BE49-F238E27FC236}">
                    <a16:creationId xmlns:a16="http://schemas.microsoft.com/office/drawing/2014/main" id="{75F69C46-61E6-9F5C-C83E-447F5C7BEF7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78711251"/>
                  </p:ext>
                </p:extLst>
              </p:nvPr>
            </p:nvGraphicFramePr>
            <p:xfrm>
              <a:off x="5952853" y="3752619"/>
              <a:ext cx="1651000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6" imgW="1650448" imgH="2211296" progId="SigmaPlotGraphicObject.12">
                      <p:embed/>
                    </p:oleObj>
                  </mc:Choice>
                  <mc:Fallback>
                    <p:oleObj name="SPW 13.0 Graph" r:id="rId16" imgW="1650448" imgH="2211296" progId="SigmaPlotGraphicObject.12">
                      <p:embed/>
                      <p:pic>
                        <p:nvPicPr>
                          <p:cNvPr id="194" name="Object 193">
                            <a:extLst>
                              <a:ext uri="{FF2B5EF4-FFF2-40B4-BE49-F238E27FC236}">
                                <a16:creationId xmlns:a16="http://schemas.microsoft.com/office/drawing/2014/main" id="{78588F95-EA6D-8B23-9E7E-970E784E5F1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5952853" y="3752619"/>
                            <a:ext cx="1651000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A8D8713C-9626-B306-646A-193257056487}"/>
                </a:ext>
              </a:extLst>
            </p:cNvPr>
            <p:cNvSpPr txBox="1"/>
            <p:nvPr/>
          </p:nvSpPr>
          <p:spPr>
            <a:xfrm>
              <a:off x="6380644" y="5291816"/>
              <a:ext cx="33029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sp>
        <p:nvSpPr>
          <p:cNvPr id="200" name="TextBox 199">
            <a:extLst>
              <a:ext uri="{FF2B5EF4-FFF2-40B4-BE49-F238E27FC236}">
                <a16:creationId xmlns:a16="http://schemas.microsoft.com/office/drawing/2014/main" id="{4E0B97A1-4FA7-C796-93FE-41E84FC2B82F}"/>
              </a:ext>
            </a:extLst>
          </p:cNvPr>
          <p:cNvSpPr txBox="1"/>
          <p:nvPr/>
        </p:nvSpPr>
        <p:spPr>
          <a:xfrm>
            <a:off x="7118564" y="4534966"/>
            <a:ext cx="312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C8572340-A1EE-415B-F280-5CCE72A68FA9}"/>
              </a:ext>
            </a:extLst>
          </p:cNvPr>
          <p:cNvGrpSpPr/>
          <p:nvPr/>
        </p:nvGrpSpPr>
        <p:grpSpPr>
          <a:xfrm>
            <a:off x="8106730" y="3743292"/>
            <a:ext cx="2162354" cy="2249487"/>
            <a:chOff x="8106730" y="3743292"/>
            <a:chExt cx="2162354" cy="2249487"/>
          </a:xfrm>
        </p:grpSpPr>
        <p:graphicFrame>
          <p:nvGraphicFramePr>
            <p:cNvPr id="201" name="Object 200">
              <a:extLst>
                <a:ext uri="{FF2B5EF4-FFF2-40B4-BE49-F238E27FC236}">
                  <a16:creationId xmlns:a16="http://schemas.microsoft.com/office/drawing/2014/main" id="{46B97C7D-3464-A1F8-5D62-FBC85C4B5C7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4504576"/>
                </p:ext>
              </p:extLst>
            </p:nvPr>
          </p:nvGraphicFramePr>
          <p:xfrm>
            <a:off x="8176759" y="3743292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8" imgW="2092371" imgH="2249446" progId="SigmaPlotGraphicObject.12">
                    <p:embed/>
                  </p:oleObj>
                </mc:Choice>
                <mc:Fallback>
                  <p:oleObj name="SPW 13.0 Graph" r:id="rId18" imgW="2092371" imgH="2249446" progId="SigmaPlotGraphicObjec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8176759" y="3743292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02" name="Straight Arrow Connector 201">
              <a:extLst>
                <a:ext uri="{FF2B5EF4-FFF2-40B4-BE49-F238E27FC236}">
                  <a16:creationId xmlns:a16="http://schemas.microsoft.com/office/drawing/2014/main" id="{DFFBEDDA-D5ED-F0FD-CD99-F6F46F9B7F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74015" y="4276973"/>
              <a:ext cx="0" cy="3299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7E9AEDF5-4514-D489-6E6A-60F9C2BF7759}"/>
                </a:ext>
              </a:extLst>
            </p:cNvPr>
            <p:cNvSpPr txBox="1"/>
            <p:nvPr/>
          </p:nvSpPr>
          <p:spPr>
            <a:xfrm>
              <a:off x="8560401" y="4596365"/>
              <a:ext cx="4748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,4-NQ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FD29AA01-2732-F267-5297-13474300E435}"/>
                </a:ext>
              </a:extLst>
            </p:cNvPr>
            <p:cNvSpPr txBox="1"/>
            <p:nvPr/>
          </p:nvSpPr>
          <p:spPr>
            <a:xfrm>
              <a:off x="8106730" y="3791414"/>
              <a:ext cx="3291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206" name="Straight Arrow Connector 205">
              <a:extLst>
                <a:ext uri="{FF2B5EF4-FFF2-40B4-BE49-F238E27FC236}">
                  <a16:creationId xmlns:a16="http://schemas.microsoft.com/office/drawing/2014/main" id="{D4E2CCE5-585E-214B-C662-72500302A2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95419" y="4282138"/>
              <a:ext cx="0" cy="2020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04E6BE97-13CE-EFAD-2387-012CEC7C11FC}"/>
                </a:ext>
              </a:extLst>
            </p:cNvPr>
            <p:cNvSpPr txBox="1"/>
            <p:nvPr/>
          </p:nvSpPr>
          <p:spPr>
            <a:xfrm>
              <a:off x="8724423" y="4446552"/>
              <a:ext cx="93487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SA, BSA+1,4-NQ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0335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6343C00F-CB02-F7C9-C6AB-01C0E4B53BCE}"/>
              </a:ext>
            </a:extLst>
          </p:cNvPr>
          <p:cNvSpPr txBox="1"/>
          <p:nvPr/>
        </p:nvSpPr>
        <p:spPr>
          <a:xfrm>
            <a:off x="202035" y="263994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2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3F8AF386-1159-04E8-8984-2A8E2369C08D}"/>
              </a:ext>
            </a:extLst>
          </p:cNvPr>
          <p:cNvGrpSpPr/>
          <p:nvPr/>
        </p:nvGrpSpPr>
        <p:grpSpPr>
          <a:xfrm>
            <a:off x="1634912" y="1406372"/>
            <a:ext cx="8683225" cy="4462487"/>
            <a:chOff x="1479941" y="1808120"/>
            <a:chExt cx="8683225" cy="4462487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11D76F2B-F8F4-B808-2ADA-F3353818A026}"/>
                </a:ext>
              </a:extLst>
            </p:cNvPr>
            <p:cNvGrpSpPr/>
            <p:nvPr/>
          </p:nvGrpSpPr>
          <p:grpSpPr>
            <a:xfrm>
              <a:off x="1479941" y="1808120"/>
              <a:ext cx="8683225" cy="2300718"/>
              <a:chOff x="1701178" y="1818394"/>
              <a:chExt cx="8683225" cy="2300718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4E1F20C-8FF6-2B6E-3CA6-81FB75583351}"/>
                  </a:ext>
                </a:extLst>
              </p:cNvPr>
              <p:cNvGrpSpPr/>
              <p:nvPr/>
            </p:nvGrpSpPr>
            <p:grpSpPr>
              <a:xfrm>
                <a:off x="1701178" y="1818394"/>
                <a:ext cx="8683225" cy="2300718"/>
                <a:chOff x="1728072" y="1244653"/>
                <a:chExt cx="8683225" cy="2300718"/>
              </a:xfrm>
            </p:grpSpPr>
            <p:graphicFrame>
              <p:nvGraphicFramePr>
                <p:cNvPr id="3" name="Object 2">
                  <a:extLst>
                    <a:ext uri="{FF2B5EF4-FFF2-40B4-BE49-F238E27FC236}">
                      <a16:creationId xmlns:a16="http://schemas.microsoft.com/office/drawing/2014/main" id="{1D9CC461-FA3A-537C-0788-14567CEBE570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1795273" y="1333984"/>
                <a:ext cx="1120775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1120140" imgH="2211296" progId="SigmaPlotGraphicObject.12">
                        <p:embed/>
                      </p:oleObj>
                    </mc:Choice>
                    <mc:Fallback>
                      <p:oleObj name="SPW 13.0 Graph" r:id="rId2" imgW="1120140" imgH="2211296" progId="SigmaPlotGraphicObject.12">
                        <p:embed/>
                        <p:pic>
                          <p:nvPicPr>
                            <p:cNvPr id="3" name="Object 2">
                              <a:extLst>
                                <a:ext uri="{FF2B5EF4-FFF2-40B4-BE49-F238E27FC236}">
                                  <a16:creationId xmlns:a16="http://schemas.microsoft.com/office/drawing/2014/main" id="{1D9CC461-FA3A-537C-0788-14567CEBE57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95273" y="1333984"/>
                              <a:ext cx="1120775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5056CBF3-252E-C18C-A2DB-2A76FCB21354}"/>
                    </a:ext>
                  </a:extLst>
                </p:cNvPr>
                <p:cNvSpPr txBox="1"/>
                <p:nvPr/>
              </p:nvSpPr>
              <p:spPr>
                <a:xfrm>
                  <a:off x="2563417" y="2507321"/>
                  <a:ext cx="1251986" cy="4154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K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SSP4 (t0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K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SSP4+GSH (t30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K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SSP4+GSH (t0)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775193DB-2B73-2774-B47F-1FE0B20CC4DF}"/>
                    </a:ext>
                  </a:extLst>
                </p:cNvPr>
                <p:cNvSpPr txBox="1"/>
                <p:nvPr/>
              </p:nvSpPr>
              <p:spPr>
                <a:xfrm>
                  <a:off x="2444989" y="3016165"/>
                  <a:ext cx="343986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6BF5605C-C470-1E17-E681-2251C87BDC08}"/>
                    </a:ext>
                  </a:extLst>
                </p:cNvPr>
                <p:cNvSpPr txBox="1"/>
                <p:nvPr/>
              </p:nvSpPr>
              <p:spPr>
                <a:xfrm>
                  <a:off x="1728072" y="1244653"/>
                  <a:ext cx="262054" cy="2813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US" sz="1200" b="1" dirty="0"/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E421DA78-8B6E-4F99-AA33-C1B0554396B9}"/>
                    </a:ext>
                  </a:extLst>
                </p:cNvPr>
                <p:cNvSpPr txBox="1"/>
                <p:nvPr/>
              </p:nvSpPr>
              <p:spPr>
                <a:xfrm>
                  <a:off x="6039224" y="2015369"/>
                  <a:ext cx="1844552" cy="116955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SSP4+K2Sn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1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10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 +1 mM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. +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. +NQ+1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. +NQ+1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. NQ+10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SH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. NQ+1uM GSH</a:t>
                  </a:r>
                </a:p>
              </p:txBody>
            </p:sp>
            <p:graphicFrame>
              <p:nvGraphicFramePr>
                <p:cNvPr id="10" name="Object 9">
                  <a:extLst>
                    <a:ext uri="{FF2B5EF4-FFF2-40B4-BE49-F238E27FC236}">
                      <a16:creationId xmlns:a16="http://schemas.microsoft.com/office/drawing/2014/main" id="{F878F7C1-ACF9-7864-0152-0521DC9DE679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790322" y="1333984"/>
                <a:ext cx="256540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564958" imgH="2211296" progId="SigmaPlotGraphicObject.12">
                        <p:embed/>
                      </p:oleObj>
                    </mc:Choice>
                    <mc:Fallback>
                      <p:oleObj name="SPW 13.0 Graph" r:id="rId4" imgW="2564958" imgH="2211296" progId="SigmaPlotGraphicObject.12">
                        <p:embed/>
                        <p:pic>
                          <p:nvPicPr>
                            <p:cNvPr id="10" name="Object 9">
                              <a:extLst>
                                <a:ext uri="{FF2B5EF4-FFF2-40B4-BE49-F238E27FC236}">
                                  <a16:creationId xmlns:a16="http://schemas.microsoft.com/office/drawing/2014/main" id="{F878F7C1-ACF9-7864-0152-0521DC9DE67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90322" y="1333984"/>
                              <a:ext cx="256540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1" name="Left Brace 10">
                  <a:extLst>
                    <a:ext uri="{FF2B5EF4-FFF2-40B4-BE49-F238E27FC236}">
                      <a16:creationId xmlns:a16="http://schemas.microsoft.com/office/drawing/2014/main" id="{EB8C293C-6E47-32A1-8503-07ADD7BFABF8}"/>
                    </a:ext>
                  </a:extLst>
                </p:cNvPr>
                <p:cNvSpPr/>
                <p:nvPr/>
              </p:nvSpPr>
              <p:spPr>
                <a:xfrm rot="5400000">
                  <a:off x="4697708" y="1273259"/>
                  <a:ext cx="78156" cy="887489"/>
                </a:xfrm>
                <a:prstGeom prst="leftBrace">
                  <a:avLst>
                    <a:gd name="adj1" fmla="val 57682"/>
                    <a:gd name="adj2" fmla="val 50000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Left Brace 11">
                  <a:extLst>
                    <a:ext uri="{FF2B5EF4-FFF2-40B4-BE49-F238E27FC236}">
                      <a16:creationId xmlns:a16="http://schemas.microsoft.com/office/drawing/2014/main" id="{653AAC9E-2DCD-89BA-3DF7-897781CA89C8}"/>
                    </a:ext>
                  </a:extLst>
                </p:cNvPr>
                <p:cNvSpPr/>
                <p:nvPr/>
              </p:nvSpPr>
              <p:spPr>
                <a:xfrm rot="5400000">
                  <a:off x="5602987" y="1271956"/>
                  <a:ext cx="78156" cy="887489"/>
                </a:xfrm>
                <a:prstGeom prst="leftBrace">
                  <a:avLst>
                    <a:gd name="adj1" fmla="val 57682"/>
                    <a:gd name="adj2" fmla="val 50000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9F9DCB5C-2028-BD50-8E8A-C68CA83973D9}"/>
                    </a:ext>
                  </a:extLst>
                </p:cNvPr>
                <p:cNvSpPr txBox="1"/>
                <p:nvPr/>
              </p:nvSpPr>
              <p:spPr>
                <a:xfrm>
                  <a:off x="4406537" y="1466514"/>
                  <a:ext cx="690083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Q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34BED81D-2AA4-BFE1-385B-57A1F0F9343E}"/>
                    </a:ext>
                  </a:extLst>
                </p:cNvPr>
                <p:cNvSpPr txBox="1"/>
                <p:nvPr/>
              </p:nvSpPr>
              <p:spPr>
                <a:xfrm>
                  <a:off x="5258616" y="1463429"/>
                  <a:ext cx="822740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Q</a:t>
                  </a:r>
                </a:p>
              </p:txBody>
            </p:sp>
            <p:graphicFrame>
              <p:nvGraphicFramePr>
                <p:cNvPr id="16" name="Object 15">
                  <a:extLst>
                    <a:ext uri="{FF2B5EF4-FFF2-40B4-BE49-F238E27FC236}">
                      <a16:creationId xmlns:a16="http://schemas.microsoft.com/office/drawing/2014/main" id="{8FE10ABF-3212-46D2-CAC9-3329C6DFA783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7147858" y="1333984"/>
                <a:ext cx="2565400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564958" imgH="2211296" progId="SigmaPlotGraphicObject.12">
                        <p:embed/>
                      </p:oleObj>
                    </mc:Choice>
                    <mc:Fallback>
                      <p:oleObj name="SPW 13.0 Graph" r:id="rId6" imgW="2564958" imgH="2211296" progId="SigmaPlotGraphicObject.12">
                        <p:embed/>
                        <p:pic>
                          <p:nvPicPr>
                            <p:cNvPr id="16" name="Object 15">
                              <a:extLst>
                                <a:ext uri="{FF2B5EF4-FFF2-40B4-BE49-F238E27FC236}">
                                  <a16:creationId xmlns:a16="http://schemas.microsoft.com/office/drawing/2014/main" id="{8FE10ABF-3212-46D2-CAC9-3329C6DFA78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47858" y="1333984"/>
                              <a:ext cx="2565400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F5BE5BEA-977B-A393-C4A6-499EF4BD791E}"/>
                    </a:ext>
                  </a:extLst>
                </p:cNvPr>
                <p:cNvGrpSpPr/>
                <p:nvPr/>
              </p:nvGrpSpPr>
              <p:grpSpPr>
                <a:xfrm>
                  <a:off x="7652488" y="1463908"/>
                  <a:ext cx="2758809" cy="1721491"/>
                  <a:chOff x="706848" y="3292017"/>
                  <a:chExt cx="2758809" cy="1721491"/>
                </a:xfrm>
              </p:grpSpPr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004E7FF5-A1C8-0D39-F6DE-50BFA206570E}"/>
                      </a:ext>
                    </a:extLst>
                  </p:cNvPr>
                  <p:cNvSpPr txBox="1"/>
                  <p:nvPr/>
                </p:nvSpPr>
                <p:spPr>
                  <a:xfrm>
                    <a:off x="2453031" y="3843957"/>
                    <a:ext cx="1012626" cy="116955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SSP4+K2Sn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10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. +1 mM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. +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. +NQ+1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. +NQ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. NQ+10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. NQ+1uM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Left Brace 18">
                    <a:extLst>
                      <a:ext uri="{FF2B5EF4-FFF2-40B4-BE49-F238E27FC236}">
                        <a16:creationId xmlns:a16="http://schemas.microsoft.com/office/drawing/2014/main" id="{76D63B2C-8FAA-24EC-4FD2-A4037B51CF8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1111515" y="3101847"/>
                    <a:ext cx="78156" cy="887489"/>
                  </a:xfrm>
                  <a:prstGeom prst="leftBrace">
                    <a:avLst>
                      <a:gd name="adj1" fmla="val 57682"/>
                      <a:gd name="adj2" fmla="val 50000"/>
                    </a:avLst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" name="Left Brace 19">
                    <a:extLst>
                      <a:ext uri="{FF2B5EF4-FFF2-40B4-BE49-F238E27FC236}">
                        <a16:creationId xmlns:a16="http://schemas.microsoft.com/office/drawing/2014/main" id="{2B7FEA39-FE84-C457-B457-B31D7C4E336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016794" y="3100544"/>
                    <a:ext cx="78156" cy="887489"/>
                  </a:xfrm>
                  <a:prstGeom prst="leftBrace">
                    <a:avLst>
                      <a:gd name="adj1" fmla="val 57682"/>
                      <a:gd name="adj2" fmla="val 50000"/>
                    </a:avLst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CA15912D-77ED-5B53-03C4-9E3F243ACD39}"/>
                      </a:ext>
                    </a:extLst>
                  </p:cNvPr>
                  <p:cNvSpPr txBox="1"/>
                  <p:nvPr/>
                </p:nvSpPr>
                <p:spPr>
                  <a:xfrm>
                    <a:off x="820344" y="3295102"/>
                    <a:ext cx="69008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</a:t>
                    </a:r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NQ</a:t>
                    </a: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C4491BD6-5976-056B-1D78-5EBE6658418A}"/>
                      </a:ext>
                    </a:extLst>
                  </p:cNvPr>
                  <p:cNvSpPr txBox="1"/>
                  <p:nvPr/>
                </p:nvSpPr>
                <p:spPr>
                  <a:xfrm>
                    <a:off x="1672423" y="3292017"/>
                    <a:ext cx="822740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 </a:t>
                    </a:r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NQ</a:t>
                    </a:r>
                  </a:p>
                </p:txBody>
              </p:sp>
            </p:grp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1B2206FF-02F3-49B0-1D88-E1533B0C2038}"/>
                    </a:ext>
                  </a:extLst>
                </p:cNvPr>
                <p:cNvSpPr txBox="1"/>
                <p:nvPr/>
              </p:nvSpPr>
              <p:spPr>
                <a:xfrm>
                  <a:off x="3736167" y="1253617"/>
                  <a:ext cx="26205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US" sz="1200" b="1" dirty="0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0FDCF0AB-EC33-19D8-6B24-28ECEC2172F4}"/>
                    </a:ext>
                  </a:extLst>
                </p:cNvPr>
                <p:cNvSpPr txBox="1"/>
                <p:nvPr/>
              </p:nvSpPr>
              <p:spPr>
                <a:xfrm>
                  <a:off x="7071038" y="1253616"/>
                  <a:ext cx="26205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US" sz="1200" b="1" dirty="0"/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08D05B03-662C-578B-185D-3229967F7F14}"/>
                    </a:ext>
                  </a:extLst>
                </p:cNvPr>
                <p:cNvSpPr txBox="1"/>
                <p:nvPr/>
              </p:nvSpPr>
              <p:spPr>
                <a:xfrm>
                  <a:off x="2140449" y="1522561"/>
                  <a:ext cx="584821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  <a:endParaRPr lang="en-US" sz="1000" dirty="0"/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A9D721A8-3D18-AF36-066B-4CF98CCF6703}"/>
                    </a:ext>
                  </a:extLst>
                </p:cNvPr>
                <p:cNvSpPr txBox="1"/>
                <p:nvPr/>
              </p:nvSpPr>
              <p:spPr>
                <a:xfrm>
                  <a:off x="4919506" y="1352228"/>
                  <a:ext cx="584821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  <a:endParaRPr lang="en-US" sz="1000" dirty="0"/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59AD774A-F442-A159-4DE6-7DD3DF87CC53}"/>
                    </a:ext>
                  </a:extLst>
                </p:cNvPr>
                <p:cNvSpPr txBox="1"/>
                <p:nvPr/>
              </p:nvSpPr>
              <p:spPr>
                <a:xfrm>
                  <a:off x="8335059" y="1352228"/>
                  <a:ext cx="584821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pt-B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sz="1000" dirty="0"/>
                </a:p>
              </p:txBody>
            </p:sp>
          </p:grp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BDB312E-D86D-717A-9961-D9F46225FEC1}"/>
                  </a:ext>
                </a:extLst>
              </p:cNvPr>
              <p:cNvSpPr txBox="1"/>
              <p:nvPr/>
            </p:nvSpPr>
            <p:spPr>
              <a:xfrm>
                <a:off x="4562335" y="2935484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A822691-D32B-4CC4-554A-F6A23097C9D3}"/>
                  </a:ext>
                </a:extLst>
              </p:cNvPr>
              <p:cNvSpPr txBox="1"/>
              <p:nvPr/>
            </p:nvSpPr>
            <p:spPr>
              <a:xfrm>
                <a:off x="4739185" y="3347050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EC4EFEB-5477-74CF-FCD4-39AB9D985268}"/>
                  </a:ext>
                </a:extLst>
              </p:cNvPr>
              <p:cNvSpPr txBox="1"/>
              <p:nvPr/>
            </p:nvSpPr>
            <p:spPr>
              <a:xfrm>
                <a:off x="4918480" y="3509230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776A0D1-24C4-3483-4DA0-9D787391718D}"/>
                  </a:ext>
                </a:extLst>
              </p:cNvPr>
              <p:cNvSpPr txBox="1"/>
              <p:nvPr/>
            </p:nvSpPr>
            <p:spPr>
              <a:xfrm>
                <a:off x="5486521" y="2879256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C97A07B-B027-D39C-E87F-4D6CBA2A9D0C}"/>
                  </a:ext>
                </a:extLst>
              </p:cNvPr>
              <p:cNvSpPr txBox="1"/>
              <p:nvPr/>
            </p:nvSpPr>
            <p:spPr>
              <a:xfrm>
                <a:off x="5660105" y="3397577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0C46E68-3A7A-2B45-A724-584A22DD18C7}"/>
                  </a:ext>
                </a:extLst>
              </p:cNvPr>
              <p:cNvSpPr txBox="1"/>
              <p:nvPr/>
            </p:nvSpPr>
            <p:spPr>
              <a:xfrm>
                <a:off x="5836955" y="3498632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A1865763-0E39-930E-198C-A32E8864A686}"/>
                  </a:ext>
                </a:extLst>
              </p:cNvPr>
              <p:cNvSpPr txBox="1"/>
              <p:nvPr/>
            </p:nvSpPr>
            <p:spPr>
              <a:xfrm>
                <a:off x="7917574" y="3075659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0B4BC7D-B280-8146-62AB-166E68E792EE}"/>
                  </a:ext>
                </a:extLst>
              </p:cNvPr>
              <p:cNvSpPr txBox="1"/>
              <p:nvPr/>
            </p:nvSpPr>
            <p:spPr>
              <a:xfrm>
                <a:off x="8099314" y="3367420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57197D9-CA50-44C7-BBDE-EF50E8CC48EF}"/>
                  </a:ext>
                </a:extLst>
              </p:cNvPr>
              <p:cNvSpPr txBox="1"/>
              <p:nvPr/>
            </p:nvSpPr>
            <p:spPr>
              <a:xfrm>
                <a:off x="8278609" y="3529600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5B42C969-2CE7-11C1-DEA3-B6A3DAD9F303}"/>
                  </a:ext>
                </a:extLst>
              </p:cNvPr>
              <p:cNvSpPr txBox="1"/>
              <p:nvPr/>
            </p:nvSpPr>
            <p:spPr>
              <a:xfrm>
                <a:off x="8846650" y="2936301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B2EFDD7-4882-C821-3190-5C6A27F1C395}"/>
                  </a:ext>
                </a:extLst>
              </p:cNvPr>
              <p:cNvSpPr txBox="1"/>
              <p:nvPr/>
            </p:nvSpPr>
            <p:spPr>
              <a:xfrm>
                <a:off x="9020234" y="3417947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E9EA54F-1EBE-6BE3-0D38-4D55E24DB0F9}"/>
                  </a:ext>
                </a:extLst>
              </p:cNvPr>
              <p:cNvSpPr txBox="1"/>
              <p:nvPr/>
            </p:nvSpPr>
            <p:spPr>
              <a:xfrm>
                <a:off x="9197084" y="3514112"/>
                <a:ext cx="34398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DFA85157-B0E2-E29A-07E4-88C4B6A1385E}"/>
                </a:ext>
              </a:extLst>
            </p:cNvPr>
            <p:cNvGrpSpPr/>
            <p:nvPr/>
          </p:nvGrpSpPr>
          <p:grpSpPr>
            <a:xfrm>
              <a:off x="1519754" y="3990713"/>
              <a:ext cx="2774325" cy="2279894"/>
              <a:chOff x="8602864" y="1826633"/>
              <a:chExt cx="2774325" cy="2279894"/>
            </a:xfrm>
          </p:grpSpPr>
          <p:graphicFrame>
            <p:nvGraphicFramePr>
              <p:cNvPr id="44" name="Object 43">
                <a:extLst>
                  <a:ext uri="{FF2B5EF4-FFF2-40B4-BE49-F238E27FC236}">
                    <a16:creationId xmlns:a16="http://schemas.microsoft.com/office/drawing/2014/main" id="{5F44289B-1112-5E62-5E27-E433618BB99A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676216" y="1895140"/>
              <a:ext cx="2108200" cy="22113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8" imgW="2107523" imgH="2211296" progId="SigmaPlotGraphicObject.12">
                      <p:embed/>
                    </p:oleObj>
                  </mc:Choice>
                  <mc:Fallback>
                    <p:oleObj name="SPW 13.0 Graph" r:id="rId8" imgW="2107523" imgH="2211296" progId="SigmaPlotGraphicObject.12">
                      <p:embed/>
                      <p:pic>
                        <p:nvPicPr>
                          <p:cNvPr id="44" name="Object 43">
                            <a:extLst>
                              <a:ext uri="{FF2B5EF4-FFF2-40B4-BE49-F238E27FC236}">
                                <a16:creationId xmlns:a16="http://schemas.microsoft.com/office/drawing/2014/main" id="{5F44289B-1112-5E62-5E27-E433618BB99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8676216" y="1895140"/>
                            <a:ext cx="2108200" cy="22113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07B517C1-14AF-7351-247F-07C1742DE352}"/>
                  </a:ext>
                </a:extLst>
              </p:cNvPr>
              <p:cNvGrpSpPr/>
              <p:nvPr/>
            </p:nvGrpSpPr>
            <p:grpSpPr>
              <a:xfrm>
                <a:off x="10613696" y="3246713"/>
                <a:ext cx="763493" cy="334963"/>
                <a:chOff x="4087707" y="4839072"/>
                <a:chExt cx="1073171" cy="334963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C21FD74F-9A56-2386-CC9C-18E0108FA016}"/>
                    </a:ext>
                  </a:extLst>
                </p:cNvPr>
                <p:cNvSpPr txBox="1"/>
                <p:nvPr/>
              </p:nvSpPr>
              <p:spPr>
                <a:xfrm>
                  <a:off x="4148252" y="4839072"/>
                  <a:ext cx="1012626" cy="334963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75000"/>
                    </a:lnSpc>
                  </a:pP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ct val="75000"/>
                    </a:lnSpc>
                  </a:pP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ct val="75000"/>
                    </a:lnSpc>
                  </a:pP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1,4-NQ</a:t>
                  </a:r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A16549C9-E182-CC32-B0F0-62CEA7D6B78B}"/>
                    </a:ext>
                  </a:extLst>
                </p:cNvPr>
                <p:cNvSpPr/>
                <p:nvPr/>
              </p:nvSpPr>
              <p:spPr>
                <a:xfrm>
                  <a:off x="4087707" y="4861537"/>
                  <a:ext cx="102189" cy="10218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64F229B7-E698-1ACE-D122-E264AFE37C9A}"/>
                    </a:ext>
                  </a:extLst>
                </p:cNvPr>
                <p:cNvSpPr/>
                <p:nvPr/>
              </p:nvSpPr>
              <p:spPr>
                <a:xfrm>
                  <a:off x="4087707" y="5021689"/>
                  <a:ext cx="102189" cy="102189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5A10F5B-8F68-891C-2D62-A8D94E616C16}"/>
                  </a:ext>
                </a:extLst>
              </p:cNvPr>
              <p:cNvGrpSpPr/>
              <p:nvPr/>
            </p:nvGrpSpPr>
            <p:grpSpPr>
              <a:xfrm>
                <a:off x="9206721" y="2065396"/>
                <a:ext cx="1633282" cy="208070"/>
                <a:chOff x="2178281" y="4435615"/>
                <a:chExt cx="1633282" cy="208070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98BA0267-75A0-948B-4C66-485652D4B7D7}"/>
                    </a:ext>
                  </a:extLst>
                </p:cNvPr>
                <p:cNvSpPr txBox="1"/>
                <p:nvPr/>
              </p:nvSpPr>
              <p:spPr>
                <a:xfrm>
                  <a:off x="2178281" y="4435615"/>
                  <a:ext cx="413321" cy="20807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75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A6A78FF0-A4F6-6D4B-59B2-C602655E5068}"/>
                    </a:ext>
                  </a:extLst>
                </p:cNvPr>
                <p:cNvSpPr txBox="1"/>
                <p:nvPr/>
              </p:nvSpPr>
              <p:spPr>
                <a:xfrm>
                  <a:off x="2484686" y="4435615"/>
                  <a:ext cx="458238" cy="20807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75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D8A96407-2ECA-A401-46E0-1B7333F4C862}"/>
                    </a:ext>
                  </a:extLst>
                </p:cNvPr>
                <p:cNvSpPr txBox="1"/>
                <p:nvPr/>
              </p:nvSpPr>
              <p:spPr>
                <a:xfrm>
                  <a:off x="2812747" y="4435615"/>
                  <a:ext cx="457436" cy="20807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75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617D0D18-E289-08C5-277D-BC833F82D7B7}"/>
                    </a:ext>
                  </a:extLst>
                </p:cNvPr>
                <p:cNvSpPr txBox="1"/>
                <p:nvPr/>
              </p:nvSpPr>
              <p:spPr>
                <a:xfrm>
                  <a:off x="3167278" y="4435615"/>
                  <a:ext cx="644285" cy="20807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75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 min</a:t>
                  </a:r>
                </a:p>
              </p:txBody>
            </p:sp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90A7831B-079D-4E79-58F0-70E83102F911}"/>
                  </a:ext>
                </a:extLst>
              </p:cNvPr>
              <p:cNvGrpSpPr/>
              <p:nvPr/>
            </p:nvGrpSpPr>
            <p:grpSpPr>
              <a:xfrm>
                <a:off x="9170293" y="2239318"/>
                <a:ext cx="1367945" cy="52486"/>
                <a:chOff x="2206354" y="4598082"/>
                <a:chExt cx="1367945" cy="52486"/>
              </a:xfrm>
            </p:grpSpPr>
            <p:sp>
              <p:nvSpPr>
                <p:cNvPr id="53" name="Left Brace 52">
                  <a:extLst>
                    <a:ext uri="{FF2B5EF4-FFF2-40B4-BE49-F238E27FC236}">
                      <a16:creationId xmlns:a16="http://schemas.microsoft.com/office/drawing/2014/main" id="{793BAF42-C647-A3F8-5A1F-09ED63E99F1D}"/>
                    </a:ext>
                  </a:extLst>
                </p:cNvPr>
                <p:cNvSpPr/>
                <p:nvPr/>
              </p:nvSpPr>
              <p:spPr>
                <a:xfrm rot="5400000">
                  <a:off x="3378552" y="4454820"/>
                  <a:ext cx="52486" cy="339009"/>
                </a:xfrm>
                <a:prstGeom prst="leftBrace">
                  <a:avLst>
                    <a:gd name="adj1" fmla="val 38593"/>
                    <a:gd name="adj2" fmla="val 5000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54" name="Left Brace 53">
                  <a:extLst>
                    <a:ext uri="{FF2B5EF4-FFF2-40B4-BE49-F238E27FC236}">
                      <a16:creationId xmlns:a16="http://schemas.microsoft.com/office/drawing/2014/main" id="{7B69820E-BE24-F0AC-09E6-DD087BE70848}"/>
                    </a:ext>
                  </a:extLst>
                </p:cNvPr>
                <p:cNvSpPr/>
                <p:nvPr/>
              </p:nvSpPr>
              <p:spPr>
                <a:xfrm rot="5400000">
                  <a:off x="3035574" y="4454820"/>
                  <a:ext cx="52486" cy="339009"/>
                </a:xfrm>
                <a:prstGeom prst="leftBrace">
                  <a:avLst>
                    <a:gd name="adj1" fmla="val 38593"/>
                    <a:gd name="adj2" fmla="val 5000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55" name="Left Brace 54">
                  <a:extLst>
                    <a:ext uri="{FF2B5EF4-FFF2-40B4-BE49-F238E27FC236}">
                      <a16:creationId xmlns:a16="http://schemas.microsoft.com/office/drawing/2014/main" id="{84A97716-5CEF-B570-50E5-92836D044999}"/>
                    </a:ext>
                  </a:extLst>
                </p:cNvPr>
                <p:cNvSpPr/>
                <p:nvPr/>
              </p:nvSpPr>
              <p:spPr>
                <a:xfrm rot="5400000">
                  <a:off x="2692595" y="4454820"/>
                  <a:ext cx="52486" cy="339009"/>
                </a:xfrm>
                <a:prstGeom prst="leftBrace">
                  <a:avLst>
                    <a:gd name="adj1" fmla="val 38593"/>
                    <a:gd name="adj2" fmla="val 5000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56" name="Left Brace 55">
                  <a:extLst>
                    <a:ext uri="{FF2B5EF4-FFF2-40B4-BE49-F238E27FC236}">
                      <a16:creationId xmlns:a16="http://schemas.microsoft.com/office/drawing/2014/main" id="{86D2FDBF-481D-123A-61EF-51621328ED80}"/>
                    </a:ext>
                  </a:extLst>
                </p:cNvPr>
                <p:cNvSpPr/>
                <p:nvPr/>
              </p:nvSpPr>
              <p:spPr>
                <a:xfrm rot="5400000">
                  <a:off x="2349616" y="4454820"/>
                  <a:ext cx="52486" cy="339009"/>
                </a:xfrm>
                <a:prstGeom prst="leftBrace">
                  <a:avLst>
                    <a:gd name="adj1" fmla="val 38593"/>
                    <a:gd name="adj2" fmla="val 50000"/>
                  </a:avLst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CA059A37-8EA2-BF91-5E01-DF299872EB7E}"/>
                  </a:ext>
                </a:extLst>
              </p:cNvPr>
              <p:cNvSpPr txBox="1"/>
              <p:nvPr/>
            </p:nvSpPr>
            <p:spPr>
              <a:xfrm>
                <a:off x="8602864" y="1826633"/>
                <a:ext cx="26205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sz="1200" b="1" dirty="0"/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42D4F283-9DB2-B6DF-6A6C-F66C49A688E7}"/>
                </a:ext>
              </a:extLst>
            </p:cNvPr>
            <p:cNvGrpSpPr/>
            <p:nvPr/>
          </p:nvGrpSpPr>
          <p:grpSpPr>
            <a:xfrm>
              <a:off x="4364475" y="4056825"/>
              <a:ext cx="4037389" cy="2211387"/>
              <a:chOff x="7409427" y="3172905"/>
              <a:chExt cx="4037389" cy="2211387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DC785ABE-DAFE-E149-D4FA-F89A7862F2A4}"/>
                  </a:ext>
                </a:extLst>
              </p:cNvPr>
              <p:cNvGrpSpPr/>
              <p:nvPr/>
            </p:nvGrpSpPr>
            <p:grpSpPr>
              <a:xfrm>
                <a:off x="7477062" y="3172905"/>
                <a:ext cx="3969754" cy="2211387"/>
                <a:chOff x="7477062" y="3172905"/>
                <a:chExt cx="3969754" cy="2211387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86636339-94CF-3E00-0D08-FC8D2DCE0277}"/>
                    </a:ext>
                  </a:extLst>
                </p:cNvPr>
                <p:cNvSpPr txBox="1"/>
                <p:nvPr/>
              </p:nvSpPr>
              <p:spPr>
                <a:xfrm>
                  <a:off x="9399887" y="3945535"/>
                  <a:ext cx="2046929" cy="10618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 SSP4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 +PA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 +K2Sn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 +K2Sn+PA 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 +PA (+K2Sn after 10 min) 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. +K2Sn (+PA after 2hr)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. +PA+K2Sn+GSH 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. </a:t>
                  </a:r>
                  <a:r>
                    <a:rPr lang="sv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PA (+GSH+K2Sn after 10 min) 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. + PA (+K2Sn after 10min: +GSH after 2h</a:t>
                  </a:r>
                  <a:r>
                    <a:rPr lang="sv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 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63" name="Object 62">
                  <a:extLst>
                    <a:ext uri="{FF2B5EF4-FFF2-40B4-BE49-F238E27FC236}">
                      <a16:creationId xmlns:a16="http://schemas.microsoft.com/office/drawing/2014/main" id="{C1E1B2DC-E6E1-2302-B248-49033FA0B68A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7477062" y="3172905"/>
                <a:ext cx="2192337" cy="2211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2191578" imgH="2211296" progId="SigmaPlotGraphicObject.12">
                        <p:embed/>
                      </p:oleObj>
                    </mc:Choice>
                    <mc:Fallback>
                      <p:oleObj name="SPW 13.0 Graph" r:id="rId10" imgW="2191578" imgH="2211296" progId="SigmaPlotGraphicObject.12">
                        <p:embed/>
                        <p:pic>
                          <p:nvPicPr>
                            <p:cNvPr id="63" name="Object 62">
                              <a:extLst>
                                <a:ext uri="{FF2B5EF4-FFF2-40B4-BE49-F238E27FC236}">
                                  <a16:creationId xmlns:a16="http://schemas.microsoft.com/office/drawing/2014/main" id="{C1E1B2DC-E6E1-2302-B248-49033FA0B68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477062" y="3172905"/>
                              <a:ext cx="2192337" cy="2211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11F651B1-197D-BF2A-C0CF-179AC730A724}"/>
                    </a:ext>
                  </a:extLst>
                </p:cNvPr>
                <p:cNvSpPr txBox="1"/>
                <p:nvPr/>
              </p:nvSpPr>
              <p:spPr>
                <a:xfrm>
                  <a:off x="7765318" y="4806294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D9A6BA45-4AB4-247B-A4BD-15E71752D1B0}"/>
                    </a:ext>
                  </a:extLst>
                </p:cNvPr>
                <p:cNvSpPr txBox="1"/>
                <p:nvPr/>
              </p:nvSpPr>
              <p:spPr>
                <a:xfrm>
                  <a:off x="7939565" y="4733995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9A9C6C95-C712-A58C-F52D-7A6DB650CCBC}"/>
                    </a:ext>
                  </a:extLst>
                </p:cNvPr>
                <p:cNvSpPr txBox="1"/>
                <p:nvPr/>
              </p:nvSpPr>
              <p:spPr>
                <a:xfrm>
                  <a:off x="8301062" y="4159246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E525EB5C-F9FA-3104-D342-E1A4FC05288E}"/>
                    </a:ext>
                  </a:extLst>
                </p:cNvPr>
                <p:cNvSpPr txBox="1"/>
                <p:nvPr/>
              </p:nvSpPr>
              <p:spPr>
                <a:xfrm>
                  <a:off x="8465946" y="4296041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6602A78C-8F7D-2B25-2616-9DA47498D39E}"/>
                    </a:ext>
                  </a:extLst>
                </p:cNvPr>
                <p:cNvSpPr txBox="1"/>
                <p:nvPr/>
              </p:nvSpPr>
              <p:spPr>
                <a:xfrm>
                  <a:off x="8668282" y="3883572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b="1" dirty="0"/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C6485CA2-2213-BC33-6F4E-34F01483F741}"/>
                    </a:ext>
                  </a:extLst>
                </p:cNvPr>
                <p:cNvSpPr txBox="1"/>
                <p:nvPr/>
              </p:nvSpPr>
              <p:spPr>
                <a:xfrm>
                  <a:off x="8830561" y="4748040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438EDF09-13B6-F729-5843-B9A60B7AAEEB}"/>
                    </a:ext>
                  </a:extLst>
                </p:cNvPr>
                <p:cNvSpPr txBox="1"/>
                <p:nvPr/>
              </p:nvSpPr>
              <p:spPr>
                <a:xfrm>
                  <a:off x="9004808" y="4775605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FF1D99D7-3882-CE2A-E854-01B8219D6FD3}"/>
                    </a:ext>
                  </a:extLst>
                </p:cNvPr>
                <p:cNvSpPr txBox="1"/>
                <p:nvPr/>
              </p:nvSpPr>
              <p:spPr>
                <a:xfrm>
                  <a:off x="9179055" y="4363137"/>
                  <a:ext cx="30511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b="1" dirty="0"/>
                </a:p>
              </p:txBody>
            </p:sp>
          </p:grp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8F4F5DA6-45C4-C911-066A-524126A4E6E2}"/>
                  </a:ext>
                </a:extLst>
              </p:cNvPr>
              <p:cNvSpPr txBox="1"/>
              <p:nvPr/>
            </p:nvSpPr>
            <p:spPr>
              <a:xfrm>
                <a:off x="7409427" y="3243507"/>
                <a:ext cx="26946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1DCEAFD-F36B-995F-5403-E75D3B705BA6}"/>
                </a:ext>
              </a:extLst>
            </p:cNvPr>
            <p:cNvSpPr txBox="1"/>
            <p:nvPr/>
          </p:nvSpPr>
          <p:spPr>
            <a:xfrm>
              <a:off x="5165552" y="4303295"/>
              <a:ext cx="1026592" cy="2483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Arial" panose="020B0604020202020204" pitchFamily="34" charset="0"/>
                  <a:cs typeface="Arial" panose="020B0604020202020204" pitchFamily="34" charset="0"/>
                </a:rPr>
                <a:t>Propylamine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43402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8ECE51D1-C3FD-438B-8E6D-AC8E8EA317F9}"/>
              </a:ext>
            </a:extLst>
          </p:cNvPr>
          <p:cNvSpPr txBox="1"/>
          <p:nvPr/>
        </p:nvSpPr>
        <p:spPr>
          <a:xfrm>
            <a:off x="202035" y="263994"/>
            <a:ext cx="21296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3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D5564ED1-83B3-46C3-A2C9-9289C0EBB6FD}"/>
              </a:ext>
            </a:extLst>
          </p:cNvPr>
          <p:cNvGrpSpPr/>
          <p:nvPr/>
        </p:nvGrpSpPr>
        <p:grpSpPr>
          <a:xfrm>
            <a:off x="2863353" y="2532001"/>
            <a:ext cx="6235814" cy="4000802"/>
            <a:chOff x="1144281" y="1850019"/>
            <a:chExt cx="6235814" cy="4000802"/>
          </a:xfrm>
        </p:grpSpPr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F17749AE-BC16-4A25-88BD-3C64F872C719}"/>
                </a:ext>
              </a:extLst>
            </p:cNvPr>
            <p:cNvGrpSpPr/>
            <p:nvPr/>
          </p:nvGrpSpPr>
          <p:grpSpPr>
            <a:xfrm>
              <a:off x="1169471" y="1850019"/>
              <a:ext cx="6210624" cy="2094492"/>
              <a:chOff x="1169471" y="1850019"/>
              <a:chExt cx="6210624" cy="2094492"/>
            </a:xfrm>
          </p:grpSpPr>
          <p:graphicFrame>
            <p:nvGraphicFramePr>
              <p:cNvPr id="26" name="Object 25">
                <a:extLst>
                  <a:ext uri="{FF2B5EF4-FFF2-40B4-BE49-F238E27FC236}">
                    <a16:creationId xmlns:a16="http://schemas.microsoft.com/office/drawing/2014/main" id="{6DA21468-2F9D-4FE0-8F46-5ED5361BF0F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638318591"/>
                  </p:ext>
                </p:extLst>
              </p:nvPr>
            </p:nvGraphicFramePr>
            <p:xfrm>
              <a:off x="4435622" y="1850019"/>
              <a:ext cx="2587625" cy="20939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" imgW="2587686" imgH="2093965" progId="SigmaPlotGraphicObject.12">
                      <p:embed/>
                    </p:oleObj>
                  </mc:Choice>
                  <mc:Fallback>
                    <p:oleObj name="SPW 13.0 Graph" r:id="rId2" imgW="2587686" imgH="2093965" progId="SigmaPlotGraphicObject.12">
                      <p:embed/>
                      <p:pic>
                        <p:nvPicPr>
                          <p:cNvPr id="26" name="Object 25">
                            <a:extLst>
                              <a:ext uri="{FF2B5EF4-FFF2-40B4-BE49-F238E27FC236}">
                                <a16:creationId xmlns:a16="http://schemas.microsoft.com/office/drawing/2014/main" id="{6DA21468-2F9D-4FE0-8F46-5ED5361BF0F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4435622" y="1850019"/>
                            <a:ext cx="2587625" cy="20939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7" name="Object 26">
                <a:extLst>
                  <a:ext uri="{FF2B5EF4-FFF2-40B4-BE49-F238E27FC236}">
                    <a16:creationId xmlns:a16="http://schemas.microsoft.com/office/drawing/2014/main" id="{C2F5D156-6275-493E-9E29-329FCFBE16E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53515334"/>
                  </p:ext>
                </p:extLst>
              </p:nvPr>
            </p:nvGraphicFramePr>
            <p:xfrm>
              <a:off x="1257446" y="1850598"/>
              <a:ext cx="2679700" cy="20939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4" imgW="2679317" imgH="2093965" progId="SigmaPlotGraphicObject.12">
                      <p:embed/>
                    </p:oleObj>
                  </mc:Choice>
                  <mc:Fallback>
                    <p:oleObj name="SPW 13.0 Graph" r:id="rId4" imgW="2679317" imgH="2093965" progId="SigmaPlotGraphicObject.12">
                      <p:embed/>
                      <p:pic>
                        <p:nvPicPr>
                          <p:cNvPr id="27" name="Object 26">
                            <a:extLst>
                              <a:ext uri="{FF2B5EF4-FFF2-40B4-BE49-F238E27FC236}">
                                <a16:creationId xmlns:a16="http://schemas.microsoft.com/office/drawing/2014/main" id="{C2F5D156-6275-493E-9E29-329FCFBE16E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257446" y="1850598"/>
                            <a:ext cx="2679700" cy="20939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1DE3618-0F01-43F0-A6B5-58B26C909D97}"/>
                  </a:ext>
                </a:extLst>
              </p:cNvPr>
              <p:cNvSpPr txBox="1"/>
              <p:nvPr/>
            </p:nvSpPr>
            <p:spPr>
              <a:xfrm>
                <a:off x="3631431" y="2745445"/>
                <a:ext cx="647076" cy="95410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[TS]</a:t>
                </a: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0 </a:t>
                </a:r>
                <a:r>
                  <a:rPr lang="en-US" sz="700" b="0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1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 3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. 1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3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. 10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. 300 </a:t>
                </a:r>
                <a:r>
                  <a:rPr lang="en-US" sz="700" b="0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B47EB86-9E5B-4540-9E14-7996A6ADD389}"/>
                  </a:ext>
                </a:extLst>
              </p:cNvPr>
              <p:cNvSpPr txBox="1"/>
              <p:nvPr/>
            </p:nvSpPr>
            <p:spPr>
              <a:xfrm>
                <a:off x="1977434" y="2594413"/>
                <a:ext cx="1155031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dd GSH/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last </a:t>
                </a:r>
                <a:endParaRPr lang="en-US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0DFAAA3-DF5C-493D-861A-875C47A1A123}"/>
                  </a:ext>
                </a:extLst>
              </p:cNvPr>
              <p:cNvSpPr txBox="1"/>
              <p:nvPr/>
            </p:nvSpPr>
            <p:spPr>
              <a:xfrm>
                <a:off x="5467632" y="2595613"/>
                <a:ext cx="1155031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dd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gNP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last </a:t>
                </a:r>
                <a:endParaRPr lang="en-US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13D9908-5AFF-4DF7-83C8-E767CA6F91BC}"/>
                  </a:ext>
                </a:extLst>
              </p:cNvPr>
              <p:cNvSpPr txBox="1"/>
              <p:nvPr/>
            </p:nvSpPr>
            <p:spPr>
              <a:xfrm>
                <a:off x="1169471" y="1964544"/>
                <a:ext cx="286204" cy="27491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1F6029A-38CF-44BB-912E-945478D026A5}"/>
                  </a:ext>
                </a:extLst>
              </p:cNvPr>
              <p:cNvSpPr txBox="1"/>
              <p:nvPr/>
            </p:nvSpPr>
            <p:spPr>
              <a:xfrm>
                <a:off x="4366823" y="1972944"/>
                <a:ext cx="286204" cy="27491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92315D26-EA1D-4EC7-B32F-4410D85E81E7}"/>
                  </a:ext>
                </a:extLst>
              </p:cNvPr>
              <p:cNvGrpSpPr/>
              <p:nvPr/>
            </p:nvGrpSpPr>
            <p:grpSpPr>
              <a:xfrm>
                <a:off x="1770831" y="2102821"/>
                <a:ext cx="1923500" cy="269803"/>
                <a:chOff x="1770831" y="2132557"/>
                <a:chExt cx="1923500" cy="269803"/>
              </a:xfrm>
            </p:grpSpPr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7B3B307D-4CA9-468F-9C29-EDBDB2A216D7}"/>
                    </a:ext>
                  </a:extLst>
                </p:cNvPr>
                <p:cNvGrpSpPr/>
                <p:nvPr/>
              </p:nvGrpSpPr>
              <p:grpSpPr>
                <a:xfrm>
                  <a:off x="1770831" y="2321975"/>
                  <a:ext cx="1923500" cy="80385"/>
                  <a:chOff x="1770831" y="3667069"/>
                  <a:chExt cx="1923500" cy="80385"/>
                </a:xfrm>
              </p:grpSpPr>
              <p:sp>
                <p:nvSpPr>
                  <p:cNvPr id="32" name="Left Brace 31">
                    <a:extLst>
                      <a:ext uri="{FF2B5EF4-FFF2-40B4-BE49-F238E27FC236}">
                        <a16:creationId xmlns:a16="http://schemas.microsoft.com/office/drawing/2014/main" id="{698B9A14-179C-49D6-AF48-46BE79E81467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3173603" y="3226727"/>
                    <a:ext cx="80385" cy="961070"/>
                  </a:xfrm>
                  <a:prstGeom prst="leftBrace">
                    <a:avLst>
                      <a:gd name="adj1" fmla="val 56158"/>
                      <a:gd name="adj2" fmla="val 50000"/>
                    </a:avLst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3" name="Left Brace 32">
                    <a:extLst>
                      <a:ext uri="{FF2B5EF4-FFF2-40B4-BE49-F238E27FC236}">
                        <a16:creationId xmlns:a16="http://schemas.microsoft.com/office/drawing/2014/main" id="{08E3BB71-DCC8-4239-ACBC-71AB8821A89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211173" y="3226727"/>
                    <a:ext cx="80385" cy="961070"/>
                  </a:xfrm>
                  <a:prstGeom prst="leftBrace">
                    <a:avLst>
                      <a:gd name="adj1" fmla="val 56158"/>
                      <a:gd name="adj2" fmla="val 50000"/>
                    </a:avLst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C6154195-CBC1-4F9C-9968-1C73BF781718}"/>
                    </a:ext>
                  </a:extLst>
                </p:cNvPr>
                <p:cNvSpPr txBox="1"/>
                <p:nvPr/>
              </p:nvSpPr>
              <p:spPr>
                <a:xfrm>
                  <a:off x="2051564" y="2135866"/>
                  <a:ext cx="441502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  <a:endParaRPr lang="en-US" dirty="0"/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F98EEBDF-9612-47D1-B450-4470826A3AE0}"/>
                    </a:ext>
                  </a:extLst>
                </p:cNvPr>
                <p:cNvSpPr txBox="1"/>
                <p:nvPr/>
              </p:nvSpPr>
              <p:spPr>
                <a:xfrm>
                  <a:off x="3025599" y="2132557"/>
                  <a:ext cx="441502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dirty="0"/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0C920B4A-5818-4DB8-ACE6-E6C39B908F31}"/>
                  </a:ext>
                </a:extLst>
              </p:cNvPr>
              <p:cNvGrpSpPr/>
              <p:nvPr/>
            </p:nvGrpSpPr>
            <p:grpSpPr>
              <a:xfrm>
                <a:off x="4954633" y="2101158"/>
                <a:ext cx="1923500" cy="269803"/>
                <a:chOff x="1770831" y="2132557"/>
                <a:chExt cx="1923500" cy="269803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DC4DA686-1B8F-4D2C-A427-A5F3C3886E3C}"/>
                    </a:ext>
                  </a:extLst>
                </p:cNvPr>
                <p:cNvGrpSpPr/>
                <p:nvPr/>
              </p:nvGrpSpPr>
              <p:grpSpPr>
                <a:xfrm>
                  <a:off x="1770831" y="2321975"/>
                  <a:ext cx="1923500" cy="80385"/>
                  <a:chOff x="1770831" y="3667069"/>
                  <a:chExt cx="1923500" cy="80385"/>
                </a:xfrm>
              </p:grpSpPr>
              <p:sp>
                <p:nvSpPr>
                  <p:cNvPr id="40" name="Left Brace 39">
                    <a:extLst>
                      <a:ext uri="{FF2B5EF4-FFF2-40B4-BE49-F238E27FC236}">
                        <a16:creationId xmlns:a16="http://schemas.microsoft.com/office/drawing/2014/main" id="{FE8244DB-A173-4DE7-A682-FEEF8678A45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3173603" y="3226727"/>
                    <a:ext cx="80385" cy="961070"/>
                  </a:xfrm>
                  <a:prstGeom prst="leftBrace">
                    <a:avLst>
                      <a:gd name="adj1" fmla="val 56158"/>
                      <a:gd name="adj2" fmla="val 50000"/>
                    </a:avLst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1" name="Left Brace 40">
                    <a:extLst>
                      <a:ext uri="{FF2B5EF4-FFF2-40B4-BE49-F238E27FC236}">
                        <a16:creationId xmlns:a16="http://schemas.microsoft.com/office/drawing/2014/main" id="{B8BC165B-A1E7-4E61-A442-12D2A69DA84E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211173" y="3226727"/>
                    <a:ext cx="80385" cy="961070"/>
                  </a:xfrm>
                  <a:prstGeom prst="leftBrace">
                    <a:avLst>
                      <a:gd name="adj1" fmla="val 56158"/>
                      <a:gd name="adj2" fmla="val 50000"/>
                    </a:avLst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246BD531-959B-4729-BCC9-68BAF4BB80AC}"/>
                    </a:ext>
                  </a:extLst>
                </p:cNvPr>
                <p:cNvSpPr txBox="1"/>
                <p:nvPr/>
              </p:nvSpPr>
              <p:spPr>
                <a:xfrm>
                  <a:off x="2051564" y="2135866"/>
                  <a:ext cx="441502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  <a:endParaRPr lang="en-US" dirty="0"/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1B74343C-6657-42BA-AB43-34068B8AC18E}"/>
                    </a:ext>
                  </a:extLst>
                </p:cNvPr>
                <p:cNvSpPr txBox="1"/>
                <p:nvPr/>
              </p:nvSpPr>
              <p:spPr>
                <a:xfrm>
                  <a:off x="3025599" y="2132557"/>
                  <a:ext cx="441502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dirty="0"/>
                </a:p>
              </p:txBody>
            </p: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5543F093-3D5F-4CC3-912A-BAFF3796C216}"/>
                  </a:ext>
                </a:extLst>
              </p:cNvPr>
              <p:cNvGrpSpPr/>
              <p:nvPr/>
            </p:nvGrpSpPr>
            <p:grpSpPr>
              <a:xfrm>
                <a:off x="1723170" y="3712780"/>
                <a:ext cx="2011458" cy="201370"/>
                <a:chOff x="1723170" y="3683350"/>
                <a:chExt cx="2011458" cy="201370"/>
              </a:xfrm>
            </p:grpSpPr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F7C8063D-9188-45DD-AA20-85DD9490C501}"/>
                    </a:ext>
                  </a:extLst>
                </p:cNvPr>
                <p:cNvGrpSpPr/>
                <p:nvPr/>
              </p:nvGrpSpPr>
              <p:grpSpPr>
                <a:xfrm>
                  <a:off x="1723170" y="3683350"/>
                  <a:ext cx="1050626" cy="200055"/>
                  <a:chOff x="1723170" y="3683350"/>
                  <a:chExt cx="1050626" cy="200055"/>
                </a:xfrm>
              </p:grpSpPr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C4557312-B3BD-418E-968C-28248BB77E39}"/>
                      </a:ext>
                    </a:extLst>
                  </p:cNvPr>
                  <p:cNvSpPr txBox="1"/>
                  <p:nvPr/>
                </p:nvSpPr>
                <p:spPr>
                  <a:xfrm>
                    <a:off x="172317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10E70DD1-224A-49D4-A95D-230F4C12D9AD}"/>
                      </a:ext>
                    </a:extLst>
                  </p:cNvPr>
                  <p:cNvSpPr txBox="1"/>
                  <p:nvPr/>
                </p:nvSpPr>
                <p:spPr>
                  <a:xfrm>
                    <a:off x="1861836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 </a:t>
                    </a: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478A1792-99FE-4D4C-9B93-2F6F8490E63E}"/>
                      </a:ext>
                    </a:extLst>
                  </p:cNvPr>
                  <p:cNvSpPr txBox="1"/>
                  <p:nvPr/>
                </p:nvSpPr>
                <p:spPr>
                  <a:xfrm>
                    <a:off x="2000502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452BA9D8-F485-493D-8BF8-C4A2CEC48FD5}"/>
                      </a:ext>
                    </a:extLst>
                  </p:cNvPr>
                  <p:cNvSpPr txBox="1"/>
                  <p:nvPr/>
                </p:nvSpPr>
                <p:spPr>
                  <a:xfrm>
                    <a:off x="214113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836AEF24-2265-48A4-B589-520626826D5D}"/>
                      </a:ext>
                    </a:extLst>
                  </p:cNvPr>
                  <p:cNvSpPr txBox="1"/>
                  <p:nvPr/>
                </p:nvSpPr>
                <p:spPr>
                  <a:xfrm>
                    <a:off x="227391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5556B48A-CB3A-47EA-A45A-DFDE799D627C}"/>
                      </a:ext>
                    </a:extLst>
                  </p:cNvPr>
                  <p:cNvSpPr txBox="1"/>
                  <p:nvPr/>
                </p:nvSpPr>
                <p:spPr>
                  <a:xfrm>
                    <a:off x="2410613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 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6D2E7EC1-8E9E-400B-8BC4-94F64CCF2D5D}"/>
                      </a:ext>
                    </a:extLst>
                  </p:cNvPr>
                  <p:cNvSpPr txBox="1"/>
                  <p:nvPr/>
                </p:nvSpPr>
                <p:spPr>
                  <a:xfrm>
                    <a:off x="2549279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 </a:t>
                    </a:r>
                  </a:p>
                </p:txBody>
              </p:sp>
            </p:grpSp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149DEBE9-C324-4AFB-AA98-958E4D22B4CC}"/>
                    </a:ext>
                  </a:extLst>
                </p:cNvPr>
                <p:cNvGrpSpPr/>
                <p:nvPr/>
              </p:nvGrpSpPr>
              <p:grpSpPr>
                <a:xfrm>
                  <a:off x="2684002" y="3684665"/>
                  <a:ext cx="1050626" cy="200055"/>
                  <a:chOff x="1723170" y="3683350"/>
                  <a:chExt cx="1050626" cy="200055"/>
                </a:xfrm>
              </p:grpSpPr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A9EBDF01-0E69-4F98-B407-191E3636C04D}"/>
                      </a:ext>
                    </a:extLst>
                  </p:cNvPr>
                  <p:cNvSpPr txBox="1"/>
                  <p:nvPr/>
                </p:nvSpPr>
                <p:spPr>
                  <a:xfrm>
                    <a:off x="172317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CC2FCD3E-B939-44E7-8615-B98816770719}"/>
                      </a:ext>
                    </a:extLst>
                  </p:cNvPr>
                  <p:cNvSpPr txBox="1"/>
                  <p:nvPr/>
                </p:nvSpPr>
                <p:spPr>
                  <a:xfrm>
                    <a:off x="1861836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 </a:t>
                    </a:r>
                  </a:p>
                </p:txBody>
              </p:sp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3412E8AA-030B-4A5E-AD74-46A2FBDF1257}"/>
                      </a:ext>
                    </a:extLst>
                  </p:cNvPr>
                  <p:cNvSpPr txBox="1"/>
                  <p:nvPr/>
                </p:nvSpPr>
                <p:spPr>
                  <a:xfrm>
                    <a:off x="2000502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13B6ABDA-602E-441F-AD3E-95FC3CDD9277}"/>
                      </a:ext>
                    </a:extLst>
                  </p:cNvPr>
                  <p:cNvSpPr txBox="1"/>
                  <p:nvPr/>
                </p:nvSpPr>
                <p:spPr>
                  <a:xfrm>
                    <a:off x="214113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A4CDA149-2EF3-4BC7-BAC2-B11937D93895}"/>
                      </a:ext>
                    </a:extLst>
                  </p:cNvPr>
                  <p:cNvSpPr txBox="1"/>
                  <p:nvPr/>
                </p:nvSpPr>
                <p:spPr>
                  <a:xfrm>
                    <a:off x="227391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F0DA8ADF-535B-4ABD-9772-28BD0361CC3C}"/>
                      </a:ext>
                    </a:extLst>
                  </p:cNvPr>
                  <p:cNvSpPr txBox="1"/>
                  <p:nvPr/>
                </p:nvSpPr>
                <p:spPr>
                  <a:xfrm>
                    <a:off x="2410613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 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E44AEEFF-7E1C-41C0-A081-9CD51490E9E8}"/>
                      </a:ext>
                    </a:extLst>
                  </p:cNvPr>
                  <p:cNvSpPr txBox="1"/>
                  <p:nvPr/>
                </p:nvSpPr>
                <p:spPr>
                  <a:xfrm>
                    <a:off x="2549279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 </a:t>
                    </a:r>
                  </a:p>
                </p:txBody>
              </p:sp>
            </p:grpSp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4CD9AF15-B2FE-444D-8B86-1433E3522DBC}"/>
                  </a:ext>
                </a:extLst>
              </p:cNvPr>
              <p:cNvGrpSpPr/>
              <p:nvPr/>
            </p:nvGrpSpPr>
            <p:grpSpPr>
              <a:xfrm>
                <a:off x="4903294" y="3712124"/>
                <a:ext cx="1908109" cy="201370"/>
                <a:chOff x="1723170" y="3683350"/>
                <a:chExt cx="1908109" cy="201370"/>
              </a:xfrm>
            </p:grpSpPr>
            <p:grpSp>
              <p:nvGrpSpPr>
                <p:cNvPr id="58" name="Group 57">
                  <a:extLst>
                    <a:ext uri="{FF2B5EF4-FFF2-40B4-BE49-F238E27FC236}">
                      <a16:creationId xmlns:a16="http://schemas.microsoft.com/office/drawing/2014/main" id="{B007B6D9-2FE0-4AA9-A080-23614CF56206}"/>
                    </a:ext>
                  </a:extLst>
                </p:cNvPr>
                <p:cNvGrpSpPr/>
                <p:nvPr/>
              </p:nvGrpSpPr>
              <p:grpSpPr>
                <a:xfrm>
                  <a:off x="1723170" y="3683350"/>
                  <a:ext cx="1062398" cy="200055"/>
                  <a:chOff x="1723170" y="3683350"/>
                  <a:chExt cx="1062398" cy="200055"/>
                </a:xfrm>
              </p:grpSpPr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348F307C-E7E4-411B-98E0-82AE182D9973}"/>
                      </a:ext>
                    </a:extLst>
                  </p:cNvPr>
                  <p:cNvSpPr txBox="1"/>
                  <p:nvPr/>
                </p:nvSpPr>
                <p:spPr>
                  <a:xfrm>
                    <a:off x="172317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1413AE06-80A4-445F-AD81-3A32C8FF2237}"/>
                      </a:ext>
                    </a:extLst>
                  </p:cNvPr>
                  <p:cNvSpPr txBox="1"/>
                  <p:nvPr/>
                </p:nvSpPr>
                <p:spPr>
                  <a:xfrm>
                    <a:off x="1861836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 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70154E59-523B-41D5-BAC3-32184B761BB3}"/>
                      </a:ext>
                    </a:extLst>
                  </p:cNvPr>
                  <p:cNvSpPr txBox="1"/>
                  <p:nvPr/>
                </p:nvSpPr>
                <p:spPr>
                  <a:xfrm>
                    <a:off x="2002464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6A2E4703-3914-4F0D-BBBF-61671A818230}"/>
                      </a:ext>
                    </a:extLst>
                  </p:cNvPr>
                  <p:cNvSpPr txBox="1"/>
                  <p:nvPr/>
                </p:nvSpPr>
                <p:spPr>
                  <a:xfrm>
                    <a:off x="214113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9369E946-8B68-4B3E-B54B-0F5DAFE9C406}"/>
                      </a:ext>
                    </a:extLst>
                  </p:cNvPr>
                  <p:cNvSpPr txBox="1"/>
                  <p:nvPr/>
                </p:nvSpPr>
                <p:spPr>
                  <a:xfrm>
                    <a:off x="2281758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0676563B-F292-4DB2-9A8F-214563515660}"/>
                      </a:ext>
                    </a:extLst>
                  </p:cNvPr>
                  <p:cNvSpPr txBox="1"/>
                  <p:nvPr/>
                </p:nvSpPr>
                <p:spPr>
                  <a:xfrm>
                    <a:off x="2424347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 </a:t>
                    </a: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127BC8A0-16B0-47B1-9984-F7332EBD5006}"/>
                      </a:ext>
                    </a:extLst>
                  </p:cNvPr>
                  <p:cNvSpPr txBox="1"/>
                  <p:nvPr/>
                </p:nvSpPr>
                <p:spPr>
                  <a:xfrm>
                    <a:off x="2561051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 </a:t>
                    </a:r>
                  </a:p>
                </p:txBody>
              </p:sp>
            </p:grpSp>
            <p:grpSp>
              <p:nvGrpSpPr>
                <p:cNvPr id="59" name="Group 58">
                  <a:extLst>
                    <a:ext uri="{FF2B5EF4-FFF2-40B4-BE49-F238E27FC236}">
                      <a16:creationId xmlns:a16="http://schemas.microsoft.com/office/drawing/2014/main" id="{CAF83485-C153-4604-836B-6D03A2037CDB}"/>
                    </a:ext>
                  </a:extLst>
                </p:cNvPr>
                <p:cNvGrpSpPr/>
                <p:nvPr/>
              </p:nvGrpSpPr>
              <p:grpSpPr>
                <a:xfrm>
                  <a:off x="2705584" y="3684665"/>
                  <a:ext cx="925695" cy="200055"/>
                  <a:chOff x="1744752" y="3683350"/>
                  <a:chExt cx="925695" cy="200055"/>
                </a:xfrm>
              </p:grpSpPr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9C6BA639-C41B-4F5C-9873-A679DFE173C3}"/>
                      </a:ext>
                    </a:extLst>
                  </p:cNvPr>
                  <p:cNvSpPr txBox="1"/>
                  <p:nvPr/>
                </p:nvSpPr>
                <p:spPr>
                  <a:xfrm>
                    <a:off x="1744752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1D124887-5982-4401-BA49-CE9545210B3F}"/>
                      </a:ext>
                    </a:extLst>
                  </p:cNvPr>
                  <p:cNvSpPr txBox="1"/>
                  <p:nvPr/>
                </p:nvSpPr>
                <p:spPr>
                  <a:xfrm>
                    <a:off x="1881456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 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80B47102-4B8E-49E6-BE26-D45143393740}"/>
                      </a:ext>
                    </a:extLst>
                  </p:cNvPr>
                  <p:cNvSpPr txBox="1"/>
                  <p:nvPr/>
                </p:nvSpPr>
                <p:spPr>
                  <a:xfrm>
                    <a:off x="2024046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C9931517-CD5F-4135-AA58-635FF3A8D75E}"/>
                      </a:ext>
                    </a:extLst>
                  </p:cNvPr>
                  <p:cNvSpPr txBox="1"/>
                  <p:nvPr/>
                </p:nvSpPr>
                <p:spPr>
                  <a:xfrm>
                    <a:off x="2166637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37EA28A8-63F3-4FBE-9693-7CD9EB486E71}"/>
                      </a:ext>
                    </a:extLst>
                  </p:cNvPr>
                  <p:cNvSpPr txBox="1"/>
                  <p:nvPr/>
                </p:nvSpPr>
                <p:spPr>
                  <a:xfrm>
                    <a:off x="2307269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FB0ED0F3-8D61-491B-8519-F612E39950FF}"/>
                      </a:ext>
                    </a:extLst>
                  </p:cNvPr>
                  <p:cNvSpPr txBox="1"/>
                  <p:nvPr/>
                </p:nvSpPr>
                <p:spPr>
                  <a:xfrm>
                    <a:off x="2445930" y="3683350"/>
                    <a:ext cx="22451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 </a:t>
                    </a:r>
                  </a:p>
                </p:txBody>
              </p:sp>
            </p:grpSp>
          </p:grp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5FA88718-3830-4457-88D5-64482DB38BBB}"/>
                  </a:ext>
                </a:extLst>
              </p:cNvPr>
              <p:cNvSpPr txBox="1"/>
              <p:nvPr/>
            </p:nvSpPr>
            <p:spPr>
              <a:xfrm>
                <a:off x="6733019" y="2742833"/>
                <a:ext cx="647076" cy="95410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[TS]</a:t>
                </a: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0 </a:t>
                </a:r>
                <a:r>
                  <a:rPr lang="en-US" sz="700" b="0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1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 3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. 1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3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. 10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. 300 </a:t>
                </a:r>
                <a:r>
                  <a:rPr lang="en-US" sz="700" b="0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1762BED8-7810-41E1-9D44-ABF4EDEF508B}"/>
                </a:ext>
              </a:extLst>
            </p:cNvPr>
            <p:cNvGrpSpPr/>
            <p:nvPr/>
          </p:nvGrpSpPr>
          <p:grpSpPr>
            <a:xfrm>
              <a:off x="1144281" y="3784919"/>
              <a:ext cx="3040931" cy="2065902"/>
              <a:chOff x="1588034" y="4564842"/>
              <a:chExt cx="3040931" cy="2065902"/>
            </a:xfrm>
          </p:grpSpPr>
          <p:graphicFrame>
            <p:nvGraphicFramePr>
              <p:cNvPr id="104" name="Object 103">
                <a:extLst>
                  <a:ext uri="{FF2B5EF4-FFF2-40B4-BE49-F238E27FC236}">
                    <a16:creationId xmlns:a16="http://schemas.microsoft.com/office/drawing/2014/main" id="{3A7CFFFB-267B-4FE6-B948-3D0DE70347A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56065148"/>
                  </p:ext>
                </p:extLst>
              </p:nvPr>
            </p:nvGraphicFramePr>
            <p:xfrm>
              <a:off x="1588034" y="4564842"/>
              <a:ext cx="2698750" cy="1990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6" imgW="2699159" imgH="1990310" progId="SigmaPlotGraphicObject.12">
                      <p:embed/>
                    </p:oleObj>
                  </mc:Choice>
                  <mc:Fallback>
                    <p:oleObj name="SPW 13.0 Graph" r:id="rId6" imgW="2699159" imgH="1990310" progId="SigmaPlotGraphicObject.12">
                      <p:embed/>
                      <p:pic>
                        <p:nvPicPr>
                          <p:cNvPr id="104" name="Object 103">
                            <a:extLst>
                              <a:ext uri="{FF2B5EF4-FFF2-40B4-BE49-F238E27FC236}">
                                <a16:creationId xmlns:a16="http://schemas.microsoft.com/office/drawing/2014/main" id="{3A7CFFFB-267B-4FE6-B948-3D0DE70347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1588034" y="4564842"/>
                            <a:ext cx="2698750" cy="19907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30F40B5E-D5B0-4A06-9468-E8682565E840}"/>
                  </a:ext>
                </a:extLst>
              </p:cNvPr>
              <p:cNvGrpSpPr/>
              <p:nvPr/>
            </p:nvGrpSpPr>
            <p:grpSpPr>
              <a:xfrm>
                <a:off x="2223231" y="5016490"/>
                <a:ext cx="1815085" cy="80385"/>
                <a:chOff x="1770831" y="3667069"/>
                <a:chExt cx="1923500" cy="80385"/>
              </a:xfrm>
            </p:grpSpPr>
            <p:sp>
              <p:nvSpPr>
                <p:cNvPr id="83" name="Left Brace 82">
                  <a:extLst>
                    <a:ext uri="{FF2B5EF4-FFF2-40B4-BE49-F238E27FC236}">
                      <a16:creationId xmlns:a16="http://schemas.microsoft.com/office/drawing/2014/main" id="{82BAC79D-F5F4-48D7-86AC-F35D1AF511FA}"/>
                    </a:ext>
                  </a:extLst>
                </p:cNvPr>
                <p:cNvSpPr/>
                <p:nvPr/>
              </p:nvSpPr>
              <p:spPr>
                <a:xfrm rot="5400000">
                  <a:off x="3173603" y="3226727"/>
                  <a:ext cx="80385" cy="961070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4" name="Left Brace 83">
                  <a:extLst>
                    <a:ext uri="{FF2B5EF4-FFF2-40B4-BE49-F238E27FC236}">
                      <a16:creationId xmlns:a16="http://schemas.microsoft.com/office/drawing/2014/main" id="{735BD38A-6B67-408C-AFBD-811BA33C027B}"/>
                    </a:ext>
                  </a:extLst>
                </p:cNvPr>
                <p:cNvSpPr/>
                <p:nvPr/>
              </p:nvSpPr>
              <p:spPr>
                <a:xfrm rot="5400000">
                  <a:off x="2211173" y="3226727"/>
                  <a:ext cx="80385" cy="961070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5045681C-B817-4D73-BD06-D4AD6D95CC9A}"/>
                  </a:ext>
                </a:extLst>
              </p:cNvPr>
              <p:cNvSpPr txBox="1"/>
              <p:nvPr/>
            </p:nvSpPr>
            <p:spPr>
              <a:xfrm>
                <a:off x="2407858" y="4838322"/>
                <a:ext cx="591140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SH t=0</a:t>
                </a:r>
                <a:endParaRPr lang="en-US" dirty="0"/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09A4B042-446E-4DB7-8800-F04766192D51}"/>
                  </a:ext>
                </a:extLst>
              </p:cNvPr>
              <p:cNvSpPr txBox="1"/>
              <p:nvPr/>
            </p:nvSpPr>
            <p:spPr>
              <a:xfrm>
                <a:off x="3261344" y="4837953"/>
                <a:ext cx="740258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SH t=10</a:t>
                </a:r>
                <a:endParaRPr lang="en-US" dirty="0"/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C3E8F469-980D-43E4-B4D4-C9D4B5E13CD9}"/>
                  </a:ext>
                </a:extLst>
              </p:cNvPr>
              <p:cNvSpPr txBox="1"/>
              <p:nvPr/>
            </p:nvSpPr>
            <p:spPr>
              <a:xfrm>
                <a:off x="3981889" y="5566781"/>
                <a:ext cx="647076" cy="8463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[GSH]</a:t>
                </a: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0 </a:t>
                </a:r>
                <a:r>
                  <a:rPr lang="en-US" sz="700" b="0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1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 3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. 10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</a:t>
                </a: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300 </a:t>
                </a:r>
                <a:r>
                  <a:rPr lang="en-US" sz="7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. 1 mM</a:t>
                </a:r>
                <a:endPara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FBB8CF3F-B4F7-4083-8A60-BEB5A5CAEB72}"/>
                  </a:ext>
                </a:extLst>
              </p:cNvPr>
              <p:cNvGrpSpPr/>
              <p:nvPr/>
            </p:nvGrpSpPr>
            <p:grpSpPr>
              <a:xfrm>
                <a:off x="2171385" y="6430689"/>
                <a:ext cx="991826" cy="200055"/>
                <a:chOff x="1723170" y="3683350"/>
                <a:chExt cx="974527" cy="200055"/>
              </a:xfrm>
            </p:grpSpPr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7C810152-9066-44E1-98DC-A7BE8C0DDC29}"/>
                    </a:ext>
                  </a:extLst>
                </p:cNvPr>
                <p:cNvSpPr txBox="1"/>
                <p:nvPr/>
              </p:nvSpPr>
              <p:spPr>
                <a:xfrm>
                  <a:off x="1723170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20579358-BE92-4A96-A98C-1E7DB2BCAD01}"/>
                    </a:ext>
                  </a:extLst>
                </p:cNvPr>
                <p:cNvSpPr txBox="1"/>
                <p:nvPr/>
              </p:nvSpPr>
              <p:spPr>
                <a:xfrm>
                  <a:off x="1873556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25E50715-EEB5-430A-8767-ED8D98DFD339}"/>
                    </a:ext>
                  </a:extLst>
                </p:cNvPr>
                <p:cNvSpPr txBox="1"/>
                <p:nvPr/>
              </p:nvSpPr>
              <p:spPr>
                <a:xfrm>
                  <a:off x="2021998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4B9F092C-7589-4F0A-A7D2-FE8BD77AF4A2}"/>
                    </a:ext>
                  </a:extLst>
                </p:cNvPr>
                <p:cNvSpPr txBox="1"/>
                <p:nvPr/>
              </p:nvSpPr>
              <p:spPr>
                <a:xfrm>
                  <a:off x="2172383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A52EED6F-2F40-4D07-B135-AA645E401B7B}"/>
                    </a:ext>
                  </a:extLst>
                </p:cNvPr>
                <p:cNvSpPr txBox="1"/>
                <p:nvPr/>
              </p:nvSpPr>
              <p:spPr>
                <a:xfrm>
                  <a:off x="2322776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</a:p>
              </p:txBody>
            </p:sp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id="{770AF549-2F33-4D51-99AF-58717A3692D0}"/>
                    </a:ext>
                  </a:extLst>
                </p:cNvPr>
                <p:cNvSpPr txBox="1"/>
                <p:nvPr/>
              </p:nvSpPr>
              <p:spPr>
                <a:xfrm>
                  <a:off x="2473180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 </a:t>
                  </a:r>
                </a:p>
              </p:txBody>
            </p:sp>
          </p:grpSp>
          <p:grpSp>
            <p:nvGrpSpPr>
              <p:cNvPr id="105" name="Group 104">
                <a:extLst>
                  <a:ext uri="{FF2B5EF4-FFF2-40B4-BE49-F238E27FC236}">
                    <a16:creationId xmlns:a16="http://schemas.microsoft.com/office/drawing/2014/main" id="{FD1A2D0D-B85E-4A8E-8F5B-347BC75B1D69}"/>
                  </a:ext>
                </a:extLst>
              </p:cNvPr>
              <p:cNvGrpSpPr/>
              <p:nvPr/>
            </p:nvGrpSpPr>
            <p:grpSpPr>
              <a:xfrm>
                <a:off x="3083129" y="6430025"/>
                <a:ext cx="991826" cy="200055"/>
                <a:chOff x="1723170" y="3683350"/>
                <a:chExt cx="974527" cy="200055"/>
              </a:xfrm>
            </p:grpSpPr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94AB46AB-A58E-4673-94B5-521FC79A459C}"/>
                    </a:ext>
                  </a:extLst>
                </p:cNvPr>
                <p:cNvSpPr txBox="1"/>
                <p:nvPr/>
              </p:nvSpPr>
              <p:spPr>
                <a:xfrm>
                  <a:off x="1723170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58F0BB89-5ED3-458B-810B-D9FE64E93E85}"/>
                    </a:ext>
                  </a:extLst>
                </p:cNvPr>
                <p:cNvSpPr txBox="1"/>
                <p:nvPr/>
              </p:nvSpPr>
              <p:spPr>
                <a:xfrm>
                  <a:off x="1873556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74BC5CE6-A926-4E5A-9BBA-AF1DB00BABAB}"/>
                    </a:ext>
                  </a:extLst>
                </p:cNvPr>
                <p:cNvSpPr txBox="1"/>
                <p:nvPr/>
              </p:nvSpPr>
              <p:spPr>
                <a:xfrm>
                  <a:off x="2021998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C1B7FA3A-B402-4571-9862-20B8B9534531}"/>
                    </a:ext>
                  </a:extLst>
                </p:cNvPr>
                <p:cNvSpPr txBox="1"/>
                <p:nvPr/>
              </p:nvSpPr>
              <p:spPr>
                <a:xfrm>
                  <a:off x="2172383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EBC3D21B-E99B-4490-ACE7-C765DF6F3B8B}"/>
                    </a:ext>
                  </a:extLst>
                </p:cNvPr>
                <p:cNvSpPr txBox="1"/>
                <p:nvPr/>
              </p:nvSpPr>
              <p:spPr>
                <a:xfrm>
                  <a:off x="2322776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560D15C2-7E8F-494C-8EE5-C0E0783D3DAB}"/>
                    </a:ext>
                  </a:extLst>
                </p:cNvPr>
                <p:cNvSpPr txBox="1"/>
                <p:nvPr/>
              </p:nvSpPr>
              <p:spPr>
                <a:xfrm>
                  <a:off x="2473180" y="3683350"/>
                  <a:ext cx="224517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 </a:t>
                  </a:r>
                </a:p>
              </p:txBody>
            </p:sp>
          </p:grpSp>
        </p:grp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C2F9A95-C2E5-4EA1-88B3-511529CE597C}"/>
                </a:ext>
              </a:extLst>
            </p:cNvPr>
            <p:cNvSpPr txBox="1"/>
            <p:nvPr/>
          </p:nvSpPr>
          <p:spPr>
            <a:xfrm>
              <a:off x="1173949" y="3932308"/>
              <a:ext cx="28620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9C73ABD-C809-41A9-B059-7C99E7595BEF}"/>
                </a:ext>
              </a:extLst>
            </p:cNvPr>
            <p:cNvSpPr txBox="1"/>
            <p:nvPr/>
          </p:nvSpPr>
          <p:spPr>
            <a:xfrm>
              <a:off x="4358660" y="3930064"/>
              <a:ext cx="28620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4E2E2A97-4DE2-6B50-43F0-7C5542844867}"/>
              </a:ext>
            </a:extLst>
          </p:cNvPr>
          <p:cNvGrpSpPr/>
          <p:nvPr/>
        </p:nvGrpSpPr>
        <p:grpSpPr>
          <a:xfrm>
            <a:off x="2856410" y="609029"/>
            <a:ext cx="5874168" cy="2142641"/>
            <a:chOff x="2824508" y="2427192"/>
            <a:chExt cx="5874168" cy="2142641"/>
          </a:xfrm>
        </p:grpSpPr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C692DC01-9467-058E-8784-AFBD3D750BCA}"/>
                </a:ext>
              </a:extLst>
            </p:cNvPr>
            <p:cNvGrpSpPr/>
            <p:nvPr/>
          </p:nvGrpSpPr>
          <p:grpSpPr>
            <a:xfrm>
              <a:off x="2824508" y="2427192"/>
              <a:ext cx="5874168" cy="2142641"/>
              <a:chOff x="2799672" y="1024490"/>
              <a:chExt cx="5874168" cy="2142641"/>
            </a:xfrm>
          </p:grpSpPr>
          <p:graphicFrame>
            <p:nvGraphicFramePr>
              <p:cNvPr id="121" name="Object 120">
                <a:extLst>
                  <a:ext uri="{FF2B5EF4-FFF2-40B4-BE49-F238E27FC236}">
                    <a16:creationId xmlns:a16="http://schemas.microsoft.com/office/drawing/2014/main" id="{3AE39EC4-393B-5828-6C6E-04A15FA7E02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76513466"/>
                  </p:ext>
                </p:extLst>
              </p:nvPr>
            </p:nvGraphicFramePr>
            <p:xfrm>
              <a:off x="2799672" y="1024490"/>
              <a:ext cx="5440363" cy="1990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8" imgW="5440525" imgH="1990310" progId="SigmaPlotGraphicObject.12">
                      <p:embed/>
                    </p:oleObj>
                  </mc:Choice>
                  <mc:Fallback>
                    <p:oleObj name="SPW 13.0 Graph" r:id="rId8" imgW="5440525" imgH="1990310" progId="SigmaPlotGraphicObject.12">
                      <p:embed/>
                      <p:pic>
                        <p:nvPicPr>
                          <p:cNvPr id="121" name="Object 120">
                            <a:extLst>
                              <a:ext uri="{FF2B5EF4-FFF2-40B4-BE49-F238E27FC236}">
                                <a16:creationId xmlns:a16="http://schemas.microsoft.com/office/drawing/2014/main" id="{3AE39EC4-393B-5828-6C6E-04A15FA7E02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2799672" y="1024490"/>
                            <a:ext cx="5440363" cy="19907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22" name="Group 121">
                <a:extLst>
                  <a:ext uri="{FF2B5EF4-FFF2-40B4-BE49-F238E27FC236}">
                    <a16:creationId xmlns:a16="http://schemas.microsoft.com/office/drawing/2014/main" id="{78F48007-4932-354A-961D-4F47A90A39F0}"/>
                  </a:ext>
                </a:extLst>
              </p:cNvPr>
              <p:cNvGrpSpPr/>
              <p:nvPr/>
            </p:nvGrpSpPr>
            <p:grpSpPr>
              <a:xfrm>
                <a:off x="3396389" y="2897982"/>
                <a:ext cx="4661247" cy="269149"/>
                <a:chOff x="3396389" y="2871478"/>
                <a:chExt cx="4661247" cy="269149"/>
              </a:xfrm>
            </p:grpSpPr>
            <p:grpSp>
              <p:nvGrpSpPr>
                <p:cNvPr id="138" name="Group 137">
                  <a:extLst>
                    <a:ext uri="{FF2B5EF4-FFF2-40B4-BE49-F238E27FC236}">
                      <a16:creationId xmlns:a16="http://schemas.microsoft.com/office/drawing/2014/main" id="{C61255BC-604F-63A3-5C6D-BA2D8F5A07B6}"/>
                    </a:ext>
                  </a:extLst>
                </p:cNvPr>
                <p:cNvGrpSpPr/>
                <p:nvPr/>
              </p:nvGrpSpPr>
              <p:grpSpPr>
                <a:xfrm>
                  <a:off x="3396389" y="2894406"/>
                  <a:ext cx="853942" cy="246221"/>
                  <a:chOff x="3396389" y="2853951"/>
                  <a:chExt cx="853942" cy="246221"/>
                </a:xfrm>
              </p:grpSpPr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21AE5C69-6EBD-8817-B462-D4E149323612}"/>
                      </a:ext>
                    </a:extLst>
                  </p:cNvPr>
                  <p:cNvSpPr txBox="1"/>
                  <p:nvPr/>
                </p:nvSpPr>
                <p:spPr>
                  <a:xfrm>
                    <a:off x="3396389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7E7A1805-5CEB-F23F-C358-9A00EC891162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843C80E7-B28D-7964-61CC-B24772A7873B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67" name="TextBox 166">
                    <a:extLst>
                      <a:ext uri="{FF2B5EF4-FFF2-40B4-BE49-F238E27FC236}">
                        <a16:creationId xmlns:a16="http://schemas.microsoft.com/office/drawing/2014/main" id="{BB3F63A6-EB19-8093-BB14-066CB42BD68E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139" name="Group 138">
                  <a:extLst>
                    <a:ext uri="{FF2B5EF4-FFF2-40B4-BE49-F238E27FC236}">
                      <a16:creationId xmlns:a16="http://schemas.microsoft.com/office/drawing/2014/main" id="{5885FD56-73CB-DEB3-1984-B629CD15D9CE}"/>
                    </a:ext>
                  </a:extLst>
                </p:cNvPr>
                <p:cNvGrpSpPr/>
                <p:nvPr/>
              </p:nvGrpSpPr>
              <p:grpSpPr>
                <a:xfrm>
                  <a:off x="4161087" y="2871478"/>
                  <a:ext cx="853942" cy="246221"/>
                  <a:chOff x="3396389" y="2853951"/>
                  <a:chExt cx="853942" cy="246221"/>
                </a:xfrm>
              </p:grpSpPr>
              <p:sp>
                <p:nvSpPr>
                  <p:cNvPr id="160" name="TextBox 159">
                    <a:extLst>
                      <a:ext uri="{FF2B5EF4-FFF2-40B4-BE49-F238E27FC236}">
                        <a16:creationId xmlns:a16="http://schemas.microsoft.com/office/drawing/2014/main" id="{568307E9-B9B7-057D-7FB4-9445944221D5}"/>
                      </a:ext>
                    </a:extLst>
                  </p:cNvPr>
                  <p:cNvSpPr txBox="1"/>
                  <p:nvPr/>
                </p:nvSpPr>
                <p:spPr>
                  <a:xfrm>
                    <a:off x="3396389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61" name="TextBox 160">
                    <a:extLst>
                      <a:ext uri="{FF2B5EF4-FFF2-40B4-BE49-F238E27FC236}">
                        <a16:creationId xmlns:a16="http://schemas.microsoft.com/office/drawing/2014/main" id="{74DA3FAC-5820-3507-38DE-4B7586AF0893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E7D7A947-FB01-E377-BC3A-A97EC3ECDDD0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C83FF2D8-FDF2-0E3C-1360-692A283359E5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140" name="Group 139">
                  <a:extLst>
                    <a:ext uri="{FF2B5EF4-FFF2-40B4-BE49-F238E27FC236}">
                      <a16:creationId xmlns:a16="http://schemas.microsoft.com/office/drawing/2014/main" id="{05F6FDE2-220B-69E6-72B4-E5499B46C720}"/>
                    </a:ext>
                  </a:extLst>
                </p:cNvPr>
                <p:cNvGrpSpPr/>
                <p:nvPr/>
              </p:nvGrpSpPr>
              <p:grpSpPr>
                <a:xfrm>
                  <a:off x="4917693" y="2875524"/>
                  <a:ext cx="856639" cy="246221"/>
                  <a:chOff x="3393692" y="2853951"/>
                  <a:chExt cx="856639" cy="246221"/>
                </a:xfrm>
              </p:grpSpPr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0DAA77E6-AB28-6470-7162-5AEB09E44A6E}"/>
                      </a:ext>
                    </a:extLst>
                  </p:cNvPr>
                  <p:cNvSpPr txBox="1"/>
                  <p:nvPr/>
                </p:nvSpPr>
                <p:spPr>
                  <a:xfrm>
                    <a:off x="3393692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A6A8DC32-839C-41CD-5093-DEB8147B912A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E0342BAB-F6E2-4719-F88C-5B7195B21D51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59" name="TextBox 158">
                    <a:extLst>
                      <a:ext uri="{FF2B5EF4-FFF2-40B4-BE49-F238E27FC236}">
                        <a16:creationId xmlns:a16="http://schemas.microsoft.com/office/drawing/2014/main" id="{638222D7-F08D-4770-AF5D-82EF51260B8D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141" name="Group 140">
                  <a:extLst>
                    <a:ext uri="{FF2B5EF4-FFF2-40B4-BE49-F238E27FC236}">
                      <a16:creationId xmlns:a16="http://schemas.microsoft.com/office/drawing/2014/main" id="{412467C6-E6D8-20EF-3F9C-47FF0BDBF199}"/>
                    </a:ext>
                  </a:extLst>
                </p:cNvPr>
                <p:cNvGrpSpPr/>
                <p:nvPr/>
              </p:nvGrpSpPr>
              <p:grpSpPr>
                <a:xfrm>
                  <a:off x="5679693" y="2882267"/>
                  <a:ext cx="856639" cy="246221"/>
                  <a:chOff x="3393692" y="2853951"/>
                  <a:chExt cx="856639" cy="246221"/>
                </a:xfrm>
              </p:grpSpPr>
              <p:sp>
                <p:nvSpPr>
                  <p:cNvPr id="152" name="TextBox 151">
                    <a:extLst>
                      <a:ext uri="{FF2B5EF4-FFF2-40B4-BE49-F238E27FC236}">
                        <a16:creationId xmlns:a16="http://schemas.microsoft.com/office/drawing/2014/main" id="{D4E0B43A-A816-40DA-802A-198DEEB09B47}"/>
                      </a:ext>
                    </a:extLst>
                  </p:cNvPr>
                  <p:cNvSpPr txBox="1"/>
                  <p:nvPr/>
                </p:nvSpPr>
                <p:spPr>
                  <a:xfrm>
                    <a:off x="3393692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53" name="TextBox 152">
                    <a:extLst>
                      <a:ext uri="{FF2B5EF4-FFF2-40B4-BE49-F238E27FC236}">
                        <a16:creationId xmlns:a16="http://schemas.microsoft.com/office/drawing/2014/main" id="{6CF4BCED-1F33-DD63-7680-861A3B1377D8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54" name="TextBox 153">
                    <a:extLst>
                      <a:ext uri="{FF2B5EF4-FFF2-40B4-BE49-F238E27FC236}">
                        <a16:creationId xmlns:a16="http://schemas.microsoft.com/office/drawing/2014/main" id="{C34EFF10-4AD6-9521-99B8-E8481284EA12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9AE50276-DAE2-336F-92C9-122F567C5346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142" name="Group 141">
                  <a:extLst>
                    <a:ext uri="{FF2B5EF4-FFF2-40B4-BE49-F238E27FC236}">
                      <a16:creationId xmlns:a16="http://schemas.microsoft.com/office/drawing/2014/main" id="{7849D758-CD93-1F03-20B5-DFACD2A8CCC4}"/>
                    </a:ext>
                  </a:extLst>
                </p:cNvPr>
                <p:cNvGrpSpPr/>
                <p:nvPr/>
              </p:nvGrpSpPr>
              <p:grpSpPr>
                <a:xfrm>
                  <a:off x="6441693" y="2883615"/>
                  <a:ext cx="856639" cy="246221"/>
                  <a:chOff x="3393692" y="2853951"/>
                  <a:chExt cx="856639" cy="246221"/>
                </a:xfrm>
              </p:grpSpPr>
              <p:sp>
                <p:nvSpPr>
                  <p:cNvPr id="148" name="TextBox 147">
                    <a:extLst>
                      <a:ext uri="{FF2B5EF4-FFF2-40B4-BE49-F238E27FC236}">
                        <a16:creationId xmlns:a16="http://schemas.microsoft.com/office/drawing/2014/main" id="{997C559F-9B4B-34F9-2159-E4F45F435C68}"/>
                      </a:ext>
                    </a:extLst>
                  </p:cNvPr>
                  <p:cNvSpPr txBox="1"/>
                  <p:nvPr/>
                </p:nvSpPr>
                <p:spPr>
                  <a:xfrm>
                    <a:off x="3393692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49" name="TextBox 148">
                    <a:extLst>
                      <a:ext uri="{FF2B5EF4-FFF2-40B4-BE49-F238E27FC236}">
                        <a16:creationId xmlns:a16="http://schemas.microsoft.com/office/drawing/2014/main" id="{30153AAA-30AB-3921-3569-D9822A58755E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50" name="TextBox 149">
                    <a:extLst>
                      <a:ext uri="{FF2B5EF4-FFF2-40B4-BE49-F238E27FC236}">
                        <a16:creationId xmlns:a16="http://schemas.microsoft.com/office/drawing/2014/main" id="{814B345B-E11E-3156-BB02-6743B8BF7E0E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51" name="TextBox 150">
                    <a:extLst>
                      <a:ext uri="{FF2B5EF4-FFF2-40B4-BE49-F238E27FC236}">
                        <a16:creationId xmlns:a16="http://schemas.microsoft.com/office/drawing/2014/main" id="{DE3AAC42-CAD8-6656-1642-5BC4C6AF3B19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931119A1-55EB-2D43-CA9B-E62069BC25A8}"/>
                    </a:ext>
                  </a:extLst>
                </p:cNvPr>
                <p:cNvGrpSpPr/>
                <p:nvPr/>
              </p:nvGrpSpPr>
              <p:grpSpPr>
                <a:xfrm>
                  <a:off x="7200997" y="2879569"/>
                  <a:ext cx="856639" cy="246221"/>
                  <a:chOff x="3393692" y="2853951"/>
                  <a:chExt cx="856639" cy="246221"/>
                </a:xfrm>
              </p:grpSpPr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6F820E2F-B9F9-A1EE-3385-B7C697F94B8F}"/>
                      </a:ext>
                    </a:extLst>
                  </p:cNvPr>
                  <p:cNvSpPr txBox="1"/>
                  <p:nvPr/>
                </p:nvSpPr>
                <p:spPr>
                  <a:xfrm>
                    <a:off x="3393692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1</a:t>
                    </a:r>
                    <a:endParaRPr lang="en-US" sz="1000" dirty="0"/>
                  </a:p>
                </p:txBody>
              </p:sp>
              <p:sp>
                <p:nvSpPr>
                  <p:cNvPr id="145" name="TextBox 144">
                    <a:extLst>
                      <a:ext uri="{FF2B5EF4-FFF2-40B4-BE49-F238E27FC236}">
                        <a16:creationId xmlns:a16="http://schemas.microsoft.com/office/drawing/2014/main" id="{42A93B8C-549E-62BB-4890-BCDA2521E7B7}"/>
                      </a:ext>
                    </a:extLst>
                  </p:cNvPr>
                  <p:cNvSpPr txBox="1"/>
                  <p:nvPr/>
                </p:nvSpPr>
                <p:spPr>
                  <a:xfrm>
                    <a:off x="3583850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2</a:t>
                    </a:r>
                    <a:endParaRPr lang="en-US" sz="1000" dirty="0"/>
                  </a:p>
                </p:txBody>
              </p:sp>
              <p:sp>
                <p:nvSpPr>
                  <p:cNvPr id="146" name="TextBox 145">
                    <a:extLst>
                      <a:ext uri="{FF2B5EF4-FFF2-40B4-BE49-F238E27FC236}">
                        <a16:creationId xmlns:a16="http://schemas.microsoft.com/office/drawing/2014/main" id="{610D4DA6-872A-9397-7D6A-B91F539B07BB}"/>
                      </a:ext>
                    </a:extLst>
                  </p:cNvPr>
                  <p:cNvSpPr txBox="1"/>
                  <p:nvPr/>
                </p:nvSpPr>
                <p:spPr>
                  <a:xfrm>
                    <a:off x="3771311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3</a:t>
                    </a:r>
                    <a:endParaRPr lang="en-US" sz="1000" dirty="0"/>
                  </a:p>
                </p:txBody>
              </p:sp>
              <p:sp>
                <p:nvSpPr>
                  <p:cNvPr id="147" name="TextBox 146">
                    <a:extLst>
                      <a:ext uri="{FF2B5EF4-FFF2-40B4-BE49-F238E27FC236}">
                        <a16:creationId xmlns:a16="http://schemas.microsoft.com/office/drawing/2014/main" id="{E58E22E2-681E-C25E-8364-AED994864E5E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868" y="2853951"/>
                    <a:ext cx="283463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0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4</a:t>
                    </a:r>
                    <a:endParaRPr lang="en-US" sz="1000" dirty="0"/>
                  </a:p>
                </p:txBody>
              </p:sp>
            </p:grpSp>
          </p:grp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C6407FFB-1FC7-D79B-F98F-CD81D3210123}"/>
                  </a:ext>
                </a:extLst>
              </p:cNvPr>
              <p:cNvSpPr txBox="1"/>
              <p:nvPr/>
            </p:nvSpPr>
            <p:spPr>
              <a:xfrm>
                <a:off x="7924091" y="2322100"/>
                <a:ext cx="749749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1.  H</a:t>
                </a:r>
                <a:r>
                  <a:rPr lang="en-US" sz="700" b="0" i="0" u="none" strike="noStrike" baseline="-2500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2</a:t>
                </a:r>
                <a:r>
                  <a:rPr lang="en-US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S</a:t>
                </a:r>
              </a:p>
              <a:p>
                <a:r>
                  <a:rPr lang="pt-BR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2. </a:t>
                </a:r>
                <a:r>
                  <a: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+SOD</a:t>
                </a:r>
                <a:endParaRPr lang="pt-BR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endParaRPr>
              </a:p>
              <a:p>
                <a:r>
                  <a:rPr lang="pt-BR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3. +Cat</a:t>
                </a:r>
              </a:p>
              <a:p>
                <a:r>
                  <a:rPr lang="pt-BR" sz="70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4. +SOD+</a:t>
                </a:r>
                <a:r>
                  <a:rPr lang="pt-BR" sz="700" b="0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at</a:t>
                </a:r>
              </a:p>
            </p:txBody>
          </p:sp>
          <p:grpSp>
            <p:nvGrpSpPr>
              <p:cNvPr id="124" name="Group 123">
                <a:extLst>
                  <a:ext uri="{FF2B5EF4-FFF2-40B4-BE49-F238E27FC236}">
                    <a16:creationId xmlns:a16="http://schemas.microsoft.com/office/drawing/2014/main" id="{CDBA837F-C781-5F7F-DAF1-AB6F291FB883}"/>
                  </a:ext>
                </a:extLst>
              </p:cNvPr>
              <p:cNvGrpSpPr/>
              <p:nvPr/>
            </p:nvGrpSpPr>
            <p:grpSpPr>
              <a:xfrm>
                <a:off x="3433386" y="1276696"/>
                <a:ext cx="4548556" cy="80385"/>
                <a:chOff x="3433386" y="2492120"/>
                <a:chExt cx="4548556" cy="80385"/>
              </a:xfrm>
            </p:grpSpPr>
            <p:sp>
              <p:nvSpPr>
                <p:cNvPr id="132" name="Left Brace 131">
                  <a:extLst>
                    <a:ext uri="{FF2B5EF4-FFF2-40B4-BE49-F238E27FC236}">
                      <a16:creationId xmlns:a16="http://schemas.microsoft.com/office/drawing/2014/main" id="{9AB8A5D2-D032-AEBC-3A29-1D534B1FE05F}"/>
                    </a:ext>
                  </a:extLst>
                </p:cNvPr>
                <p:cNvSpPr/>
                <p:nvPr/>
              </p:nvSpPr>
              <p:spPr>
                <a:xfrm rot="5400000">
                  <a:off x="3768757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3" name="Left Brace 132">
                  <a:extLst>
                    <a:ext uri="{FF2B5EF4-FFF2-40B4-BE49-F238E27FC236}">
                      <a16:creationId xmlns:a16="http://schemas.microsoft.com/office/drawing/2014/main" id="{0085D0F5-DF20-EF42-DD2E-545A37D81AE0}"/>
                    </a:ext>
                  </a:extLst>
                </p:cNvPr>
                <p:cNvSpPr/>
                <p:nvPr/>
              </p:nvSpPr>
              <p:spPr>
                <a:xfrm rot="5400000">
                  <a:off x="4528243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4" name="Left Brace 133">
                  <a:extLst>
                    <a:ext uri="{FF2B5EF4-FFF2-40B4-BE49-F238E27FC236}">
                      <a16:creationId xmlns:a16="http://schemas.microsoft.com/office/drawing/2014/main" id="{85DEBE6B-E1C5-0611-8238-EBCF78F61339}"/>
                    </a:ext>
                  </a:extLst>
                </p:cNvPr>
                <p:cNvSpPr/>
                <p:nvPr/>
              </p:nvSpPr>
              <p:spPr>
                <a:xfrm rot="5400000">
                  <a:off x="5287729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5" name="Left Brace 134">
                  <a:extLst>
                    <a:ext uri="{FF2B5EF4-FFF2-40B4-BE49-F238E27FC236}">
                      <a16:creationId xmlns:a16="http://schemas.microsoft.com/office/drawing/2014/main" id="{FFCF946A-07A0-EAA3-430F-F79015F7597C}"/>
                    </a:ext>
                  </a:extLst>
                </p:cNvPr>
                <p:cNvSpPr/>
                <p:nvPr/>
              </p:nvSpPr>
              <p:spPr>
                <a:xfrm rot="5400000">
                  <a:off x="6047215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6" name="Left Brace 135">
                  <a:extLst>
                    <a:ext uri="{FF2B5EF4-FFF2-40B4-BE49-F238E27FC236}">
                      <a16:creationId xmlns:a16="http://schemas.microsoft.com/office/drawing/2014/main" id="{A1A23417-55C9-58FC-528E-5717BD214D4F}"/>
                    </a:ext>
                  </a:extLst>
                </p:cNvPr>
                <p:cNvSpPr/>
                <p:nvPr/>
              </p:nvSpPr>
              <p:spPr>
                <a:xfrm rot="5400000">
                  <a:off x="6806701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7" name="Left Brace 136">
                  <a:extLst>
                    <a:ext uri="{FF2B5EF4-FFF2-40B4-BE49-F238E27FC236}">
                      <a16:creationId xmlns:a16="http://schemas.microsoft.com/office/drawing/2014/main" id="{8DA4792D-D3EE-1FA5-65E3-B27D25B72D0F}"/>
                    </a:ext>
                  </a:extLst>
                </p:cNvPr>
                <p:cNvSpPr/>
                <p:nvPr/>
              </p:nvSpPr>
              <p:spPr>
                <a:xfrm rot="5400000">
                  <a:off x="7566185" y="2156749"/>
                  <a:ext cx="80385" cy="751128"/>
                </a:xfrm>
                <a:prstGeom prst="leftBrace">
                  <a:avLst>
                    <a:gd name="adj1" fmla="val 56158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25" name="Group 124">
                <a:extLst>
                  <a:ext uri="{FF2B5EF4-FFF2-40B4-BE49-F238E27FC236}">
                    <a16:creationId xmlns:a16="http://schemas.microsoft.com/office/drawing/2014/main" id="{C29BA88E-F6B2-8FAD-862E-815241CEE5B5}"/>
                  </a:ext>
                </a:extLst>
              </p:cNvPr>
              <p:cNvGrpSpPr/>
              <p:nvPr/>
            </p:nvGrpSpPr>
            <p:grpSpPr>
              <a:xfrm>
                <a:off x="3550883" y="1112986"/>
                <a:ext cx="4494923" cy="200055"/>
                <a:chOff x="3550883" y="1112986"/>
                <a:chExt cx="4494923" cy="200055"/>
              </a:xfrm>
            </p:grpSpPr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F1F4E6E2-2A21-D3FA-3548-ED57FE29E313}"/>
                    </a:ext>
                  </a:extLst>
                </p:cNvPr>
                <p:cNvSpPr txBox="1"/>
                <p:nvPr/>
              </p:nvSpPr>
              <p:spPr>
                <a:xfrm>
                  <a:off x="4287695" y="1112986"/>
                  <a:ext cx="73775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</a:t>
                  </a:r>
                  <a:r>
                    <a:rPr lang="en-US" sz="700" b="0" i="0" u="none" strike="noStrike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a</a:t>
                  </a:r>
                  <a:endParaRPr lang="en-US" sz="700" dirty="0"/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D303A0E4-B906-B275-ABA2-26BD7AADA521}"/>
                    </a:ext>
                  </a:extLst>
                </p:cNvPr>
                <p:cNvSpPr txBox="1"/>
                <p:nvPr/>
              </p:nvSpPr>
              <p:spPr>
                <a:xfrm>
                  <a:off x="5059989" y="1112986"/>
                  <a:ext cx="604478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GSH</a:t>
                  </a:r>
                  <a:endParaRPr lang="en-US" sz="700" dirty="0"/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6449FCAE-BC80-272F-39F2-46E55A14BBE5}"/>
                    </a:ext>
                  </a:extLst>
                </p:cNvPr>
                <p:cNvSpPr txBox="1"/>
                <p:nvPr/>
              </p:nvSpPr>
              <p:spPr>
                <a:xfrm>
                  <a:off x="3550883" y="1112986"/>
                  <a:ext cx="591700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 </a:t>
                  </a:r>
                  <a:r>
                    <a:rPr lang="en-US" sz="700" b="0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only</a:t>
                  </a:r>
                  <a:r>
                    <a:rPr lang="en-US" sz="700" b="0" i="0" u="none" strike="noStrike" baseline="30000" dirty="0" err="1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a</a:t>
                  </a:r>
                  <a:endParaRPr lang="en-US" sz="700" baseline="30000" dirty="0"/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028D3617-E70D-7C6F-A827-BE79BD445E0B}"/>
                    </a:ext>
                  </a:extLst>
                </p:cNvPr>
                <p:cNvSpPr txBox="1"/>
                <p:nvPr/>
              </p:nvSpPr>
              <p:spPr>
                <a:xfrm>
                  <a:off x="5725665" y="1112986"/>
                  <a:ext cx="80643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+GSH</a:t>
                  </a:r>
                  <a:endParaRPr lang="en-US" sz="700" dirty="0"/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7C253976-7155-F669-9FFD-59D238C4AF45}"/>
                    </a:ext>
                  </a:extLst>
                </p:cNvPr>
                <p:cNvSpPr txBox="1"/>
                <p:nvPr/>
              </p:nvSpPr>
              <p:spPr>
                <a:xfrm>
                  <a:off x="6581187" y="1112986"/>
                  <a:ext cx="572794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Cys</a:t>
                  </a:r>
                  <a:endParaRPr lang="en-US" sz="700" dirty="0"/>
                </a:p>
              </p:txBody>
            </p:sp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FE8CDAC9-9368-268D-6BB4-149A39750109}"/>
                    </a:ext>
                  </a:extLst>
                </p:cNvPr>
                <p:cNvSpPr txBox="1"/>
                <p:nvPr/>
              </p:nvSpPr>
              <p:spPr>
                <a:xfrm>
                  <a:off x="7239371" y="1112986"/>
                  <a:ext cx="80643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H</a:t>
                  </a:r>
                  <a:r>
                    <a:rPr lang="en-US" sz="700" b="0" i="0" u="none" strike="noStrike" baseline="-2500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2</a:t>
                  </a:r>
                  <a:r>
                    <a:rPr lang="en-US" sz="700" b="0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</a:rPr>
                    <a:t>S+NQ+Cys</a:t>
                  </a:r>
                  <a:endParaRPr lang="en-US" sz="700" dirty="0"/>
                </a:p>
              </p:txBody>
            </p:sp>
          </p:grp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FF2F803-222B-5E45-0650-B1FD634A5FD5}"/>
                </a:ext>
              </a:extLst>
            </p:cNvPr>
            <p:cNvSpPr txBox="1"/>
            <p:nvPr/>
          </p:nvSpPr>
          <p:spPr>
            <a:xfrm>
              <a:off x="2920328" y="2503392"/>
              <a:ext cx="26205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B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200" b="1" dirty="0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E9F80097-BC76-6273-0AB0-114B9E97F353}"/>
                </a:ext>
              </a:extLst>
            </p:cNvPr>
            <p:cNvSpPr txBox="1"/>
            <p:nvPr/>
          </p:nvSpPr>
          <p:spPr>
            <a:xfrm>
              <a:off x="4342490" y="2783519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F4FA59A-268F-8763-A8AC-9672E71B5D3D}"/>
                </a:ext>
              </a:extLst>
            </p:cNvPr>
            <p:cNvSpPr txBox="1"/>
            <p:nvPr/>
          </p:nvSpPr>
          <p:spPr>
            <a:xfrm>
              <a:off x="4003356" y="3731049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61751B0-B1F1-98DD-D33D-92EB2696CD91}"/>
                </a:ext>
              </a:extLst>
            </p:cNvPr>
            <p:cNvSpPr txBox="1"/>
            <p:nvPr/>
          </p:nvSpPr>
          <p:spPr>
            <a:xfrm>
              <a:off x="3761497" y="4070183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B3A5090-B825-D5A6-0909-CC22F85F3331}"/>
                </a:ext>
              </a:extLst>
            </p:cNvPr>
            <p:cNvSpPr txBox="1"/>
            <p:nvPr/>
          </p:nvSpPr>
          <p:spPr>
            <a:xfrm>
              <a:off x="4531030" y="3680445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A43EF7D4-7C41-E540-64A5-01298543ADB4}"/>
                </a:ext>
              </a:extLst>
            </p:cNvPr>
            <p:cNvSpPr txBox="1"/>
            <p:nvPr/>
          </p:nvSpPr>
          <p:spPr>
            <a:xfrm>
              <a:off x="6667629" y="3926811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A04B3B07-B3AA-3641-531F-B3F32524EBCD}"/>
                </a:ext>
              </a:extLst>
            </p:cNvPr>
            <p:cNvSpPr txBox="1"/>
            <p:nvPr/>
          </p:nvSpPr>
          <p:spPr>
            <a:xfrm>
              <a:off x="6812801" y="4039455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D73C3CA-E09B-2E19-8EB3-AEBF13C248CC}"/>
                </a:ext>
              </a:extLst>
            </p:cNvPr>
            <p:cNvSpPr txBox="1"/>
            <p:nvPr/>
          </p:nvSpPr>
          <p:spPr>
            <a:xfrm>
              <a:off x="7001341" y="4083428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9263D2A5-3FA2-4F46-CCCD-8EB5B8A0D334}"/>
                </a:ext>
              </a:extLst>
            </p:cNvPr>
            <p:cNvSpPr txBox="1"/>
            <p:nvPr/>
          </p:nvSpPr>
          <p:spPr>
            <a:xfrm>
              <a:off x="7579617" y="4040057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B4BCCBBA-6E70-C103-FCE2-341226A0B187}"/>
                </a:ext>
              </a:extLst>
            </p:cNvPr>
            <p:cNvSpPr txBox="1"/>
            <p:nvPr/>
          </p:nvSpPr>
          <p:spPr>
            <a:xfrm>
              <a:off x="7768157" y="4058733"/>
              <a:ext cx="34398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6928760-93B8-CF93-E5B0-1502C8FB69B5}"/>
              </a:ext>
            </a:extLst>
          </p:cNvPr>
          <p:cNvGrpSpPr/>
          <p:nvPr/>
        </p:nvGrpSpPr>
        <p:grpSpPr>
          <a:xfrm>
            <a:off x="5981692" y="4464978"/>
            <a:ext cx="2132761" cy="2109787"/>
            <a:chOff x="10511843" y="4535450"/>
            <a:chExt cx="2132761" cy="2109787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6DC2F97-953B-570B-6B02-B617C7C3FC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93870094"/>
                </p:ext>
              </p:extLst>
            </p:nvPr>
          </p:nvGraphicFramePr>
          <p:xfrm>
            <a:off x="10511843" y="4535450"/>
            <a:ext cx="1487487" cy="2109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1487387" imgH="2109081" progId="SigmaPlotGraphicObject.12">
                    <p:embed/>
                  </p:oleObj>
                </mc:Choice>
                <mc:Fallback>
                  <p:oleObj name="SPW 13.0 Graph" r:id="rId10" imgW="1487387" imgH="2109081" progId="SigmaPlotGraphicObject.12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56DC2F97-953B-570B-6B02-B617C7C3FC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0511843" y="4535450"/>
                          <a:ext cx="1487487" cy="2109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A24E29D-1A3C-BB0F-D7A8-60A44EF74D1C}"/>
                </a:ext>
              </a:extLst>
            </p:cNvPr>
            <p:cNvSpPr txBox="1"/>
            <p:nvPr/>
          </p:nvSpPr>
          <p:spPr>
            <a:xfrm>
              <a:off x="11676030" y="5858244"/>
              <a:ext cx="968574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1. H</a:t>
              </a:r>
              <a:r>
                <a:rPr lang="en-US" sz="700" b="0" i="0" u="none" strike="noStrike" baseline="-25000" dirty="0">
                  <a:solidFill>
                    <a:srgbClr val="000000"/>
                  </a:solidFill>
                  <a:latin typeface="Arial" panose="020B0604020202020204" pitchFamily="34" charset="0"/>
                </a:rPr>
                <a:t>2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S</a:t>
              </a:r>
            </a:p>
            <a:p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2. H</a:t>
              </a:r>
              <a:r>
                <a:rPr lang="en-US" sz="700" b="0" i="0" u="none" strike="noStrike" baseline="-25000" dirty="0">
                  <a:solidFill>
                    <a:srgbClr val="000000"/>
                  </a:solidFill>
                  <a:latin typeface="Arial" panose="020B0604020202020204" pitchFamily="34" charset="0"/>
                </a:rPr>
                <a:t>2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S+NQ</a:t>
              </a:r>
            </a:p>
            <a:p>
              <a:r>
                <a:rPr lang="pt-BR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3. 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H</a:t>
              </a:r>
              <a:r>
                <a:rPr lang="en-US" sz="700" b="0" i="0" u="none" strike="noStrike" baseline="-25000" dirty="0">
                  <a:solidFill>
                    <a:srgbClr val="000000"/>
                  </a:solidFill>
                  <a:latin typeface="Arial" panose="020B0604020202020204" pitchFamily="34" charset="0"/>
                </a:rPr>
                <a:t>2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S+NQ</a:t>
              </a:r>
              <a:r>
                <a:rPr lang="pt-BR" sz="700" dirty="0">
                  <a:solidFill>
                    <a:srgbClr val="000000"/>
                  </a:solidFill>
                  <a:latin typeface="Arial" panose="020B0604020202020204" pitchFamily="34" charset="0"/>
                </a:rPr>
                <a:t>+GSH</a:t>
              </a:r>
              <a:endParaRPr lang="pt-BR" sz="7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r>
                <a:rPr lang="pt-BR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4. 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H</a:t>
              </a:r>
              <a:r>
                <a:rPr lang="en-US" sz="700" b="0" i="0" u="none" strike="noStrike" baseline="-25000" dirty="0">
                  <a:solidFill>
                    <a:srgbClr val="000000"/>
                  </a:solidFill>
                  <a:latin typeface="Arial" panose="020B0604020202020204" pitchFamily="34" charset="0"/>
                </a:rPr>
                <a:t>2</a:t>
              </a:r>
              <a:r>
                <a:rPr lang="en-US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S+NQ</a:t>
              </a:r>
              <a:r>
                <a:rPr lang="pt-BR" sz="700" b="0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</a:rPr>
                <a:t>+Cys</a:t>
              </a:r>
            </a:p>
          </p:txBody>
        </p:sp>
      </p:grp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DBD302E5-CA2F-38A2-02D1-D9F2A26538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1227089"/>
              </p:ext>
            </p:extLst>
          </p:nvPr>
        </p:nvGraphicFramePr>
        <p:xfrm>
          <a:off x="7008485" y="996441"/>
          <a:ext cx="949176" cy="1009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12" imgW="2129168" imgH="2263123" progId="SigmaPlotGraphicObject.12">
                  <p:embed/>
                </p:oleObj>
              </mc:Choice>
              <mc:Fallback>
                <p:oleObj name="SPW 13.0 Graph" r:id="rId12" imgW="2129168" imgH="2263123" progId="SigmaPlotGraphicObject.12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DBD302E5-CA2F-38A2-02D1-D9F2A26538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008485" y="996441"/>
                        <a:ext cx="949176" cy="1009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919931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3137B6FE-72E0-1019-B4CA-615AB24FAB93}"/>
              </a:ext>
            </a:extLst>
          </p:cNvPr>
          <p:cNvSpPr txBox="1"/>
          <p:nvPr/>
        </p:nvSpPr>
        <p:spPr>
          <a:xfrm>
            <a:off x="202035" y="263994"/>
            <a:ext cx="2550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4</a:t>
            </a:r>
          </a:p>
        </p:txBody>
      </p:sp>
      <p:grpSp>
        <p:nvGrpSpPr>
          <p:cNvPr id="552" name="Group 551">
            <a:extLst>
              <a:ext uri="{FF2B5EF4-FFF2-40B4-BE49-F238E27FC236}">
                <a16:creationId xmlns:a16="http://schemas.microsoft.com/office/drawing/2014/main" id="{E8494666-1006-9300-61D7-3DC8BC0876B2}"/>
              </a:ext>
            </a:extLst>
          </p:cNvPr>
          <p:cNvGrpSpPr/>
          <p:nvPr/>
        </p:nvGrpSpPr>
        <p:grpSpPr>
          <a:xfrm>
            <a:off x="3903744" y="785075"/>
            <a:ext cx="3174180" cy="4314490"/>
            <a:chOff x="1214972" y="425846"/>
            <a:chExt cx="3174180" cy="4314490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9FAF78C6-5E27-DE88-C971-0704DE9D55C6}"/>
                </a:ext>
              </a:extLst>
            </p:cNvPr>
            <p:cNvGrpSpPr/>
            <p:nvPr/>
          </p:nvGrpSpPr>
          <p:grpSpPr>
            <a:xfrm>
              <a:off x="1214972" y="425846"/>
              <a:ext cx="2993471" cy="4314490"/>
              <a:chOff x="766045" y="1367955"/>
              <a:chExt cx="2993471" cy="4314490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3F7BE9A-121F-6208-FAF1-DD59D8452354}"/>
                  </a:ext>
                </a:extLst>
              </p:cNvPr>
              <p:cNvSpPr txBox="1"/>
              <p:nvPr/>
            </p:nvSpPr>
            <p:spPr>
              <a:xfrm>
                <a:off x="2344609" y="3232375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6E1249D5-3376-06F8-5CFF-B0D9234E73E8}"/>
                  </a:ext>
                </a:extLst>
              </p:cNvPr>
              <p:cNvSpPr txBox="1"/>
              <p:nvPr/>
            </p:nvSpPr>
            <p:spPr>
              <a:xfrm>
                <a:off x="1256963" y="3270632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295" name="Group 294">
                <a:extLst>
                  <a:ext uri="{FF2B5EF4-FFF2-40B4-BE49-F238E27FC236}">
                    <a16:creationId xmlns:a16="http://schemas.microsoft.com/office/drawing/2014/main" id="{D0610A43-FF41-F11C-0FBA-8141E1A5B7E4}"/>
                  </a:ext>
                </a:extLst>
              </p:cNvPr>
              <p:cNvGrpSpPr/>
              <p:nvPr/>
            </p:nvGrpSpPr>
            <p:grpSpPr>
              <a:xfrm>
                <a:off x="855911" y="1367955"/>
                <a:ext cx="2903605" cy="2209652"/>
                <a:chOff x="1028211" y="672954"/>
                <a:chExt cx="2903605" cy="2209652"/>
              </a:xfrm>
            </p:grpSpPr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F90E20F2-D0B6-36F7-A712-B44D671298E4}"/>
                    </a:ext>
                  </a:extLst>
                </p:cNvPr>
                <p:cNvSpPr txBox="1"/>
                <p:nvPr/>
              </p:nvSpPr>
              <p:spPr>
                <a:xfrm>
                  <a:off x="1598457" y="1465647"/>
                  <a:ext cx="3417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a)</a:t>
                  </a:r>
                </a:p>
              </p:txBody>
            </p:sp>
            <p:sp>
              <p:nvSpPr>
                <p:cNvPr id="314" name="TextBox 313">
                  <a:extLst>
                    <a:ext uri="{FF2B5EF4-FFF2-40B4-BE49-F238E27FC236}">
                      <a16:creationId xmlns:a16="http://schemas.microsoft.com/office/drawing/2014/main" id="{B0E50FD4-EC92-0D91-93F2-5DDAF873F871}"/>
                    </a:ext>
                  </a:extLst>
                </p:cNvPr>
                <p:cNvSpPr txBox="1"/>
                <p:nvPr/>
              </p:nvSpPr>
              <p:spPr>
                <a:xfrm>
                  <a:off x="1585320" y="1862412"/>
                  <a:ext cx="3497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b)</a:t>
                  </a:r>
                </a:p>
              </p:txBody>
            </p:sp>
            <p:sp>
              <p:nvSpPr>
                <p:cNvPr id="315" name="TextBox 314">
                  <a:extLst>
                    <a:ext uri="{FF2B5EF4-FFF2-40B4-BE49-F238E27FC236}">
                      <a16:creationId xmlns:a16="http://schemas.microsoft.com/office/drawing/2014/main" id="{365067AA-FC32-7F55-1A97-36402757390B}"/>
                    </a:ext>
                  </a:extLst>
                </p:cNvPr>
                <p:cNvSpPr txBox="1"/>
                <p:nvPr/>
              </p:nvSpPr>
              <p:spPr>
                <a:xfrm>
                  <a:off x="1432919" y="1284344"/>
                  <a:ext cx="29527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316" name="TextBox 315">
                  <a:extLst>
                    <a:ext uri="{FF2B5EF4-FFF2-40B4-BE49-F238E27FC236}">
                      <a16:creationId xmlns:a16="http://schemas.microsoft.com/office/drawing/2014/main" id="{569FC002-A378-DB6A-3456-EA75878CE4B7}"/>
                    </a:ext>
                  </a:extLst>
                </p:cNvPr>
                <p:cNvSpPr txBox="1"/>
                <p:nvPr/>
              </p:nvSpPr>
              <p:spPr>
                <a:xfrm>
                  <a:off x="2455177" y="1241635"/>
                  <a:ext cx="4619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</a:p>
              </p:txBody>
            </p:sp>
            <p:grpSp>
              <p:nvGrpSpPr>
                <p:cNvPr id="317" name="Group 316">
                  <a:extLst>
                    <a:ext uri="{FF2B5EF4-FFF2-40B4-BE49-F238E27FC236}">
                      <a16:creationId xmlns:a16="http://schemas.microsoft.com/office/drawing/2014/main" id="{ABA5B0A1-D18A-2502-20C9-5E877609F565}"/>
                    </a:ext>
                  </a:extLst>
                </p:cNvPr>
                <p:cNvGrpSpPr/>
                <p:nvPr/>
              </p:nvGrpSpPr>
              <p:grpSpPr>
                <a:xfrm>
                  <a:off x="1028211" y="672954"/>
                  <a:ext cx="2755900" cy="2209652"/>
                  <a:chOff x="1028211" y="672954"/>
                  <a:chExt cx="2755900" cy="2209652"/>
                </a:xfrm>
              </p:grpSpPr>
              <p:graphicFrame>
                <p:nvGraphicFramePr>
                  <p:cNvPr id="69" name="Object 68">
                    <a:extLst>
                      <a:ext uri="{FF2B5EF4-FFF2-40B4-BE49-F238E27FC236}">
                        <a16:creationId xmlns:a16="http://schemas.microsoft.com/office/drawing/2014/main" id="{35D649CE-1FE0-A236-3B88-1F172251F132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1028211" y="1063331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" imgW="2755436" imgH="1819712" progId="SigmaPlotGraphicObject.12">
                          <p:embed/>
                        </p:oleObj>
                      </mc:Choice>
                      <mc:Fallback>
                        <p:oleObj name="SPW 13.0 Graph" r:id="rId2" imgW="2755436" imgH="1819712" progId="SigmaPlotGraphicObject.12">
                          <p:embed/>
                          <p:pic>
                            <p:nvPicPr>
                              <p:cNvPr id="69" name="Object 68">
                                <a:extLst>
                                  <a:ext uri="{FF2B5EF4-FFF2-40B4-BE49-F238E27FC236}">
                                    <a16:creationId xmlns:a16="http://schemas.microsoft.com/office/drawing/2014/main" id="{35D649CE-1FE0-A236-3B88-1F172251F132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028211" y="1063331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3" name="Object 72">
                    <a:extLst>
                      <a:ext uri="{FF2B5EF4-FFF2-40B4-BE49-F238E27FC236}">
                        <a16:creationId xmlns:a16="http://schemas.microsoft.com/office/drawing/2014/main" id="{CB5E0E29-DE9E-88FD-75F4-F040F34FFF0C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1028211" y="672954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4" imgW="2755436" imgH="1819712" progId="SigmaPlotGraphicObject.12">
                          <p:embed/>
                        </p:oleObj>
                      </mc:Choice>
                      <mc:Fallback>
                        <p:oleObj name="SPW 13.0 Graph" r:id="rId4" imgW="2755436" imgH="1819712" progId="SigmaPlotGraphicObject.12">
                          <p:embed/>
                          <p:pic>
                            <p:nvPicPr>
                              <p:cNvPr id="73" name="Object 72">
                                <a:extLst>
                                  <a:ext uri="{FF2B5EF4-FFF2-40B4-BE49-F238E27FC236}">
                                    <a16:creationId xmlns:a16="http://schemas.microsoft.com/office/drawing/2014/main" id="{CB5E0E29-DE9E-88FD-75F4-F040F34FFF0C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028211" y="672954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sp>
              <p:nvSpPr>
                <p:cNvPr id="318" name="TextBox 317">
                  <a:extLst>
                    <a:ext uri="{FF2B5EF4-FFF2-40B4-BE49-F238E27FC236}">
                      <a16:creationId xmlns:a16="http://schemas.microsoft.com/office/drawing/2014/main" id="{FC99619B-1527-2165-5B7F-0BF013592B5F}"/>
                    </a:ext>
                  </a:extLst>
                </p:cNvPr>
                <p:cNvSpPr txBox="1"/>
                <p:nvPr/>
              </p:nvSpPr>
              <p:spPr>
                <a:xfrm>
                  <a:off x="3497082" y="1504189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  <p:sp>
              <p:nvSpPr>
                <p:cNvPr id="319" name="TextBox 318">
                  <a:extLst>
                    <a:ext uri="{FF2B5EF4-FFF2-40B4-BE49-F238E27FC236}">
                      <a16:creationId xmlns:a16="http://schemas.microsoft.com/office/drawing/2014/main" id="{EF44852F-7918-AD7B-CA67-A9412E903FA8}"/>
                    </a:ext>
                  </a:extLst>
                </p:cNvPr>
                <p:cNvSpPr txBox="1"/>
                <p:nvPr/>
              </p:nvSpPr>
              <p:spPr>
                <a:xfrm>
                  <a:off x="3497082" y="1881441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</p:grpSp>
          <p:grpSp>
            <p:nvGrpSpPr>
              <p:cNvPr id="296" name="Group 295">
                <a:extLst>
                  <a:ext uri="{FF2B5EF4-FFF2-40B4-BE49-F238E27FC236}">
                    <a16:creationId xmlns:a16="http://schemas.microsoft.com/office/drawing/2014/main" id="{73E00564-FE8D-17D7-B484-B6CCC2C5E0BA}"/>
                  </a:ext>
                </a:extLst>
              </p:cNvPr>
              <p:cNvGrpSpPr/>
              <p:nvPr/>
            </p:nvGrpSpPr>
            <p:grpSpPr>
              <a:xfrm>
                <a:off x="766045" y="2689109"/>
                <a:ext cx="2960295" cy="2993336"/>
                <a:chOff x="728466" y="1899969"/>
                <a:chExt cx="2960295" cy="2993336"/>
              </a:xfrm>
            </p:grpSpPr>
            <p:grpSp>
              <p:nvGrpSpPr>
                <p:cNvPr id="297" name="Group 296">
                  <a:extLst>
                    <a:ext uri="{FF2B5EF4-FFF2-40B4-BE49-F238E27FC236}">
                      <a16:creationId xmlns:a16="http://schemas.microsoft.com/office/drawing/2014/main" id="{DEB63603-7779-9E70-4F2B-8665A78B9CD9}"/>
                    </a:ext>
                  </a:extLst>
                </p:cNvPr>
                <p:cNvGrpSpPr/>
                <p:nvPr/>
              </p:nvGrpSpPr>
              <p:grpSpPr>
                <a:xfrm>
                  <a:off x="1378681" y="2699101"/>
                  <a:ext cx="349776" cy="1415605"/>
                  <a:chOff x="1661485" y="2699101"/>
                  <a:chExt cx="349776" cy="1415605"/>
                </a:xfrm>
              </p:grpSpPr>
              <p:sp>
                <p:nvSpPr>
                  <p:cNvPr id="309" name="TextBox 308">
                    <a:extLst>
                      <a:ext uri="{FF2B5EF4-FFF2-40B4-BE49-F238E27FC236}">
                        <a16:creationId xmlns:a16="http://schemas.microsoft.com/office/drawing/2014/main" id="{4DA86F21-9AB1-8EB5-162A-0212E6F3D3FF}"/>
                      </a:ext>
                    </a:extLst>
                  </p:cNvPr>
                  <p:cNvSpPr txBox="1"/>
                  <p:nvPr/>
                </p:nvSpPr>
                <p:spPr>
                  <a:xfrm>
                    <a:off x="1661485" y="2699101"/>
                    <a:ext cx="34176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a)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0" name="TextBox 309">
                    <a:extLst>
                      <a:ext uri="{FF2B5EF4-FFF2-40B4-BE49-F238E27FC236}">
                        <a16:creationId xmlns:a16="http://schemas.microsoft.com/office/drawing/2014/main" id="{0CA8B4E1-8F88-29C7-8A66-C4859F18B158}"/>
                      </a:ext>
                    </a:extLst>
                  </p:cNvPr>
                  <p:cNvSpPr txBox="1"/>
                  <p:nvPr/>
                </p:nvSpPr>
                <p:spPr>
                  <a:xfrm>
                    <a:off x="1661485" y="3004765"/>
                    <a:ext cx="34977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b)</a:t>
                    </a:r>
                  </a:p>
                </p:txBody>
              </p:sp>
              <p:sp>
                <p:nvSpPr>
                  <p:cNvPr id="311" name="TextBox 310">
                    <a:extLst>
                      <a:ext uri="{FF2B5EF4-FFF2-40B4-BE49-F238E27FC236}">
                        <a16:creationId xmlns:a16="http://schemas.microsoft.com/office/drawing/2014/main" id="{3603265A-C4F7-D896-39E2-F1648F82B7EF}"/>
                      </a:ext>
                    </a:extLst>
                  </p:cNvPr>
                  <p:cNvSpPr txBox="1"/>
                  <p:nvPr/>
                </p:nvSpPr>
                <p:spPr>
                  <a:xfrm>
                    <a:off x="1661485" y="3412771"/>
                    <a:ext cx="34176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c)</a:t>
                    </a:r>
                  </a:p>
                </p:txBody>
              </p:sp>
              <p:sp>
                <p:nvSpPr>
                  <p:cNvPr id="312" name="TextBox 311">
                    <a:extLst>
                      <a:ext uri="{FF2B5EF4-FFF2-40B4-BE49-F238E27FC236}">
                        <a16:creationId xmlns:a16="http://schemas.microsoft.com/office/drawing/2014/main" id="{7811E117-D8F8-2F25-807A-5929668CEBFF}"/>
                      </a:ext>
                    </a:extLst>
                  </p:cNvPr>
                  <p:cNvSpPr txBox="1"/>
                  <p:nvPr/>
                </p:nvSpPr>
                <p:spPr>
                  <a:xfrm>
                    <a:off x="1661485" y="3868485"/>
                    <a:ext cx="34977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d)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98" name="Group 297">
                  <a:extLst>
                    <a:ext uri="{FF2B5EF4-FFF2-40B4-BE49-F238E27FC236}">
                      <a16:creationId xmlns:a16="http://schemas.microsoft.com/office/drawing/2014/main" id="{10C7F023-AD7B-0D8B-5AB6-DBB4B6A988F9}"/>
                    </a:ext>
                  </a:extLst>
                </p:cNvPr>
                <p:cNvGrpSpPr/>
                <p:nvPr/>
              </p:nvGrpSpPr>
              <p:grpSpPr>
                <a:xfrm>
                  <a:off x="728466" y="1899969"/>
                  <a:ext cx="2960295" cy="2993336"/>
                  <a:chOff x="728466" y="1899969"/>
                  <a:chExt cx="2960295" cy="2993336"/>
                </a:xfrm>
              </p:grpSpPr>
              <p:grpSp>
                <p:nvGrpSpPr>
                  <p:cNvPr id="299" name="Group 298">
                    <a:extLst>
                      <a:ext uri="{FF2B5EF4-FFF2-40B4-BE49-F238E27FC236}">
                        <a16:creationId xmlns:a16="http://schemas.microsoft.com/office/drawing/2014/main" id="{4AE502BE-B7CD-7EB5-D66A-44C5466769F7}"/>
                      </a:ext>
                    </a:extLst>
                  </p:cNvPr>
                  <p:cNvGrpSpPr/>
                  <p:nvPr/>
                </p:nvGrpSpPr>
                <p:grpSpPr>
                  <a:xfrm>
                    <a:off x="728466" y="1899969"/>
                    <a:ext cx="2860675" cy="2993336"/>
                    <a:chOff x="-1119187" y="1899969"/>
                    <a:chExt cx="2860675" cy="2993336"/>
                  </a:xfrm>
                </p:grpSpPr>
                <p:graphicFrame>
                  <p:nvGraphicFramePr>
                    <p:cNvPr id="305" name="Object 304">
                      <a:extLst>
                        <a:ext uri="{FF2B5EF4-FFF2-40B4-BE49-F238E27FC236}">
                          <a16:creationId xmlns:a16="http://schemas.microsoft.com/office/drawing/2014/main" id="{CE97F83E-9674-8A2A-E6E7-4BEF3D7A69CF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-1119187" y="3074030"/>
                    <a:ext cx="2860675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6" imgW="2860415" imgH="1819712" progId="SigmaPlotGraphicObject.12">
                            <p:embed/>
                          </p:oleObj>
                        </mc:Choice>
                        <mc:Fallback>
                          <p:oleObj name="SPW 13.0 Graph" r:id="rId6" imgW="2860415" imgH="1819712" progId="SigmaPlotGraphicObject.12">
                            <p:embed/>
                            <p:pic>
                              <p:nvPicPr>
                                <p:cNvPr id="305" name="Object 304">
                                  <a:extLst>
                                    <a:ext uri="{FF2B5EF4-FFF2-40B4-BE49-F238E27FC236}">
                                      <a16:creationId xmlns:a16="http://schemas.microsoft.com/office/drawing/2014/main" id="{CE97F83E-9674-8A2A-E6E7-4BEF3D7A69CF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-1119187" y="3074030"/>
                                  <a:ext cx="2860675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06" name="Object 305">
                      <a:extLst>
                        <a:ext uri="{FF2B5EF4-FFF2-40B4-BE49-F238E27FC236}">
                          <a16:creationId xmlns:a16="http://schemas.microsoft.com/office/drawing/2014/main" id="{69CFE475-001A-A7E6-6438-F318F01A0C36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-1119187" y="2623666"/>
                    <a:ext cx="2860675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8" imgW="2860415" imgH="1819712" progId="SigmaPlotGraphicObject.12">
                            <p:embed/>
                          </p:oleObj>
                        </mc:Choice>
                        <mc:Fallback>
                          <p:oleObj name="SPW 13.0 Graph" r:id="rId8" imgW="2860415" imgH="1819712" progId="SigmaPlotGraphicObject.12">
                            <p:embed/>
                            <p:pic>
                              <p:nvPicPr>
                                <p:cNvPr id="306" name="Object 305">
                                  <a:extLst>
                                    <a:ext uri="{FF2B5EF4-FFF2-40B4-BE49-F238E27FC236}">
                                      <a16:creationId xmlns:a16="http://schemas.microsoft.com/office/drawing/2014/main" id="{69CFE475-001A-A7E6-6438-F318F01A0C36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9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-1119187" y="2623666"/>
                                  <a:ext cx="2860675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07" name="Object 306">
                      <a:extLst>
                        <a:ext uri="{FF2B5EF4-FFF2-40B4-BE49-F238E27FC236}">
                          <a16:creationId xmlns:a16="http://schemas.microsoft.com/office/drawing/2014/main" id="{FF4E9213-3C65-174D-DEA7-FED9CDE11E04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-1119187" y="2214446"/>
                    <a:ext cx="2860675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10" imgW="2860415" imgH="1819712" progId="SigmaPlotGraphicObject.12">
                            <p:embed/>
                          </p:oleObj>
                        </mc:Choice>
                        <mc:Fallback>
                          <p:oleObj name="SPW 13.0 Graph" r:id="rId10" imgW="2860415" imgH="1819712" progId="SigmaPlotGraphicObject.12">
                            <p:embed/>
                            <p:pic>
                              <p:nvPicPr>
                                <p:cNvPr id="307" name="Object 306">
                                  <a:extLst>
                                    <a:ext uri="{FF2B5EF4-FFF2-40B4-BE49-F238E27FC236}">
                                      <a16:creationId xmlns:a16="http://schemas.microsoft.com/office/drawing/2014/main" id="{FF4E9213-3C65-174D-DEA7-FED9CDE11E04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1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-1119187" y="2214446"/>
                                  <a:ext cx="2860675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08" name="Object 307">
                      <a:extLst>
                        <a:ext uri="{FF2B5EF4-FFF2-40B4-BE49-F238E27FC236}">
                          <a16:creationId xmlns:a16="http://schemas.microsoft.com/office/drawing/2014/main" id="{24317ABA-CC7C-671A-50F1-AB25534395F4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-1119187" y="1899969"/>
                    <a:ext cx="2860675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12" imgW="2860415" imgH="1819712" progId="SigmaPlotGraphicObject.12">
                            <p:embed/>
                          </p:oleObj>
                        </mc:Choice>
                        <mc:Fallback>
                          <p:oleObj name="SPW 13.0 Graph" r:id="rId12" imgW="2860415" imgH="1819712" progId="SigmaPlotGraphicObject.12">
                            <p:embed/>
                            <p:pic>
                              <p:nvPicPr>
                                <p:cNvPr id="308" name="Object 307">
                                  <a:extLst>
                                    <a:ext uri="{FF2B5EF4-FFF2-40B4-BE49-F238E27FC236}">
                                      <a16:creationId xmlns:a16="http://schemas.microsoft.com/office/drawing/2014/main" id="{24317ABA-CC7C-671A-50F1-AB25534395F4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3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-1119187" y="1899969"/>
                                  <a:ext cx="2860675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</p:grpSp>
              <p:grpSp>
                <p:nvGrpSpPr>
                  <p:cNvPr id="300" name="Group 299">
                    <a:extLst>
                      <a:ext uri="{FF2B5EF4-FFF2-40B4-BE49-F238E27FC236}">
                        <a16:creationId xmlns:a16="http://schemas.microsoft.com/office/drawing/2014/main" id="{6E55885E-80D2-FC3D-A487-E5B3F75C0559}"/>
                      </a:ext>
                    </a:extLst>
                  </p:cNvPr>
                  <p:cNvGrpSpPr/>
                  <p:nvPr/>
                </p:nvGrpSpPr>
                <p:grpSpPr>
                  <a:xfrm>
                    <a:off x="3303719" y="2731380"/>
                    <a:ext cx="385042" cy="1371422"/>
                    <a:chOff x="3303719" y="2731380"/>
                    <a:chExt cx="385042" cy="1371422"/>
                  </a:xfrm>
                </p:grpSpPr>
                <p:sp>
                  <p:nvSpPr>
                    <p:cNvPr id="301" name="TextBox 300">
                      <a:extLst>
                        <a:ext uri="{FF2B5EF4-FFF2-40B4-BE49-F238E27FC236}">
                          <a16:creationId xmlns:a16="http://schemas.microsoft.com/office/drawing/2014/main" id="{E7DFDF9E-0E16-0797-CA4B-C5BAE6D9AEB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03719" y="2731380"/>
                      <a:ext cx="38504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:1</a:t>
                      </a:r>
                    </a:p>
                  </p:txBody>
                </p:sp>
                <p:sp>
                  <p:nvSpPr>
                    <p:cNvPr id="302" name="TextBox 301">
                      <a:extLst>
                        <a:ext uri="{FF2B5EF4-FFF2-40B4-BE49-F238E27FC236}">
                          <a16:creationId xmlns:a16="http://schemas.microsoft.com/office/drawing/2014/main" id="{CF6494B9-6098-C453-5778-04EA4E23970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03719" y="3037426"/>
                      <a:ext cx="38504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:1</a:t>
                      </a:r>
                    </a:p>
                  </p:txBody>
                </p:sp>
                <p:sp>
                  <p:nvSpPr>
                    <p:cNvPr id="303" name="TextBox 302">
                      <a:extLst>
                        <a:ext uri="{FF2B5EF4-FFF2-40B4-BE49-F238E27FC236}">
                          <a16:creationId xmlns:a16="http://schemas.microsoft.com/office/drawing/2014/main" id="{528195A1-2A9A-79FE-7634-9313A8FC75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03719" y="3902747"/>
                      <a:ext cx="38504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:1</a:t>
                      </a:r>
                    </a:p>
                  </p:txBody>
                </p:sp>
                <p:sp>
                  <p:nvSpPr>
                    <p:cNvPr id="304" name="TextBox 303">
                      <a:extLst>
                        <a:ext uri="{FF2B5EF4-FFF2-40B4-BE49-F238E27FC236}">
                          <a16:creationId xmlns:a16="http://schemas.microsoft.com/office/drawing/2014/main" id="{6BBF9A7D-1764-15FF-F112-29CBF1DC45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03719" y="3464922"/>
                      <a:ext cx="38504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:1</a:t>
                      </a:r>
                    </a:p>
                  </p:txBody>
                </p:sp>
              </p:grpSp>
            </p:grpSp>
          </p:grpSp>
        </p:grpSp>
        <p:grpSp>
          <p:nvGrpSpPr>
            <p:cNvPr id="422" name="Group 421">
              <a:extLst>
                <a:ext uri="{FF2B5EF4-FFF2-40B4-BE49-F238E27FC236}">
                  <a16:creationId xmlns:a16="http://schemas.microsoft.com/office/drawing/2014/main" id="{BBEF984C-B44D-2ABA-614E-2052F205A3C4}"/>
                </a:ext>
              </a:extLst>
            </p:cNvPr>
            <p:cNvGrpSpPr/>
            <p:nvPr/>
          </p:nvGrpSpPr>
          <p:grpSpPr>
            <a:xfrm>
              <a:off x="1894573" y="4327163"/>
              <a:ext cx="2296423" cy="400453"/>
              <a:chOff x="1193620" y="4720059"/>
              <a:chExt cx="2296423" cy="400453"/>
            </a:xfrm>
          </p:grpSpPr>
          <p:sp>
            <p:nvSpPr>
              <p:cNvPr id="423" name="TextBox 422">
                <a:extLst>
                  <a:ext uri="{FF2B5EF4-FFF2-40B4-BE49-F238E27FC236}">
                    <a16:creationId xmlns:a16="http://schemas.microsoft.com/office/drawing/2014/main" id="{06336AD8-8C94-A197-BF49-1AA81ECE7C8C}"/>
                  </a:ext>
                </a:extLst>
              </p:cNvPr>
              <p:cNvSpPr txBox="1"/>
              <p:nvPr/>
            </p:nvSpPr>
            <p:spPr>
              <a:xfrm>
                <a:off x="1193620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15</a:t>
                </a:r>
              </a:p>
            </p:txBody>
          </p:sp>
          <p:sp>
            <p:nvSpPr>
              <p:cNvPr id="424" name="TextBox 423">
                <a:extLst>
                  <a:ext uri="{FF2B5EF4-FFF2-40B4-BE49-F238E27FC236}">
                    <a16:creationId xmlns:a16="http://schemas.microsoft.com/office/drawing/2014/main" id="{C116CF6B-3CD4-BB23-DB82-D0DBFE6BD88F}"/>
                  </a:ext>
                </a:extLst>
              </p:cNvPr>
              <p:cNvSpPr txBox="1"/>
              <p:nvPr/>
            </p:nvSpPr>
            <p:spPr>
              <a:xfrm>
                <a:off x="2060819" y="4874291"/>
                <a:ext cx="5533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uss</a:t>
                </a:r>
              </a:p>
            </p:txBody>
          </p:sp>
          <p:sp>
            <p:nvSpPr>
              <p:cNvPr id="425" name="TextBox 424">
                <a:extLst>
                  <a:ext uri="{FF2B5EF4-FFF2-40B4-BE49-F238E27FC236}">
                    <a16:creationId xmlns:a16="http://schemas.microsoft.com/office/drawing/2014/main" id="{1D407E57-382E-27A1-F802-72A5CAA449C3}"/>
                  </a:ext>
                </a:extLst>
              </p:cNvPr>
              <p:cNvSpPr txBox="1"/>
              <p:nvPr/>
            </p:nvSpPr>
            <p:spPr>
              <a:xfrm>
                <a:off x="1651648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0</a:t>
                </a:r>
              </a:p>
            </p:txBody>
          </p:sp>
          <p:sp>
            <p:nvSpPr>
              <p:cNvPr id="426" name="TextBox 425">
                <a:extLst>
                  <a:ext uri="{FF2B5EF4-FFF2-40B4-BE49-F238E27FC236}">
                    <a16:creationId xmlns:a16="http://schemas.microsoft.com/office/drawing/2014/main" id="{74A220B4-18E3-F2EC-29B1-C0428BEF6CB9}"/>
                  </a:ext>
                </a:extLst>
              </p:cNvPr>
              <p:cNvSpPr txBox="1"/>
              <p:nvPr/>
            </p:nvSpPr>
            <p:spPr>
              <a:xfrm>
                <a:off x="2112162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5</a:t>
                </a:r>
              </a:p>
            </p:txBody>
          </p:sp>
          <p:sp>
            <p:nvSpPr>
              <p:cNvPr id="427" name="TextBox 426">
                <a:extLst>
                  <a:ext uri="{FF2B5EF4-FFF2-40B4-BE49-F238E27FC236}">
                    <a16:creationId xmlns:a16="http://schemas.microsoft.com/office/drawing/2014/main" id="{7A3D197E-0BFE-D175-5D10-338C931587DC}"/>
                  </a:ext>
                </a:extLst>
              </p:cNvPr>
              <p:cNvSpPr txBox="1"/>
              <p:nvPr/>
            </p:nvSpPr>
            <p:spPr>
              <a:xfrm>
                <a:off x="2565221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0</a:t>
                </a:r>
              </a:p>
            </p:txBody>
          </p:sp>
          <p:sp>
            <p:nvSpPr>
              <p:cNvPr id="428" name="TextBox 427">
                <a:extLst>
                  <a:ext uri="{FF2B5EF4-FFF2-40B4-BE49-F238E27FC236}">
                    <a16:creationId xmlns:a16="http://schemas.microsoft.com/office/drawing/2014/main" id="{B14A2B20-4036-C586-F4D1-409DCC7A495E}"/>
                  </a:ext>
                </a:extLst>
              </p:cNvPr>
              <p:cNvSpPr txBox="1"/>
              <p:nvPr/>
            </p:nvSpPr>
            <p:spPr>
              <a:xfrm>
                <a:off x="3023249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5</a:t>
                </a:r>
              </a:p>
            </p:txBody>
          </p:sp>
          <p:grpSp>
            <p:nvGrpSpPr>
              <p:cNvPr id="429" name="Group 428">
                <a:extLst>
                  <a:ext uri="{FF2B5EF4-FFF2-40B4-BE49-F238E27FC236}">
                    <a16:creationId xmlns:a16="http://schemas.microsoft.com/office/drawing/2014/main" id="{B85658D7-E706-86FE-9B80-EE401B9DE8AB}"/>
                  </a:ext>
                </a:extLst>
              </p:cNvPr>
              <p:cNvGrpSpPr/>
              <p:nvPr/>
            </p:nvGrpSpPr>
            <p:grpSpPr>
              <a:xfrm>
                <a:off x="1427115" y="4721272"/>
                <a:ext cx="1826315" cy="49693"/>
                <a:chOff x="8073059" y="5173317"/>
                <a:chExt cx="1826315" cy="49693"/>
              </a:xfrm>
            </p:grpSpPr>
            <p:cxnSp>
              <p:nvCxnSpPr>
                <p:cNvPr id="430" name="Straight Connector 429">
                  <a:extLst>
                    <a:ext uri="{FF2B5EF4-FFF2-40B4-BE49-F238E27FC236}">
                      <a16:creationId xmlns:a16="http://schemas.microsoft.com/office/drawing/2014/main" id="{EF944E64-52AD-CFCD-B1E3-41F51A4330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73059" y="5173317"/>
                  <a:ext cx="182631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31" name="Group 430">
                  <a:extLst>
                    <a:ext uri="{FF2B5EF4-FFF2-40B4-BE49-F238E27FC236}">
                      <a16:creationId xmlns:a16="http://schemas.microsoft.com/office/drawing/2014/main" id="{B9314A1A-94A7-7756-3EA3-6968E8BAACD4}"/>
                    </a:ext>
                  </a:extLst>
                </p:cNvPr>
                <p:cNvGrpSpPr/>
                <p:nvPr/>
              </p:nvGrpSpPr>
              <p:grpSpPr>
                <a:xfrm>
                  <a:off x="8073059" y="5174143"/>
                  <a:ext cx="1826315" cy="48867"/>
                  <a:chOff x="8073059" y="5034997"/>
                  <a:chExt cx="1826315" cy="129209"/>
                </a:xfrm>
              </p:grpSpPr>
              <p:cxnSp>
                <p:nvCxnSpPr>
                  <p:cNvPr id="432" name="Straight Connector 431">
                    <a:extLst>
                      <a:ext uri="{FF2B5EF4-FFF2-40B4-BE49-F238E27FC236}">
                        <a16:creationId xmlns:a16="http://schemas.microsoft.com/office/drawing/2014/main" id="{D4451E99-9278-3766-2921-DF80770BF8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529638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3" name="Straight Connector 432">
                    <a:extLst>
                      <a:ext uri="{FF2B5EF4-FFF2-40B4-BE49-F238E27FC236}">
                        <a16:creationId xmlns:a16="http://schemas.microsoft.com/office/drawing/2014/main" id="{C083189A-7910-0000-A8CC-87A91424CD2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86217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4" name="Straight Connector 433">
                    <a:extLst>
                      <a:ext uri="{FF2B5EF4-FFF2-40B4-BE49-F238E27FC236}">
                        <a16:creationId xmlns:a16="http://schemas.microsoft.com/office/drawing/2014/main" id="{CBFF7305-9D50-D740-AA6E-6C969DBE63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442796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5" name="Straight Connector 434">
                    <a:extLst>
                      <a:ext uri="{FF2B5EF4-FFF2-40B4-BE49-F238E27FC236}">
                        <a16:creationId xmlns:a16="http://schemas.microsoft.com/office/drawing/2014/main" id="{18520AEC-A8FB-230C-16BE-4C964DE08A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73059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6" name="Straight Connector 435">
                    <a:extLst>
                      <a:ext uri="{FF2B5EF4-FFF2-40B4-BE49-F238E27FC236}">
                        <a16:creationId xmlns:a16="http://schemas.microsoft.com/office/drawing/2014/main" id="{FC2436B0-EE47-52AE-A4AD-CD36EA83CE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899374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550" name="TextBox 549">
              <a:extLst>
                <a:ext uri="{FF2B5EF4-FFF2-40B4-BE49-F238E27FC236}">
                  <a16:creationId xmlns:a16="http://schemas.microsoft.com/office/drawing/2014/main" id="{2A6924AB-E3DF-F4F9-6ED6-18A09931E2DB}"/>
                </a:ext>
              </a:extLst>
            </p:cNvPr>
            <p:cNvSpPr txBox="1"/>
            <p:nvPr/>
          </p:nvSpPr>
          <p:spPr>
            <a:xfrm>
              <a:off x="3694731" y="1089405"/>
              <a:ext cx="6944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SH:1,4-NQ</a:t>
              </a:r>
            </a:p>
          </p:txBody>
        </p:sp>
        <p:sp>
          <p:nvSpPr>
            <p:cNvPr id="551" name="TextBox 550">
              <a:extLst>
                <a:ext uri="{FF2B5EF4-FFF2-40B4-BE49-F238E27FC236}">
                  <a16:creationId xmlns:a16="http://schemas.microsoft.com/office/drawing/2014/main" id="{DDF6CE1E-9F14-C0D5-96A4-40D8411D3D55}"/>
                </a:ext>
              </a:extLst>
            </p:cNvPr>
            <p:cNvSpPr txBox="1"/>
            <p:nvPr/>
          </p:nvSpPr>
          <p:spPr>
            <a:xfrm>
              <a:off x="3726723" y="2436690"/>
              <a:ext cx="6543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ys:1,4-NQ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3117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>
            <a:extLst>
              <a:ext uri="{FF2B5EF4-FFF2-40B4-BE49-F238E27FC236}">
                <a16:creationId xmlns:a16="http://schemas.microsoft.com/office/drawing/2014/main" id="{17088CD6-0D3D-8DFC-E941-FFCB15B27599}"/>
              </a:ext>
            </a:extLst>
          </p:cNvPr>
          <p:cNvSpPr txBox="1"/>
          <p:nvPr/>
        </p:nvSpPr>
        <p:spPr>
          <a:xfrm>
            <a:off x="238129" y="263994"/>
            <a:ext cx="242084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5</a:t>
            </a:r>
          </a:p>
        </p:txBody>
      </p: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9CA5C5FE-8EBA-AA8D-1CFF-633008C01153}"/>
              </a:ext>
            </a:extLst>
          </p:cNvPr>
          <p:cNvGrpSpPr/>
          <p:nvPr/>
        </p:nvGrpSpPr>
        <p:grpSpPr>
          <a:xfrm>
            <a:off x="755804" y="1400697"/>
            <a:ext cx="10179349" cy="4562476"/>
            <a:chOff x="429233" y="1019697"/>
            <a:chExt cx="10179349" cy="4562476"/>
          </a:xfrm>
        </p:grpSpPr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548786E-DE87-350F-5169-D75009CDCC96}"/>
                </a:ext>
              </a:extLst>
            </p:cNvPr>
            <p:cNvSpPr txBox="1"/>
            <p:nvPr/>
          </p:nvSpPr>
          <p:spPr>
            <a:xfrm>
              <a:off x="5914908" y="168824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0B6D2B71-AE04-D7F1-B9BB-D71A2EFB270F}"/>
                </a:ext>
              </a:extLst>
            </p:cNvPr>
            <p:cNvSpPr txBox="1"/>
            <p:nvPr/>
          </p:nvSpPr>
          <p:spPr>
            <a:xfrm>
              <a:off x="1096568" y="166044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92042A2B-90AB-4015-7F71-9AA4895B9081}"/>
                </a:ext>
              </a:extLst>
            </p:cNvPr>
            <p:cNvGrpSpPr/>
            <p:nvPr/>
          </p:nvGrpSpPr>
          <p:grpSpPr>
            <a:xfrm>
              <a:off x="4175106" y="4439416"/>
              <a:ext cx="2296423" cy="400453"/>
              <a:chOff x="1193620" y="4720059"/>
              <a:chExt cx="2296423" cy="400453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FEF73E5C-0656-E5C2-50AC-FD2BE425759B}"/>
                  </a:ext>
                </a:extLst>
              </p:cNvPr>
              <p:cNvSpPr txBox="1"/>
              <p:nvPr/>
            </p:nvSpPr>
            <p:spPr>
              <a:xfrm>
                <a:off x="1193620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15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669C62E1-3D18-D883-F275-2C0779C5A602}"/>
                  </a:ext>
                </a:extLst>
              </p:cNvPr>
              <p:cNvSpPr txBox="1"/>
              <p:nvPr/>
            </p:nvSpPr>
            <p:spPr>
              <a:xfrm>
                <a:off x="2060819" y="4874291"/>
                <a:ext cx="5533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uss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0DA852A-AD26-727B-5C5A-BBA415901A41}"/>
                  </a:ext>
                </a:extLst>
              </p:cNvPr>
              <p:cNvSpPr txBox="1"/>
              <p:nvPr/>
            </p:nvSpPr>
            <p:spPr>
              <a:xfrm>
                <a:off x="1651648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0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B993D9E-4E23-BAEE-5048-41BE673785DE}"/>
                  </a:ext>
                </a:extLst>
              </p:cNvPr>
              <p:cNvSpPr txBox="1"/>
              <p:nvPr/>
            </p:nvSpPr>
            <p:spPr>
              <a:xfrm>
                <a:off x="2112162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5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742DEC9-AA1D-B4A3-AFFC-E0B9148DD0E6}"/>
                  </a:ext>
                </a:extLst>
              </p:cNvPr>
              <p:cNvSpPr txBox="1"/>
              <p:nvPr/>
            </p:nvSpPr>
            <p:spPr>
              <a:xfrm>
                <a:off x="2565221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14EA5E1-C1A0-E618-2C22-BFEE2247B7ED}"/>
                  </a:ext>
                </a:extLst>
              </p:cNvPr>
              <p:cNvSpPr txBox="1"/>
              <p:nvPr/>
            </p:nvSpPr>
            <p:spPr>
              <a:xfrm>
                <a:off x="3023249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5</a:t>
                </a:r>
              </a:p>
            </p:txBody>
          </p: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A84EDCD4-E110-F1B3-A26D-1E38547A212D}"/>
                  </a:ext>
                </a:extLst>
              </p:cNvPr>
              <p:cNvGrpSpPr/>
              <p:nvPr/>
            </p:nvGrpSpPr>
            <p:grpSpPr>
              <a:xfrm>
                <a:off x="1427115" y="4721272"/>
                <a:ext cx="1826315" cy="49693"/>
                <a:chOff x="8073059" y="5173317"/>
                <a:chExt cx="1826315" cy="49693"/>
              </a:xfrm>
            </p:grpSpPr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6A1B059A-DFB7-E37E-6727-C642017D8F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73059" y="5173317"/>
                  <a:ext cx="182631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4" name="Group 53">
                  <a:extLst>
                    <a:ext uri="{FF2B5EF4-FFF2-40B4-BE49-F238E27FC236}">
                      <a16:creationId xmlns:a16="http://schemas.microsoft.com/office/drawing/2014/main" id="{AA7D9278-0BB6-914E-7FB4-E5EB90EC87B1}"/>
                    </a:ext>
                  </a:extLst>
                </p:cNvPr>
                <p:cNvGrpSpPr/>
                <p:nvPr/>
              </p:nvGrpSpPr>
              <p:grpSpPr>
                <a:xfrm>
                  <a:off x="8073059" y="5174143"/>
                  <a:ext cx="1826315" cy="48867"/>
                  <a:chOff x="8073059" y="5034997"/>
                  <a:chExt cx="1826315" cy="129209"/>
                </a:xfrm>
              </p:grpSpPr>
              <p:cxnSp>
                <p:nvCxnSpPr>
                  <p:cNvPr id="55" name="Straight Connector 54">
                    <a:extLst>
                      <a:ext uri="{FF2B5EF4-FFF2-40B4-BE49-F238E27FC236}">
                        <a16:creationId xmlns:a16="http://schemas.microsoft.com/office/drawing/2014/main" id="{32686868-644E-44C4-2AAA-1B52B10C07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529638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Straight Connector 55">
                    <a:extLst>
                      <a:ext uri="{FF2B5EF4-FFF2-40B4-BE49-F238E27FC236}">
                        <a16:creationId xmlns:a16="http://schemas.microsoft.com/office/drawing/2014/main" id="{D62CB3BE-3148-9E04-2742-9727430985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86217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Straight Connector 57">
                    <a:extLst>
                      <a:ext uri="{FF2B5EF4-FFF2-40B4-BE49-F238E27FC236}">
                        <a16:creationId xmlns:a16="http://schemas.microsoft.com/office/drawing/2014/main" id="{3ED43598-C5A6-59C0-EC43-C62087BFFA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442796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>
                    <a:extLst>
                      <a:ext uri="{FF2B5EF4-FFF2-40B4-BE49-F238E27FC236}">
                        <a16:creationId xmlns:a16="http://schemas.microsoft.com/office/drawing/2014/main" id="{7D16D009-4C8E-899D-3DD5-94695884D0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73059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Straight Connector 59">
                    <a:extLst>
                      <a:ext uri="{FF2B5EF4-FFF2-40B4-BE49-F238E27FC236}">
                        <a16:creationId xmlns:a16="http://schemas.microsoft.com/office/drawing/2014/main" id="{E10B7D74-B711-E174-D910-AC3DBAE44A0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899374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37705877-911E-474D-DB57-178A068B07DC}"/>
                </a:ext>
              </a:extLst>
            </p:cNvPr>
            <p:cNvGrpSpPr/>
            <p:nvPr/>
          </p:nvGrpSpPr>
          <p:grpSpPr>
            <a:xfrm>
              <a:off x="429233" y="1019697"/>
              <a:ext cx="3182475" cy="4562476"/>
              <a:chOff x="429233" y="1019697"/>
              <a:chExt cx="3182475" cy="4562476"/>
            </a:xfrm>
          </p:grpSpPr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BA5F560D-EDF6-7108-4E0E-CC141F877D5C}"/>
                  </a:ext>
                </a:extLst>
              </p:cNvPr>
              <p:cNvSpPr txBox="1"/>
              <p:nvPr/>
            </p:nvSpPr>
            <p:spPr>
              <a:xfrm>
                <a:off x="1565599" y="1645773"/>
                <a:ext cx="15103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Juglone-GSH (21% O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F192C6CE-2D50-94F1-E9C2-70542493DABD}"/>
                  </a:ext>
                </a:extLst>
              </p:cNvPr>
              <p:cNvGrpSpPr/>
              <p:nvPr/>
            </p:nvGrpSpPr>
            <p:grpSpPr>
              <a:xfrm>
                <a:off x="2894845" y="1863628"/>
                <a:ext cx="716863" cy="2924532"/>
                <a:chOff x="2958049" y="2273078"/>
                <a:chExt cx="716863" cy="2924532"/>
              </a:xfrm>
            </p:grpSpPr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A4C51A3B-C512-6556-CD0F-62CCCE4A4AB6}"/>
                    </a:ext>
                  </a:extLst>
                </p:cNvPr>
                <p:cNvSpPr txBox="1"/>
                <p:nvPr/>
              </p:nvSpPr>
              <p:spPr>
                <a:xfrm>
                  <a:off x="2958049" y="325288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5:1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855034FC-E164-250D-BE50-FB1D340CFA7B}"/>
                    </a:ext>
                  </a:extLst>
                </p:cNvPr>
                <p:cNvSpPr txBox="1"/>
                <p:nvPr/>
              </p:nvSpPr>
              <p:spPr>
                <a:xfrm>
                  <a:off x="2958049" y="499755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249" name="TextBox 248">
                  <a:extLst>
                    <a:ext uri="{FF2B5EF4-FFF2-40B4-BE49-F238E27FC236}">
                      <a16:creationId xmlns:a16="http://schemas.microsoft.com/office/drawing/2014/main" id="{E1DBC54E-D639-FF31-594D-35963B9FF036}"/>
                    </a:ext>
                  </a:extLst>
                </p:cNvPr>
                <p:cNvSpPr txBox="1"/>
                <p:nvPr/>
              </p:nvSpPr>
              <p:spPr>
                <a:xfrm>
                  <a:off x="2958049" y="2273078"/>
                  <a:ext cx="48442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ug(ox)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D64D5B7E-8539-3D4E-A041-3E886B64510C}"/>
                    </a:ext>
                  </a:extLst>
                </p:cNvPr>
                <p:cNvSpPr txBox="1"/>
                <p:nvPr/>
              </p:nvSpPr>
              <p:spPr>
                <a:xfrm>
                  <a:off x="2958049" y="2624434"/>
                  <a:ext cx="71686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x NaBH4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971CF11F-22D4-6312-3920-532BDCAACA47}"/>
                    </a:ext>
                  </a:extLst>
                </p:cNvPr>
                <p:cNvSpPr txBox="1"/>
                <p:nvPr/>
              </p:nvSpPr>
              <p:spPr>
                <a:xfrm>
                  <a:off x="2958049" y="378450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4FA69413-6CD2-0C99-8EF3-13641B149C99}"/>
                    </a:ext>
                  </a:extLst>
                </p:cNvPr>
                <p:cNvSpPr txBox="1"/>
                <p:nvPr/>
              </p:nvSpPr>
              <p:spPr>
                <a:xfrm>
                  <a:off x="2958049" y="422328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F50A2015-7861-0F2E-13F8-701432A45334}"/>
                    </a:ext>
                  </a:extLst>
                </p:cNvPr>
                <p:cNvSpPr txBox="1"/>
                <p:nvPr/>
              </p:nvSpPr>
              <p:spPr>
                <a:xfrm>
                  <a:off x="2958049" y="4537420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8A53D08D-05BA-7F03-7C2D-C81555AE3D93}"/>
                    </a:ext>
                  </a:extLst>
                </p:cNvPr>
                <p:cNvSpPr txBox="1"/>
                <p:nvPr/>
              </p:nvSpPr>
              <p:spPr>
                <a:xfrm>
                  <a:off x="2958049" y="479987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</p:grp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92EEBAF5-62A1-32C2-AAA5-03EC36987094}"/>
                  </a:ext>
                </a:extLst>
              </p:cNvPr>
              <p:cNvGrpSpPr/>
              <p:nvPr/>
            </p:nvGrpSpPr>
            <p:grpSpPr>
              <a:xfrm>
                <a:off x="429233" y="1019697"/>
                <a:ext cx="2755900" cy="4562476"/>
                <a:chOff x="-277123" y="-55534"/>
                <a:chExt cx="2755900" cy="4562476"/>
              </a:xfrm>
            </p:grpSpPr>
            <p:graphicFrame>
              <p:nvGraphicFramePr>
                <p:cNvPr id="3" name="Object 2">
                  <a:extLst>
                    <a:ext uri="{FF2B5EF4-FFF2-40B4-BE49-F238E27FC236}">
                      <a16:creationId xmlns:a16="http://schemas.microsoft.com/office/drawing/2014/main" id="{4FD537A9-8EDE-1F1B-48D9-92EDF579992E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-55534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2755436" imgH="1819712" progId="SigmaPlotGraphicObject.12">
                        <p:embed/>
                      </p:oleObj>
                    </mc:Choice>
                    <mc:Fallback>
                      <p:oleObj name="SPW 13.0 Graph" r:id="rId2" imgW="2755436" imgH="1819712" progId="SigmaPlotGraphicObject.12">
                        <p:embed/>
                        <p:pic>
                          <p:nvPicPr>
                            <p:cNvPr id="3" name="Object 2">
                              <a:extLst>
                                <a:ext uri="{FF2B5EF4-FFF2-40B4-BE49-F238E27FC236}">
                                  <a16:creationId xmlns:a16="http://schemas.microsoft.com/office/drawing/2014/main" id="{4FD537A9-8EDE-1F1B-48D9-92EDF579992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-55534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" name="Object 1">
                  <a:extLst>
                    <a:ext uri="{FF2B5EF4-FFF2-40B4-BE49-F238E27FC236}">
                      <a16:creationId xmlns:a16="http://schemas.microsoft.com/office/drawing/2014/main" id="{9072ECDA-F48B-0EF6-3457-7204DD6C5A7A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322603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755436" imgH="1819712" progId="SigmaPlotGraphicObject.12">
                        <p:embed/>
                      </p:oleObj>
                    </mc:Choice>
                    <mc:Fallback>
                      <p:oleObj name="SPW 13.0 Graph" r:id="rId4" imgW="2755436" imgH="1819712" progId="SigmaPlotGraphicObject.12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9072ECDA-F48B-0EF6-3457-7204DD6C5A7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322603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" name="Object 3">
                  <a:extLst>
                    <a:ext uri="{FF2B5EF4-FFF2-40B4-BE49-F238E27FC236}">
                      <a16:creationId xmlns:a16="http://schemas.microsoft.com/office/drawing/2014/main" id="{138B708C-2FD9-96E5-1F2D-31F0EFBCA9B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96474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755436" imgH="1819712" progId="SigmaPlotGraphicObject.12">
                        <p:embed/>
                      </p:oleObj>
                    </mc:Choice>
                    <mc:Fallback>
                      <p:oleObj name="SPW 13.0 Graph" r:id="rId6" imgW="2755436" imgH="1819712" progId="SigmaPlotGraphicObject.12">
                        <p:embed/>
                        <p:pic>
                          <p:nvPicPr>
                            <p:cNvPr id="4" name="Object 3">
                              <a:extLst>
                                <a:ext uri="{FF2B5EF4-FFF2-40B4-BE49-F238E27FC236}">
                                  <a16:creationId xmlns:a16="http://schemas.microsoft.com/office/drawing/2014/main" id="{138B708C-2FD9-96E5-1F2D-31F0EFBCA9B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96474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5" name="Object 4">
                  <a:extLst>
                    <a:ext uri="{FF2B5EF4-FFF2-40B4-BE49-F238E27FC236}">
                      <a16:creationId xmlns:a16="http://schemas.microsoft.com/office/drawing/2014/main" id="{1ACAACA8-DDC8-4482-3706-9C5754758A6F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1494135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2755436" imgH="1819712" progId="SigmaPlotGraphicObject.12">
                        <p:embed/>
                      </p:oleObj>
                    </mc:Choice>
                    <mc:Fallback>
                      <p:oleObj name="SPW 13.0 Graph" r:id="rId8" imgW="2755436" imgH="1819712" progId="SigmaPlotGraphicObject.12">
                        <p:embed/>
                        <p:pic>
                          <p:nvPicPr>
                            <p:cNvPr id="5" name="Object 4">
                              <a:extLst>
                                <a:ext uri="{FF2B5EF4-FFF2-40B4-BE49-F238E27FC236}">
                                  <a16:creationId xmlns:a16="http://schemas.microsoft.com/office/drawing/2014/main" id="{1ACAACA8-DDC8-4482-3706-9C5754758A6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1494135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01C25845-876C-2FCE-C01E-2896743D065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192245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2755436" imgH="1819712" progId="SigmaPlotGraphicObject.12">
                        <p:embed/>
                      </p:oleObj>
                    </mc:Choice>
                    <mc:Fallback>
                      <p:oleObj name="SPW 13.0 Graph" r:id="rId10" imgW="2755436" imgH="1819712" progId="SigmaPlotGraphicObject.12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01C25845-876C-2FCE-C01E-2896743D065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192245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7" name="Object 6">
                  <a:extLst>
                    <a:ext uri="{FF2B5EF4-FFF2-40B4-BE49-F238E27FC236}">
                      <a16:creationId xmlns:a16="http://schemas.microsoft.com/office/drawing/2014/main" id="{75D332D2-2E17-7C9F-123D-1FE560AF21C4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223046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2755436" imgH="1819712" progId="SigmaPlotGraphicObject.12">
                        <p:embed/>
                      </p:oleObj>
                    </mc:Choice>
                    <mc:Fallback>
                      <p:oleObj name="SPW 13.0 Graph" r:id="rId12" imgW="2755436" imgH="1819712" progId="SigmaPlotGraphicObject.12">
                        <p:embed/>
                        <p:pic>
                          <p:nvPicPr>
                            <p:cNvPr id="7" name="Object 6">
                              <a:extLst>
                                <a:ext uri="{FF2B5EF4-FFF2-40B4-BE49-F238E27FC236}">
                                  <a16:creationId xmlns:a16="http://schemas.microsoft.com/office/drawing/2014/main" id="{75D332D2-2E17-7C9F-123D-1FE560AF21C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223046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8" name="Object 7">
                  <a:extLst>
                    <a:ext uri="{FF2B5EF4-FFF2-40B4-BE49-F238E27FC236}">
                      <a16:creationId xmlns:a16="http://schemas.microsoft.com/office/drawing/2014/main" id="{41E20256-5C9F-0440-C2DC-F9C81DB485B7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2490351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4" imgW="2755436" imgH="1819712" progId="SigmaPlotGraphicObject.12">
                        <p:embed/>
                      </p:oleObj>
                    </mc:Choice>
                    <mc:Fallback>
                      <p:oleObj name="SPW 13.0 Graph" r:id="rId14" imgW="2755436" imgH="1819712" progId="SigmaPlotGraphicObject.12">
                        <p:embed/>
                        <p:pic>
                          <p:nvPicPr>
                            <p:cNvPr id="8" name="Object 7">
                              <a:extLst>
                                <a:ext uri="{FF2B5EF4-FFF2-40B4-BE49-F238E27FC236}">
                                  <a16:creationId xmlns:a16="http://schemas.microsoft.com/office/drawing/2014/main" id="{41E20256-5C9F-0440-C2DC-F9C81DB485B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2490351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" name="Object 8">
                  <a:extLst>
                    <a:ext uri="{FF2B5EF4-FFF2-40B4-BE49-F238E27FC236}">
                      <a16:creationId xmlns:a16="http://schemas.microsoft.com/office/drawing/2014/main" id="{E30FCF1F-2E94-D1CF-38AC-94630CDE002A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277123" y="2687667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6" imgW="2755436" imgH="1819712" progId="SigmaPlotGraphicObject.12">
                        <p:embed/>
                      </p:oleObj>
                    </mc:Choice>
                    <mc:Fallback>
                      <p:oleObj name="SPW 13.0 Graph" r:id="rId16" imgW="2755436" imgH="1819712" progId="SigmaPlotGraphicObject.12">
                        <p:embed/>
                        <p:pic>
                          <p:nvPicPr>
                            <p:cNvPr id="9" name="Object 8">
                              <a:extLst>
                                <a:ext uri="{FF2B5EF4-FFF2-40B4-BE49-F238E27FC236}">
                                  <a16:creationId xmlns:a16="http://schemas.microsoft.com/office/drawing/2014/main" id="{E30FCF1F-2E94-D1CF-38AC-94630CDE002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77123" y="2687667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A230714-9E8C-C497-1504-DD923E483F24}"/>
                </a:ext>
              </a:extLst>
            </p:cNvPr>
            <p:cNvSpPr txBox="1"/>
            <p:nvPr/>
          </p:nvSpPr>
          <p:spPr>
            <a:xfrm>
              <a:off x="3446404" y="165976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BC8A5E06-8C76-D4B0-87C3-3E5D478487A8}"/>
                </a:ext>
              </a:extLst>
            </p:cNvPr>
            <p:cNvSpPr txBox="1"/>
            <p:nvPr/>
          </p:nvSpPr>
          <p:spPr>
            <a:xfrm>
              <a:off x="3870544" y="1635078"/>
              <a:ext cx="14622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Juglone-GSH (0% O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62846AB-2CAE-B7C5-1B10-309DFF382429}"/>
                </a:ext>
              </a:extLst>
            </p:cNvPr>
            <p:cNvSpPr txBox="1"/>
            <p:nvPr/>
          </p:nvSpPr>
          <p:spPr>
            <a:xfrm>
              <a:off x="10096903" y="1990438"/>
              <a:ext cx="5116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:Jug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99930F2B-B22F-5EF6-AE24-CF271FABAA4D}"/>
                </a:ext>
              </a:extLst>
            </p:cNvPr>
            <p:cNvSpPr txBox="1"/>
            <p:nvPr/>
          </p:nvSpPr>
          <p:spPr>
            <a:xfrm>
              <a:off x="7691655" y="1997066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:Ju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2BB1351F-34EC-1A3D-EE53-556B26F49D4B}"/>
                </a:ext>
              </a:extLst>
            </p:cNvPr>
            <p:cNvSpPr txBox="1"/>
            <p:nvPr/>
          </p:nvSpPr>
          <p:spPr>
            <a:xfrm>
              <a:off x="5257262" y="2128263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:Ju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DD963E10-53C2-9AD4-0877-415D9B7F193B}"/>
                </a:ext>
              </a:extLst>
            </p:cNvPr>
            <p:cNvSpPr txBox="1"/>
            <p:nvPr/>
          </p:nvSpPr>
          <p:spPr>
            <a:xfrm>
              <a:off x="2915635" y="2683522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SH:Ju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1" name="Group 230">
              <a:extLst>
                <a:ext uri="{FF2B5EF4-FFF2-40B4-BE49-F238E27FC236}">
                  <a16:creationId xmlns:a16="http://schemas.microsoft.com/office/drawing/2014/main" id="{78192985-F74B-6659-03BF-1B7FDDADEFF2}"/>
                </a:ext>
              </a:extLst>
            </p:cNvPr>
            <p:cNvGrpSpPr/>
            <p:nvPr/>
          </p:nvGrpSpPr>
          <p:grpSpPr>
            <a:xfrm>
              <a:off x="7567186" y="1313221"/>
              <a:ext cx="2949876" cy="4109988"/>
              <a:chOff x="7567186" y="1313221"/>
              <a:chExt cx="2949876" cy="4109988"/>
            </a:xfrm>
          </p:grpSpPr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C7EFB7F4-9248-7CA4-9EF6-D4390D717899}"/>
                  </a:ext>
                </a:extLst>
              </p:cNvPr>
              <p:cNvSpPr txBox="1"/>
              <p:nvPr/>
            </p:nvSpPr>
            <p:spPr>
              <a:xfrm>
                <a:off x="8260069" y="1701006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3C0A81C9-C25F-F742-EFE5-0608570EDF87}"/>
                  </a:ext>
                </a:extLst>
              </p:cNvPr>
              <p:cNvSpPr txBox="1"/>
              <p:nvPr/>
            </p:nvSpPr>
            <p:spPr>
              <a:xfrm>
                <a:off x="8962532" y="1750904"/>
                <a:ext cx="9220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Juglone-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grpSp>
            <p:nvGrpSpPr>
              <p:cNvPr id="234" name="Group 233">
                <a:extLst>
                  <a:ext uri="{FF2B5EF4-FFF2-40B4-BE49-F238E27FC236}">
                    <a16:creationId xmlns:a16="http://schemas.microsoft.com/office/drawing/2014/main" id="{1E80F480-DE30-7A80-5C7D-4DE7683EE594}"/>
                  </a:ext>
                </a:extLst>
              </p:cNvPr>
              <p:cNvGrpSpPr/>
              <p:nvPr/>
            </p:nvGrpSpPr>
            <p:grpSpPr>
              <a:xfrm>
                <a:off x="7567186" y="1313221"/>
                <a:ext cx="2755900" cy="4109988"/>
                <a:chOff x="7567186" y="1313221"/>
                <a:chExt cx="2755900" cy="4109988"/>
              </a:xfrm>
            </p:grpSpPr>
            <p:graphicFrame>
              <p:nvGraphicFramePr>
                <p:cNvPr id="37" name="Object 36">
                  <a:extLst>
                    <a:ext uri="{FF2B5EF4-FFF2-40B4-BE49-F238E27FC236}">
                      <a16:creationId xmlns:a16="http://schemas.microsoft.com/office/drawing/2014/main" id="{B6564BF3-C719-6C6B-A612-2ACC86AF19C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536449622"/>
                    </p:ext>
                  </p:extLst>
                </p:nvPr>
              </p:nvGraphicFramePr>
              <p:xfrm>
                <a:off x="7567186" y="3603934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8" imgW="2755436" imgH="1819712" progId="SigmaPlotGraphicObject.12">
                        <p:embed/>
                      </p:oleObj>
                    </mc:Choice>
                    <mc:Fallback>
                      <p:oleObj name="SPW 13.0 Graph" r:id="rId18" imgW="2755436" imgH="1819712" progId="SigmaPlotGraphicObject.12">
                        <p:embed/>
                        <p:pic>
                          <p:nvPicPr>
                            <p:cNvPr id="57" name="Object 56">
                              <a:extLst>
                                <a:ext uri="{FF2B5EF4-FFF2-40B4-BE49-F238E27FC236}">
                                  <a16:creationId xmlns:a16="http://schemas.microsoft.com/office/drawing/2014/main" id="{3851246D-8C4B-20A5-66CC-52D0992D1AB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3603934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8" name="Object 37">
                  <a:extLst>
                    <a:ext uri="{FF2B5EF4-FFF2-40B4-BE49-F238E27FC236}">
                      <a16:creationId xmlns:a16="http://schemas.microsoft.com/office/drawing/2014/main" id="{B07F2971-1EE1-82DC-E882-59EE2263121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71894586"/>
                    </p:ext>
                  </p:extLst>
                </p:nvPr>
              </p:nvGraphicFramePr>
              <p:xfrm>
                <a:off x="7567186" y="3076034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0" imgW="2755436" imgH="1819712" progId="SigmaPlotGraphicObject.12">
                        <p:embed/>
                      </p:oleObj>
                    </mc:Choice>
                    <mc:Fallback>
                      <p:oleObj name="SPW 13.0 Graph" r:id="rId20" imgW="2755436" imgH="1819712" progId="SigmaPlotGraphicObject.12">
                        <p:embed/>
                        <p:pic>
                          <p:nvPicPr>
                            <p:cNvPr id="93" name="Object 92">
                              <a:extLst>
                                <a:ext uri="{FF2B5EF4-FFF2-40B4-BE49-F238E27FC236}">
                                  <a16:creationId xmlns:a16="http://schemas.microsoft.com/office/drawing/2014/main" id="{3724E08A-ECEB-7E2A-7456-E2BA9A9E159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3076034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9" name="Object 38">
                  <a:extLst>
                    <a:ext uri="{FF2B5EF4-FFF2-40B4-BE49-F238E27FC236}">
                      <a16:creationId xmlns:a16="http://schemas.microsoft.com/office/drawing/2014/main" id="{EB409949-6EA9-0DB6-3B1D-C1CD802E2C3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31689800"/>
                    </p:ext>
                  </p:extLst>
                </p:nvPr>
              </p:nvGraphicFramePr>
              <p:xfrm>
                <a:off x="7567186" y="2425584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2" imgW="2755436" imgH="1819712" progId="SigmaPlotGraphicObject.12">
                        <p:embed/>
                      </p:oleObj>
                    </mc:Choice>
                    <mc:Fallback>
                      <p:oleObj name="SPW 13.0 Graph" r:id="rId22" imgW="2755436" imgH="1819712" progId="SigmaPlotGraphicObject.12">
                        <p:embed/>
                        <p:pic>
                          <p:nvPicPr>
                            <p:cNvPr id="94" name="Object 93">
                              <a:extLst>
                                <a:ext uri="{FF2B5EF4-FFF2-40B4-BE49-F238E27FC236}">
                                  <a16:creationId xmlns:a16="http://schemas.microsoft.com/office/drawing/2014/main" id="{99D9C9F5-ADB8-047F-BB50-DC1F82B4CC2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2425584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0" name="Object 39">
                  <a:extLst>
                    <a:ext uri="{FF2B5EF4-FFF2-40B4-BE49-F238E27FC236}">
                      <a16:creationId xmlns:a16="http://schemas.microsoft.com/office/drawing/2014/main" id="{AB49F63A-92A1-ECFA-7984-EBD731892DE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517822918"/>
                    </p:ext>
                  </p:extLst>
                </p:nvPr>
              </p:nvGraphicFramePr>
              <p:xfrm>
                <a:off x="7567186" y="202023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4" imgW="2755436" imgH="1819712" progId="SigmaPlotGraphicObject.12">
                        <p:embed/>
                      </p:oleObj>
                    </mc:Choice>
                    <mc:Fallback>
                      <p:oleObj name="SPW 13.0 Graph" r:id="rId24" imgW="2755436" imgH="1819712" progId="SigmaPlotGraphicObject.12">
                        <p:embed/>
                        <p:pic>
                          <p:nvPicPr>
                            <p:cNvPr id="95" name="Object 94">
                              <a:extLst>
                                <a:ext uri="{FF2B5EF4-FFF2-40B4-BE49-F238E27FC236}">
                                  <a16:creationId xmlns:a16="http://schemas.microsoft.com/office/drawing/2014/main" id="{81A749BC-927B-34E7-33D7-806F5AC0A11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202023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1" name="Object 40">
                  <a:extLst>
                    <a:ext uri="{FF2B5EF4-FFF2-40B4-BE49-F238E27FC236}">
                      <a16:creationId xmlns:a16="http://schemas.microsoft.com/office/drawing/2014/main" id="{586C0DAC-7A4E-2258-B545-3BB1576FA52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73148134"/>
                    </p:ext>
                  </p:extLst>
                </p:nvPr>
              </p:nvGraphicFramePr>
              <p:xfrm>
                <a:off x="7567186" y="160545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6" imgW="2755436" imgH="1819712" progId="SigmaPlotGraphicObject.12">
                        <p:embed/>
                      </p:oleObj>
                    </mc:Choice>
                    <mc:Fallback>
                      <p:oleObj name="SPW 13.0 Graph" r:id="rId26" imgW="2755436" imgH="1819712" progId="SigmaPlotGraphicObject.12">
                        <p:embed/>
                        <p:pic>
                          <p:nvPicPr>
                            <p:cNvPr id="128" name="Object 127">
                              <a:extLst>
                                <a:ext uri="{FF2B5EF4-FFF2-40B4-BE49-F238E27FC236}">
                                  <a16:creationId xmlns:a16="http://schemas.microsoft.com/office/drawing/2014/main" id="{68427C59-5729-B7BB-7246-2C745F57F37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160545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2" name="Object 41">
                  <a:extLst>
                    <a:ext uri="{FF2B5EF4-FFF2-40B4-BE49-F238E27FC236}">
                      <a16:creationId xmlns:a16="http://schemas.microsoft.com/office/drawing/2014/main" id="{EDAC551E-7E63-D880-5418-814894C7879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17151401"/>
                    </p:ext>
                  </p:extLst>
                </p:nvPr>
              </p:nvGraphicFramePr>
              <p:xfrm>
                <a:off x="7567186" y="1313221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8" imgW="2755436" imgH="1819712" progId="SigmaPlotGraphicObject.12">
                        <p:embed/>
                      </p:oleObj>
                    </mc:Choice>
                    <mc:Fallback>
                      <p:oleObj name="SPW 13.0 Graph" r:id="rId28" imgW="2755436" imgH="1819712" progId="SigmaPlotGraphicObject.12">
                        <p:embed/>
                        <p:pic>
                          <p:nvPicPr>
                            <p:cNvPr id="129" name="Object 128">
                              <a:extLst>
                                <a:ext uri="{FF2B5EF4-FFF2-40B4-BE49-F238E27FC236}">
                                  <a16:creationId xmlns:a16="http://schemas.microsoft.com/office/drawing/2014/main" id="{BD06C89D-4CC5-5BF9-48D6-776F9862C72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567186" y="1313221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236" name="Group 235">
                <a:extLst>
                  <a:ext uri="{FF2B5EF4-FFF2-40B4-BE49-F238E27FC236}">
                    <a16:creationId xmlns:a16="http://schemas.microsoft.com/office/drawing/2014/main" id="{64778312-7227-23C3-C8DA-187DB21A3984}"/>
                  </a:ext>
                </a:extLst>
              </p:cNvPr>
              <p:cNvGrpSpPr/>
              <p:nvPr/>
            </p:nvGrpSpPr>
            <p:grpSpPr>
              <a:xfrm>
                <a:off x="10079678" y="2134886"/>
                <a:ext cx="437384" cy="2507157"/>
                <a:chOff x="10060014" y="2134886"/>
                <a:chExt cx="437384" cy="2507157"/>
              </a:xfrm>
            </p:grpSpPr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9E35E77F-8FC9-C4EA-41E1-6893C600F5F1}"/>
                    </a:ext>
                  </a:extLst>
                </p:cNvPr>
                <p:cNvSpPr txBox="1"/>
                <p:nvPr/>
              </p:nvSpPr>
              <p:spPr>
                <a:xfrm>
                  <a:off x="10062664" y="3909829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255" name="TextBox 254">
                  <a:extLst>
                    <a:ext uri="{FF2B5EF4-FFF2-40B4-BE49-F238E27FC236}">
                      <a16:creationId xmlns:a16="http://schemas.microsoft.com/office/drawing/2014/main" id="{842F9976-5BE1-33D3-F5B2-CACCB86FE7AD}"/>
                    </a:ext>
                  </a:extLst>
                </p:cNvPr>
                <p:cNvSpPr txBox="1"/>
                <p:nvPr/>
              </p:nvSpPr>
              <p:spPr>
                <a:xfrm>
                  <a:off x="10060014" y="2134886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6EB41B3E-F99F-38EE-D37D-49C71132C548}"/>
                    </a:ext>
                  </a:extLst>
                </p:cNvPr>
                <p:cNvSpPr txBox="1"/>
                <p:nvPr/>
              </p:nvSpPr>
              <p:spPr>
                <a:xfrm>
                  <a:off x="10062664" y="2434698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CCE35F6E-3CF5-9008-D1AE-D4DAF1226315}"/>
                    </a:ext>
                  </a:extLst>
                </p:cNvPr>
                <p:cNvSpPr txBox="1"/>
                <p:nvPr/>
              </p:nvSpPr>
              <p:spPr>
                <a:xfrm>
                  <a:off x="10062664" y="2840094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47E735E5-CA30-1E1E-0005-5BB1FF3422EC}"/>
                    </a:ext>
                  </a:extLst>
                </p:cNvPr>
                <p:cNvSpPr txBox="1"/>
                <p:nvPr/>
              </p:nvSpPr>
              <p:spPr>
                <a:xfrm>
                  <a:off x="10062664" y="3243022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8AB3825F-466A-F87A-E10D-4A5CA5C5F40B}"/>
                    </a:ext>
                  </a:extLst>
                </p:cNvPr>
                <p:cNvSpPr txBox="1"/>
                <p:nvPr/>
              </p:nvSpPr>
              <p:spPr>
                <a:xfrm>
                  <a:off x="10061362" y="4441988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:1</a:t>
                  </a:r>
                </a:p>
              </p:txBody>
            </p:sp>
          </p:grp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1A742E4F-0546-FEE8-F50A-FCB73BA718C1}"/>
                </a:ext>
              </a:extLst>
            </p:cNvPr>
            <p:cNvGrpSpPr/>
            <p:nvPr/>
          </p:nvGrpSpPr>
          <p:grpSpPr>
            <a:xfrm>
              <a:off x="5214889" y="1488609"/>
              <a:ext cx="2893004" cy="3551824"/>
              <a:chOff x="2862332" y="2156466"/>
              <a:chExt cx="2893004" cy="3551824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C423E684-6B15-0020-710E-FC114306D24C}"/>
                  </a:ext>
                </a:extLst>
              </p:cNvPr>
              <p:cNvGrpSpPr/>
              <p:nvPr/>
            </p:nvGrpSpPr>
            <p:grpSpPr>
              <a:xfrm>
                <a:off x="2862332" y="2156466"/>
                <a:ext cx="2755900" cy="3551824"/>
                <a:chOff x="5006811" y="1815130"/>
                <a:chExt cx="2755900" cy="3551824"/>
              </a:xfrm>
            </p:grpSpPr>
            <p:graphicFrame>
              <p:nvGraphicFramePr>
                <p:cNvPr id="92" name="Object 91">
                  <a:extLst>
                    <a:ext uri="{FF2B5EF4-FFF2-40B4-BE49-F238E27FC236}">
                      <a16:creationId xmlns:a16="http://schemas.microsoft.com/office/drawing/2014/main" id="{AE35D919-905F-642B-B900-CB2969DC4CC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1815130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0" imgW="2755436" imgH="1819712" progId="SigmaPlotGraphicObject.12">
                        <p:embed/>
                      </p:oleObj>
                    </mc:Choice>
                    <mc:Fallback>
                      <p:oleObj name="SPW 13.0 Graph" r:id="rId30" imgW="2755436" imgH="1819712" progId="SigmaPlotGraphicObject.12">
                        <p:embed/>
                        <p:pic>
                          <p:nvPicPr>
                            <p:cNvPr id="10" name="Object 9">
                              <a:extLst>
                                <a:ext uri="{FF2B5EF4-FFF2-40B4-BE49-F238E27FC236}">
                                  <a16:creationId xmlns:a16="http://schemas.microsoft.com/office/drawing/2014/main" id="{251ACFC2-60EA-D083-82B3-A7E161929CB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1815130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0" name="Object 129">
                  <a:extLst>
                    <a:ext uri="{FF2B5EF4-FFF2-40B4-BE49-F238E27FC236}">
                      <a16:creationId xmlns:a16="http://schemas.microsoft.com/office/drawing/2014/main" id="{81487182-EF7B-F1F6-949D-7A5950BB2020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2339707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2" imgW="2755436" imgH="1819712" progId="SigmaPlotGraphicObject.12">
                        <p:embed/>
                      </p:oleObj>
                    </mc:Choice>
                    <mc:Fallback>
                      <p:oleObj name="SPW 13.0 Graph" r:id="rId32" imgW="2755436" imgH="1819712" progId="SigmaPlotGraphicObject.12">
                        <p:embed/>
                        <p:pic>
                          <p:nvPicPr>
                            <p:cNvPr id="11" name="Object 10">
                              <a:extLst>
                                <a:ext uri="{FF2B5EF4-FFF2-40B4-BE49-F238E27FC236}">
                                  <a16:creationId xmlns:a16="http://schemas.microsoft.com/office/drawing/2014/main" id="{2226A711-8190-7B88-54B3-A42FAAF20D9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2339707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1" name="Object 130">
                  <a:extLst>
                    <a:ext uri="{FF2B5EF4-FFF2-40B4-BE49-F238E27FC236}">
                      <a16:creationId xmlns:a16="http://schemas.microsoft.com/office/drawing/2014/main" id="{B239AA83-3B5D-675A-55CF-BEEA5C091A36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2763221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4" imgW="2755436" imgH="1819712" progId="SigmaPlotGraphicObject.12">
                        <p:embed/>
                      </p:oleObj>
                    </mc:Choice>
                    <mc:Fallback>
                      <p:oleObj name="SPW 13.0 Graph" r:id="rId34" imgW="2755436" imgH="1819712" progId="SigmaPlotGraphicObject.12">
                        <p:embed/>
                        <p:pic>
                          <p:nvPicPr>
                            <p:cNvPr id="12" name="Object 11">
                              <a:extLst>
                                <a:ext uri="{FF2B5EF4-FFF2-40B4-BE49-F238E27FC236}">
                                  <a16:creationId xmlns:a16="http://schemas.microsoft.com/office/drawing/2014/main" id="{B60013B9-2B35-F69C-EB53-EF48A92C3C3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2763221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2" name="Object 131">
                  <a:extLst>
                    <a:ext uri="{FF2B5EF4-FFF2-40B4-BE49-F238E27FC236}">
                      <a16:creationId xmlns:a16="http://schemas.microsoft.com/office/drawing/2014/main" id="{2B072501-016C-3FFA-A4B2-809E628EF226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308085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6" imgW="2755436" imgH="1819712" progId="SigmaPlotGraphicObject.12">
                        <p:embed/>
                      </p:oleObj>
                    </mc:Choice>
                    <mc:Fallback>
                      <p:oleObj name="SPW 13.0 Graph" r:id="rId36" imgW="2755436" imgH="1819712" progId="SigmaPlotGraphicObject.12">
                        <p:embed/>
                        <p:pic>
                          <p:nvPicPr>
                            <p:cNvPr id="13" name="Object 12">
                              <a:extLst>
                                <a:ext uri="{FF2B5EF4-FFF2-40B4-BE49-F238E27FC236}">
                                  <a16:creationId xmlns:a16="http://schemas.microsoft.com/office/drawing/2014/main" id="{36828B7E-DCE3-B374-BC93-F47ADE2E690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308085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3" name="Object 132">
                  <a:extLst>
                    <a:ext uri="{FF2B5EF4-FFF2-40B4-BE49-F238E27FC236}">
                      <a16:creationId xmlns:a16="http://schemas.microsoft.com/office/drawing/2014/main" id="{6B792A2E-F2AD-C301-0571-55A04ECBFB81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3355173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8" imgW="2755436" imgH="1819712" progId="SigmaPlotGraphicObject.12">
                        <p:embed/>
                      </p:oleObj>
                    </mc:Choice>
                    <mc:Fallback>
                      <p:oleObj name="SPW 13.0 Graph" r:id="rId38" imgW="2755436" imgH="1819712" progId="SigmaPlotGraphicObject.12">
                        <p:embed/>
                        <p:pic>
                          <p:nvPicPr>
                            <p:cNvPr id="14" name="Object 13">
                              <a:extLst>
                                <a:ext uri="{FF2B5EF4-FFF2-40B4-BE49-F238E27FC236}">
                                  <a16:creationId xmlns:a16="http://schemas.microsoft.com/office/drawing/2014/main" id="{C5AC699C-3CEE-4DF8-2D1C-BAB669B9354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3355173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4" name="Object 133">
                  <a:extLst>
                    <a:ext uri="{FF2B5EF4-FFF2-40B4-BE49-F238E27FC236}">
                      <a16:creationId xmlns:a16="http://schemas.microsoft.com/office/drawing/2014/main" id="{1F958056-8FCD-28F9-99B5-B6D0ADDE259B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006811" y="354767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0" imgW="2755436" imgH="1819712" progId="SigmaPlotGraphicObject.12">
                        <p:embed/>
                      </p:oleObj>
                    </mc:Choice>
                    <mc:Fallback>
                      <p:oleObj name="SPW 13.0 Graph" r:id="rId40" imgW="2755436" imgH="1819712" progId="SigmaPlotGraphicObject.12">
                        <p:embed/>
                        <p:pic>
                          <p:nvPicPr>
                            <p:cNvPr id="15" name="Object 14">
                              <a:extLst>
                                <a:ext uri="{FF2B5EF4-FFF2-40B4-BE49-F238E27FC236}">
                                  <a16:creationId xmlns:a16="http://schemas.microsoft.com/office/drawing/2014/main" id="{827D6EB2-5019-2ACD-A769-6A4D3B0D3D1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6811" y="354767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4D433473-05AC-D805-7D3D-C9B6DC2C68B4}"/>
                  </a:ext>
                </a:extLst>
              </p:cNvPr>
              <p:cNvGrpSpPr/>
              <p:nvPr/>
            </p:nvGrpSpPr>
            <p:grpSpPr>
              <a:xfrm>
                <a:off x="5320602" y="2970042"/>
                <a:ext cx="434734" cy="1944726"/>
                <a:chOff x="2958049" y="3252884"/>
                <a:chExt cx="434734" cy="1944726"/>
              </a:xfrm>
            </p:grpSpPr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0C751AB9-CCE9-2436-3347-6DCA2E9159F8}"/>
                    </a:ext>
                  </a:extLst>
                </p:cNvPr>
                <p:cNvSpPr txBox="1"/>
                <p:nvPr/>
              </p:nvSpPr>
              <p:spPr>
                <a:xfrm>
                  <a:off x="2958049" y="325288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5:1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03262CAC-E986-86D9-76DA-9DCF890987C1}"/>
                    </a:ext>
                  </a:extLst>
                </p:cNvPr>
                <p:cNvSpPr txBox="1"/>
                <p:nvPr/>
              </p:nvSpPr>
              <p:spPr>
                <a:xfrm>
                  <a:off x="2958049" y="499755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0829E901-1471-DB61-CC25-A59D3A4370F4}"/>
                    </a:ext>
                  </a:extLst>
                </p:cNvPr>
                <p:cNvSpPr txBox="1"/>
                <p:nvPr/>
              </p:nvSpPr>
              <p:spPr>
                <a:xfrm>
                  <a:off x="2958049" y="378450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ADA8CB47-50CD-8E26-BB36-DFCD9CE7729E}"/>
                    </a:ext>
                  </a:extLst>
                </p:cNvPr>
                <p:cNvSpPr txBox="1"/>
                <p:nvPr/>
              </p:nvSpPr>
              <p:spPr>
                <a:xfrm>
                  <a:off x="2958049" y="4219489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E64895B3-B232-950A-992B-EE281A012EE5}"/>
                    </a:ext>
                  </a:extLst>
                </p:cNvPr>
                <p:cNvSpPr txBox="1"/>
                <p:nvPr/>
              </p:nvSpPr>
              <p:spPr>
                <a:xfrm>
                  <a:off x="2958049" y="4537420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6614841C-2C59-CA9F-86B2-AA385F34924F}"/>
                    </a:ext>
                  </a:extLst>
                </p:cNvPr>
                <p:cNvSpPr txBox="1"/>
                <p:nvPr/>
              </p:nvSpPr>
              <p:spPr>
                <a:xfrm>
                  <a:off x="2958049" y="479987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</p:grp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F673546C-C8B1-FC59-1EBC-1A0F42A2713B}"/>
                  </a:ext>
                </a:extLst>
              </p:cNvPr>
              <p:cNvSpPr txBox="1"/>
              <p:nvPr/>
            </p:nvSpPr>
            <p:spPr>
              <a:xfrm>
                <a:off x="4164334" y="2430742"/>
                <a:ext cx="8947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Juglone-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39E7DDAA-58CB-0D82-05CC-4E22E6744687}"/>
                </a:ext>
              </a:extLst>
            </p:cNvPr>
            <p:cNvGrpSpPr/>
            <p:nvPr/>
          </p:nvGrpSpPr>
          <p:grpSpPr>
            <a:xfrm>
              <a:off x="2771799" y="1044321"/>
              <a:ext cx="3145656" cy="3850087"/>
              <a:chOff x="3180276" y="1072734"/>
              <a:chExt cx="3145656" cy="3850087"/>
            </a:xfrm>
          </p:grpSpPr>
          <p:grpSp>
            <p:nvGrpSpPr>
              <p:cNvPr id="151" name="Group 150">
                <a:extLst>
                  <a:ext uri="{FF2B5EF4-FFF2-40B4-BE49-F238E27FC236}">
                    <a16:creationId xmlns:a16="http://schemas.microsoft.com/office/drawing/2014/main" id="{844D25DD-8939-B080-BB40-A9F790F360F2}"/>
                  </a:ext>
                </a:extLst>
              </p:cNvPr>
              <p:cNvGrpSpPr/>
              <p:nvPr/>
            </p:nvGrpSpPr>
            <p:grpSpPr>
              <a:xfrm>
                <a:off x="3180276" y="1072734"/>
                <a:ext cx="3145656" cy="3850087"/>
                <a:chOff x="2878618" y="1025599"/>
                <a:chExt cx="3145656" cy="3850087"/>
              </a:xfrm>
            </p:grpSpPr>
            <p:grpSp>
              <p:nvGrpSpPr>
                <p:cNvPr id="155" name="Group 154">
                  <a:extLst>
                    <a:ext uri="{FF2B5EF4-FFF2-40B4-BE49-F238E27FC236}">
                      <a16:creationId xmlns:a16="http://schemas.microsoft.com/office/drawing/2014/main" id="{C2B9F3A0-3605-EDDC-D443-EAE3488187CF}"/>
                    </a:ext>
                  </a:extLst>
                </p:cNvPr>
                <p:cNvGrpSpPr/>
                <p:nvPr/>
              </p:nvGrpSpPr>
              <p:grpSpPr>
                <a:xfrm>
                  <a:off x="5369928" y="1848680"/>
                  <a:ext cx="654346" cy="2240835"/>
                  <a:chOff x="2958049" y="2273078"/>
                  <a:chExt cx="654346" cy="2240835"/>
                </a:xfrm>
              </p:grpSpPr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91599A35-25BE-1A8D-B5D9-F0CC81CAE836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4313858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:1</a:t>
                    </a:r>
                  </a:p>
                </p:txBody>
              </p:sp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A36871F7-28D4-40F1-AB51-220794823FB2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2273078"/>
                    <a:ext cx="6543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ug (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x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03DDEB94-455F-9D22-4102-16B394DCEE46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2681361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:1</a:t>
                    </a:r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609C4B6B-6DF0-03AD-30AC-6469A13A387E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3246370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5:1</a:t>
                    </a:r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F8246EA1-DB07-8F96-47A9-4AAA2AA65D00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3769837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:1</a:t>
                    </a:r>
                  </a:p>
                </p:txBody>
              </p:sp>
              <p:sp>
                <p:nvSpPr>
                  <p:cNvPr id="167" name="TextBox 166">
                    <a:extLst>
                      <a:ext uri="{FF2B5EF4-FFF2-40B4-BE49-F238E27FC236}">
                        <a16:creationId xmlns:a16="http://schemas.microsoft.com/office/drawing/2014/main" id="{B1090ECB-CCEA-496F-C79B-44C9E2E33D76}"/>
                      </a:ext>
                    </a:extLst>
                  </p:cNvPr>
                  <p:cNvSpPr txBox="1"/>
                  <p:nvPr/>
                </p:nvSpPr>
                <p:spPr>
                  <a:xfrm>
                    <a:off x="2958049" y="4082626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:1</a:t>
                    </a:r>
                  </a:p>
                </p:txBody>
              </p:sp>
            </p:grpSp>
            <p:grpSp>
              <p:nvGrpSpPr>
                <p:cNvPr id="156" name="Group 155">
                  <a:extLst>
                    <a:ext uri="{FF2B5EF4-FFF2-40B4-BE49-F238E27FC236}">
                      <a16:creationId xmlns:a16="http://schemas.microsoft.com/office/drawing/2014/main" id="{EF97DECF-FFA5-989B-7C55-9762116EED76}"/>
                    </a:ext>
                  </a:extLst>
                </p:cNvPr>
                <p:cNvGrpSpPr/>
                <p:nvPr/>
              </p:nvGrpSpPr>
              <p:grpSpPr>
                <a:xfrm>
                  <a:off x="2878618" y="1025599"/>
                  <a:ext cx="2755900" cy="3850087"/>
                  <a:chOff x="2878618" y="997319"/>
                  <a:chExt cx="2755900" cy="3850087"/>
                </a:xfrm>
              </p:grpSpPr>
              <p:graphicFrame>
                <p:nvGraphicFramePr>
                  <p:cNvPr id="157" name="Object 156">
                    <a:extLst>
                      <a:ext uri="{FF2B5EF4-FFF2-40B4-BE49-F238E27FC236}">
                        <a16:creationId xmlns:a16="http://schemas.microsoft.com/office/drawing/2014/main" id="{11C6D76C-17E7-B32A-C767-C7B9C1AE7C0C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699264607"/>
                      </p:ext>
                    </p:extLst>
                  </p:nvPr>
                </p:nvGraphicFramePr>
                <p:xfrm>
                  <a:off x="2878618" y="1991115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42" imgW="2755436" imgH="1819712" progId="SigmaPlotGraphicObject.12">
                          <p:embed/>
                        </p:oleObj>
                      </mc:Choice>
                      <mc:Fallback>
                        <p:oleObj name="SPW 13.0 Graph" r:id="rId42" imgW="2755436" imgH="1819712" progId="SigmaPlotGraphicObject.12">
                          <p:embed/>
                          <p:pic>
                            <p:nvPicPr>
                              <p:cNvPr id="253" name="Object 252">
                                <a:extLst>
                                  <a:ext uri="{FF2B5EF4-FFF2-40B4-BE49-F238E27FC236}">
                                    <a16:creationId xmlns:a16="http://schemas.microsoft.com/office/drawing/2014/main" id="{3D91D9C6-74D8-0685-68BF-0650BF47AD7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4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878618" y="1991115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58" name="Object 157">
                    <a:extLst>
                      <a:ext uri="{FF2B5EF4-FFF2-40B4-BE49-F238E27FC236}">
                        <a16:creationId xmlns:a16="http://schemas.microsoft.com/office/drawing/2014/main" id="{03290A1D-B5F0-C90D-299F-8DFFE5539433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656169827"/>
                      </p:ext>
                    </p:extLst>
                  </p:nvPr>
                </p:nvGraphicFramePr>
                <p:xfrm>
                  <a:off x="2878618" y="2507137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44" imgW="2755436" imgH="1819712" progId="SigmaPlotGraphicObject.12">
                          <p:embed/>
                        </p:oleObj>
                      </mc:Choice>
                      <mc:Fallback>
                        <p:oleObj name="SPW 13.0 Graph" r:id="rId44" imgW="2755436" imgH="1819712" progId="SigmaPlotGraphicObject.12">
                          <p:embed/>
                          <p:pic>
                            <p:nvPicPr>
                              <p:cNvPr id="71" name="Object 70">
                                <a:extLst>
                                  <a:ext uri="{FF2B5EF4-FFF2-40B4-BE49-F238E27FC236}">
                                    <a16:creationId xmlns:a16="http://schemas.microsoft.com/office/drawing/2014/main" id="{8BD6F41F-EE1B-7248-23E3-2EEA6E3DD83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4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878618" y="2507137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59" name="Object 158">
                    <a:extLst>
                      <a:ext uri="{FF2B5EF4-FFF2-40B4-BE49-F238E27FC236}">
                        <a16:creationId xmlns:a16="http://schemas.microsoft.com/office/drawing/2014/main" id="{E46C6735-CA1E-F935-9FBD-B51EB47CB74B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18137187"/>
                      </p:ext>
                    </p:extLst>
                  </p:nvPr>
                </p:nvGraphicFramePr>
                <p:xfrm>
                  <a:off x="2878618" y="2783594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46" imgW="2755436" imgH="1819712" progId="SigmaPlotGraphicObject.12">
                          <p:embed/>
                        </p:oleObj>
                      </mc:Choice>
                      <mc:Fallback>
                        <p:oleObj name="SPW 13.0 Graph" r:id="rId46" imgW="2755436" imgH="1819712" progId="SigmaPlotGraphicObject.12">
                          <p:embed/>
                          <p:pic>
                            <p:nvPicPr>
                              <p:cNvPr id="72" name="Object 71">
                                <a:extLst>
                                  <a:ext uri="{FF2B5EF4-FFF2-40B4-BE49-F238E27FC236}">
                                    <a16:creationId xmlns:a16="http://schemas.microsoft.com/office/drawing/2014/main" id="{C584FB41-9F4B-BE8A-AA56-3330A95F1AF9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4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878618" y="2783594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60" name="Object 159">
                    <a:extLst>
                      <a:ext uri="{FF2B5EF4-FFF2-40B4-BE49-F238E27FC236}">
                        <a16:creationId xmlns:a16="http://schemas.microsoft.com/office/drawing/2014/main" id="{56434BD5-6AF8-5144-C9B7-C6D8BEBA3651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969468486"/>
                      </p:ext>
                    </p:extLst>
                  </p:nvPr>
                </p:nvGraphicFramePr>
                <p:xfrm>
                  <a:off x="2878618" y="3028131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48" imgW="2755436" imgH="1819712" progId="SigmaPlotGraphicObject.12">
                          <p:embed/>
                        </p:oleObj>
                      </mc:Choice>
                      <mc:Fallback>
                        <p:oleObj name="SPW 13.0 Graph" r:id="rId48" imgW="2755436" imgH="1819712" progId="SigmaPlotGraphicObject.12">
                          <p:embed/>
                          <p:pic>
                            <p:nvPicPr>
                              <p:cNvPr id="73" name="Object 72">
                                <a:extLst>
                                  <a:ext uri="{FF2B5EF4-FFF2-40B4-BE49-F238E27FC236}">
                                    <a16:creationId xmlns:a16="http://schemas.microsoft.com/office/drawing/2014/main" id="{F77D3E96-77BF-ACC7-8791-857042ACF51B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4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878618" y="3028131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61" name="Object 160">
                    <a:extLst>
                      <a:ext uri="{FF2B5EF4-FFF2-40B4-BE49-F238E27FC236}">
                        <a16:creationId xmlns:a16="http://schemas.microsoft.com/office/drawing/2014/main" id="{70B4F9D5-B024-5506-6F10-484C47A29B2B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514135028"/>
                      </p:ext>
                    </p:extLst>
                  </p:nvPr>
                </p:nvGraphicFramePr>
                <p:xfrm>
                  <a:off x="2878618" y="997319"/>
                  <a:ext cx="2755900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50" imgW="2755436" imgH="1819712" progId="SigmaPlotGraphicObject.12">
                          <p:embed/>
                        </p:oleObj>
                      </mc:Choice>
                      <mc:Fallback>
                        <p:oleObj name="SPW 13.0 Graph" r:id="rId50" imgW="2755436" imgH="1819712" progId="SigmaPlotGraphicObject.12">
                          <p:embed/>
                          <p:pic>
                            <p:nvPicPr>
                              <p:cNvPr id="74" name="Object 73">
                                <a:extLst>
                                  <a:ext uri="{FF2B5EF4-FFF2-40B4-BE49-F238E27FC236}">
                                    <a16:creationId xmlns:a16="http://schemas.microsoft.com/office/drawing/2014/main" id="{4CED050E-86F2-3407-6874-7E73EFC4266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5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878618" y="997319"/>
                                <a:ext cx="2755900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</p:grpSp>
          <p:graphicFrame>
            <p:nvGraphicFramePr>
              <p:cNvPr id="153" name="Object 152">
                <a:extLst>
                  <a:ext uri="{FF2B5EF4-FFF2-40B4-BE49-F238E27FC236}">
                    <a16:creationId xmlns:a16="http://schemas.microsoft.com/office/drawing/2014/main" id="{D9C7B908-1A14-7ECE-5FFF-274CFE4C85E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39169172"/>
                  </p:ext>
                </p:extLst>
              </p:nvPr>
            </p:nvGraphicFramePr>
            <p:xfrm>
              <a:off x="3180418" y="1474080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52" imgW="2755436" imgH="1819712" progId="SigmaPlotGraphicObject.12">
                      <p:embed/>
                    </p:oleObj>
                  </mc:Choice>
                  <mc:Fallback>
                    <p:oleObj name="SPW 13.0 Graph" r:id="rId52" imgW="2755436" imgH="1819712" progId="SigmaPlotGraphicObject.12">
                      <p:embed/>
                      <p:pic>
                        <p:nvPicPr>
                          <p:cNvPr id="17" name="Object 16">
                            <a:extLst>
                              <a:ext uri="{FF2B5EF4-FFF2-40B4-BE49-F238E27FC236}">
                                <a16:creationId xmlns:a16="http://schemas.microsoft.com/office/drawing/2014/main" id="{F235C449-1F2A-454F-7A59-EFA96008BE6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3"/>
                          <a:stretch>
                            <a:fillRect/>
                          </a:stretch>
                        </p:blipFill>
                        <p:spPr>
                          <a:xfrm>
                            <a:off x="3180418" y="1474080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443442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>
            <a:extLst>
              <a:ext uri="{FF2B5EF4-FFF2-40B4-BE49-F238E27FC236}">
                <a16:creationId xmlns:a16="http://schemas.microsoft.com/office/drawing/2014/main" id="{17088CD6-0D3D-8DFC-E941-FFCB15B27599}"/>
              </a:ext>
            </a:extLst>
          </p:cNvPr>
          <p:cNvSpPr txBox="1"/>
          <p:nvPr/>
        </p:nvSpPr>
        <p:spPr>
          <a:xfrm>
            <a:off x="294972" y="210278"/>
            <a:ext cx="242084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6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0F9D9D2-EFD8-D6C8-3D2F-74B9C111E9EB}"/>
              </a:ext>
            </a:extLst>
          </p:cNvPr>
          <p:cNvGrpSpPr/>
          <p:nvPr/>
        </p:nvGrpSpPr>
        <p:grpSpPr>
          <a:xfrm>
            <a:off x="1540055" y="1350093"/>
            <a:ext cx="8544690" cy="3888028"/>
            <a:chOff x="1224370" y="566322"/>
            <a:chExt cx="8544690" cy="3888028"/>
          </a:xfrm>
        </p:grpSpPr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548786E-DE87-350F-5169-D75009CDCC96}"/>
                </a:ext>
              </a:extLst>
            </p:cNvPr>
            <p:cNvSpPr txBox="1"/>
            <p:nvPr/>
          </p:nvSpPr>
          <p:spPr>
            <a:xfrm>
              <a:off x="6934793" y="103710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41EF30F3-DA6F-380C-96A2-0932C27150E4}"/>
                </a:ext>
              </a:extLst>
            </p:cNvPr>
            <p:cNvSpPr txBox="1"/>
            <p:nvPr/>
          </p:nvSpPr>
          <p:spPr>
            <a:xfrm>
              <a:off x="7531545" y="1100657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lumbagin-H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5AFDB242-9DCD-A01F-17C1-0B4BA5BE7E07}"/>
                </a:ext>
              </a:extLst>
            </p:cNvPr>
            <p:cNvSpPr txBox="1"/>
            <p:nvPr/>
          </p:nvSpPr>
          <p:spPr>
            <a:xfrm>
              <a:off x="3524434" y="322871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315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0D82E2C8-7C00-155B-C252-B25D8466F89C}"/>
                </a:ext>
              </a:extLst>
            </p:cNvPr>
            <p:cNvSpPr txBox="1"/>
            <p:nvPr/>
          </p:nvSpPr>
          <p:spPr>
            <a:xfrm>
              <a:off x="4391633" y="3382948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uss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30BCC4D3-2F82-5758-C89D-BEA8C9FAC4C9}"/>
                </a:ext>
              </a:extLst>
            </p:cNvPr>
            <p:cNvSpPr txBox="1"/>
            <p:nvPr/>
          </p:nvSpPr>
          <p:spPr>
            <a:xfrm>
              <a:off x="3982462" y="322871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320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E636F1E2-B307-4E3A-8882-CA4CB50791EE}"/>
                </a:ext>
              </a:extLst>
            </p:cNvPr>
            <p:cNvSpPr txBox="1"/>
            <p:nvPr/>
          </p:nvSpPr>
          <p:spPr>
            <a:xfrm>
              <a:off x="4442976" y="322871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325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9DE24BB0-BC23-48D9-045E-D08827076892}"/>
                </a:ext>
              </a:extLst>
            </p:cNvPr>
            <p:cNvSpPr txBox="1"/>
            <p:nvPr/>
          </p:nvSpPr>
          <p:spPr>
            <a:xfrm>
              <a:off x="4896035" y="322871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330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BD6D9CD7-535E-4C26-EA80-7736B2DE670D}"/>
                </a:ext>
              </a:extLst>
            </p:cNvPr>
            <p:cNvSpPr txBox="1"/>
            <p:nvPr/>
          </p:nvSpPr>
          <p:spPr>
            <a:xfrm>
              <a:off x="5354063" y="322871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335</a:t>
              </a:r>
            </a:p>
          </p:txBody>
        </p:sp>
        <p:grpSp>
          <p:nvGrpSpPr>
            <p:cNvPr id="243" name="Group 242">
              <a:extLst>
                <a:ext uri="{FF2B5EF4-FFF2-40B4-BE49-F238E27FC236}">
                  <a16:creationId xmlns:a16="http://schemas.microsoft.com/office/drawing/2014/main" id="{E3B65FC1-793C-4F78-69BB-179EE7755485}"/>
                </a:ext>
              </a:extLst>
            </p:cNvPr>
            <p:cNvGrpSpPr/>
            <p:nvPr/>
          </p:nvGrpSpPr>
          <p:grpSpPr>
            <a:xfrm>
              <a:off x="3757929" y="3229929"/>
              <a:ext cx="1826315" cy="49693"/>
              <a:chOff x="8073059" y="5173317"/>
              <a:chExt cx="1826315" cy="49693"/>
            </a:xfrm>
          </p:grpSpPr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B628E7E6-E116-205D-707E-35CDF497CF6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73059" y="5173317"/>
                <a:ext cx="182631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0" name="Group 269">
                <a:extLst>
                  <a:ext uri="{FF2B5EF4-FFF2-40B4-BE49-F238E27FC236}">
                    <a16:creationId xmlns:a16="http://schemas.microsoft.com/office/drawing/2014/main" id="{98E9879D-B5F0-669B-BE1C-CE831BCEF420}"/>
                  </a:ext>
                </a:extLst>
              </p:cNvPr>
              <p:cNvGrpSpPr/>
              <p:nvPr/>
            </p:nvGrpSpPr>
            <p:grpSpPr>
              <a:xfrm>
                <a:off x="8073059" y="5174143"/>
                <a:ext cx="1826315" cy="48867"/>
                <a:chOff x="8073059" y="5034997"/>
                <a:chExt cx="1826315" cy="129209"/>
              </a:xfrm>
            </p:grpSpPr>
            <p:cxnSp>
              <p:nvCxnSpPr>
                <p:cNvPr id="271" name="Straight Connector 270">
                  <a:extLst>
                    <a:ext uri="{FF2B5EF4-FFF2-40B4-BE49-F238E27FC236}">
                      <a16:creationId xmlns:a16="http://schemas.microsoft.com/office/drawing/2014/main" id="{C70C6848-90E3-0201-BAA2-C6D8F934FE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29638" y="5034997"/>
                  <a:ext cx="0" cy="12920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2" name="Straight Connector 271">
                  <a:extLst>
                    <a:ext uri="{FF2B5EF4-FFF2-40B4-BE49-F238E27FC236}">
                      <a16:creationId xmlns:a16="http://schemas.microsoft.com/office/drawing/2014/main" id="{7604C061-078F-1CD1-25B2-A15E6C6512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86217" y="5034997"/>
                  <a:ext cx="0" cy="12920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3" name="Straight Connector 272">
                  <a:extLst>
                    <a:ext uri="{FF2B5EF4-FFF2-40B4-BE49-F238E27FC236}">
                      <a16:creationId xmlns:a16="http://schemas.microsoft.com/office/drawing/2014/main" id="{07641ED6-5AE5-49F7-5AD0-B3045D0F6E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42796" y="5034997"/>
                  <a:ext cx="0" cy="12920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4" name="Straight Connector 273">
                  <a:extLst>
                    <a:ext uri="{FF2B5EF4-FFF2-40B4-BE49-F238E27FC236}">
                      <a16:creationId xmlns:a16="http://schemas.microsoft.com/office/drawing/2014/main" id="{6A732FF8-A0E4-1220-40E1-967802B417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73059" y="5034997"/>
                  <a:ext cx="0" cy="12920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5" name="Straight Connector 274">
                  <a:extLst>
                    <a:ext uri="{FF2B5EF4-FFF2-40B4-BE49-F238E27FC236}">
                      <a16:creationId xmlns:a16="http://schemas.microsoft.com/office/drawing/2014/main" id="{ECB6CF33-8779-7250-9D71-345D12D183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99374" y="5034997"/>
                  <a:ext cx="0" cy="12920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9B85EF35-EEBC-7C28-2BAF-8401A79E023D}"/>
                </a:ext>
              </a:extLst>
            </p:cNvPr>
            <p:cNvSpPr txBox="1"/>
            <p:nvPr/>
          </p:nvSpPr>
          <p:spPr>
            <a:xfrm>
              <a:off x="1899284" y="10485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05A5CDF1-4223-4380-DBB5-A6C686AA4839}"/>
                </a:ext>
              </a:extLst>
            </p:cNvPr>
            <p:cNvSpPr txBox="1"/>
            <p:nvPr/>
          </p:nvSpPr>
          <p:spPr>
            <a:xfrm>
              <a:off x="4402722" y="103442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253" name="Group 252">
              <a:extLst>
                <a:ext uri="{FF2B5EF4-FFF2-40B4-BE49-F238E27FC236}">
                  <a16:creationId xmlns:a16="http://schemas.microsoft.com/office/drawing/2014/main" id="{54C86FF5-569B-0195-FE36-9B5E4521A2C6}"/>
                </a:ext>
              </a:extLst>
            </p:cNvPr>
            <p:cNvGrpSpPr/>
            <p:nvPr/>
          </p:nvGrpSpPr>
          <p:grpSpPr>
            <a:xfrm>
              <a:off x="3758112" y="838685"/>
              <a:ext cx="3282015" cy="3052795"/>
              <a:chOff x="6970297" y="1302666"/>
              <a:chExt cx="3282015" cy="3052795"/>
            </a:xfrm>
          </p:grpSpPr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5AFA055D-CC20-F7CA-16E4-E3F557A75FC7}"/>
                  </a:ext>
                </a:extLst>
              </p:cNvPr>
              <p:cNvGrpSpPr/>
              <p:nvPr/>
            </p:nvGrpSpPr>
            <p:grpSpPr>
              <a:xfrm>
                <a:off x="6970297" y="1302666"/>
                <a:ext cx="2755900" cy="3052795"/>
                <a:chOff x="6970297" y="1302666"/>
                <a:chExt cx="2755900" cy="3052795"/>
              </a:xfrm>
            </p:grpSpPr>
            <p:graphicFrame>
              <p:nvGraphicFramePr>
                <p:cNvPr id="263" name="Object 262">
                  <a:extLst>
                    <a:ext uri="{FF2B5EF4-FFF2-40B4-BE49-F238E27FC236}">
                      <a16:creationId xmlns:a16="http://schemas.microsoft.com/office/drawing/2014/main" id="{4580C4F9-E5D0-041E-EE99-2ECF6287766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740715732"/>
                    </p:ext>
                  </p:extLst>
                </p:nvPr>
              </p:nvGraphicFramePr>
              <p:xfrm>
                <a:off x="6970297" y="130266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2755436" imgH="1819712" progId="SigmaPlotGraphicObject.12">
                        <p:embed/>
                      </p:oleObj>
                    </mc:Choice>
                    <mc:Fallback>
                      <p:oleObj name="SPW 13.0 Graph" r:id="rId2" imgW="2755436" imgH="1819712" progId="SigmaPlotGraphicObject.12">
                        <p:embed/>
                        <p:pic>
                          <p:nvPicPr>
                            <p:cNvPr id="263" name="Object 262">
                              <a:extLst>
                                <a:ext uri="{FF2B5EF4-FFF2-40B4-BE49-F238E27FC236}">
                                  <a16:creationId xmlns:a16="http://schemas.microsoft.com/office/drawing/2014/main" id="{4580C4F9-E5D0-041E-EE99-2ECF6287766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130266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4" name="Object 263">
                  <a:extLst>
                    <a:ext uri="{FF2B5EF4-FFF2-40B4-BE49-F238E27FC236}">
                      <a16:creationId xmlns:a16="http://schemas.microsoft.com/office/drawing/2014/main" id="{FF9AB937-14D5-8C34-7480-4539A555AD6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218646110"/>
                    </p:ext>
                  </p:extLst>
                </p:nvPr>
              </p:nvGraphicFramePr>
              <p:xfrm>
                <a:off x="6970297" y="1492911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755436" imgH="1819712" progId="SigmaPlotGraphicObject.12">
                        <p:embed/>
                      </p:oleObj>
                    </mc:Choice>
                    <mc:Fallback>
                      <p:oleObj name="SPW 13.0 Graph" r:id="rId4" imgW="2755436" imgH="1819712" progId="SigmaPlotGraphicObject.12">
                        <p:embed/>
                        <p:pic>
                          <p:nvPicPr>
                            <p:cNvPr id="264" name="Object 263">
                              <a:extLst>
                                <a:ext uri="{FF2B5EF4-FFF2-40B4-BE49-F238E27FC236}">
                                  <a16:creationId xmlns:a16="http://schemas.microsoft.com/office/drawing/2014/main" id="{FF9AB937-14D5-8C34-7480-4539A555AD6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1492911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5" name="Object 264">
                  <a:extLst>
                    <a:ext uri="{FF2B5EF4-FFF2-40B4-BE49-F238E27FC236}">
                      <a16:creationId xmlns:a16="http://schemas.microsoft.com/office/drawing/2014/main" id="{661F08A1-A169-0940-6967-5E331DB52F0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85655342"/>
                    </p:ext>
                  </p:extLst>
                </p:nvPr>
              </p:nvGraphicFramePr>
              <p:xfrm>
                <a:off x="6970297" y="178134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755436" imgH="1819712" progId="SigmaPlotGraphicObject.12">
                        <p:embed/>
                      </p:oleObj>
                    </mc:Choice>
                    <mc:Fallback>
                      <p:oleObj name="SPW 13.0 Graph" r:id="rId6" imgW="2755436" imgH="1819712" progId="SigmaPlotGraphicObject.12">
                        <p:embed/>
                        <p:pic>
                          <p:nvPicPr>
                            <p:cNvPr id="265" name="Object 264">
                              <a:extLst>
                                <a:ext uri="{FF2B5EF4-FFF2-40B4-BE49-F238E27FC236}">
                                  <a16:creationId xmlns:a16="http://schemas.microsoft.com/office/drawing/2014/main" id="{661F08A1-A169-0940-6967-5E331DB52F0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178134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6" name="Object 265">
                  <a:extLst>
                    <a:ext uri="{FF2B5EF4-FFF2-40B4-BE49-F238E27FC236}">
                      <a16:creationId xmlns:a16="http://schemas.microsoft.com/office/drawing/2014/main" id="{8E66F968-5EC4-A5DB-276F-5B13BBE56B1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7071199"/>
                    </p:ext>
                  </p:extLst>
                </p:nvPr>
              </p:nvGraphicFramePr>
              <p:xfrm>
                <a:off x="6970297" y="2063643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2755436" imgH="1819712" progId="SigmaPlotGraphicObject.12">
                        <p:embed/>
                      </p:oleObj>
                    </mc:Choice>
                    <mc:Fallback>
                      <p:oleObj name="SPW 13.0 Graph" r:id="rId8" imgW="2755436" imgH="1819712" progId="SigmaPlotGraphicObject.12">
                        <p:embed/>
                        <p:pic>
                          <p:nvPicPr>
                            <p:cNvPr id="266" name="Object 265">
                              <a:extLst>
                                <a:ext uri="{FF2B5EF4-FFF2-40B4-BE49-F238E27FC236}">
                                  <a16:creationId xmlns:a16="http://schemas.microsoft.com/office/drawing/2014/main" id="{8E66F968-5EC4-A5DB-276F-5B13BBE56B1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2063643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7" name="Object 266">
                  <a:extLst>
                    <a:ext uri="{FF2B5EF4-FFF2-40B4-BE49-F238E27FC236}">
                      <a16:creationId xmlns:a16="http://schemas.microsoft.com/office/drawing/2014/main" id="{6882B29B-A54D-3665-F433-2730EE09F02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004361025"/>
                    </p:ext>
                  </p:extLst>
                </p:nvPr>
              </p:nvGraphicFramePr>
              <p:xfrm>
                <a:off x="6970297" y="2309120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2755436" imgH="1819712" progId="SigmaPlotGraphicObject.12">
                        <p:embed/>
                      </p:oleObj>
                    </mc:Choice>
                    <mc:Fallback>
                      <p:oleObj name="SPW 13.0 Graph" r:id="rId10" imgW="2755436" imgH="1819712" progId="SigmaPlotGraphicObject.12">
                        <p:embed/>
                        <p:pic>
                          <p:nvPicPr>
                            <p:cNvPr id="267" name="Object 266">
                              <a:extLst>
                                <a:ext uri="{FF2B5EF4-FFF2-40B4-BE49-F238E27FC236}">
                                  <a16:creationId xmlns:a16="http://schemas.microsoft.com/office/drawing/2014/main" id="{6882B29B-A54D-3665-F433-2730EE09F02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2309120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8" name="Object 267">
                  <a:extLst>
                    <a:ext uri="{FF2B5EF4-FFF2-40B4-BE49-F238E27FC236}">
                      <a16:creationId xmlns:a16="http://schemas.microsoft.com/office/drawing/2014/main" id="{6487B71A-B8B3-5098-8089-1F88EA0240A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65101447"/>
                    </p:ext>
                  </p:extLst>
                </p:nvPr>
              </p:nvGraphicFramePr>
              <p:xfrm>
                <a:off x="6970297" y="253618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2755436" imgH="1819712" progId="SigmaPlotGraphicObject.12">
                        <p:embed/>
                      </p:oleObj>
                    </mc:Choice>
                    <mc:Fallback>
                      <p:oleObj name="SPW 13.0 Graph" r:id="rId12" imgW="2755436" imgH="1819712" progId="SigmaPlotGraphicObject.12">
                        <p:embed/>
                        <p:pic>
                          <p:nvPicPr>
                            <p:cNvPr id="268" name="Object 267">
                              <a:extLst>
                                <a:ext uri="{FF2B5EF4-FFF2-40B4-BE49-F238E27FC236}">
                                  <a16:creationId xmlns:a16="http://schemas.microsoft.com/office/drawing/2014/main" id="{6487B71A-B8B3-5098-8089-1F88EA0240A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70297" y="253618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56B16EB9-275C-D21A-D43E-C9DAC2CAF2CB}"/>
                  </a:ext>
                </a:extLst>
              </p:cNvPr>
              <p:cNvGrpSpPr/>
              <p:nvPr/>
            </p:nvGrpSpPr>
            <p:grpSpPr>
              <a:xfrm>
                <a:off x="9445681" y="2136128"/>
                <a:ext cx="806631" cy="1428240"/>
                <a:chOff x="2958049" y="3668922"/>
                <a:chExt cx="806631" cy="1428240"/>
              </a:xfrm>
            </p:grpSpPr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CBB9EB5F-D594-C4AF-C428-25902BE70636}"/>
                    </a:ext>
                  </a:extLst>
                </p:cNvPr>
                <p:cNvSpPr txBox="1"/>
                <p:nvPr/>
              </p:nvSpPr>
              <p:spPr>
                <a:xfrm>
                  <a:off x="2958049" y="4897107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257" name="TextBox 256">
                  <a:extLst>
                    <a:ext uri="{FF2B5EF4-FFF2-40B4-BE49-F238E27FC236}">
                      <a16:creationId xmlns:a16="http://schemas.microsoft.com/office/drawing/2014/main" id="{82BDDE6B-E794-F211-A6A7-FD73A3490288}"/>
                    </a:ext>
                  </a:extLst>
                </p:cNvPr>
                <p:cNvSpPr txBox="1"/>
                <p:nvPr/>
              </p:nvSpPr>
              <p:spPr>
                <a:xfrm>
                  <a:off x="2958049" y="3668922"/>
                  <a:ext cx="80663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umb(hypoxia)</a:t>
                  </a:r>
                </a:p>
              </p:txBody>
            </p:sp>
            <p:sp>
              <p:nvSpPr>
                <p:cNvPr id="259" name="TextBox 258">
                  <a:extLst>
                    <a:ext uri="{FF2B5EF4-FFF2-40B4-BE49-F238E27FC236}">
                      <a16:creationId xmlns:a16="http://schemas.microsoft.com/office/drawing/2014/main" id="{E47AF6A2-4B2E-4569-6F70-EE280C8FD008}"/>
                    </a:ext>
                  </a:extLst>
                </p:cNvPr>
                <p:cNvSpPr txBox="1"/>
                <p:nvPr/>
              </p:nvSpPr>
              <p:spPr>
                <a:xfrm>
                  <a:off x="2958049" y="3850315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260" name="TextBox 259">
                  <a:extLst>
                    <a:ext uri="{FF2B5EF4-FFF2-40B4-BE49-F238E27FC236}">
                      <a16:creationId xmlns:a16="http://schemas.microsoft.com/office/drawing/2014/main" id="{2BB4FD23-2A4F-6858-686E-C09FE2D6A26A}"/>
                    </a:ext>
                  </a:extLst>
                </p:cNvPr>
                <p:cNvSpPr txBox="1"/>
                <p:nvPr/>
              </p:nvSpPr>
              <p:spPr>
                <a:xfrm>
                  <a:off x="2958049" y="4143288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261" name="TextBox 260">
                  <a:extLst>
                    <a:ext uri="{FF2B5EF4-FFF2-40B4-BE49-F238E27FC236}">
                      <a16:creationId xmlns:a16="http://schemas.microsoft.com/office/drawing/2014/main" id="{5D751766-5EE1-1BED-37CF-F831EB8A253A}"/>
                    </a:ext>
                  </a:extLst>
                </p:cNvPr>
                <p:cNvSpPr txBox="1"/>
                <p:nvPr/>
              </p:nvSpPr>
              <p:spPr>
                <a:xfrm>
                  <a:off x="2958049" y="4436973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262" name="TextBox 261">
                  <a:extLst>
                    <a:ext uri="{FF2B5EF4-FFF2-40B4-BE49-F238E27FC236}">
                      <a16:creationId xmlns:a16="http://schemas.microsoft.com/office/drawing/2014/main" id="{BF61A01E-5819-BB7E-B7B5-638A6B5D2473}"/>
                    </a:ext>
                  </a:extLst>
                </p:cNvPr>
                <p:cNvSpPr txBox="1"/>
                <p:nvPr/>
              </p:nvSpPr>
              <p:spPr>
                <a:xfrm>
                  <a:off x="2958049" y="4682110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</p:grpSp>
        </p:grp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0594591A-1AA9-B721-716F-CCEBEC0CAE1A}"/>
                </a:ext>
              </a:extLst>
            </p:cNvPr>
            <p:cNvSpPr txBox="1"/>
            <p:nvPr/>
          </p:nvSpPr>
          <p:spPr>
            <a:xfrm>
              <a:off x="4617768" y="1153903"/>
              <a:ext cx="16209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lumbagin-GSH (0% O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255" name="Group 254">
              <a:extLst>
                <a:ext uri="{FF2B5EF4-FFF2-40B4-BE49-F238E27FC236}">
                  <a16:creationId xmlns:a16="http://schemas.microsoft.com/office/drawing/2014/main" id="{270D291B-3685-7A4A-FD8B-7215F5B5304D}"/>
                </a:ext>
              </a:extLst>
            </p:cNvPr>
            <p:cNvGrpSpPr/>
            <p:nvPr/>
          </p:nvGrpSpPr>
          <p:grpSpPr>
            <a:xfrm>
              <a:off x="1224370" y="752489"/>
              <a:ext cx="3202011" cy="3124314"/>
              <a:chOff x="6594393" y="2597955"/>
              <a:chExt cx="3202011" cy="3124314"/>
            </a:xfrm>
          </p:grpSpPr>
          <p:graphicFrame>
            <p:nvGraphicFramePr>
              <p:cNvPr id="32" name="Object 31">
                <a:extLst>
                  <a:ext uri="{FF2B5EF4-FFF2-40B4-BE49-F238E27FC236}">
                    <a16:creationId xmlns:a16="http://schemas.microsoft.com/office/drawing/2014/main" id="{8E4AE50C-D142-BFF1-27D8-B7F22A83C8B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50068700"/>
                  </p:ext>
                </p:extLst>
              </p:nvPr>
            </p:nvGraphicFramePr>
            <p:xfrm>
              <a:off x="6600181" y="2597955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4" imgW="2755436" imgH="1819712" progId="SigmaPlotGraphicObject.12">
                      <p:embed/>
                    </p:oleObj>
                  </mc:Choice>
                  <mc:Fallback>
                    <p:oleObj name="SPW 13.0 Graph" r:id="rId14" imgW="2755436" imgH="1819712" progId="SigmaPlotGraphicObject.12">
                      <p:embed/>
                      <p:pic>
                        <p:nvPicPr>
                          <p:cNvPr id="32" name="Object 31">
                            <a:extLst>
                              <a:ext uri="{FF2B5EF4-FFF2-40B4-BE49-F238E27FC236}">
                                <a16:creationId xmlns:a16="http://schemas.microsoft.com/office/drawing/2014/main" id="{8E4AE50C-D142-BFF1-27D8-B7F22A83C8B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6600181" y="2597955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4" name="Object 33">
                <a:extLst>
                  <a:ext uri="{FF2B5EF4-FFF2-40B4-BE49-F238E27FC236}">
                    <a16:creationId xmlns:a16="http://schemas.microsoft.com/office/drawing/2014/main" id="{6B2C582E-B402-F47B-C324-2089A7A446C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241237001"/>
                  </p:ext>
                </p:extLst>
              </p:nvPr>
            </p:nvGraphicFramePr>
            <p:xfrm>
              <a:off x="6594393" y="2859017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6" imgW="2755436" imgH="1819712" progId="SigmaPlotGraphicObject.12">
                      <p:embed/>
                    </p:oleObj>
                  </mc:Choice>
                  <mc:Fallback>
                    <p:oleObj name="SPW 13.0 Graph" r:id="rId16" imgW="2755436" imgH="1819712" progId="SigmaPlotGraphicObject.12">
                      <p:embed/>
                      <p:pic>
                        <p:nvPicPr>
                          <p:cNvPr id="34" name="Object 33">
                            <a:extLst>
                              <a:ext uri="{FF2B5EF4-FFF2-40B4-BE49-F238E27FC236}">
                                <a16:creationId xmlns:a16="http://schemas.microsoft.com/office/drawing/2014/main" id="{6B2C582E-B402-F47B-C324-2089A7A446C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6594393" y="2859017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5" name="Object 34">
                <a:extLst>
                  <a:ext uri="{FF2B5EF4-FFF2-40B4-BE49-F238E27FC236}">
                    <a16:creationId xmlns:a16="http://schemas.microsoft.com/office/drawing/2014/main" id="{4A95A91D-736D-D29E-D5D1-8D60A9D74F4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600181" y="3116627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8" imgW="2755436" imgH="1819712" progId="SigmaPlotGraphicObject.12">
                      <p:embed/>
                    </p:oleObj>
                  </mc:Choice>
                  <mc:Fallback>
                    <p:oleObj name="SPW 13.0 Graph" r:id="rId18" imgW="2755436" imgH="1819712" progId="SigmaPlotGraphicObject.12">
                      <p:embed/>
                      <p:pic>
                        <p:nvPicPr>
                          <p:cNvPr id="35" name="Object 34">
                            <a:extLst>
                              <a:ext uri="{FF2B5EF4-FFF2-40B4-BE49-F238E27FC236}">
                                <a16:creationId xmlns:a16="http://schemas.microsoft.com/office/drawing/2014/main" id="{4A95A91D-736D-D29E-D5D1-8D60A9D74F4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6600181" y="3116627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6" name="Object 35">
                <a:extLst>
                  <a:ext uri="{FF2B5EF4-FFF2-40B4-BE49-F238E27FC236}">
                    <a16:creationId xmlns:a16="http://schemas.microsoft.com/office/drawing/2014/main" id="{6A921FEC-41D3-E66D-40CF-18CAEEE010C9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600181" y="3422974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0" imgW="2755436" imgH="1819712" progId="SigmaPlotGraphicObject.12">
                      <p:embed/>
                    </p:oleObj>
                  </mc:Choice>
                  <mc:Fallback>
                    <p:oleObj name="SPW 13.0 Graph" r:id="rId20" imgW="2755436" imgH="1819712" progId="SigmaPlotGraphicObject.12">
                      <p:embed/>
                      <p:pic>
                        <p:nvPicPr>
                          <p:cNvPr id="36" name="Object 35">
                            <a:extLst>
                              <a:ext uri="{FF2B5EF4-FFF2-40B4-BE49-F238E27FC236}">
                                <a16:creationId xmlns:a16="http://schemas.microsoft.com/office/drawing/2014/main" id="{6A921FEC-41D3-E66D-40CF-18CAEEE010C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6600181" y="3422974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7" name="Object 36">
                <a:extLst>
                  <a:ext uri="{FF2B5EF4-FFF2-40B4-BE49-F238E27FC236}">
                    <a16:creationId xmlns:a16="http://schemas.microsoft.com/office/drawing/2014/main" id="{E4CCC4DF-2310-9440-41C0-508A7891E880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600181" y="3697339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2" imgW="2755436" imgH="1819712" progId="SigmaPlotGraphicObject.12">
                      <p:embed/>
                    </p:oleObj>
                  </mc:Choice>
                  <mc:Fallback>
                    <p:oleObj name="SPW 13.0 Graph" r:id="rId22" imgW="2755436" imgH="1819712" progId="SigmaPlotGraphicObject.12">
                      <p:embed/>
                      <p:pic>
                        <p:nvPicPr>
                          <p:cNvPr id="37" name="Object 36">
                            <a:extLst>
                              <a:ext uri="{FF2B5EF4-FFF2-40B4-BE49-F238E27FC236}">
                                <a16:creationId xmlns:a16="http://schemas.microsoft.com/office/drawing/2014/main" id="{E4CCC4DF-2310-9440-41C0-508A7891E8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6600181" y="3697339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8" name="Object 37">
                <a:extLst>
                  <a:ext uri="{FF2B5EF4-FFF2-40B4-BE49-F238E27FC236}">
                    <a16:creationId xmlns:a16="http://schemas.microsoft.com/office/drawing/2014/main" id="{EA13F090-1DDA-44FD-B305-F7ED078BBA4D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600181" y="3902994"/>
              <a:ext cx="2755900" cy="1819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4" imgW="2755436" imgH="1819712" progId="SigmaPlotGraphicObject.12">
                      <p:embed/>
                    </p:oleObj>
                  </mc:Choice>
                  <mc:Fallback>
                    <p:oleObj name="SPW 13.0 Graph" r:id="rId24" imgW="2755436" imgH="1819712" progId="SigmaPlotGraphicObject.12">
                      <p:embed/>
                      <p:pic>
                        <p:nvPicPr>
                          <p:cNvPr id="38" name="Object 37">
                            <a:extLst>
                              <a:ext uri="{FF2B5EF4-FFF2-40B4-BE49-F238E27FC236}">
                                <a16:creationId xmlns:a16="http://schemas.microsoft.com/office/drawing/2014/main" id="{EA13F090-1DDA-44FD-B305-F7ED078BBA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6600181" y="3902994"/>
                            <a:ext cx="2755900" cy="1819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23B3E56E-3294-8FEB-6BE8-E8C776CDF2A7}"/>
                  </a:ext>
                </a:extLst>
              </p:cNvPr>
              <p:cNvGrpSpPr/>
              <p:nvPr/>
            </p:nvGrpSpPr>
            <p:grpSpPr>
              <a:xfrm>
                <a:off x="9079541" y="3413679"/>
                <a:ext cx="716863" cy="1523876"/>
                <a:chOff x="2958049" y="3673734"/>
                <a:chExt cx="716863" cy="1523876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E433A01A-8215-CCB6-E207-1E309219DFF0}"/>
                    </a:ext>
                  </a:extLst>
                </p:cNvPr>
                <p:cNvSpPr txBox="1"/>
                <p:nvPr/>
              </p:nvSpPr>
              <p:spPr>
                <a:xfrm>
                  <a:off x="2958049" y="499755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5AEEEA59-D188-AE23-86FF-54FE812BE09A}"/>
                    </a:ext>
                  </a:extLst>
                </p:cNvPr>
                <p:cNvSpPr txBox="1"/>
                <p:nvPr/>
              </p:nvSpPr>
              <p:spPr>
                <a:xfrm>
                  <a:off x="2958049" y="3673734"/>
                  <a:ext cx="71686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x NaBH4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26453640-5941-AC02-15BE-072859B28A41}"/>
                    </a:ext>
                  </a:extLst>
                </p:cNvPr>
                <p:cNvSpPr txBox="1"/>
                <p:nvPr/>
              </p:nvSpPr>
              <p:spPr>
                <a:xfrm>
                  <a:off x="2958049" y="3952392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C7EAA811-8C64-2430-3B3A-29B4FD8B397D}"/>
                    </a:ext>
                  </a:extLst>
                </p:cNvPr>
                <p:cNvSpPr txBox="1"/>
                <p:nvPr/>
              </p:nvSpPr>
              <p:spPr>
                <a:xfrm>
                  <a:off x="2958049" y="4219489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C5FF7FBE-F74A-B579-90C4-D14BF6FC10E8}"/>
                    </a:ext>
                  </a:extLst>
                </p:cNvPr>
                <p:cNvSpPr txBox="1"/>
                <p:nvPr/>
              </p:nvSpPr>
              <p:spPr>
                <a:xfrm>
                  <a:off x="2958049" y="4537420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73F20839-5E79-F293-EFBA-818922FA7C0A}"/>
                    </a:ext>
                  </a:extLst>
                </p:cNvPr>
                <p:cNvSpPr txBox="1"/>
                <p:nvPr/>
              </p:nvSpPr>
              <p:spPr>
                <a:xfrm>
                  <a:off x="2958049" y="4799875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</p:grp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EBCED36-937D-883D-D548-63931DB5D7FC}"/>
                  </a:ext>
                </a:extLst>
              </p:cNvPr>
              <p:cNvSpPr txBox="1"/>
              <p:nvPr/>
            </p:nvSpPr>
            <p:spPr>
              <a:xfrm>
                <a:off x="7590487" y="3000705"/>
                <a:ext cx="16898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umbagin-GSH (21% O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6D8A3E7-C850-3B75-2991-2EDA335BA46D}"/>
                </a:ext>
              </a:extLst>
            </p:cNvPr>
            <p:cNvSpPr txBox="1"/>
            <p:nvPr/>
          </p:nvSpPr>
          <p:spPr>
            <a:xfrm>
              <a:off x="8770040" y="1257521"/>
              <a:ext cx="4860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:PB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4510266-D07F-BF3B-239C-00A4F99DE4FB}"/>
                </a:ext>
              </a:extLst>
            </p:cNvPr>
            <p:cNvGrpSpPr/>
            <p:nvPr/>
          </p:nvGrpSpPr>
          <p:grpSpPr>
            <a:xfrm>
              <a:off x="6280695" y="566322"/>
              <a:ext cx="3488365" cy="3888028"/>
              <a:chOff x="6755199" y="843966"/>
              <a:chExt cx="3488365" cy="3888028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8AD62346-7D77-4F87-74AE-2CC56188D3A0}"/>
                  </a:ext>
                </a:extLst>
              </p:cNvPr>
              <p:cNvGrpSpPr/>
              <p:nvPr/>
            </p:nvGrpSpPr>
            <p:grpSpPr>
              <a:xfrm>
                <a:off x="6755199" y="843966"/>
                <a:ext cx="2755900" cy="3888028"/>
                <a:chOff x="6721948" y="935406"/>
                <a:chExt cx="2755900" cy="3888028"/>
              </a:xfrm>
            </p:grpSpPr>
            <p:graphicFrame>
              <p:nvGraphicFramePr>
                <p:cNvPr id="13" name="Object 12">
                  <a:extLst>
                    <a:ext uri="{FF2B5EF4-FFF2-40B4-BE49-F238E27FC236}">
                      <a16:creationId xmlns:a16="http://schemas.microsoft.com/office/drawing/2014/main" id="{F459B5EE-EE39-091D-5925-BD67554B9CC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47387021"/>
                    </p:ext>
                  </p:extLst>
                </p:nvPr>
              </p:nvGraphicFramePr>
              <p:xfrm>
                <a:off x="6721948" y="300415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6" imgW="2755436" imgH="1819712" progId="SigmaPlotGraphicObject.12">
                        <p:embed/>
                      </p:oleObj>
                    </mc:Choice>
                    <mc:Fallback>
                      <p:oleObj name="SPW 13.0 Graph" r:id="rId26" imgW="2755436" imgH="1819712" progId="SigmaPlotGraphicObject.12">
                        <p:embed/>
                        <p:pic>
                          <p:nvPicPr>
                            <p:cNvPr id="284" name="Object 283">
                              <a:extLst>
                                <a:ext uri="{FF2B5EF4-FFF2-40B4-BE49-F238E27FC236}">
                                  <a16:creationId xmlns:a16="http://schemas.microsoft.com/office/drawing/2014/main" id="{37140005-D8BD-F8A9-5FFC-B6E6F664718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300415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4" name="Object 13">
                  <a:extLst>
                    <a:ext uri="{FF2B5EF4-FFF2-40B4-BE49-F238E27FC236}">
                      <a16:creationId xmlns:a16="http://schemas.microsoft.com/office/drawing/2014/main" id="{5BD417AE-785A-F2DC-F95D-0B0D2190EBE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126269986"/>
                    </p:ext>
                  </p:extLst>
                </p:nvPr>
              </p:nvGraphicFramePr>
              <p:xfrm>
                <a:off x="6721948" y="2744754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8" imgW="2755436" imgH="1819712" progId="SigmaPlotGraphicObject.12">
                        <p:embed/>
                      </p:oleObj>
                    </mc:Choice>
                    <mc:Fallback>
                      <p:oleObj name="SPW 13.0 Graph" r:id="rId28" imgW="2755436" imgH="1819712" progId="SigmaPlotGraphicObject.12">
                        <p:embed/>
                        <p:pic>
                          <p:nvPicPr>
                            <p:cNvPr id="71" name="Object 70">
                              <a:extLst>
                                <a:ext uri="{FF2B5EF4-FFF2-40B4-BE49-F238E27FC236}">
                                  <a16:creationId xmlns:a16="http://schemas.microsoft.com/office/drawing/2014/main" id="{54967A57-B290-E6ED-1FF8-B8B11B4CE82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2744754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5" name="Object 14">
                  <a:extLst>
                    <a:ext uri="{FF2B5EF4-FFF2-40B4-BE49-F238E27FC236}">
                      <a16:creationId xmlns:a16="http://schemas.microsoft.com/office/drawing/2014/main" id="{D3F26DA3-68AF-3C00-439F-5D0272571B2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03054361"/>
                    </p:ext>
                  </p:extLst>
                </p:nvPr>
              </p:nvGraphicFramePr>
              <p:xfrm>
                <a:off x="6721948" y="231673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0" imgW="2755436" imgH="1819712" progId="SigmaPlotGraphicObject.12">
                        <p:embed/>
                      </p:oleObj>
                    </mc:Choice>
                    <mc:Fallback>
                      <p:oleObj name="SPW 13.0 Graph" r:id="rId30" imgW="2755436" imgH="1819712" progId="SigmaPlotGraphicObject.12">
                        <p:embed/>
                        <p:pic>
                          <p:nvPicPr>
                            <p:cNvPr id="72" name="Object 71">
                              <a:extLst>
                                <a:ext uri="{FF2B5EF4-FFF2-40B4-BE49-F238E27FC236}">
                                  <a16:creationId xmlns:a16="http://schemas.microsoft.com/office/drawing/2014/main" id="{7DDBCCDB-9653-96A5-2D1F-A742F708EC4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231673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6" name="Object 15">
                  <a:extLst>
                    <a:ext uri="{FF2B5EF4-FFF2-40B4-BE49-F238E27FC236}">
                      <a16:creationId xmlns:a16="http://schemas.microsoft.com/office/drawing/2014/main" id="{60DC3CE0-9594-B71F-9FFC-4CB6E26C716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57343316"/>
                    </p:ext>
                  </p:extLst>
                </p:nvPr>
              </p:nvGraphicFramePr>
              <p:xfrm>
                <a:off x="6721948" y="172659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2" imgW="2755436" imgH="1819712" progId="SigmaPlotGraphicObject.12">
                        <p:embed/>
                      </p:oleObj>
                    </mc:Choice>
                    <mc:Fallback>
                      <p:oleObj name="SPW 13.0 Graph" r:id="rId32" imgW="2755436" imgH="1819712" progId="SigmaPlotGraphicObject.12">
                        <p:embed/>
                        <p:pic>
                          <p:nvPicPr>
                            <p:cNvPr id="73" name="Object 72">
                              <a:extLst>
                                <a:ext uri="{FF2B5EF4-FFF2-40B4-BE49-F238E27FC236}">
                                  <a16:creationId xmlns:a16="http://schemas.microsoft.com/office/drawing/2014/main" id="{4E4CB110-59D5-AB32-C81E-1041035BC0E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172659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9" name="Object 18">
                  <a:extLst>
                    <a:ext uri="{FF2B5EF4-FFF2-40B4-BE49-F238E27FC236}">
                      <a16:creationId xmlns:a16="http://schemas.microsoft.com/office/drawing/2014/main" id="{C2D017DB-B75C-4BF5-B2B3-F75DE073D57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37840041"/>
                    </p:ext>
                  </p:extLst>
                </p:nvPr>
              </p:nvGraphicFramePr>
              <p:xfrm>
                <a:off x="6721948" y="1376397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4" imgW="2755436" imgH="1819712" progId="SigmaPlotGraphicObject.12">
                        <p:embed/>
                      </p:oleObj>
                    </mc:Choice>
                    <mc:Fallback>
                      <p:oleObj name="SPW 13.0 Graph" r:id="rId34" imgW="2755436" imgH="1819712" progId="SigmaPlotGraphicObject.12">
                        <p:embed/>
                        <p:pic>
                          <p:nvPicPr>
                            <p:cNvPr id="74" name="Object 73">
                              <a:extLst>
                                <a:ext uri="{FF2B5EF4-FFF2-40B4-BE49-F238E27FC236}">
                                  <a16:creationId xmlns:a16="http://schemas.microsoft.com/office/drawing/2014/main" id="{3AEB8CA8-35FF-377F-2BD0-AD704099D0B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1376397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0" name="Object 19">
                  <a:extLst>
                    <a:ext uri="{FF2B5EF4-FFF2-40B4-BE49-F238E27FC236}">
                      <a16:creationId xmlns:a16="http://schemas.microsoft.com/office/drawing/2014/main" id="{AC63A7B7-6DA2-8A67-E0BD-DA72F6F9AE9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963232455"/>
                    </p:ext>
                  </p:extLst>
                </p:nvPr>
              </p:nvGraphicFramePr>
              <p:xfrm>
                <a:off x="6721948" y="93540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6" imgW="2755436" imgH="1819712" progId="SigmaPlotGraphicObject.12">
                        <p:embed/>
                      </p:oleObj>
                    </mc:Choice>
                    <mc:Fallback>
                      <p:oleObj name="SPW 13.0 Graph" r:id="rId36" imgW="2755436" imgH="1819712" progId="SigmaPlotGraphicObject.12">
                        <p:embed/>
                        <p:pic>
                          <p:nvPicPr>
                            <p:cNvPr id="75" name="Object 74">
                              <a:extLst>
                                <a:ext uri="{FF2B5EF4-FFF2-40B4-BE49-F238E27FC236}">
                                  <a16:creationId xmlns:a16="http://schemas.microsoft.com/office/drawing/2014/main" id="{0F5E64C4-D8C4-611D-9F13-46A3B980059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93540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1" name="Object 20">
                  <a:extLst>
                    <a:ext uri="{FF2B5EF4-FFF2-40B4-BE49-F238E27FC236}">
                      <a16:creationId xmlns:a16="http://schemas.microsoft.com/office/drawing/2014/main" id="{627CFD82-92A4-A627-2047-6978E7375EB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8775551"/>
                    </p:ext>
                  </p:extLst>
                </p:nvPr>
              </p:nvGraphicFramePr>
              <p:xfrm>
                <a:off x="6721948" y="1149415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8" imgW="2755436" imgH="1819712" progId="SigmaPlotGraphicObject.12">
                        <p:embed/>
                      </p:oleObj>
                    </mc:Choice>
                    <mc:Fallback>
                      <p:oleObj name="SPW 13.0 Graph" r:id="rId38" imgW="2755436" imgH="1819712" progId="SigmaPlotGraphicObject.12">
                        <p:embed/>
                        <p:pic>
                          <p:nvPicPr>
                            <p:cNvPr id="76" name="Object 75">
                              <a:extLst>
                                <a:ext uri="{FF2B5EF4-FFF2-40B4-BE49-F238E27FC236}">
                                  <a16:creationId xmlns:a16="http://schemas.microsoft.com/office/drawing/2014/main" id="{44D76429-3100-895F-E604-EA8616F2251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21948" y="1149415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5AA48873-0F3B-95F8-2A39-E08EC206A9FE}"/>
                  </a:ext>
                </a:extLst>
              </p:cNvPr>
              <p:cNvGrpSpPr/>
              <p:nvPr/>
            </p:nvGrpSpPr>
            <p:grpSpPr>
              <a:xfrm>
                <a:off x="9254191" y="1669239"/>
                <a:ext cx="989373" cy="2291798"/>
                <a:chOff x="9271846" y="1669239"/>
                <a:chExt cx="989373" cy="2291798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F5A70C0-1AA5-1042-72F3-5E66EC096BF4}"/>
                    </a:ext>
                  </a:extLst>
                </p:cNvPr>
                <p:cNvSpPr txBox="1"/>
                <p:nvPr/>
              </p:nvSpPr>
              <p:spPr>
                <a:xfrm>
                  <a:off x="9271846" y="3483018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:1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BB186A46-7DCD-4A26-132B-6EE037BC4147}"/>
                    </a:ext>
                  </a:extLst>
                </p:cNvPr>
                <p:cNvSpPr txBox="1"/>
                <p:nvPr/>
              </p:nvSpPr>
              <p:spPr>
                <a:xfrm>
                  <a:off x="9271846" y="1669239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8E2448E7-14D3-7A33-BA33-166CA6F16A7A}"/>
                    </a:ext>
                  </a:extLst>
                </p:cNvPr>
                <p:cNvSpPr txBox="1"/>
                <p:nvPr/>
              </p:nvSpPr>
              <p:spPr>
                <a:xfrm>
                  <a:off x="9271846" y="2113801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:1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EEB4C28-060A-291A-A2FF-ED8743716094}"/>
                    </a:ext>
                  </a:extLst>
                </p:cNvPr>
                <p:cNvSpPr txBox="1"/>
                <p:nvPr/>
              </p:nvSpPr>
              <p:spPr>
                <a:xfrm>
                  <a:off x="9271846" y="2476832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:1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A6F0838-520D-9296-0CDC-4695AACC722D}"/>
                    </a:ext>
                  </a:extLst>
                </p:cNvPr>
                <p:cNvSpPr txBox="1"/>
                <p:nvPr/>
              </p:nvSpPr>
              <p:spPr>
                <a:xfrm>
                  <a:off x="9271846" y="3052754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:1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BE8540C6-5A5A-D9EE-847D-E669A3EC87D7}"/>
                    </a:ext>
                  </a:extLst>
                </p:cNvPr>
                <p:cNvSpPr txBox="1"/>
                <p:nvPr/>
              </p:nvSpPr>
              <p:spPr>
                <a:xfrm>
                  <a:off x="9271846" y="3760982"/>
                  <a:ext cx="38504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:1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15419042-78FF-E720-74D2-C8CF5166C79B}"/>
                    </a:ext>
                  </a:extLst>
                </p:cNvPr>
                <p:cNvSpPr txBox="1"/>
                <p:nvPr/>
              </p:nvSpPr>
              <p:spPr>
                <a:xfrm>
                  <a:off x="9271846" y="1902841"/>
                  <a:ext cx="98937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:1 (enlarged 4x)</a:t>
                  </a:r>
                </a:p>
              </p:txBody>
            </p:sp>
          </p:grp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0D3E340-CA6F-4FB3-75CE-14B1CAE056DF}"/>
                </a:ext>
              </a:extLst>
            </p:cNvPr>
            <p:cNvSpPr txBox="1"/>
            <p:nvPr/>
          </p:nvSpPr>
          <p:spPr>
            <a:xfrm>
              <a:off x="6182117" y="1762949"/>
              <a:ext cx="5229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SH:PB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7321BCE-8937-D321-CB04-7DD6ED9CB190}"/>
                </a:ext>
              </a:extLst>
            </p:cNvPr>
            <p:cNvSpPr txBox="1"/>
            <p:nvPr/>
          </p:nvSpPr>
          <p:spPr>
            <a:xfrm>
              <a:off x="3712830" y="1727260"/>
              <a:ext cx="5229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SH:P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705695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extBox 145">
            <a:extLst>
              <a:ext uri="{FF2B5EF4-FFF2-40B4-BE49-F238E27FC236}">
                <a16:creationId xmlns:a16="http://schemas.microsoft.com/office/drawing/2014/main" id="{C9B652F0-1DA3-E589-9275-F4578242E4E7}"/>
              </a:ext>
            </a:extLst>
          </p:cNvPr>
          <p:cNvSpPr txBox="1"/>
          <p:nvPr/>
        </p:nvSpPr>
        <p:spPr>
          <a:xfrm>
            <a:off x="294972" y="210278"/>
            <a:ext cx="242084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7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5D9F3B56-A69E-C4C7-00FA-BFE857B6FC8B}"/>
              </a:ext>
            </a:extLst>
          </p:cNvPr>
          <p:cNvGrpSpPr/>
          <p:nvPr/>
        </p:nvGrpSpPr>
        <p:grpSpPr>
          <a:xfrm>
            <a:off x="1036927" y="782768"/>
            <a:ext cx="8591663" cy="5025786"/>
            <a:chOff x="282547" y="394148"/>
            <a:chExt cx="8591663" cy="5025786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E3506382-C34A-70E6-6B48-8A778C1A405D}"/>
                </a:ext>
              </a:extLst>
            </p:cNvPr>
            <p:cNvGrpSpPr/>
            <p:nvPr/>
          </p:nvGrpSpPr>
          <p:grpSpPr>
            <a:xfrm>
              <a:off x="5672174" y="394148"/>
              <a:ext cx="3202036" cy="5025786"/>
              <a:chOff x="2062765" y="1075423"/>
              <a:chExt cx="3202036" cy="5025786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AC16F37-64FA-1D42-0D91-35D4FDC91E80}"/>
                  </a:ext>
                </a:extLst>
              </p:cNvPr>
              <p:cNvSpPr txBox="1"/>
              <p:nvPr/>
            </p:nvSpPr>
            <p:spPr>
              <a:xfrm>
                <a:off x="3425975" y="1683173"/>
                <a:ext cx="8675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-MNQ-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5FD25CD0-4E17-C15D-6D32-F9DE21BD522D}"/>
                  </a:ext>
                </a:extLst>
              </p:cNvPr>
              <p:cNvGrpSpPr/>
              <p:nvPr/>
            </p:nvGrpSpPr>
            <p:grpSpPr>
              <a:xfrm>
                <a:off x="2062765" y="1075423"/>
                <a:ext cx="3202036" cy="5025786"/>
                <a:chOff x="2062765" y="1075423"/>
                <a:chExt cx="3202036" cy="5025786"/>
              </a:xfrm>
            </p:grpSpPr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10FD22D1-8A03-E3E0-51AA-1B71FFBAF954}"/>
                    </a:ext>
                  </a:extLst>
                </p:cNvPr>
                <p:cNvGrpSpPr/>
                <p:nvPr/>
              </p:nvGrpSpPr>
              <p:grpSpPr>
                <a:xfrm>
                  <a:off x="2062765" y="1075423"/>
                  <a:ext cx="2755900" cy="5025786"/>
                  <a:chOff x="2062765" y="1075423"/>
                  <a:chExt cx="2755900" cy="5025786"/>
                </a:xfrm>
              </p:grpSpPr>
              <p:sp>
                <p:nvSpPr>
                  <p:cNvPr id="35" name="Left Bracket 34">
                    <a:extLst>
                      <a:ext uri="{FF2B5EF4-FFF2-40B4-BE49-F238E27FC236}">
                        <a16:creationId xmlns:a16="http://schemas.microsoft.com/office/drawing/2014/main" id="{D37EECD7-CA90-761F-F30E-6F45F53FE71A}"/>
                      </a:ext>
                    </a:extLst>
                  </p:cNvPr>
                  <p:cNvSpPr/>
                  <p:nvPr/>
                </p:nvSpPr>
                <p:spPr>
                  <a:xfrm>
                    <a:off x="2896168" y="2326949"/>
                    <a:ext cx="51395" cy="512433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grpSp>
                <p:nvGrpSpPr>
                  <p:cNvPr id="37" name="Group 36">
                    <a:extLst>
                      <a:ext uri="{FF2B5EF4-FFF2-40B4-BE49-F238E27FC236}">
                        <a16:creationId xmlns:a16="http://schemas.microsoft.com/office/drawing/2014/main" id="{1A37EF74-ACCE-82A6-9F2F-7E4B96AE3BEE}"/>
                      </a:ext>
                    </a:extLst>
                  </p:cNvPr>
                  <p:cNvGrpSpPr/>
                  <p:nvPr/>
                </p:nvGrpSpPr>
                <p:grpSpPr>
                  <a:xfrm>
                    <a:off x="2062765" y="1075423"/>
                    <a:ext cx="2755900" cy="5025786"/>
                    <a:chOff x="2071598" y="1075424"/>
                    <a:chExt cx="2755900" cy="5025786"/>
                  </a:xfrm>
                </p:grpSpPr>
                <p:graphicFrame>
                  <p:nvGraphicFramePr>
                    <p:cNvPr id="29" name="Object 28">
                      <a:extLst>
                        <a:ext uri="{FF2B5EF4-FFF2-40B4-BE49-F238E27FC236}">
                          <a16:creationId xmlns:a16="http://schemas.microsoft.com/office/drawing/2014/main" id="{A91A086B-76B1-B320-EA6F-C8066F16FD91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1916561768"/>
                        </p:ext>
                      </p:extLst>
                    </p:nvPr>
                  </p:nvGraphicFramePr>
                  <p:xfrm>
                    <a:off x="2071598" y="4281935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2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2" imgW="2755436" imgH="1819712" progId="SigmaPlotGraphicObject.12">
                            <p:embed/>
                            <p:pic>
                              <p:nvPicPr>
                                <p:cNvPr id="29" name="Object 28">
                                  <a:extLst>
                                    <a:ext uri="{FF2B5EF4-FFF2-40B4-BE49-F238E27FC236}">
                                      <a16:creationId xmlns:a16="http://schemas.microsoft.com/office/drawing/2014/main" id="{A91A086B-76B1-B320-EA6F-C8066F16FD91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3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4281935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0" name="Object 29">
                      <a:extLst>
                        <a:ext uri="{FF2B5EF4-FFF2-40B4-BE49-F238E27FC236}">
                          <a16:creationId xmlns:a16="http://schemas.microsoft.com/office/drawing/2014/main" id="{42C5A2AD-6982-DE6C-C601-A4881B540FFD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650581736"/>
                        </p:ext>
                      </p:extLst>
                    </p:nvPr>
                  </p:nvGraphicFramePr>
                  <p:xfrm>
                    <a:off x="2071598" y="3471931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4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4" imgW="2755436" imgH="1819712" progId="SigmaPlotGraphicObject.12">
                            <p:embed/>
                            <p:pic>
                              <p:nvPicPr>
                                <p:cNvPr id="30" name="Object 29">
                                  <a:extLst>
                                    <a:ext uri="{FF2B5EF4-FFF2-40B4-BE49-F238E27FC236}">
                                      <a16:creationId xmlns:a16="http://schemas.microsoft.com/office/drawing/2014/main" id="{42C5A2AD-6982-DE6C-C601-A4881B540FFD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5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3471931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1" name="Object 30">
                      <a:extLst>
                        <a:ext uri="{FF2B5EF4-FFF2-40B4-BE49-F238E27FC236}">
                          <a16:creationId xmlns:a16="http://schemas.microsoft.com/office/drawing/2014/main" id="{DA479E43-A176-7370-121C-C82E532A2E97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4120656125"/>
                        </p:ext>
                      </p:extLst>
                    </p:nvPr>
                  </p:nvGraphicFramePr>
                  <p:xfrm>
                    <a:off x="2071598" y="2670794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6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6" imgW="2755436" imgH="1819712" progId="SigmaPlotGraphicObject.12">
                            <p:embed/>
                            <p:pic>
                              <p:nvPicPr>
                                <p:cNvPr id="31" name="Object 30">
                                  <a:extLst>
                                    <a:ext uri="{FF2B5EF4-FFF2-40B4-BE49-F238E27FC236}">
                                      <a16:creationId xmlns:a16="http://schemas.microsoft.com/office/drawing/2014/main" id="{DA479E43-A176-7370-121C-C82E532A2E97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2670794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2" name="Object 31">
                      <a:extLst>
                        <a:ext uri="{FF2B5EF4-FFF2-40B4-BE49-F238E27FC236}">
                          <a16:creationId xmlns:a16="http://schemas.microsoft.com/office/drawing/2014/main" id="{296D5336-ECB0-650B-51E5-68328E24E6BF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974730169"/>
                        </p:ext>
                      </p:extLst>
                    </p:nvPr>
                  </p:nvGraphicFramePr>
                  <p:xfrm>
                    <a:off x="2071598" y="2133892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8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8" imgW="2755436" imgH="1819712" progId="SigmaPlotGraphicObject.12">
                            <p:embed/>
                            <p:pic>
                              <p:nvPicPr>
                                <p:cNvPr id="32" name="Object 31">
                                  <a:extLst>
                                    <a:ext uri="{FF2B5EF4-FFF2-40B4-BE49-F238E27FC236}">
                                      <a16:creationId xmlns:a16="http://schemas.microsoft.com/office/drawing/2014/main" id="{296D5336-ECB0-650B-51E5-68328E24E6BF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9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2133892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3" name="Object 32">
                      <a:extLst>
                        <a:ext uri="{FF2B5EF4-FFF2-40B4-BE49-F238E27FC236}">
                          <a16:creationId xmlns:a16="http://schemas.microsoft.com/office/drawing/2014/main" id="{9FEAF350-14AA-C3EB-2285-17EA7A4DFD0B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634799038"/>
                        </p:ext>
                      </p:extLst>
                    </p:nvPr>
                  </p:nvGraphicFramePr>
                  <p:xfrm>
                    <a:off x="2071598" y="1288580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10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10" imgW="2755436" imgH="1819712" progId="SigmaPlotGraphicObject.12">
                            <p:embed/>
                            <p:pic>
                              <p:nvPicPr>
                                <p:cNvPr id="33" name="Object 32">
                                  <a:extLst>
                                    <a:ext uri="{FF2B5EF4-FFF2-40B4-BE49-F238E27FC236}">
                                      <a16:creationId xmlns:a16="http://schemas.microsoft.com/office/drawing/2014/main" id="{9FEAF350-14AA-C3EB-2285-17EA7A4DFD0B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1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1288580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4" name="Object 33">
                      <a:extLst>
                        <a:ext uri="{FF2B5EF4-FFF2-40B4-BE49-F238E27FC236}">
                          <a16:creationId xmlns:a16="http://schemas.microsoft.com/office/drawing/2014/main" id="{B4BC6991-565C-C71B-58C2-3952338CD7D0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507656174"/>
                        </p:ext>
                      </p:extLst>
                    </p:nvPr>
                  </p:nvGraphicFramePr>
                  <p:xfrm>
                    <a:off x="2071598" y="1657993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12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12" imgW="2755436" imgH="1819712" progId="SigmaPlotGraphicObject.12">
                            <p:embed/>
                            <p:pic>
                              <p:nvPicPr>
                                <p:cNvPr id="34" name="Object 33">
                                  <a:extLst>
                                    <a:ext uri="{FF2B5EF4-FFF2-40B4-BE49-F238E27FC236}">
                                      <a16:creationId xmlns:a16="http://schemas.microsoft.com/office/drawing/2014/main" id="{B4BC6991-565C-C71B-58C2-3952338CD7D0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3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1657993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36" name="Object 35">
                      <a:extLst>
                        <a:ext uri="{FF2B5EF4-FFF2-40B4-BE49-F238E27FC236}">
                          <a16:creationId xmlns:a16="http://schemas.microsoft.com/office/drawing/2014/main" id="{C285BCFF-3767-BE27-B55C-7CC8994C2FCD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4058951111"/>
                        </p:ext>
                      </p:extLst>
                    </p:nvPr>
                  </p:nvGraphicFramePr>
                  <p:xfrm>
                    <a:off x="2071598" y="1075424"/>
                    <a:ext cx="2755900" cy="18192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14" imgW="2755436" imgH="1819712" progId="SigmaPlotGraphicObject.12">
                            <p:embed/>
                          </p:oleObj>
                        </mc:Choice>
                        <mc:Fallback>
                          <p:oleObj name="SPW 13.0 Graph" r:id="rId14" imgW="2755436" imgH="1819712" progId="SigmaPlotGraphicObject.12">
                            <p:embed/>
                            <p:pic>
                              <p:nvPicPr>
                                <p:cNvPr id="36" name="Object 35">
                                  <a:extLst>
                                    <a:ext uri="{FF2B5EF4-FFF2-40B4-BE49-F238E27FC236}">
                                      <a16:creationId xmlns:a16="http://schemas.microsoft.com/office/drawing/2014/main" id="{C285BCFF-3767-BE27-B55C-7CC8994C2FCD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5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071598" y="1075424"/>
                                  <a:ext cx="2755900" cy="18192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</p:grpSp>
              <p:sp>
                <p:nvSpPr>
                  <p:cNvPr id="38" name="Left Bracket 37">
                    <a:extLst>
                      <a:ext uri="{FF2B5EF4-FFF2-40B4-BE49-F238E27FC236}">
                        <a16:creationId xmlns:a16="http://schemas.microsoft.com/office/drawing/2014/main" id="{0B0C8F0B-9442-85C6-949F-0045FC976FAD}"/>
                      </a:ext>
                    </a:extLst>
                  </p:cNvPr>
                  <p:cNvSpPr/>
                  <p:nvPr/>
                </p:nvSpPr>
                <p:spPr>
                  <a:xfrm flipH="1">
                    <a:off x="4552670" y="2326949"/>
                    <a:ext cx="51395" cy="512433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0598F1A1-6B0A-9E66-CAE6-0B42D3C0F85A}"/>
                    </a:ext>
                  </a:extLst>
                </p:cNvPr>
                <p:cNvGrpSpPr/>
                <p:nvPr/>
              </p:nvGrpSpPr>
              <p:grpSpPr>
                <a:xfrm>
                  <a:off x="4594425" y="1917435"/>
                  <a:ext cx="670376" cy="3383732"/>
                  <a:chOff x="4502985" y="1917435"/>
                  <a:chExt cx="670376" cy="3383732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3A500C51-631A-6D42-8E44-D815FC7448FC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2117338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5:1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8B630A73-B71D-56AE-2A02-27FE99860E25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510111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.0:1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45A16366-FE90-9570-F4A3-9E4BACFF4981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1917435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:1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74C96AB8-6B46-628E-E1D1-15E621E2F598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296274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:1</a:t>
                    </a: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E9C49CD2-07D4-69DF-D946-8EE33CA1DB7A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348856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:1</a:t>
                    </a: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58E95A4B-F063-EBA0-C3A1-D42B53971DF2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4291353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:1</a:t>
                    </a: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B96BD85D-478A-3ADA-13E4-B0D7D96190F3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985" y="2498338"/>
                    <a:ext cx="67037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5:1 [10X]</a:t>
                    </a:r>
                  </a:p>
                </p:txBody>
              </p:sp>
            </p:grpSp>
          </p:grp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0EDA4E3C-F892-8A6F-1BC3-75DCA3C70173}"/>
                </a:ext>
              </a:extLst>
            </p:cNvPr>
            <p:cNvGrpSpPr/>
            <p:nvPr/>
          </p:nvGrpSpPr>
          <p:grpSpPr>
            <a:xfrm>
              <a:off x="2848004" y="548483"/>
              <a:ext cx="3311685" cy="3184528"/>
              <a:chOff x="5013220" y="938357"/>
              <a:chExt cx="3311685" cy="3184528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1FE83FA-98D1-AAAE-F513-BE2EC643B644}"/>
                  </a:ext>
                </a:extLst>
              </p:cNvPr>
              <p:cNvSpPr txBox="1"/>
              <p:nvPr/>
            </p:nvSpPr>
            <p:spPr>
              <a:xfrm>
                <a:off x="6557188" y="1257424"/>
                <a:ext cx="8627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-MNQ-Cys</a:t>
                </a:r>
              </a:p>
            </p:txBody>
          </p:sp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24ACDD51-38E4-3FB2-DAE2-C085BF389655}"/>
                  </a:ext>
                </a:extLst>
              </p:cNvPr>
              <p:cNvGrpSpPr/>
              <p:nvPr/>
            </p:nvGrpSpPr>
            <p:grpSpPr>
              <a:xfrm>
                <a:off x="5013220" y="938357"/>
                <a:ext cx="3311685" cy="3184528"/>
                <a:chOff x="5013220" y="938357"/>
                <a:chExt cx="3311685" cy="3184528"/>
              </a:xfrm>
            </p:grpSpPr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5F5C8B26-421E-31A9-0618-E9E551E74AC7}"/>
                    </a:ext>
                  </a:extLst>
                </p:cNvPr>
                <p:cNvGrpSpPr/>
                <p:nvPr/>
              </p:nvGrpSpPr>
              <p:grpSpPr>
                <a:xfrm>
                  <a:off x="5013220" y="938357"/>
                  <a:ext cx="2860675" cy="3184528"/>
                  <a:chOff x="5013220" y="938357"/>
                  <a:chExt cx="2860675" cy="3184528"/>
                </a:xfrm>
              </p:grpSpPr>
              <p:graphicFrame>
                <p:nvGraphicFramePr>
                  <p:cNvPr id="69" name="Object 68">
                    <a:extLst>
                      <a:ext uri="{FF2B5EF4-FFF2-40B4-BE49-F238E27FC236}">
                        <a16:creationId xmlns:a16="http://schemas.microsoft.com/office/drawing/2014/main" id="{9E11BD5E-774D-648C-5D76-03D808F60831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713516469"/>
                      </p:ext>
                    </p:extLst>
                  </p:nvPr>
                </p:nvGraphicFramePr>
                <p:xfrm>
                  <a:off x="5013220" y="938357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16" imgW="2860415" imgH="1819712" progId="SigmaPlotGraphicObject.12">
                          <p:embed/>
                        </p:oleObj>
                      </mc:Choice>
                      <mc:Fallback>
                        <p:oleObj name="SPW 13.0 Graph" r:id="rId16" imgW="2860415" imgH="1819712" progId="SigmaPlotGraphicObject.12">
                          <p:embed/>
                          <p:pic>
                            <p:nvPicPr>
                              <p:cNvPr id="69" name="Object 68">
                                <a:extLst>
                                  <a:ext uri="{FF2B5EF4-FFF2-40B4-BE49-F238E27FC236}">
                                    <a16:creationId xmlns:a16="http://schemas.microsoft.com/office/drawing/2014/main" id="{9E11BD5E-774D-648C-5D76-03D808F6083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938357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0" name="Object 69">
                    <a:extLst>
                      <a:ext uri="{FF2B5EF4-FFF2-40B4-BE49-F238E27FC236}">
                        <a16:creationId xmlns:a16="http://schemas.microsoft.com/office/drawing/2014/main" id="{F9981B45-9DEF-E948-81F6-FFEA7F134A49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306233334"/>
                      </p:ext>
                    </p:extLst>
                  </p:nvPr>
                </p:nvGraphicFramePr>
                <p:xfrm>
                  <a:off x="5013220" y="1326284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18" imgW="2860415" imgH="1819712" progId="SigmaPlotGraphicObject.12">
                          <p:embed/>
                        </p:oleObj>
                      </mc:Choice>
                      <mc:Fallback>
                        <p:oleObj name="SPW 13.0 Graph" r:id="rId18" imgW="2860415" imgH="1819712" progId="SigmaPlotGraphicObject.12">
                          <p:embed/>
                          <p:pic>
                            <p:nvPicPr>
                              <p:cNvPr id="70" name="Object 69">
                                <a:extLst>
                                  <a:ext uri="{FF2B5EF4-FFF2-40B4-BE49-F238E27FC236}">
                                    <a16:creationId xmlns:a16="http://schemas.microsoft.com/office/drawing/2014/main" id="{F9981B45-9DEF-E948-81F6-FFEA7F134A49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1326284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1" name="Object 70">
                    <a:extLst>
                      <a:ext uri="{FF2B5EF4-FFF2-40B4-BE49-F238E27FC236}">
                        <a16:creationId xmlns:a16="http://schemas.microsoft.com/office/drawing/2014/main" id="{CAC6ECD0-147E-6DDC-4E45-110882C348AE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83189332"/>
                      </p:ext>
                    </p:extLst>
                  </p:nvPr>
                </p:nvGraphicFramePr>
                <p:xfrm>
                  <a:off x="5013220" y="1547957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0" imgW="2860415" imgH="1819712" progId="SigmaPlotGraphicObject.12">
                          <p:embed/>
                        </p:oleObj>
                      </mc:Choice>
                      <mc:Fallback>
                        <p:oleObj name="SPW 13.0 Graph" r:id="rId20" imgW="2860415" imgH="1819712" progId="SigmaPlotGraphicObject.12">
                          <p:embed/>
                          <p:pic>
                            <p:nvPicPr>
                              <p:cNvPr id="71" name="Object 70">
                                <a:extLst>
                                  <a:ext uri="{FF2B5EF4-FFF2-40B4-BE49-F238E27FC236}">
                                    <a16:creationId xmlns:a16="http://schemas.microsoft.com/office/drawing/2014/main" id="{CAC6ECD0-147E-6DDC-4E45-110882C348AE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1547957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2" name="Object 71">
                    <a:extLst>
                      <a:ext uri="{FF2B5EF4-FFF2-40B4-BE49-F238E27FC236}">
                        <a16:creationId xmlns:a16="http://schemas.microsoft.com/office/drawing/2014/main" id="{975357D1-31DA-4061-EE73-205F6896408D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490809351"/>
                      </p:ext>
                    </p:extLst>
                  </p:nvPr>
                </p:nvGraphicFramePr>
                <p:xfrm>
                  <a:off x="5013220" y="1797338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2" imgW="2860415" imgH="1819712" progId="SigmaPlotGraphicObject.12">
                          <p:embed/>
                        </p:oleObj>
                      </mc:Choice>
                      <mc:Fallback>
                        <p:oleObj name="SPW 13.0 Graph" r:id="rId22" imgW="2860415" imgH="1819712" progId="SigmaPlotGraphicObject.12">
                          <p:embed/>
                          <p:pic>
                            <p:nvPicPr>
                              <p:cNvPr id="72" name="Object 71">
                                <a:extLst>
                                  <a:ext uri="{FF2B5EF4-FFF2-40B4-BE49-F238E27FC236}">
                                    <a16:creationId xmlns:a16="http://schemas.microsoft.com/office/drawing/2014/main" id="{975357D1-31DA-4061-EE73-205F6896408D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1797338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3" name="Object 72">
                    <a:extLst>
                      <a:ext uri="{FF2B5EF4-FFF2-40B4-BE49-F238E27FC236}">
                        <a16:creationId xmlns:a16="http://schemas.microsoft.com/office/drawing/2014/main" id="{4187221F-F020-BA7D-CCDB-5E51DF271F8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794360934"/>
                      </p:ext>
                    </p:extLst>
                  </p:nvPr>
                </p:nvGraphicFramePr>
                <p:xfrm>
                  <a:off x="5013220" y="2054019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4" imgW="2860415" imgH="1819712" progId="SigmaPlotGraphicObject.12">
                          <p:embed/>
                        </p:oleObj>
                      </mc:Choice>
                      <mc:Fallback>
                        <p:oleObj name="SPW 13.0 Graph" r:id="rId24" imgW="2860415" imgH="1819712" progId="SigmaPlotGraphicObject.12">
                          <p:embed/>
                          <p:pic>
                            <p:nvPicPr>
                              <p:cNvPr id="73" name="Object 72">
                                <a:extLst>
                                  <a:ext uri="{FF2B5EF4-FFF2-40B4-BE49-F238E27FC236}">
                                    <a16:creationId xmlns:a16="http://schemas.microsoft.com/office/drawing/2014/main" id="{4187221F-F020-BA7D-CCDB-5E51DF271F8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2054019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74" name="Object 73">
                    <a:extLst>
                      <a:ext uri="{FF2B5EF4-FFF2-40B4-BE49-F238E27FC236}">
                        <a16:creationId xmlns:a16="http://schemas.microsoft.com/office/drawing/2014/main" id="{1EA4C179-DF13-701E-C730-2C60D9C99282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192003666"/>
                      </p:ext>
                    </p:extLst>
                  </p:nvPr>
                </p:nvGraphicFramePr>
                <p:xfrm>
                  <a:off x="5013220" y="2303610"/>
                  <a:ext cx="2860675" cy="18192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6" imgW="2860415" imgH="1819712" progId="SigmaPlotGraphicObject.12">
                          <p:embed/>
                        </p:oleObj>
                      </mc:Choice>
                      <mc:Fallback>
                        <p:oleObj name="SPW 13.0 Graph" r:id="rId26" imgW="2860415" imgH="1819712" progId="SigmaPlotGraphicObject.12">
                          <p:embed/>
                          <p:pic>
                            <p:nvPicPr>
                              <p:cNvPr id="74" name="Object 73">
                                <a:extLst>
                                  <a:ext uri="{FF2B5EF4-FFF2-40B4-BE49-F238E27FC236}">
                                    <a16:creationId xmlns:a16="http://schemas.microsoft.com/office/drawing/2014/main" id="{1EA4C179-DF13-701E-C730-2C60D9C99282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013220" y="2303610"/>
                                <a:ext cx="2860675" cy="18192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F0FF5F08-51ED-82CA-4F10-6506428C5682}"/>
                    </a:ext>
                  </a:extLst>
                </p:cNvPr>
                <p:cNvGrpSpPr/>
                <p:nvPr/>
              </p:nvGrpSpPr>
              <p:grpSpPr>
                <a:xfrm>
                  <a:off x="7608042" y="1761566"/>
                  <a:ext cx="716863" cy="1605711"/>
                  <a:chOff x="8651471" y="2441446"/>
                  <a:chExt cx="716863" cy="1605711"/>
                </a:xfrm>
              </p:grpSpPr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42E61EAC-B4DE-1EC1-F4FC-F395053F7143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84710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:1</a:t>
                    </a:r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923A0B26-5E23-510C-8897-91DEBA9DD478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441446"/>
                    <a:ext cx="716863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x NaBH4</a:t>
                    </a:r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609C5C2B-6330-9847-7996-62D756B988CD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840877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:1</a:t>
                    </a: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2E49A472-CAD5-138F-5780-1904C727E676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066313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5:1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A3F20E30-0E9A-0828-EF93-1F35FC058E65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333897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:1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FC37B922-0667-6758-D244-F4300F3E844F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550994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:1</a:t>
                    </a:r>
                  </a:p>
                </p:txBody>
              </p:sp>
            </p:grpSp>
          </p:grp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B4A43EE9-4957-7106-F7D7-EB11720C6BED}"/>
                </a:ext>
              </a:extLst>
            </p:cNvPr>
            <p:cNvGrpSpPr/>
            <p:nvPr/>
          </p:nvGrpSpPr>
          <p:grpSpPr>
            <a:xfrm>
              <a:off x="282547" y="555843"/>
              <a:ext cx="3404820" cy="3506561"/>
              <a:chOff x="5390743" y="1150863"/>
              <a:chExt cx="3404820" cy="3506561"/>
            </a:xfrm>
          </p:grpSpPr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9807E68E-94AB-D4C9-2D5E-C759F3DD3652}"/>
                  </a:ext>
                </a:extLst>
              </p:cNvPr>
              <p:cNvGrpSpPr/>
              <p:nvPr/>
            </p:nvGrpSpPr>
            <p:grpSpPr>
              <a:xfrm>
                <a:off x="5390743" y="1150863"/>
                <a:ext cx="3404820" cy="3506561"/>
                <a:chOff x="6017127" y="1244146"/>
                <a:chExt cx="3404820" cy="3506561"/>
              </a:xfrm>
            </p:grpSpPr>
            <p:graphicFrame>
              <p:nvGraphicFramePr>
                <p:cNvPr id="93" name="Object 92">
                  <a:extLst>
                    <a:ext uri="{FF2B5EF4-FFF2-40B4-BE49-F238E27FC236}">
                      <a16:creationId xmlns:a16="http://schemas.microsoft.com/office/drawing/2014/main" id="{DE50CE30-032F-9B91-83BF-2D435E8023C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54207615"/>
                    </p:ext>
                  </p:extLst>
                </p:nvPr>
              </p:nvGraphicFramePr>
              <p:xfrm>
                <a:off x="6089651" y="159248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8" imgW="2755436" imgH="1819712" progId="SigmaPlotGraphicObject.12">
                        <p:embed/>
                      </p:oleObj>
                    </mc:Choice>
                    <mc:Fallback>
                      <p:oleObj name="SPW 13.0 Graph" r:id="rId28" imgW="2755436" imgH="1819712" progId="SigmaPlotGraphicObject.12">
                        <p:embed/>
                        <p:pic>
                          <p:nvPicPr>
                            <p:cNvPr id="93" name="Object 92">
                              <a:extLst>
                                <a:ext uri="{FF2B5EF4-FFF2-40B4-BE49-F238E27FC236}">
                                  <a16:creationId xmlns:a16="http://schemas.microsoft.com/office/drawing/2014/main" id="{DE50CE30-032F-9B91-83BF-2D435E8023C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159248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4" name="Object 93">
                  <a:extLst>
                    <a:ext uri="{FF2B5EF4-FFF2-40B4-BE49-F238E27FC236}">
                      <a16:creationId xmlns:a16="http://schemas.microsoft.com/office/drawing/2014/main" id="{05870ABF-AE78-A84B-275E-8A238C4790C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013245755"/>
                    </p:ext>
                  </p:extLst>
                </p:nvPr>
              </p:nvGraphicFramePr>
              <p:xfrm>
                <a:off x="6089651" y="1897289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0" imgW="2755436" imgH="1819712" progId="SigmaPlotGraphicObject.12">
                        <p:embed/>
                      </p:oleObj>
                    </mc:Choice>
                    <mc:Fallback>
                      <p:oleObj name="SPW 13.0 Graph" r:id="rId30" imgW="2755436" imgH="1819712" progId="SigmaPlotGraphicObject.12">
                        <p:embed/>
                        <p:pic>
                          <p:nvPicPr>
                            <p:cNvPr id="94" name="Object 93">
                              <a:extLst>
                                <a:ext uri="{FF2B5EF4-FFF2-40B4-BE49-F238E27FC236}">
                                  <a16:creationId xmlns:a16="http://schemas.microsoft.com/office/drawing/2014/main" id="{05870ABF-AE78-A84B-275E-8A238C4790C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1897289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5" name="Object 94">
                  <a:extLst>
                    <a:ext uri="{FF2B5EF4-FFF2-40B4-BE49-F238E27FC236}">
                      <a16:creationId xmlns:a16="http://schemas.microsoft.com/office/drawing/2014/main" id="{1AB01172-5356-95DB-7384-AD39DD7811B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963493808"/>
                    </p:ext>
                  </p:extLst>
                </p:nvPr>
              </p:nvGraphicFramePr>
              <p:xfrm>
                <a:off x="6089651" y="209323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2" imgW="2755436" imgH="1819712" progId="SigmaPlotGraphicObject.12">
                        <p:embed/>
                      </p:oleObj>
                    </mc:Choice>
                    <mc:Fallback>
                      <p:oleObj name="SPW 13.0 Graph" r:id="rId32" imgW="2755436" imgH="1819712" progId="SigmaPlotGraphicObject.12">
                        <p:embed/>
                        <p:pic>
                          <p:nvPicPr>
                            <p:cNvPr id="95" name="Object 94">
                              <a:extLst>
                                <a:ext uri="{FF2B5EF4-FFF2-40B4-BE49-F238E27FC236}">
                                  <a16:creationId xmlns:a16="http://schemas.microsoft.com/office/drawing/2014/main" id="{1AB01172-5356-95DB-7384-AD39DD7811B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209323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6" name="Object 95">
                  <a:extLst>
                    <a:ext uri="{FF2B5EF4-FFF2-40B4-BE49-F238E27FC236}">
                      <a16:creationId xmlns:a16="http://schemas.microsoft.com/office/drawing/2014/main" id="{841C7B4C-64DA-A250-4580-1F686AC55A5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06665756"/>
                    </p:ext>
                  </p:extLst>
                </p:nvPr>
              </p:nvGraphicFramePr>
              <p:xfrm>
                <a:off x="6089651" y="2321832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4" imgW="2755436" imgH="1819712" progId="SigmaPlotGraphicObject.12">
                        <p:embed/>
                      </p:oleObj>
                    </mc:Choice>
                    <mc:Fallback>
                      <p:oleObj name="SPW 13.0 Graph" r:id="rId34" imgW="2755436" imgH="1819712" progId="SigmaPlotGraphicObject.12">
                        <p:embed/>
                        <p:pic>
                          <p:nvPicPr>
                            <p:cNvPr id="96" name="Object 95">
                              <a:extLst>
                                <a:ext uri="{FF2B5EF4-FFF2-40B4-BE49-F238E27FC236}">
                                  <a16:creationId xmlns:a16="http://schemas.microsoft.com/office/drawing/2014/main" id="{841C7B4C-64DA-A250-4580-1F686AC55A5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2321832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7" name="Object 96">
                  <a:extLst>
                    <a:ext uri="{FF2B5EF4-FFF2-40B4-BE49-F238E27FC236}">
                      <a16:creationId xmlns:a16="http://schemas.microsoft.com/office/drawing/2014/main" id="{2B82AA8E-5128-E6D6-CDAA-1AC01F14E32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65934015"/>
                    </p:ext>
                  </p:extLst>
                </p:nvPr>
              </p:nvGraphicFramePr>
              <p:xfrm>
                <a:off x="6089651" y="2528660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6" imgW="2755436" imgH="1819712" progId="SigmaPlotGraphicObject.12">
                        <p:embed/>
                      </p:oleObj>
                    </mc:Choice>
                    <mc:Fallback>
                      <p:oleObj name="SPW 13.0 Graph" r:id="rId36" imgW="2755436" imgH="1819712" progId="SigmaPlotGraphicObject.12">
                        <p:embed/>
                        <p:pic>
                          <p:nvPicPr>
                            <p:cNvPr id="97" name="Object 96">
                              <a:extLst>
                                <a:ext uri="{FF2B5EF4-FFF2-40B4-BE49-F238E27FC236}">
                                  <a16:creationId xmlns:a16="http://schemas.microsoft.com/office/drawing/2014/main" id="{2B82AA8E-5128-E6D6-CDAA-1AC01F14E32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2528660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8" name="Object 97">
                  <a:extLst>
                    <a:ext uri="{FF2B5EF4-FFF2-40B4-BE49-F238E27FC236}">
                      <a16:creationId xmlns:a16="http://schemas.microsoft.com/office/drawing/2014/main" id="{2A948960-8B43-BC68-82E0-D6DC47DA9A0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111573022"/>
                    </p:ext>
                  </p:extLst>
                </p:nvPr>
              </p:nvGraphicFramePr>
              <p:xfrm>
                <a:off x="6089651" y="2724603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8" imgW="2755436" imgH="1819712" progId="SigmaPlotGraphicObject.12">
                        <p:embed/>
                      </p:oleObj>
                    </mc:Choice>
                    <mc:Fallback>
                      <p:oleObj name="SPW 13.0 Graph" r:id="rId38" imgW="2755436" imgH="1819712" progId="SigmaPlotGraphicObject.12">
                        <p:embed/>
                        <p:pic>
                          <p:nvPicPr>
                            <p:cNvPr id="98" name="Object 97">
                              <a:extLst>
                                <a:ext uri="{FF2B5EF4-FFF2-40B4-BE49-F238E27FC236}">
                                  <a16:creationId xmlns:a16="http://schemas.microsoft.com/office/drawing/2014/main" id="{2A948960-8B43-BC68-82E0-D6DC47DA9A0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2724603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9" name="Object 98">
                  <a:extLst>
                    <a:ext uri="{FF2B5EF4-FFF2-40B4-BE49-F238E27FC236}">
                      <a16:creationId xmlns:a16="http://schemas.microsoft.com/office/drawing/2014/main" id="{8C690F4C-811D-1F67-092F-6DBBAFBF705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969370680"/>
                    </p:ext>
                  </p:extLst>
                </p:nvPr>
              </p:nvGraphicFramePr>
              <p:xfrm>
                <a:off x="6017127" y="2883556"/>
                <a:ext cx="2828424" cy="186715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0" imgW="2755436" imgH="1819712" progId="SigmaPlotGraphicObject.12">
                        <p:embed/>
                      </p:oleObj>
                    </mc:Choice>
                    <mc:Fallback>
                      <p:oleObj name="SPW 13.0 Graph" r:id="rId40" imgW="2755436" imgH="1819712" progId="SigmaPlotGraphicObject.12">
                        <p:embed/>
                        <p:pic>
                          <p:nvPicPr>
                            <p:cNvPr id="99" name="Object 98">
                              <a:extLst>
                                <a:ext uri="{FF2B5EF4-FFF2-40B4-BE49-F238E27FC236}">
                                  <a16:creationId xmlns:a16="http://schemas.microsoft.com/office/drawing/2014/main" id="{8C690F4C-811D-1F67-092F-6DBBAFBF705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17127" y="2883556"/>
                              <a:ext cx="2828424" cy="1867151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00" name="Object 99">
                  <a:extLst>
                    <a:ext uri="{FF2B5EF4-FFF2-40B4-BE49-F238E27FC236}">
                      <a16:creationId xmlns:a16="http://schemas.microsoft.com/office/drawing/2014/main" id="{40950312-84A1-B0A7-D849-EFF97EE1216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2029799"/>
                    </p:ext>
                  </p:extLst>
                </p:nvPr>
              </p:nvGraphicFramePr>
              <p:xfrm>
                <a:off x="6089651" y="1244146"/>
                <a:ext cx="2755900" cy="18192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2" imgW="2755436" imgH="1819712" progId="SigmaPlotGraphicObject.12">
                        <p:embed/>
                      </p:oleObj>
                    </mc:Choice>
                    <mc:Fallback>
                      <p:oleObj name="SPW 13.0 Graph" r:id="rId42" imgW="2755436" imgH="1819712" progId="SigmaPlotGraphicObject.12">
                        <p:embed/>
                        <p:pic>
                          <p:nvPicPr>
                            <p:cNvPr id="100" name="Object 99">
                              <a:extLst>
                                <a:ext uri="{FF2B5EF4-FFF2-40B4-BE49-F238E27FC236}">
                                  <a16:creationId xmlns:a16="http://schemas.microsoft.com/office/drawing/2014/main" id="{40950312-84A1-B0A7-D849-EFF97EE1216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89651" y="1244146"/>
                              <a:ext cx="2755900" cy="18192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E04FAC0C-28E6-5461-D79C-065F358D0CB3}"/>
                    </a:ext>
                  </a:extLst>
                </p:cNvPr>
                <p:cNvGrpSpPr/>
                <p:nvPr/>
              </p:nvGrpSpPr>
              <p:grpSpPr>
                <a:xfrm>
                  <a:off x="8578446" y="2061515"/>
                  <a:ext cx="843501" cy="1895832"/>
                  <a:chOff x="8651471" y="2061515"/>
                  <a:chExt cx="843501" cy="1895832"/>
                </a:xfrm>
              </p:grpSpPr>
              <p:sp>
                <p:nvSpPr>
                  <p:cNvPr id="102" name="TextBox 101">
                    <a:extLst>
                      <a:ext uri="{FF2B5EF4-FFF2-40B4-BE49-F238E27FC236}">
                        <a16:creationId xmlns:a16="http://schemas.microsoft.com/office/drawing/2014/main" id="{C8338111-15BF-204A-58C0-295F58FB9A58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733346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5:1</a:t>
                    </a:r>
                  </a:p>
                </p:txBody>
              </p:sp>
              <p:sp>
                <p:nvSpPr>
                  <p:cNvPr id="103" name="TextBox 102">
                    <a:extLst>
                      <a:ext uri="{FF2B5EF4-FFF2-40B4-BE49-F238E27FC236}">
                        <a16:creationId xmlns:a16="http://schemas.microsoft.com/office/drawing/2014/main" id="{257CA0C3-F6D4-7BC4-A51D-ABE090EA5499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75729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:1</a:t>
                    </a:r>
                  </a:p>
                </p:txBody>
              </p: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E622A96A-5E8B-7340-FD70-CEC8CFFF5815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061515"/>
                    <a:ext cx="843501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-MNQ(hypoxia)</a:t>
                    </a:r>
                  </a:p>
                </p:txBody>
              </p: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264C5A65-C43A-EB4B-119D-FA00CA89447F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441446"/>
                    <a:ext cx="716863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x NaBH4</a:t>
                    </a:r>
                  </a:p>
                </p:txBody>
              </p: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689753B0-A090-2B3C-E23C-297068D441F2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2934766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5:1</a:t>
                    </a:r>
                  </a:p>
                </p:txBody>
              </p:sp>
              <p:sp>
                <p:nvSpPr>
                  <p:cNvPr id="107" name="TextBox 106">
                    <a:extLst>
                      <a:ext uri="{FF2B5EF4-FFF2-40B4-BE49-F238E27FC236}">
                        <a16:creationId xmlns:a16="http://schemas.microsoft.com/office/drawing/2014/main" id="{491815E0-AC7B-A4FF-B4AE-7B0E26992CD8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131626"/>
                    <a:ext cx="4347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5:1</a:t>
                    </a:r>
                  </a:p>
                </p:txBody>
              </p:sp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E8B447AF-1A39-A92C-58AA-813B4C463A67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354307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:1</a:t>
                    </a:r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CF7D57D9-4225-2959-2F7B-A944A887A6EA}"/>
                      </a:ext>
                    </a:extLst>
                  </p:cNvPr>
                  <p:cNvSpPr txBox="1"/>
                  <p:nvPr/>
                </p:nvSpPr>
                <p:spPr>
                  <a:xfrm>
                    <a:off x="8651471" y="3546912"/>
                    <a:ext cx="38504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:1</a:t>
                    </a:r>
                  </a:p>
                </p:txBody>
              </p:sp>
            </p:grpSp>
          </p:grp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0F128B5D-265D-42E4-826B-328508E5AF93}"/>
                  </a:ext>
                </a:extLst>
              </p:cNvPr>
              <p:cNvSpPr txBox="1"/>
              <p:nvPr/>
            </p:nvSpPr>
            <p:spPr>
              <a:xfrm>
                <a:off x="6596620" y="1659945"/>
                <a:ext cx="14302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-MNQ-GSH (0% O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DCADFA60-75E2-50EC-6DDD-50AE03D64F51}"/>
                </a:ext>
              </a:extLst>
            </p:cNvPr>
            <p:cNvSpPr txBox="1"/>
            <p:nvPr/>
          </p:nvSpPr>
          <p:spPr>
            <a:xfrm>
              <a:off x="6302933" y="78107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F9F0D73-52E0-4CD9-F0BB-E995C94B1EEB}"/>
                </a:ext>
              </a:extLst>
            </p:cNvPr>
            <p:cNvSpPr txBox="1"/>
            <p:nvPr/>
          </p:nvSpPr>
          <p:spPr>
            <a:xfrm>
              <a:off x="1023797" y="77802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D9E34438-FDA0-389C-31DB-5DF600841E17}"/>
                </a:ext>
              </a:extLst>
            </p:cNvPr>
            <p:cNvSpPr txBox="1"/>
            <p:nvPr/>
          </p:nvSpPr>
          <p:spPr>
            <a:xfrm>
              <a:off x="3663365" y="78412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056264E-ED61-5126-78F4-B3ED8E8D2F03}"/>
                </a:ext>
              </a:extLst>
            </p:cNvPr>
            <p:cNvGrpSpPr/>
            <p:nvPr/>
          </p:nvGrpSpPr>
          <p:grpSpPr>
            <a:xfrm>
              <a:off x="3548653" y="3502419"/>
              <a:ext cx="2296423" cy="400453"/>
              <a:chOff x="1193620" y="4720059"/>
              <a:chExt cx="2296423" cy="400453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99291868-C3F2-556F-2C98-FB7AFD743666}"/>
                  </a:ext>
                </a:extLst>
              </p:cNvPr>
              <p:cNvSpPr txBox="1"/>
              <p:nvPr/>
            </p:nvSpPr>
            <p:spPr>
              <a:xfrm>
                <a:off x="1193620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15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7191C284-DC82-7AF4-89CE-D478E8FEF5DB}"/>
                  </a:ext>
                </a:extLst>
              </p:cNvPr>
              <p:cNvSpPr txBox="1"/>
              <p:nvPr/>
            </p:nvSpPr>
            <p:spPr>
              <a:xfrm>
                <a:off x="2060819" y="4874291"/>
                <a:ext cx="5533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uss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94A3709E-55F9-4110-B736-545F15E7E7FE}"/>
                  </a:ext>
                </a:extLst>
              </p:cNvPr>
              <p:cNvSpPr txBox="1"/>
              <p:nvPr/>
            </p:nvSpPr>
            <p:spPr>
              <a:xfrm>
                <a:off x="1651648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0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1650E0F-76B0-281F-35EE-68E23193591C}"/>
                  </a:ext>
                </a:extLst>
              </p:cNvPr>
              <p:cNvSpPr txBox="1"/>
              <p:nvPr/>
            </p:nvSpPr>
            <p:spPr>
              <a:xfrm>
                <a:off x="2112162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25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C0672C8B-AC16-E95D-EF5F-DEC1F2FAF474}"/>
                  </a:ext>
                </a:extLst>
              </p:cNvPr>
              <p:cNvSpPr txBox="1"/>
              <p:nvPr/>
            </p:nvSpPr>
            <p:spPr>
              <a:xfrm>
                <a:off x="2565221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43C7AC5-1DD7-7984-E16A-249B9B896814}"/>
                  </a:ext>
                </a:extLst>
              </p:cNvPr>
              <p:cNvSpPr txBox="1"/>
              <p:nvPr/>
            </p:nvSpPr>
            <p:spPr>
              <a:xfrm>
                <a:off x="3023249" y="4720059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335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E1FBF154-DC07-300D-C78C-534394D324CC}"/>
                  </a:ext>
                </a:extLst>
              </p:cNvPr>
              <p:cNvGrpSpPr/>
              <p:nvPr/>
            </p:nvGrpSpPr>
            <p:grpSpPr>
              <a:xfrm>
                <a:off x="1427115" y="4721272"/>
                <a:ext cx="1826315" cy="49693"/>
                <a:chOff x="8073059" y="5173317"/>
                <a:chExt cx="1826315" cy="49693"/>
              </a:xfrm>
            </p:grpSpPr>
            <p:cxnSp>
              <p:nvCxnSpPr>
                <p:cNvPr id="10" name="Straight Connector 9">
                  <a:extLst>
                    <a:ext uri="{FF2B5EF4-FFF2-40B4-BE49-F238E27FC236}">
                      <a16:creationId xmlns:a16="http://schemas.microsoft.com/office/drawing/2014/main" id="{6F568363-25A8-1AF9-4F89-99D1A2CE96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73059" y="5173317"/>
                  <a:ext cx="182631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D5C19E85-F355-9760-A8B7-F237D02C8D78}"/>
                    </a:ext>
                  </a:extLst>
                </p:cNvPr>
                <p:cNvGrpSpPr/>
                <p:nvPr/>
              </p:nvGrpSpPr>
              <p:grpSpPr>
                <a:xfrm>
                  <a:off x="8073059" y="5174143"/>
                  <a:ext cx="1826315" cy="48867"/>
                  <a:chOff x="8073059" y="5034997"/>
                  <a:chExt cx="1826315" cy="129209"/>
                </a:xfrm>
              </p:grpSpPr>
              <p:cxnSp>
                <p:nvCxnSpPr>
                  <p:cNvPr id="12" name="Straight Connector 11">
                    <a:extLst>
                      <a:ext uri="{FF2B5EF4-FFF2-40B4-BE49-F238E27FC236}">
                        <a16:creationId xmlns:a16="http://schemas.microsoft.com/office/drawing/2014/main" id="{8B7C8D9A-497F-2B26-105A-3179EC15D74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529638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Connector 13">
                    <a:extLst>
                      <a:ext uri="{FF2B5EF4-FFF2-40B4-BE49-F238E27FC236}">
                        <a16:creationId xmlns:a16="http://schemas.microsoft.com/office/drawing/2014/main" id="{A87D27B1-B550-A189-A4D5-8BF2370B6C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86217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Straight Connector 16">
                    <a:extLst>
                      <a:ext uri="{FF2B5EF4-FFF2-40B4-BE49-F238E27FC236}">
                        <a16:creationId xmlns:a16="http://schemas.microsoft.com/office/drawing/2014/main" id="{77E268A8-1C9B-AA5C-381A-3B8A7D5D0FF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442796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Connector 20">
                    <a:extLst>
                      <a:ext uri="{FF2B5EF4-FFF2-40B4-BE49-F238E27FC236}">
                        <a16:creationId xmlns:a16="http://schemas.microsoft.com/office/drawing/2014/main" id="{C9AAD341-F87E-DDDF-4180-48D1E30AD53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73059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Straight Connector 22">
                    <a:extLst>
                      <a:ext uri="{FF2B5EF4-FFF2-40B4-BE49-F238E27FC236}">
                        <a16:creationId xmlns:a16="http://schemas.microsoft.com/office/drawing/2014/main" id="{4CC34233-2C9B-7F88-23A5-A7DED52B16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899374" y="5034997"/>
                    <a:ext cx="0" cy="12920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3D642B1-40BE-90D4-0527-A226EFDA2372}"/>
                </a:ext>
              </a:extLst>
            </p:cNvPr>
            <p:cNvSpPr txBox="1"/>
            <p:nvPr/>
          </p:nvSpPr>
          <p:spPr>
            <a:xfrm>
              <a:off x="8142073" y="1107200"/>
              <a:ext cx="6575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:2-MNQ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EFF662F-788D-F9D6-ADC1-1E6CCD9105F4}"/>
                </a:ext>
              </a:extLst>
            </p:cNvPr>
            <p:cNvSpPr txBox="1"/>
            <p:nvPr/>
          </p:nvSpPr>
          <p:spPr>
            <a:xfrm>
              <a:off x="5346264" y="1585662"/>
              <a:ext cx="6543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ys:2-MNQ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F35F5C3-6380-EDFF-0CA8-9F5E8F177F8D}"/>
                </a:ext>
              </a:extLst>
            </p:cNvPr>
            <p:cNvSpPr txBox="1"/>
            <p:nvPr/>
          </p:nvSpPr>
          <p:spPr>
            <a:xfrm>
              <a:off x="2749498" y="1914944"/>
              <a:ext cx="6944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SH:2-MNQ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640451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4AECBD1-2A77-59A9-4280-DD38D809EE83}"/>
              </a:ext>
            </a:extLst>
          </p:cNvPr>
          <p:cNvSpPr txBox="1"/>
          <p:nvPr/>
        </p:nvSpPr>
        <p:spPr>
          <a:xfrm>
            <a:off x="-26565" y="31931"/>
            <a:ext cx="21157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8</a:t>
            </a:r>
          </a:p>
        </p:txBody>
      </p:sp>
      <p:grpSp>
        <p:nvGrpSpPr>
          <p:cNvPr id="178" name="Group 177">
            <a:extLst>
              <a:ext uri="{FF2B5EF4-FFF2-40B4-BE49-F238E27FC236}">
                <a16:creationId xmlns:a16="http://schemas.microsoft.com/office/drawing/2014/main" id="{7562424C-D3BB-25D5-ADFE-395319C861E5}"/>
              </a:ext>
            </a:extLst>
          </p:cNvPr>
          <p:cNvGrpSpPr/>
          <p:nvPr/>
        </p:nvGrpSpPr>
        <p:grpSpPr>
          <a:xfrm>
            <a:off x="352042" y="1095319"/>
            <a:ext cx="11663817" cy="4316006"/>
            <a:chOff x="88806" y="929065"/>
            <a:chExt cx="11663817" cy="4316006"/>
          </a:xfrm>
        </p:grpSpPr>
        <p:graphicFrame>
          <p:nvGraphicFramePr>
            <p:cNvPr id="179" name="Object 178">
              <a:extLst>
                <a:ext uri="{FF2B5EF4-FFF2-40B4-BE49-F238E27FC236}">
                  <a16:creationId xmlns:a16="http://schemas.microsoft.com/office/drawing/2014/main" id="{A1FC9BD5-05E1-7D9A-72EC-462C9C0B1A6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08410" y="929065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2092371" imgH="2249446" progId="SigmaPlotGraphicObject.12">
                    <p:embed/>
                  </p:oleObj>
                </mc:Choice>
                <mc:Fallback>
                  <p:oleObj name="SPW 13.0 Graph" r:id="rId2" imgW="2092371" imgH="2249446" progId="SigmaPlotGraphicObject.12">
                    <p:embed/>
                    <p:pic>
                      <p:nvPicPr>
                        <p:cNvPr id="179" name="Object 178">
                          <a:extLst>
                            <a:ext uri="{FF2B5EF4-FFF2-40B4-BE49-F238E27FC236}">
                              <a16:creationId xmlns:a16="http://schemas.microsoft.com/office/drawing/2014/main" id="{A1FC9BD5-05E1-7D9A-72EC-462C9C0B1A6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708410" y="929065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8C40D629-56A7-DE64-C214-49BCC1B05194}"/>
                </a:ext>
              </a:extLst>
            </p:cNvPr>
            <p:cNvSpPr txBox="1"/>
            <p:nvPr/>
          </p:nvSpPr>
          <p:spPr>
            <a:xfrm>
              <a:off x="5488629" y="1884572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OD</a:t>
              </a:r>
            </a:p>
          </p:txBody>
        </p:sp>
        <p:cxnSp>
          <p:nvCxnSpPr>
            <p:cNvPr id="181" name="Straight Arrow Connector 180">
              <a:extLst>
                <a:ext uri="{FF2B5EF4-FFF2-40B4-BE49-F238E27FC236}">
                  <a16:creationId xmlns:a16="http://schemas.microsoft.com/office/drawing/2014/main" id="{DE735D72-A12B-DD2C-79AF-BD802817343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79256" y="1712421"/>
              <a:ext cx="0" cy="21344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6A297F4F-8557-93DE-8A2F-67C6C5BB8E32}"/>
                </a:ext>
              </a:extLst>
            </p:cNvPr>
            <p:cNvSpPr txBox="1"/>
            <p:nvPr/>
          </p:nvSpPr>
          <p:spPr>
            <a:xfrm>
              <a:off x="3142067" y="1039170"/>
              <a:ext cx="6303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Juglone</a:t>
              </a:r>
            </a:p>
          </p:txBody>
        </p:sp>
        <p:graphicFrame>
          <p:nvGraphicFramePr>
            <p:cNvPr id="183" name="Object 182">
              <a:extLst>
                <a:ext uri="{FF2B5EF4-FFF2-40B4-BE49-F238E27FC236}">
                  <a16:creationId xmlns:a16="http://schemas.microsoft.com/office/drawing/2014/main" id="{D773BA07-F49C-F8F5-A00F-0801036DB8F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8806" y="936637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2092371" imgH="2249446" progId="SigmaPlotGraphicObject.12">
                    <p:embed/>
                  </p:oleObj>
                </mc:Choice>
                <mc:Fallback>
                  <p:oleObj name="SPW 13.0 Graph" r:id="rId4" imgW="2092371" imgH="2249446" progId="SigmaPlotGraphicObject.12">
                    <p:embed/>
                    <p:pic>
                      <p:nvPicPr>
                        <p:cNvPr id="183" name="Object 182">
                          <a:extLst>
                            <a:ext uri="{FF2B5EF4-FFF2-40B4-BE49-F238E27FC236}">
                              <a16:creationId xmlns:a16="http://schemas.microsoft.com/office/drawing/2014/main" id="{D773BA07-F49C-F8F5-A00F-0801036DB8F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8806" y="936637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4" name="Object 183">
              <a:extLst>
                <a:ext uri="{FF2B5EF4-FFF2-40B4-BE49-F238E27FC236}">
                  <a16:creationId xmlns:a16="http://schemas.microsoft.com/office/drawing/2014/main" id="{C50F2FB4-C05E-12AC-7A31-E22FE261AD5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3645" y="2991464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2092371" imgH="2249446" progId="SigmaPlotGraphicObject.12">
                    <p:embed/>
                  </p:oleObj>
                </mc:Choice>
                <mc:Fallback>
                  <p:oleObj name="SPW 13.0 Graph" r:id="rId6" imgW="2092371" imgH="2249446" progId="SigmaPlotGraphicObject.12">
                    <p:embed/>
                    <p:pic>
                      <p:nvPicPr>
                        <p:cNvPr id="184" name="Object 183">
                          <a:extLst>
                            <a:ext uri="{FF2B5EF4-FFF2-40B4-BE49-F238E27FC236}">
                              <a16:creationId xmlns:a16="http://schemas.microsoft.com/office/drawing/2014/main" id="{C50F2FB4-C05E-12AC-7A31-E22FE261AD5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93645" y="2991464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F92032C-3F5E-D2C4-F843-813226670994}"/>
                </a:ext>
              </a:extLst>
            </p:cNvPr>
            <p:cNvSpPr txBox="1"/>
            <p:nvPr/>
          </p:nvSpPr>
          <p:spPr>
            <a:xfrm>
              <a:off x="5454848" y="1051045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lumbagin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F83C6BA1-65D4-4514-B9BD-067E165F2225}"/>
                </a:ext>
              </a:extLst>
            </p:cNvPr>
            <p:cNvSpPr txBox="1"/>
            <p:nvPr/>
          </p:nvSpPr>
          <p:spPr>
            <a:xfrm>
              <a:off x="10504978" y="1051045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-MNQ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CC426DC6-FC4E-DA7D-718C-D12137404A69}"/>
                </a:ext>
              </a:extLst>
            </p:cNvPr>
            <p:cNvSpPr txBox="1"/>
            <p:nvPr/>
          </p:nvSpPr>
          <p:spPr>
            <a:xfrm>
              <a:off x="122994" y="1165411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SH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D6297406-0337-ABAC-4ECD-F04E6C8469FE}"/>
                </a:ext>
              </a:extLst>
            </p:cNvPr>
            <p:cNvSpPr txBox="1"/>
            <p:nvPr/>
          </p:nvSpPr>
          <p:spPr>
            <a:xfrm>
              <a:off x="101289" y="3226841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y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9" name="Group 188">
              <a:extLst>
                <a:ext uri="{FF2B5EF4-FFF2-40B4-BE49-F238E27FC236}">
                  <a16:creationId xmlns:a16="http://schemas.microsoft.com/office/drawing/2014/main" id="{82EF13CC-2941-8326-2B39-A249DE347432}"/>
                </a:ext>
              </a:extLst>
            </p:cNvPr>
            <p:cNvGrpSpPr/>
            <p:nvPr/>
          </p:nvGrpSpPr>
          <p:grpSpPr>
            <a:xfrm>
              <a:off x="2275694" y="935708"/>
              <a:ext cx="2450860" cy="2249487"/>
              <a:chOff x="3103274" y="1790846"/>
              <a:chExt cx="2450860" cy="2249487"/>
            </a:xfrm>
          </p:grpSpPr>
          <p:graphicFrame>
            <p:nvGraphicFramePr>
              <p:cNvPr id="288" name="Object 287">
                <a:extLst>
                  <a:ext uri="{FF2B5EF4-FFF2-40B4-BE49-F238E27FC236}">
                    <a16:creationId xmlns:a16="http://schemas.microsoft.com/office/drawing/2014/main" id="{0C297D84-F3C4-BA3E-E2C0-EE58BD297DF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3103274" y="1790846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8" imgW="2092371" imgH="2249446" progId="SigmaPlotGraphicObject.12">
                      <p:embed/>
                    </p:oleObj>
                  </mc:Choice>
                  <mc:Fallback>
                    <p:oleObj name="SPW 13.0 Graph" r:id="rId8" imgW="2092371" imgH="2249446" progId="SigmaPlotGraphicObject.12">
                      <p:embed/>
                      <p:pic>
                        <p:nvPicPr>
                          <p:cNvPr id="288" name="Object 287">
                            <a:extLst>
                              <a:ext uri="{FF2B5EF4-FFF2-40B4-BE49-F238E27FC236}">
                                <a16:creationId xmlns:a16="http://schemas.microsoft.com/office/drawing/2014/main" id="{0C297D84-F3C4-BA3E-E2C0-EE58BD297D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3103274" y="1790846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89" name="TextBox 288">
                <a:extLst>
                  <a:ext uri="{FF2B5EF4-FFF2-40B4-BE49-F238E27FC236}">
                    <a16:creationId xmlns:a16="http://schemas.microsoft.com/office/drawing/2014/main" id="{0CF6C4A7-C0A3-E28F-6B04-62D0A198512A}"/>
                  </a:ext>
                </a:extLst>
              </p:cNvPr>
              <p:cNvSpPr txBox="1"/>
              <p:nvPr/>
            </p:nvSpPr>
            <p:spPr>
              <a:xfrm>
                <a:off x="3538910" y="2693643"/>
                <a:ext cx="32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Jug</a:t>
                </a:r>
              </a:p>
            </p:txBody>
          </p:sp>
          <p:sp>
            <p:nvSpPr>
              <p:cNvPr id="290" name="TextBox 289">
                <a:extLst>
                  <a:ext uri="{FF2B5EF4-FFF2-40B4-BE49-F238E27FC236}">
                    <a16:creationId xmlns:a16="http://schemas.microsoft.com/office/drawing/2014/main" id="{F1EA18ED-39B4-4C44-0589-C6498197B132}"/>
                  </a:ext>
                </a:extLst>
              </p:cNvPr>
              <p:cNvSpPr txBox="1"/>
              <p:nvPr/>
            </p:nvSpPr>
            <p:spPr>
              <a:xfrm>
                <a:off x="3850302" y="2123520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SH</a:t>
                </a:r>
              </a:p>
            </p:txBody>
          </p:sp>
          <p:cxnSp>
            <p:nvCxnSpPr>
              <p:cNvPr id="291" name="Straight Arrow Connector 290">
                <a:extLst>
                  <a:ext uri="{FF2B5EF4-FFF2-40B4-BE49-F238E27FC236}">
                    <a16:creationId xmlns:a16="http://schemas.microsoft.com/office/drawing/2014/main" id="{14886841-8181-AE98-87AD-65405EDA35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4477" y="2268269"/>
                <a:ext cx="0" cy="170172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Straight Arrow Connector 291">
                <a:extLst>
                  <a:ext uri="{FF2B5EF4-FFF2-40B4-BE49-F238E27FC236}">
                    <a16:creationId xmlns:a16="http://schemas.microsoft.com/office/drawing/2014/main" id="{D2EAE4A4-0355-4979-9201-42A70CB2E4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711020" y="2581953"/>
                <a:ext cx="0" cy="16124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0E009617-6A32-2C7C-01E3-0D19A4387552}"/>
                  </a:ext>
                </a:extLst>
              </p:cNvPr>
              <p:cNvSpPr txBox="1"/>
              <p:nvPr/>
            </p:nvSpPr>
            <p:spPr>
              <a:xfrm>
                <a:off x="4815851" y="2437119"/>
                <a:ext cx="32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Jug</a:t>
                </a: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1298089C-84B0-1816-6149-C678F08B4604}"/>
                  </a:ext>
                </a:extLst>
              </p:cNvPr>
              <p:cNvSpPr txBox="1"/>
              <p:nvPr/>
            </p:nvSpPr>
            <p:spPr>
              <a:xfrm>
                <a:off x="4904120" y="3025657"/>
                <a:ext cx="4315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</a:t>
                </a: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61286338-370F-C585-9B10-ADD942AE5103}"/>
                  </a:ext>
                </a:extLst>
              </p:cNvPr>
              <p:cNvSpPr txBox="1"/>
              <p:nvPr/>
            </p:nvSpPr>
            <p:spPr>
              <a:xfrm>
                <a:off x="4875743" y="3113775"/>
                <a:ext cx="6783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+SOD</a:t>
                </a:r>
              </a:p>
            </p:txBody>
          </p:sp>
          <p:cxnSp>
            <p:nvCxnSpPr>
              <p:cNvPr id="296" name="Straight Arrow Connector 295">
                <a:extLst>
                  <a:ext uri="{FF2B5EF4-FFF2-40B4-BE49-F238E27FC236}">
                    <a16:creationId xmlns:a16="http://schemas.microsoft.com/office/drawing/2014/main" id="{48DBE44A-BA4D-03F9-75D5-4FE27FE000B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08453" y="2557708"/>
                <a:ext cx="0" cy="49722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66F2C6A1-0BDC-7CB0-169D-60FD41B41248}"/>
                  </a:ext>
                </a:extLst>
              </p:cNvPr>
              <p:cNvSpPr txBox="1"/>
              <p:nvPr/>
            </p:nvSpPr>
            <p:spPr>
              <a:xfrm>
                <a:off x="3718889" y="3027184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</p:grpSp>
        <p:grpSp>
          <p:nvGrpSpPr>
            <p:cNvPr id="190" name="Group 189">
              <a:extLst>
                <a:ext uri="{FF2B5EF4-FFF2-40B4-BE49-F238E27FC236}">
                  <a16:creationId xmlns:a16="http://schemas.microsoft.com/office/drawing/2014/main" id="{95A327E5-5450-BE43-09FC-024F3F6D6F35}"/>
                </a:ext>
              </a:extLst>
            </p:cNvPr>
            <p:cNvGrpSpPr/>
            <p:nvPr/>
          </p:nvGrpSpPr>
          <p:grpSpPr>
            <a:xfrm>
              <a:off x="2285095" y="2991382"/>
              <a:ext cx="2206657" cy="2249487"/>
              <a:chOff x="8468447" y="1943248"/>
              <a:chExt cx="2206657" cy="2249487"/>
            </a:xfrm>
          </p:grpSpPr>
          <p:graphicFrame>
            <p:nvGraphicFramePr>
              <p:cNvPr id="278" name="Object 277">
                <a:extLst>
                  <a:ext uri="{FF2B5EF4-FFF2-40B4-BE49-F238E27FC236}">
                    <a16:creationId xmlns:a16="http://schemas.microsoft.com/office/drawing/2014/main" id="{C0447C1D-12D1-B7BA-1D76-DD7C4B19B936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468447" y="1943248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0" imgW="2092371" imgH="2249446" progId="SigmaPlotGraphicObject.12">
                      <p:embed/>
                    </p:oleObj>
                  </mc:Choice>
                  <mc:Fallback>
                    <p:oleObj name="SPW 13.0 Graph" r:id="rId10" imgW="2092371" imgH="2249446" progId="SigmaPlotGraphicObject.12">
                      <p:embed/>
                      <p:pic>
                        <p:nvPicPr>
                          <p:cNvPr id="278" name="Object 277">
                            <a:extLst>
                              <a:ext uri="{FF2B5EF4-FFF2-40B4-BE49-F238E27FC236}">
                                <a16:creationId xmlns:a16="http://schemas.microsoft.com/office/drawing/2014/main" id="{C0447C1D-12D1-B7BA-1D76-DD7C4B19B9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468447" y="1943248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2FDFF28E-5A1F-C1E2-59A7-0638DB008E7C}"/>
                  </a:ext>
                </a:extLst>
              </p:cNvPr>
              <p:cNvSpPr txBox="1"/>
              <p:nvPr/>
            </p:nvSpPr>
            <p:spPr>
              <a:xfrm>
                <a:off x="9000291" y="2836190"/>
                <a:ext cx="32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Jug</a:t>
                </a: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C6E266EA-7E17-6EFD-FD5C-4A3E2D97202F}"/>
                  </a:ext>
                </a:extLst>
              </p:cNvPr>
              <p:cNvSpPr txBox="1"/>
              <p:nvPr/>
            </p:nvSpPr>
            <p:spPr>
              <a:xfrm>
                <a:off x="9242766" y="2297126"/>
                <a:ext cx="3385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1" name="Straight Arrow Connector 280">
                <a:extLst>
                  <a:ext uri="{FF2B5EF4-FFF2-40B4-BE49-F238E27FC236}">
                    <a16:creationId xmlns:a16="http://schemas.microsoft.com/office/drawing/2014/main" id="{98200230-C767-DB13-C05B-18789A9395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20797" y="2448803"/>
                <a:ext cx="0" cy="170172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Arrow Connector 281">
                <a:extLst>
                  <a:ext uri="{FF2B5EF4-FFF2-40B4-BE49-F238E27FC236}">
                    <a16:creationId xmlns:a16="http://schemas.microsoft.com/office/drawing/2014/main" id="{599DCCBC-322E-A2C3-939F-2A3BB92A3AC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155365" y="2715763"/>
                <a:ext cx="0" cy="16124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73FF453C-DFD8-F48A-BF4E-650DC4B62C5B}"/>
                  </a:ext>
                </a:extLst>
              </p:cNvPr>
              <p:cNvSpPr txBox="1"/>
              <p:nvPr/>
            </p:nvSpPr>
            <p:spPr>
              <a:xfrm>
                <a:off x="10261977" y="2633021"/>
                <a:ext cx="32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Jug</a:t>
                </a:r>
              </a:p>
            </p:txBody>
          </p:sp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D78E0408-E05B-E091-7534-B4FCC9328D96}"/>
                  </a:ext>
                </a:extLst>
              </p:cNvPr>
              <p:cNvSpPr txBox="1"/>
              <p:nvPr/>
            </p:nvSpPr>
            <p:spPr>
              <a:xfrm>
                <a:off x="10038381" y="3140677"/>
                <a:ext cx="3914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TextBox 284">
                <a:extLst>
                  <a:ext uri="{FF2B5EF4-FFF2-40B4-BE49-F238E27FC236}">
                    <a16:creationId xmlns:a16="http://schemas.microsoft.com/office/drawing/2014/main" id="{36C87C56-488B-411B-FED1-BD86DBC63868}"/>
                  </a:ext>
                </a:extLst>
              </p:cNvPr>
              <p:cNvSpPr txBox="1"/>
              <p:nvPr/>
            </p:nvSpPr>
            <p:spPr>
              <a:xfrm>
                <a:off x="10036788" y="3238218"/>
                <a:ext cx="638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SO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TextBox 285">
                <a:extLst>
                  <a:ext uri="{FF2B5EF4-FFF2-40B4-BE49-F238E27FC236}">
                    <a16:creationId xmlns:a16="http://schemas.microsoft.com/office/drawing/2014/main" id="{44EB177E-3A27-5793-5343-6C4A5997C65A}"/>
                  </a:ext>
                </a:extLst>
              </p:cNvPr>
              <p:cNvSpPr txBox="1"/>
              <p:nvPr/>
            </p:nvSpPr>
            <p:spPr>
              <a:xfrm>
                <a:off x="9111998" y="3096208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  <p:cxnSp>
            <p:nvCxnSpPr>
              <p:cNvPr id="287" name="Straight Arrow Connector 286">
                <a:extLst>
                  <a:ext uri="{FF2B5EF4-FFF2-40B4-BE49-F238E27FC236}">
                    <a16:creationId xmlns:a16="http://schemas.microsoft.com/office/drawing/2014/main" id="{4026319E-0AD1-490C-4121-720B00EC680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307753" y="2698444"/>
                <a:ext cx="0" cy="43961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78413A60-12E8-39A9-2C82-41FEBA0807AE}"/>
                </a:ext>
              </a:extLst>
            </p:cNvPr>
            <p:cNvSpPr txBox="1"/>
            <p:nvPr/>
          </p:nvSpPr>
          <p:spPr>
            <a:xfrm>
              <a:off x="5203750" y="1804101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E9C6BE76-1B88-2E62-FABB-0B07EFFC48AC}"/>
                </a:ext>
              </a:extLst>
            </p:cNvPr>
            <p:cNvSpPr txBox="1"/>
            <p:nvPr/>
          </p:nvSpPr>
          <p:spPr>
            <a:xfrm>
              <a:off x="5485526" y="1247834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SH</a:t>
              </a:r>
            </a:p>
          </p:txBody>
        </p:sp>
        <p:cxnSp>
          <p:nvCxnSpPr>
            <p:cNvPr id="193" name="Straight Arrow Connector 192">
              <a:extLst>
                <a:ext uri="{FF2B5EF4-FFF2-40B4-BE49-F238E27FC236}">
                  <a16:creationId xmlns:a16="http://schemas.microsoft.com/office/drawing/2014/main" id="{163B5B95-CD71-D917-D36D-84F805056681}"/>
                </a:ext>
              </a:extLst>
            </p:cNvPr>
            <p:cNvCxnSpPr>
              <a:cxnSpLocks/>
            </p:cNvCxnSpPr>
            <p:nvPr/>
          </p:nvCxnSpPr>
          <p:spPr>
            <a:xfrm>
              <a:off x="5663557" y="1399511"/>
              <a:ext cx="0" cy="170172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Arrow Connector 193">
              <a:extLst>
                <a:ext uri="{FF2B5EF4-FFF2-40B4-BE49-F238E27FC236}">
                  <a16:creationId xmlns:a16="http://schemas.microsoft.com/office/drawing/2014/main" id="{CC28463A-44C3-5AA9-C144-4C38DC3663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46244" y="1692411"/>
              <a:ext cx="0" cy="16124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7ECCD2E7-0624-177E-D63A-EB13137B8C16}"/>
                </a:ext>
              </a:extLst>
            </p:cNvPr>
            <p:cNvSpPr txBox="1"/>
            <p:nvPr/>
          </p:nvSpPr>
          <p:spPr>
            <a:xfrm>
              <a:off x="6406651" y="1632724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F49BF322-BC81-36D8-BB9E-7C781F5803E6}"/>
                </a:ext>
              </a:extLst>
            </p:cNvPr>
            <p:cNvSpPr txBox="1"/>
            <p:nvPr/>
          </p:nvSpPr>
          <p:spPr>
            <a:xfrm>
              <a:off x="6408694" y="2009475"/>
              <a:ext cx="4315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GSH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4DAD0569-C6DE-72FF-3261-D31CEBD2DF16}"/>
                </a:ext>
              </a:extLst>
            </p:cNvPr>
            <p:cNvSpPr txBox="1"/>
            <p:nvPr/>
          </p:nvSpPr>
          <p:spPr>
            <a:xfrm>
              <a:off x="6409218" y="1894823"/>
              <a:ext cx="6783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GSH+SOD</a:t>
              </a:r>
            </a:p>
          </p:txBody>
        </p:sp>
        <p:grpSp>
          <p:nvGrpSpPr>
            <p:cNvPr id="198" name="Group 197">
              <a:extLst>
                <a:ext uri="{FF2B5EF4-FFF2-40B4-BE49-F238E27FC236}">
                  <a16:creationId xmlns:a16="http://schemas.microsoft.com/office/drawing/2014/main" id="{01554F03-AAE5-3897-750B-4DE48E5C8B4E}"/>
                </a:ext>
              </a:extLst>
            </p:cNvPr>
            <p:cNvGrpSpPr/>
            <p:nvPr/>
          </p:nvGrpSpPr>
          <p:grpSpPr>
            <a:xfrm>
              <a:off x="9352580" y="933952"/>
              <a:ext cx="2400043" cy="2249487"/>
              <a:chOff x="5960703" y="4026100"/>
              <a:chExt cx="2400043" cy="2249487"/>
            </a:xfrm>
          </p:grpSpPr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F0C02BB3-9B02-6B03-CE55-72CFF2FEBD50}"/>
                  </a:ext>
                </a:extLst>
              </p:cNvPr>
              <p:cNvSpPr txBox="1"/>
              <p:nvPr/>
            </p:nvSpPr>
            <p:spPr>
              <a:xfrm>
                <a:off x="6532557" y="5241026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  <p:grpSp>
            <p:nvGrpSpPr>
              <p:cNvPr id="265" name="Group 264">
                <a:extLst>
                  <a:ext uri="{FF2B5EF4-FFF2-40B4-BE49-F238E27FC236}">
                    <a16:creationId xmlns:a16="http://schemas.microsoft.com/office/drawing/2014/main" id="{838CBFAA-BFD4-1F3C-6EA9-D80FB33F98E7}"/>
                  </a:ext>
                </a:extLst>
              </p:cNvPr>
              <p:cNvGrpSpPr/>
              <p:nvPr/>
            </p:nvGrpSpPr>
            <p:grpSpPr>
              <a:xfrm>
                <a:off x="5960703" y="4026100"/>
                <a:ext cx="2400043" cy="2249487"/>
                <a:chOff x="3058478" y="4125490"/>
                <a:chExt cx="2400043" cy="2249487"/>
              </a:xfrm>
            </p:grpSpPr>
            <p:graphicFrame>
              <p:nvGraphicFramePr>
                <p:cNvPr id="266" name="Object 265">
                  <a:extLst>
                    <a:ext uri="{FF2B5EF4-FFF2-40B4-BE49-F238E27FC236}">
                      <a16:creationId xmlns:a16="http://schemas.microsoft.com/office/drawing/2014/main" id="{ACFD00B1-BE2B-9E21-7961-4E27D3E7DEF1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058478" y="4125490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2092371" imgH="2249446" progId="SigmaPlotGraphicObject.12">
                        <p:embed/>
                      </p:oleObj>
                    </mc:Choice>
                    <mc:Fallback>
                      <p:oleObj name="SPW 13.0 Graph" r:id="rId12" imgW="2092371" imgH="2249446" progId="SigmaPlotGraphicObject.12">
                        <p:embed/>
                        <p:pic>
                          <p:nvPicPr>
                            <p:cNvPr id="266" name="Object 265">
                              <a:extLst>
                                <a:ext uri="{FF2B5EF4-FFF2-40B4-BE49-F238E27FC236}">
                                  <a16:creationId xmlns:a16="http://schemas.microsoft.com/office/drawing/2014/main" id="{ACFD00B1-BE2B-9E21-7961-4E27D3E7DEF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058478" y="4125490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67" name="TextBox 266">
                  <a:extLst>
                    <a:ext uri="{FF2B5EF4-FFF2-40B4-BE49-F238E27FC236}">
                      <a16:creationId xmlns:a16="http://schemas.microsoft.com/office/drawing/2014/main" id="{5F8928D6-3C0D-C08F-B8C9-ABD4EDDBDB45}"/>
                    </a:ext>
                  </a:extLst>
                </p:cNvPr>
                <p:cNvSpPr txBox="1"/>
                <p:nvPr/>
              </p:nvSpPr>
              <p:spPr>
                <a:xfrm>
                  <a:off x="3496247" y="5017468"/>
                  <a:ext cx="3946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NQ</a:t>
                  </a:r>
                </a:p>
              </p:txBody>
            </p:sp>
            <p:sp>
              <p:nvSpPr>
                <p:cNvPr id="268" name="TextBox 267">
                  <a:extLst>
                    <a:ext uri="{FF2B5EF4-FFF2-40B4-BE49-F238E27FC236}">
                      <a16:creationId xmlns:a16="http://schemas.microsoft.com/office/drawing/2014/main" id="{E1E6D1FF-F03D-3A14-8310-1B95E256AD0D}"/>
                    </a:ext>
                  </a:extLst>
                </p:cNvPr>
                <p:cNvSpPr txBox="1"/>
                <p:nvPr/>
              </p:nvSpPr>
              <p:spPr>
                <a:xfrm>
                  <a:off x="3726442" y="4404973"/>
                  <a:ext cx="37863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</a:p>
              </p:txBody>
            </p:sp>
            <p:cxnSp>
              <p:nvCxnSpPr>
                <p:cNvPr id="269" name="Straight Arrow Connector 268">
                  <a:extLst>
                    <a:ext uri="{FF2B5EF4-FFF2-40B4-BE49-F238E27FC236}">
                      <a16:creationId xmlns:a16="http://schemas.microsoft.com/office/drawing/2014/main" id="{31FCC4BD-08FF-13EA-1A79-65395B65A7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90617" y="4549722"/>
                  <a:ext cx="0" cy="170172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0" name="Straight Arrow Connector 269">
                  <a:extLst>
                    <a:ext uri="{FF2B5EF4-FFF2-40B4-BE49-F238E27FC236}">
                      <a16:creationId xmlns:a16="http://schemas.microsoft.com/office/drawing/2014/main" id="{99A30A22-FB2D-0B7F-1EFE-C96C64FC05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689543" y="4891654"/>
                  <a:ext cx="0" cy="161248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5CAC7D37-26B3-441D-E896-CBEDF4E8CBC3}"/>
                    </a:ext>
                  </a:extLst>
                </p:cNvPr>
                <p:cNvSpPr txBox="1"/>
                <p:nvPr/>
              </p:nvSpPr>
              <p:spPr>
                <a:xfrm>
                  <a:off x="4921481" y="4771534"/>
                  <a:ext cx="3946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NQ</a:t>
                  </a:r>
                </a:p>
              </p:txBody>
            </p:sp>
            <p:sp>
              <p:nvSpPr>
                <p:cNvPr id="272" name="TextBox 271">
                  <a:extLst>
                    <a:ext uri="{FF2B5EF4-FFF2-40B4-BE49-F238E27FC236}">
                      <a16:creationId xmlns:a16="http://schemas.microsoft.com/office/drawing/2014/main" id="{74EB9DAC-5D7C-1964-9755-0BD559E0007A}"/>
                    </a:ext>
                  </a:extLst>
                </p:cNvPr>
                <p:cNvSpPr txBox="1"/>
                <p:nvPr/>
              </p:nvSpPr>
              <p:spPr>
                <a:xfrm>
                  <a:off x="4833220" y="4639850"/>
                  <a:ext cx="43152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GSH</a:t>
                  </a:r>
                </a:p>
              </p:txBody>
            </p:sp>
            <p:sp>
              <p:nvSpPr>
                <p:cNvPr id="273" name="TextBox 272">
                  <a:extLst>
                    <a:ext uri="{FF2B5EF4-FFF2-40B4-BE49-F238E27FC236}">
                      <a16:creationId xmlns:a16="http://schemas.microsoft.com/office/drawing/2014/main" id="{9634FEE0-100D-CDC3-D211-669B17AB99A7}"/>
                    </a:ext>
                  </a:extLst>
                </p:cNvPr>
                <p:cNvSpPr txBox="1"/>
                <p:nvPr/>
              </p:nvSpPr>
              <p:spPr>
                <a:xfrm>
                  <a:off x="4780130" y="4978633"/>
                  <a:ext cx="67839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GSH+SOD</a:t>
                  </a:r>
                </a:p>
              </p:txBody>
            </p:sp>
            <p:cxnSp>
              <p:nvCxnSpPr>
                <p:cNvPr id="274" name="Straight Arrow Connector 273">
                  <a:extLst>
                    <a:ext uri="{FF2B5EF4-FFF2-40B4-BE49-F238E27FC236}">
                      <a16:creationId xmlns:a16="http://schemas.microsoft.com/office/drawing/2014/main" id="{0863042F-371F-5F05-ADAE-C7A2DC766D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02907" y="4867409"/>
                  <a:ext cx="0" cy="49722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5" name="Straight Arrow Connector 274">
                  <a:extLst>
                    <a:ext uri="{FF2B5EF4-FFF2-40B4-BE49-F238E27FC236}">
                      <a16:creationId xmlns:a16="http://schemas.microsoft.com/office/drawing/2014/main" id="{96DC6066-747F-21CB-5B3D-DF442E2231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812674" y="4759117"/>
                  <a:ext cx="98255" cy="70811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6" name="Straight Arrow Connector 275">
                  <a:extLst>
                    <a:ext uri="{FF2B5EF4-FFF2-40B4-BE49-F238E27FC236}">
                      <a16:creationId xmlns:a16="http://schemas.microsoft.com/office/drawing/2014/main" id="{2722318D-95FE-F412-C4CA-F79796AB4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848567" y="4865822"/>
                  <a:ext cx="118849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Straight Arrow Connector 276">
                  <a:extLst>
                    <a:ext uri="{FF2B5EF4-FFF2-40B4-BE49-F238E27FC236}">
                      <a16:creationId xmlns:a16="http://schemas.microsoft.com/office/drawing/2014/main" id="{56391B06-C48D-CE2F-DE90-04BA10AAAE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764430" y="4944081"/>
                  <a:ext cx="107669" cy="83354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99" name="Group 198">
              <a:extLst>
                <a:ext uri="{FF2B5EF4-FFF2-40B4-BE49-F238E27FC236}">
                  <a16:creationId xmlns:a16="http://schemas.microsoft.com/office/drawing/2014/main" id="{E024BB0E-2E1A-AA61-5B69-D3069DC2E519}"/>
                </a:ext>
              </a:extLst>
            </p:cNvPr>
            <p:cNvGrpSpPr/>
            <p:nvPr/>
          </p:nvGrpSpPr>
          <p:grpSpPr>
            <a:xfrm>
              <a:off x="9367079" y="2995584"/>
              <a:ext cx="2254571" cy="2249487"/>
              <a:chOff x="5579413" y="4128732"/>
              <a:chExt cx="2254571" cy="2249487"/>
            </a:xfrm>
          </p:grpSpPr>
          <p:graphicFrame>
            <p:nvGraphicFramePr>
              <p:cNvPr id="251" name="Object 250">
                <a:extLst>
                  <a:ext uri="{FF2B5EF4-FFF2-40B4-BE49-F238E27FC236}">
                    <a16:creationId xmlns:a16="http://schemas.microsoft.com/office/drawing/2014/main" id="{6BA2DDB1-4307-4EB9-4C65-FA8EAF77890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579413" y="4128732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4" imgW="2092371" imgH="2249446" progId="SigmaPlotGraphicObject.12">
                      <p:embed/>
                    </p:oleObj>
                  </mc:Choice>
                  <mc:Fallback>
                    <p:oleObj name="SPW 13.0 Graph" r:id="rId14" imgW="2092371" imgH="2249446" progId="SigmaPlotGraphicObject.12">
                      <p:embed/>
                      <p:pic>
                        <p:nvPicPr>
                          <p:cNvPr id="251" name="Object 250">
                            <a:extLst>
                              <a:ext uri="{FF2B5EF4-FFF2-40B4-BE49-F238E27FC236}">
                                <a16:creationId xmlns:a16="http://schemas.microsoft.com/office/drawing/2014/main" id="{6BA2DDB1-4307-4EB9-4C65-FA8EAF77890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5579413" y="4128732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A9F4C423-1934-6779-9E70-D4A8889F6CFE}"/>
                  </a:ext>
                </a:extLst>
              </p:cNvPr>
              <p:cNvSpPr txBox="1"/>
              <p:nvPr/>
            </p:nvSpPr>
            <p:spPr>
              <a:xfrm>
                <a:off x="6014090" y="5014526"/>
                <a:ext cx="3946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NQ</a:t>
                </a:r>
              </a:p>
            </p:txBody>
          </p:sp>
          <p:sp>
            <p:nvSpPr>
              <p:cNvPr id="253" name="TextBox 252">
                <a:extLst>
                  <a:ext uri="{FF2B5EF4-FFF2-40B4-BE49-F238E27FC236}">
                    <a16:creationId xmlns:a16="http://schemas.microsoft.com/office/drawing/2014/main" id="{8B909BDB-C875-06D8-4A08-56F863E2FE22}"/>
                  </a:ext>
                </a:extLst>
              </p:cNvPr>
              <p:cNvSpPr txBox="1"/>
              <p:nvPr/>
            </p:nvSpPr>
            <p:spPr>
              <a:xfrm>
                <a:off x="6244285" y="4402031"/>
                <a:ext cx="3385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4" name="Straight Arrow Connector 253">
                <a:extLst>
                  <a:ext uri="{FF2B5EF4-FFF2-40B4-BE49-F238E27FC236}">
                    <a16:creationId xmlns:a16="http://schemas.microsoft.com/office/drawing/2014/main" id="{2BD9047D-5EF3-2DA9-37FB-1BC95848BF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08460" y="4546780"/>
                <a:ext cx="0" cy="170172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Arrow Connector 254">
                <a:extLst>
                  <a:ext uri="{FF2B5EF4-FFF2-40B4-BE49-F238E27FC236}">
                    <a16:creationId xmlns:a16="http://schemas.microsoft.com/office/drawing/2014/main" id="{CB2419B7-C594-61A4-3537-849D550833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207386" y="4888712"/>
                <a:ext cx="0" cy="16124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F351AB34-946D-350E-50A6-AE3333BE4AE5}"/>
                  </a:ext>
                </a:extLst>
              </p:cNvPr>
              <p:cNvSpPr txBox="1"/>
              <p:nvPr/>
            </p:nvSpPr>
            <p:spPr>
              <a:xfrm>
                <a:off x="7439324" y="4768592"/>
                <a:ext cx="3946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NQ</a:t>
                </a:r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35D0FE06-14FD-097F-2CFE-1F455E8718BF}"/>
                  </a:ext>
                </a:extLst>
              </p:cNvPr>
              <p:cNvSpPr txBox="1"/>
              <p:nvPr/>
            </p:nvSpPr>
            <p:spPr>
              <a:xfrm>
                <a:off x="7435795" y="4901695"/>
                <a:ext cx="3914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C99ADB09-7B8E-9959-FF5E-2A5B0B38BE0C}"/>
                  </a:ext>
                </a:extLst>
              </p:cNvPr>
              <p:cNvSpPr txBox="1"/>
              <p:nvPr/>
            </p:nvSpPr>
            <p:spPr>
              <a:xfrm>
                <a:off x="7184998" y="5085137"/>
                <a:ext cx="638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SO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9" name="Straight Arrow Connector 258">
                <a:extLst>
                  <a:ext uri="{FF2B5EF4-FFF2-40B4-BE49-F238E27FC236}">
                    <a16:creationId xmlns:a16="http://schemas.microsoft.com/office/drawing/2014/main" id="{787F23FD-4731-8F98-EA96-37F9A77D03F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30680" y="4864467"/>
                <a:ext cx="0" cy="49722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Straight Arrow Connector 259">
                <a:extLst>
                  <a:ext uri="{FF2B5EF4-FFF2-40B4-BE49-F238E27FC236}">
                    <a16:creationId xmlns:a16="http://schemas.microsoft.com/office/drawing/2014/main" id="{4C41D0E2-28EF-F5EF-6AEA-56262887030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348170" y="4954084"/>
                <a:ext cx="161208" cy="3804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Straight Arrow Connector 260">
                <a:extLst>
                  <a:ext uri="{FF2B5EF4-FFF2-40B4-BE49-F238E27FC236}">
                    <a16:creationId xmlns:a16="http://schemas.microsoft.com/office/drawing/2014/main" id="{E901A4AE-6A9B-D6EA-25EC-22E24922CC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66410" y="4862880"/>
                <a:ext cx="118849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Straight Arrow Connector 261">
                <a:extLst>
                  <a:ext uri="{FF2B5EF4-FFF2-40B4-BE49-F238E27FC236}">
                    <a16:creationId xmlns:a16="http://schemas.microsoft.com/office/drawing/2014/main" id="{7DB2EAB0-3FE0-E924-1E07-96DC05BEF07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324640" y="5004688"/>
                <a:ext cx="75293" cy="103949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B02BD790-6D7A-9D1B-72F3-86766836C3E5}"/>
                  </a:ext>
                </a:extLst>
              </p:cNvPr>
              <p:cNvSpPr txBox="1"/>
              <p:nvPr/>
            </p:nvSpPr>
            <p:spPr>
              <a:xfrm>
                <a:off x="6142485" y="5327611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</p:grpSp>
        <p:grpSp>
          <p:nvGrpSpPr>
            <p:cNvPr id="200" name="Group 199">
              <a:extLst>
                <a:ext uri="{FF2B5EF4-FFF2-40B4-BE49-F238E27FC236}">
                  <a16:creationId xmlns:a16="http://schemas.microsoft.com/office/drawing/2014/main" id="{79869D57-07F8-4C51-E875-9C119CAA1043}"/>
                </a:ext>
              </a:extLst>
            </p:cNvPr>
            <p:cNvGrpSpPr/>
            <p:nvPr/>
          </p:nvGrpSpPr>
          <p:grpSpPr>
            <a:xfrm>
              <a:off x="7152004" y="939418"/>
              <a:ext cx="2267362" cy="2249487"/>
              <a:chOff x="7488238" y="512763"/>
              <a:chExt cx="2267362" cy="2249487"/>
            </a:xfrm>
          </p:grpSpPr>
          <p:graphicFrame>
            <p:nvGraphicFramePr>
              <p:cNvPr id="240" name="Object 239">
                <a:extLst>
                  <a:ext uri="{FF2B5EF4-FFF2-40B4-BE49-F238E27FC236}">
                    <a16:creationId xmlns:a16="http://schemas.microsoft.com/office/drawing/2014/main" id="{E975D681-D2C4-28CE-F466-FA43C83BF9A9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7488238" y="512763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6" imgW="2092371" imgH="2249446" progId="SigmaPlotGraphicObject.12">
                      <p:embed/>
                    </p:oleObj>
                  </mc:Choice>
                  <mc:Fallback>
                    <p:oleObj name="SPW 13.0 Graph" r:id="rId16" imgW="2092371" imgH="2249446" progId="SigmaPlotGraphicObject.12">
                      <p:embed/>
                      <p:pic>
                        <p:nvPicPr>
                          <p:cNvPr id="240" name="Object 239">
                            <a:extLst>
                              <a:ext uri="{FF2B5EF4-FFF2-40B4-BE49-F238E27FC236}">
                                <a16:creationId xmlns:a16="http://schemas.microsoft.com/office/drawing/2014/main" id="{E975D681-D2C4-28CE-F466-FA43C83BF9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7488238" y="512763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AFF52DB0-F48A-98F6-517F-842CE4ED627C}"/>
                  </a:ext>
                </a:extLst>
              </p:cNvPr>
              <p:cNvSpPr txBox="1"/>
              <p:nvPr/>
            </p:nvSpPr>
            <p:spPr>
              <a:xfrm>
                <a:off x="8260959" y="624390"/>
                <a:ext cx="8146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02AC60A1-3863-7EDC-C1EF-901402C65533}"/>
                  </a:ext>
                </a:extLst>
              </p:cNvPr>
              <p:cNvSpPr txBox="1"/>
              <p:nvPr/>
            </p:nvSpPr>
            <p:spPr>
              <a:xfrm>
                <a:off x="7984992" y="1315926"/>
                <a:ext cx="4587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722C9255-987C-9A83-B542-0A9C10AC6203}"/>
                  </a:ext>
                </a:extLst>
              </p:cNvPr>
              <p:cNvSpPr txBox="1"/>
              <p:nvPr/>
            </p:nvSpPr>
            <p:spPr>
              <a:xfrm>
                <a:off x="8208046" y="763853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SH</a:t>
                </a:r>
              </a:p>
            </p:txBody>
          </p:sp>
          <p:cxnSp>
            <p:nvCxnSpPr>
              <p:cNvPr id="244" name="Straight Arrow Connector 243">
                <a:extLst>
                  <a:ext uri="{FF2B5EF4-FFF2-40B4-BE49-F238E27FC236}">
                    <a16:creationId xmlns:a16="http://schemas.microsoft.com/office/drawing/2014/main" id="{57E02EEA-7BC4-C3AD-7BD7-BAFD700DB73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127486" y="1200042"/>
                <a:ext cx="0" cy="16124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61C24862-8D44-6CB4-AE34-2463129050BF}"/>
                  </a:ext>
                </a:extLst>
              </p:cNvPr>
              <p:cNvSpPr txBox="1"/>
              <p:nvPr/>
            </p:nvSpPr>
            <p:spPr>
              <a:xfrm>
                <a:off x="9192088" y="1094214"/>
                <a:ext cx="4587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83712AEF-2983-7BFC-2E5A-9A8C68CEE312}"/>
                  </a:ext>
                </a:extLst>
              </p:cNvPr>
              <p:cNvSpPr txBox="1"/>
              <p:nvPr/>
            </p:nvSpPr>
            <p:spPr>
              <a:xfrm>
                <a:off x="9173158" y="1223489"/>
                <a:ext cx="4315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D8131098-EEAC-057F-3190-2C04E7AC9690}"/>
                  </a:ext>
                </a:extLst>
              </p:cNvPr>
              <p:cNvSpPr txBox="1"/>
              <p:nvPr/>
            </p:nvSpPr>
            <p:spPr>
              <a:xfrm>
                <a:off x="9077209" y="1364702"/>
                <a:ext cx="6783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+SOD</a:t>
                </a:r>
              </a:p>
            </p:txBody>
          </p:sp>
          <p:cxnSp>
            <p:nvCxnSpPr>
              <p:cNvPr id="248" name="Straight Arrow Connector 247">
                <a:extLst>
                  <a:ext uri="{FF2B5EF4-FFF2-40B4-BE49-F238E27FC236}">
                    <a16:creationId xmlns:a16="http://schemas.microsoft.com/office/drawing/2014/main" id="{E1968FB9-DEF2-5A37-CC79-DAD41BE945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8470" y="918594"/>
                <a:ext cx="0" cy="13907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586A4274-3683-A07E-2022-929CCA4BFCEA}"/>
                  </a:ext>
                </a:extLst>
              </p:cNvPr>
              <p:cNvSpPr txBox="1"/>
              <p:nvPr/>
            </p:nvSpPr>
            <p:spPr>
              <a:xfrm>
                <a:off x="7992239" y="762096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  <p:cxnSp>
            <p:nvCxnSpPr>
              <p:cNvPr id="250" name="Straight Arrow Connector 249">
                <a:extLst>
                  <a:ext uri="{FF2B5EF4-FFF2-40B4-BE49-F238E27FC236}">
                    <a16:creationId xmlns:a16="http://schemas.microsoft.com/office/drawing/2014/main" id="{3230147F-8E0E-F0D8-6D03-0EE60C1A49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32482" y="915805"/>
                <a:ext cx="0" cy="13907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139787E4-36B4-BAC6-563E-B99C7CB9B671}"/>
                </a:ext>
              </a:extLst>
            </p:cNvPr>
            <p:cNvGrpSpPr/>
            <p:nvPr/>
          </p:nvGrpSpPr>
          <p:grpSpPr>
            <a:xfrm>
              <a:off x="7154794" y="2986900"/>
              <a:ext cx="2214767" cy="2249487"/>
              <a:chOff x="7491028" y="2404131"/>
              <a:chExt cx="2214767" cy="2249487"/>
            </a:xfrm>
          </p:grpSpPr>
          <p:graphicFrame>
            <p:nvGraphicFramePr>
              <p:cNvPr id="230" name="Object 229">
                <a:extLst>
                  <a:ext uri="{FF2B5EF4-FFF2-40B4-BE49-F238E27FC236}">
                    <a16:creationId xmlns:a16="http://schemas.microsoft.com/office/drawing/2014/main" id="{610FD3AD-5B21-A1CE-DE3E-BD3EDBC5FCF9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7491028" y="2404131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8" imgW="2092371" imgH="2249446" progId="SigmaPlotGraphicObject.12">
                      <p:embed/>
                    </p:oleObj>
                  </mc:Choice>
                  <mc:Fallback>
                    <p:oleObj name="SPW 13.0 Graph" r:id="rId18" imgW="2092371" imgH="2249446" progId="SigmaPlotGraphicObject.12">
                      <p:embed/>
                      <p:pic>
                        <p:nvPicPr>
                          <p:cNvPr id="230" name="Object 229">
                            <a:extLst>
                              <a:ext uri="{FF2B5EF4-FFF2-40B4-BE49-F238E27FC236}">
                                <a16:creationId xmlns:a16="http://schemas.microsoft.com/office/drawing/2014/main" id="{610FD3AD-5B21-A1CE-DE3E-BD3EDBC5FCF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7491028" y="2404131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DC914472-6296-D3BB-7319-EA71F1AE2E0C}"/>
                  </a:ext>
                </a:extLst>
              </p:cNvPr>
              <p:cNvSpPr txBox="1"/>
              <p:nvPr/>
            </p:nvSpPr>
            <p:spPr>
              <a:xfrm>
                <a:off x="7997960" y="3170201"/>
                <a:ext cx="4587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B28894F5-675B-80C3-0353-CAA56E074530}"/>
                  </a:ext>
                </a:extLst>
              </p:cNvPr>
              <p:cNvSpPr txBox="1"/>
              <p:nvPr/>
            </p:nvSpPr>
            <p:spPr>
              <a:xfrm>
                <a:off x="8328022" y="2663524"/>
                <a:ext cx="3385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3" name="Straight Arrow Connector 232">
                <a:extLst>
                  <a:ext uri="{FF2B5EF4-FFF2-40B4-BE49-F238E27FC236}">
                    <a16:creationId xmlns:a16="http://schemas.microsoft.com/office/drawing/2014/main" id="{E6E6630C-031E-38A2-FA92-DAA3F3F19C5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189090" y="3054315"/>
                <a:ext cx="0" cy="16124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68E4F2CC-A349-0ECD-50B6-9A2EA11E0013}"/>
                  </a:ext>
                </a:extLst>
              </p:cNvPr>
              <p:cNvSpPr txBox="1"/>
              <p:nvPr/>
            </p:nvSpPr>
            <p:spPr>
              <a:xfrm>
                <a:off x="9227751" y="2993885"/>
                <a:ext cx="4587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77EFD2C7-E18F-FE74-B6DF-0ED7590D6F23}"/>
                  </a:ext>
                </a:extLst>
              </p:cNvPr>
              <p:cNvSpPr txBox="1"/>
              <p:nvPr/>
            </p:nvSpPr>
            <p:spPr>
              <a:xfrm>
                <a:off x="9182884" y="3603057"/>
                <a:ext cx="39145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796BFC78-8760-22E1-9BC0-001DE265AFD1}"/>
                  </a:ext>
                </a:extLst>
              </p:cNvPr>
              <p:cNvSpPr txBox="1"/>
              <p:nvPr/>
            </p:nvSpPr>
            <p:spPr>
              <a:xfrm>
                <a:off x="9067479" y="3390833"/>
                <a:ext cx="638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s+SO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7" name="Straight Arrow Connector 236">
                <a:extLst>
                  <a:ext uri="{FF2B5EF4-FFF2-40B4-BE49-F238E27FC236}">
                    <a16:creationId xmlns:a16="http://schemas.microsoft.com/office/drawing/2014/main" id="{44FEF655-0DF6-592A-1CB4-FA40231596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08446" y="2818265"/>
                <a:ext cx="0" cy="13907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57C232AF-75D0-E36A-9CB6-0A0669EA8061}"/>
                  </a:ext>
                </a:extLst>
              </p:cNvPr>
              <p:cNvSpPr txBox="1"/>
              <p:nvPr/>
            </p:nvSpPr>
            <p:spPr>
              <a:xfrm>
                <a:off x="8112215" y="2661767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  <p:cxnSp>
            <p:nvCxnSpPr>
              <p:cNvPr id="239" name="Straight Arrow Connector 238">
                <a:extLst>
                  <a:ext uri="{FF2B5EF4-FFF2-40B4-BE49-F238E27FC236}">
                    <a16:creationId xmlns:a16="http://schemas.microsoft.com/office/drawing/2014/main" id="{2FAA38F1-722C-7804-1F4B-94736B05B7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52458" y="2815476"/>
                <a:ext cx="0" cy="13907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2" name="Group 201">
              <a:extLst>
                <a:ext uri="{FF2B5EF4-FFF2-40B4-BE49-F238E27FC236}">
                  <a16:creationId xmlns:a16="http://schemas.microsoft.com/office/drawing/2014/main" id="{6DCFD8CB-6E86-5392-7ACA-938EE16E2298}"/>
                </a:ext>
              </a:extLst>
            </p:cNvPr>
            <p:cNvGrpSpPr/>
            <p:nvPr/>
          </p:nvGrpSpPr>
          <p:grpSpPr>
            <a:xfrm>
              <a:off x="4716836" y="2986595"/>
              <a:ext cx="2338076" cy="2249487"/>
              <a:chOff x="4934320" y="2571092"/>
              <a:chExt cx="2338076" cy="2249487"/>
            </a:xfrm>
          </p:grpSpPr>
          <p:graphicFrame>
            <p:nvGraphicFramePr>
              <p:cNvPr id="221" name="Object 220">
                <a:extLst>
                  <a:ext uri="{FF2B5EF4-FFF2-40B4-BE49-F238E27FC236}">
                    <a16:creationId xmlns:a16="http://schemas.microsoft.com/office/drawing/2014/main" id="{EFF68B5C-8679-B52D-1FCF-3F8F5F7D34BC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934320" y="2571092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0" imgW="2092371" imgH="2249446" progId="SigmaPlotGraphicObject.12">
                      <p:embed/>
                    </p:oleObj>
                  </mc:Choice>
                  <mc:Fallback>
                    <p:oleObj name="SPW 13.0 Graph" r:id="rId20" imgW="2092371" imgH="2249446" progId="SigmaPlotGraphicObject.12">
                      <p:embed/>
                      <p:pic>
                        <p:nvPicPr>
                          <p:cNvPr id="221" name="Object 220">
                            <a:extLst>
                              <a:ext uri="{FF2B5EF4-FFF2-40B4-BE49-F238E27FC236}">
                                <a16:creationId xmlns:a16="http://schemas.microsoft.com/office/drawing/2014/main" id="{EFF68B5C-8679-B52D-1FCF-3F8F5F7D34B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4934320" y="2571092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222" name="Group 221">
                <a:extLst>
                  <a:ext uri="{FF2B5EF4-FFF2-40B4-BE49-F238E27FC236}">
                    <a16:creationId xmlns:a16="http://schemas.microsoft.com/office/drawing/2014/main" id="{0EF9B6D6-1F8B-C6FD-D569-CEE06332BA4E}"/>
                  </a:ext>
                </a:extLst>
              </p:cNvPr>
              <p:cNvGrpSpPr/>
              <p:nvPr/>
            </p:nvGrpSpPr>
            <p:grpSpPr>
              <a:xfrm>
                <a:off x="5428612" y="2893180"/>
                <a:ext cx="1843784" cy="1139117"/>
                <a:chOff x="3786545" y="4508109"/>
                <a:chExt cx="1843784" cy="1139117"/>
              </a:xfrm>
            </p:grpSpPr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06E55664-5968-4BB5-9079-088424F21FE5}"/>
                    </a:ext>
                  </a:extLst>
                </p:cNvPr>
                <p:cNvSpPr txBox="1"/>
                <p:nvPr/>
              </p:nvSpPr>
              <p:spPr>
                <a:xfrm>
                  <a:off x="3786545" y="5064376"/>
                  <a:ext cx="303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</a:t>
                  </a:r>
                </a:p>
              </p:txBody>
            </p: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198CD828-F021-8B2E-C803-C041671EC032}"/>
                    </a:ext>
                  </a:extLst>
                </p:cNvPr>
                <p:cNvSpPr txBox="1"/>
                <p:nvPr/>
              </p:nvSpPr>
              <p:spPr>
                <a:xfrm>
                  <a:off x="4068321" y="4508109"/>
                  <a:ext cx="33855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5" name="Straight Arrow Connector 224">
                  <a:extLst>
                    <a:ext uri="{FF2B5EF4-FFF2-40B4-BE49-F238E27FC236}">
                      <a16:creationId xmlns:a16="http://schemas.microsoft.com/office/drawing/2014/main" id="{33B32BF3-4CEB-48C5-F929-E351A1D03D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6352" y="4659786"/>
                  <a:ext cx="0" cy="170172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Straight Arrow Connector 225">
                  <a:extLst>
                    <a:ext uri="{FF2B5EF4-FFF2-40B4-BE49-F238E27FC236}">
                      <a16:creationId xmlns:a16="http://schemas.microsoft.com/office/drawing/2014/main" id="{344E76B8-19D8-189D-600E-89A82A4C48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929039" y="4952686"/>
                  <a:ext cx="0" cy="161248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9D6B0AD8-48A0-C2EF-473C-0E9A7DE2B8F3}"/>
                    </a:ext>
                  </a:extLst>
                </p:cNvPr>
                <p:cNvSpPr txBox="1"/>
                <p:nvPr/>
              </p:nvSpPr>
              <p:spPr>
                <a:xfrm>
                  <a:off x="5025840" y="4888450"/>
                  <a:ext cx="303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35CFB16B-6E4D-DE65-AFF0-5926393FB0AB}"/>
                    </a:ext>
                  </a:extLst>
                </p:cNvPr>
                <p:cNvSpPr txBox="1"/>
                <p:nvPr/>
              </p:nvSpPr>
              <p:spPr>
                <a:xfrm>
                  <a:off x="4991489" y="5447171"/>
                  <a:ext cx="39145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3C602E6D-3638-2E74-CDEC-8CD914C1FEC7}"/>
                    </a:ext>
                  </a:extLst>
                </p:cNvPr>
                <p:cNvSpPr txBox="1"/>
                <p:nvPr/>
              </p:nvSpPr>
              <p:spPr>
                <a:xfrm>
                  <a:off x="4992013" y="5332521"/>
                  <a:ext cx="63831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+SOD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D772EB01-D2B8-9732-2435-C526427C9AB9}"/>
                </a:ext>
              </a:extLst>
            </p:cNvPr>
            <p:cNvSpPr txBox="1"/>
            <p:nvPr/>
          </p:nvSpPr>
          <p:spPr>
            <a:xfrm>
              <a:off x="722814" y="3759554"/>
              <a:ext cx="378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Q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OD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F3F59D3C-A765-98D8-A748-861644B17888}"/>
                </a:ext>
              </a:extLst>
            </p:cNvPr>
            <p:cNvSpPr txBox="1"/>
            <p:nvPr/>
          </p:nvSpPr>
          <p:spPr>
            <a:xfrm>
              <a:off x="851568" y="3243661"/>
              <a:ext cx="33855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5" name="Straight Arrow Connector 204">
              <a:extLst>
                <a:ext uri="{FF2B5EF4-FFF2-40B4-BE49-F238E27FC236}">
                  <a16:creationId xmlns:a16="http://schemas.microsoft.com/office/drawing/2014/main" id="{7DA8B1AF-D2FB-019C-DE41-88360FE87217}"/>
                </a:ext>
              </a:extLst>
            </p:cNvPr>
            <p:cNvCxnSpPr>
              <a:cxnSpLocks/>
            </p:cNvCxnSpPr>
            <p:nvPr/>
          </p:nvCxnSpPr>
          <p:spPr>
            <a:xfrm>
              <a:off x="1029599" y="3395338"/>
              <a:ext cx="0" cy="170172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Arrow Connector 205">
              <a:extLst>
                <a:ext uri="{FF2B5EF4-FFF2-40B4-BE49-F238E27FC236}">
                  <a16:creationId xmlns:a16="http://schemas.microsoft.com/office/drawing/2014/main" id="{7ACC821A-C890-4245-52D6-BF54A73198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9185" y="3635576"/>
              <a:ext cx="0" cy="16124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2BC154E1-071D-060C-F18D-94A9EF526E51}"/>
                </a:ext>
              </a:extLst>
            </p:cNvPr>
            <p:cNvSpPr txBox="1"/>
            <p:nvPr/>
          </p:nvSpPr>
          <p:spPr>
            <a:xfrm>
              <a:off x="1676315" y="3521983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Q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630C5DA5-4026-9F3D-BBB0-B7980A563A2E}"/>
                </a:ext>
              </a:extLst>
            </p:cNvPr>
            <p:cNvSpPr txBox="1"/>
            <p:nvPr/>
          </p:nvSpPr>
          <p:spPr>
            <a:xfrm>
              <a:off x="1003716" y="4429266"/>
              <a:ext cx="39145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6A2B2764-E935-95B1-E89B-F3A7C1FAB765}"/>
                </a:ext>
              </a:extLst>
            </p:cNvPr>
            <p:cNvSpPr txBox="1"/>
            <p:nvPr/>
          </p:nvSpPr>
          <p:spPr>
            <a:xfrm>
              <a:off x="1621528" y="4095720"/>
              <a:ext cx="63831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ys+SO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0" name="Group 209">
              <a:extLst>
                <a:ext uri="{FF2B5EF4-FFF2-40B4-BE49-F238E27FC236}">
                  <a16:creationId xmlns:a16="http://schemas.microsoft.com/office/drawing/2014/main" id="{12092E19-AD5C-0C4D-C386-F31D55288FC4}"/>
                </a:ext>
              </a:extLst>
            </p:cNvPr>
            <p:cNvGrpSpPr/>
            <p:nvPr/>
          </p:nvGrpSpPr>
          <p:grpSpPr>
            <a:xfrm>
              <a:off x="734193" y="1051045"/>
              <a:ext cx="1558761" cy="1251945"/>
              <a:chOff x="749802" y="624390"/>
              <a:chExt cx="1558761" cy="1251945"/>
            </a:xfrm>
          </p:grpSpPr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6CF1D555-ADE1-4FF9-373C-B7E671C2D843}"/>
                  </a:ext>
                </a:extLst>
              </p:cNvPr>
              <p:cNvSpPr txBox="1"/>
              <p:nvPr/>
            </p:nvSpPr>
            <p:spPr>
              <a:xfrm>
                <a:off x="1038870" y="624390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cxnSp>
            <p:nvCxnSpPr>
              <p:cNvPr id="212" name="Straight Arrow Connector 211">
                <a:extLst>
                  <a:ext uri="{FF2B5EF4-FFF2-40B4-BE49-F238E27FC236}">
                    <a16:creationId xmlns:a16="http://schemas.microsoft.com/office/drawing/2014/main" id="{3FB76F02-A804-5A6C-1853-D48CF5B597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85281" y="1579140"/>
                <a:ext cx="0" cy="132041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Arrow Connector 212">
                <a:extLst>
                  <a:ext uri="{FF2B5EF4-FFF2-40B4-BE49-F238E27FC236}">
                    <a16:creationId xmlns:a16="http://schemas.microsoft.com/office/drawing/2014/main" id="{3739CA43-32B6-BBB1-FF4E-BEB03A2EF78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39076" y="1150677"/>
                <a:ext cx="0" cy="169702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8FE22BBC-D849-77D7-C193-D9645B1C45EC}"/>
                  </a:ext>
                </a:extLst>
              </p:cNvPr>
              <p:cNvSpPr txBox="1"/>
              <p:nvPr/>
            </p:nvSpPr>
            <p:spPr>
              <a:xfrm>
                <a:off x="1707215" y="1043289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61F602F7-6C99-B3E6-E643-5F0942413654}"/>
                  </a:ext>
                </a:extLst>
              </p:cNvPr>
              <p:cNvSpPr txBox="1"/>
              <p:nvPr/>
            </p:nvSpPr>
            <p:spPr>
              <a:xfrm>
                <a:off x="1136496" y="1676280"/>
                <a:ext cx="4315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ADF8BF3E-5FD3-CFE5-E639-F858C39B6F1E}"/>
                  </a:ext>
                </a:extLst>
              </p:cNvPr>
              <p:cNvSpPr txBox="1"/>
              <p:nvPr/>
            </p:nvSpPr>
            <p:spPr>
              <a:xfrm>
                <a:off x="1630172" y="1489953"/>
                <a:ext cx="6783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+SOD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CEAD71D6-0E57-B2B6-F8F3-D373F3E3CAD3}"/>
                  </a:ext>
                </a:extLst>
              </p:cNvPr>
              <p:cNvSpPr txBox="1"/>
              <p:nvPr/>
            </p:nvSpPr>
            <p:spPr>
              <a:xfrm>
                <a:off x="749802" y="1294219"/>
                <a:ext cx="3786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D</a:t>
                </a:r>
              </a:p>
            </p:txBody>
          </p:sp>
          <p:cxnSp>
            <p:nvCxnSpPr>
              <p:cNvPr id="218" name="Straight Arrow Connector 217">
                <a:extLst>
                  <a:ext uri="{FF2B5EF4-FFF2-40B4-BE49-F238E27FC236}">
                    <a16:creationId xmlns:a16="http://schemas.microsoft.com/office/drawing/2014/main" id="{BD6552D2-B563-845E-A43D-E794ACE46D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1927" y="964693"/>
                <a:ext cx="0" cy="105742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C41A0EDA-275B-20F8-BCB5-AB5D4E56FCD8}"/>
                  </a:ext>
                </a:extLst>
              </p:cNvPr>
              <p:cNvSpPr txBox="1"/>
              <p:nvPr/>
            </p:nvSpPr>
            <p:spPr>
              <a:xfrm>
                <a:off x="870219" y="819734"/>
                <a:ext cx="3786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SH</a:t>
                </a:r>
              </a:p>
            </p:txBody>
          </p:sp>
          <p:cxnSp>
            <p:nvCxnSpPr>
              <p:cNvPr id="220" name="Straight Arrow Connector 219">
                <a:extLst>
                  <a:ext uri="{FF2B5EF4-FFF2-40B4-BE49-F238E27FC236}">
                    <a16:creationId xmlns:a16="http://schemas.microsoft.com/office/drawing/2014/main" id="{BBFFAF5C-7EA1-C1CB-80FB-A449919793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53393" y="1584972"/>
                <a:ext cx="16518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7627350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>
            <a:extLst>
              <a:ext uri="{FF2B5EF4-FFF2-40B4-BE49-F238E27FC236}">
                <a16:creationId xmlns:a16="http://schemas.microsoft.com/office/drawing/2014/main" id="{7A454E23-F57A-2666-0730-49B60DA49423}"/>
              </a:ext>
            </a:extLst>
          </p:cNvPr>
          <p:cNvSpPr txBox="1"/>
          <p:nvPr/>
        </p:nvSpPr>
        <p:spPr>
          <a:xfrm>
            <a:off x="202035" y="263994"/>
            <a:ext cx="20393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9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DEE4422-FF2E-76D3-D614-8D8334DF5821}"/>
              </a:ext>
            </a:extLst>
          </p:cNvPr>
          <p:cNvGrpSpPr/>
          <p:nvPr/>
        </p:nvGrpSpPr>
        <p:grpSpPr>
          <a:xfrm>
            <a:off x="1009634" y="823253"/>
            <a:ext cx="10385581" cy="2271229"/>
            <a:chOff x="480245" y="799190"/>
            <a:chExt cx="10385581" cy="227122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FF8CFE0-0050-A556-9C5F-D1A5BA2EA39F}"/>
                </a:ext>
              </a:extLst>
            </p:cNvPr>
            <p:cNvGrpSpPr/>
            <p:nvPr/>
          </p:nvGrpSpPr>
          <p:grpSpPr>
            <a:xfrm>
              <a:off x="5542357" y="819112"/>
              <a:ext cx="2216084" cy="2249487"/>
              <a:chOff x="9519813" y="1044900"/>
              <a:chExt cx="2216084" cy="2249487"/>
            </a:xfrm>
          </p:grpSpPr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80E0ADA8-0952-940F-43BE-3B5A86B39BCE}"/>
                  </a:ext>
                </a:extLst>
              </p:cNvPr>
              <p:cNvSpPr txBox="1"/>
              <p:nvPr/>
            </p:nvSpPr>
            <p:spPr>
              <a:xfrm>
                <a:off x="10825372" y="2221309"/>
                <a:ext cx="61735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119,</a:t>
                </a:r>
                <a:r>
                  <a:rPr lang="en-US" sz="7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18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CC7FA9B4-92BB-F4AB-05E5-D948AA927157}"/>
                  </a:ext>
                </a:extLst>
              </p:cNvPr>
              <p:cNvSpPr txBox="1"/>
              <p:nvPr/>
            </p:nvSpPr>
            <p:spPr>
              <a:xfrm>
                <a:off x="10854457" y="1848139"/>
                <a:ext cx="49127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79,</a:t>
                </a:r>
                <a:r>
                  <a:rPr lang="en-US" sz="7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182" name="Group 181">
                <a:extLst>
                  <a:ext uri="{FF2B5EF4-FFF2-40B4-BE49-F238E27FC236}">
                    <a16:creationId xmlns:a16="http://schemas.microsoft.com/office/drawing/2014/main" id="{20B8C936-CEEA-89B0-AD7F-045076477903}"/>
                  </a:ext>
                </a:extLst>
              </p:cNvPr>
              <p:cNvGrpSpPr/>
              <p:nvPr/>
            </p:nvGrpSpPr>
            <p:grpSpPr>
              <a:xfrm>
                <a:off x="9519813" y="1044900"/>
                <a:ext cx="2216084" cy="2249487"/>
                <a:chOff x="7315277" y="800392"/>
                <a:chExt cx="2216084" cy="2249487"/>
              </a:xfrm>
            </p:grpSpPr>
            <p:graphicFrame>
              <p:nvGraphicFramePr>
                <p:cNvPr id="184" name="Object 183">
                  <a:extLst>
                    <a:ext uri="{FF2B5EF4-FFF2-40B4-BE49-F238E27FC236}">
                      <a16:creationId xmlns:a16="http://schemas.microsoft.com/office/drawing/2014/main" id="{07C8126D-CBE3-DA6F-0D26-2ABC3711848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75671868"/>
                    </p:ext>
                  </p:extLst>
                </p:nvPr>
              </p:nvGraphicFramePr>
              <p:xfrm>
                <a:off x="7315277" y="800392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2092371" imgH="2249446" progId="SigmaPlotGraphicObject.12">
                        <p:embed/>
                      </p:oleObj>
                    </mc:Choice>
                    <mc:Fallback>
                      <p:oleObj name="SPW 13.0 Graph" r:id="rId2" imgW="2092371" imgH="2249446" progId="SigmaPlotGraphicObject.12">
                        <p:embed/>
                        <p:pic>
                          <p:nvPicPr>
                            <p:cNvPr id="184" name="Object 183">
                              <a:extLst>
                                <a:ext uri="{FF2B5EF4-FFF2-40B4-BE49-F238E27FC236}">
                                  <a16:creationId xmlns:a16="http://schemas.microsoft.com/office/drawing/2014/main" id="{07C8126D-CBE3-DA6F-0D26-2ABC3711848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315277" y="800392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185" name="Straight Arrow Connector 184">
                  <a:extLst>
                    <a:ext uri="{FF2B5EF4-FFF2-40B4-BE49-F238E27FC236}">
                      <a16:creationId xmlns:a16="http://schemas.microsoft.com/office/drawing/2014/main" id="{BAA725B4-3BBD-AA98-2519-27A1CD6342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356822" y="1438896"/>
                  <a:ext cx="88047" cy="465192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6" name="Straight Arrow Connector 185">
                  <a:extLst>
                    <a:ext uri="{FF2B5EF4-FFF2-40B4-BE49-F238E27FC236}">
                      <a16:creationId xmlns:a16="http://schemas.microsoft.com/office/drawing/2014/main" id="{C63A8289-2907-CDCD-D5D0-CCFA9A1132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139556" y="1410484"/>
                  <a:ext cx="0" cy="180582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7" name="TextBox 186">
                  <a:extLst>
                    <a:ext uri="{FF2B5EF4-FFF2-40B4-BE49-F238E27FC236}">
                      <a16:creationId xmlns:a16="http://schemas.microsoft.com/office/drawing/2014/main" id="{351D0AF7-219A-4E1E-DC3F-4EEBF77D598E}"/>
                    </a:ext>
                  </a:extLst>
                </p:cNvPr>
                <p:cNvSpPr txBox="1"/>
                <p:nvPr/>
              </p:nvSpPr>
              <p:spPr>
                <a:xfrm>
                  <a:off x="7877361" y="1550771"/>
                  <a:ext cx="515057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Q</a:t>
                  </a:r>
                </a:p>
                <a:p>
                  <a:pPr algn="ctr"/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Q+P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A2A51AAC-0D66-085B-ADCB-1791531250E4}"/>
                    </a:ext>
                  </a:extLst>
                </p:cNvPr>
                <p:cNvSpPr txBox="1"/>
                <p:nvPr/>
              </p:nvSpPr>
              <p:spPr>
                <a:xfrm>
                  <a:off x="8130581" y="1876656"/>
                  <a:ext cx="414995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</a:p>
                <a:p>
                  <a:pPr algn="ctr"/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ys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B522ACC7-59E3-98B4-904E-94381CE36141}"/>
                    </a:ext>
                  </a:extLst>
                </p:cNvPr>
                <p:cNvSpPr txBox="1"/>
                <p:nvPr/>
              </p:nvSpPr>
              <p:spPr>
                <a:xfrm>
                  <a:off x="9127777" y="1661910"/>
                  <a:ext cx="390904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H</a:t>
                  </a:r>
                </a:p>
              </p:txBody>
            </p:sp>
            <p:grpSp>
              <p:nvGrpSpPr>
                <p:cNvPr id="190" name="Group 189">
                  <a:extLst>
                    <a:ext uri="{FF2B5EF4-FFF2-40B4-BE49-F238E27FC236}">
                      <a16:creationId xmlns:a16="http://schemas.microsoft.com/office/drawing/2014/main" id="{DA83EE67-1CE6-0DB7-C4B6-BE19F8E548D4}"/>
                    </a:ext>
                  </a:extLst>
                </p:cNvPr>
                <p:cNvGrpSpPr/>
                <p:nvPr/>
              </p:nvGrpSpPr>
              <p:grpSpPr>
                <a:xfrm>
                  <a:off x="8469994" y="2148048"/>
                  <a:ext cx="746097" cy="407451"/>
                  <a:chOff x="10479157" y="1355288"/>
                  <a:chExt cx="746097" cy="407451"/>
                </a:xfrm>
              </p:grpSpPr>
              <p:cxnSp>
                <p:nvCxnSpPr>
                  <p:cNvPr id="197" name="Straight Connector 196">
                    <a:extLst>
                      <a:ext uri="{FF2B5EF4-FFF2-40B4-BE49-F238E27FC236}">
                        <a16:creationId xmlns:a16="http://schemas.microsoft.com/office/drawing/2014/main" id="{1761FEF1-C9BA-FD12-86E6-70E760392C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479157" y="1559450"/>
                    <a:ext cx="103367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8" name="Straight Connector 197">
                    <a:extLst>
                      <a:ext uri="{FF2B5EF4-FFF2-40B4-BE49-F238E27FC236}">
                        <a16:creationId xmlns:a16="http://schemas.microsoft.com/office/drawing/2014/main" id="{88B3E300-EFCA-3E5F-B07B-3244E1B1AF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479157" y="1456414"/>
                    <a:ext cx="103367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Straight Connector 198">
                    <a:extLst>
                      <a:ext uri="{FF2B5EF4-FFF2-40B4-BE49-F238E27FC236}">
                        <a16:creationId xmlns:a16="http://schemas.microsoft.com/office/drawing/2014/main" id="{8075B00C-7E88-EEBE-7BD1-1FE35763AE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479157" y="1662485"/>
                    <a:ext cx="103367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0" name="TextBox 199">
                    <a:extLst>
                      <a:ext uri="{FF2B5EF4-FFF2-40B4-BE49-F238E27FC236}">
                        <a16:creationId xmlns:a16="http://schemas.microsoft.com/office/drawing/2014/main" id="{D2A6301F-F8F2-343D-D016-5AF03F89F50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23069" y="1355288"/>
                    <a:ext cx="574147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a</a:t>
                    </a:r>
                  </a:p>
                </p:txBody>
              </p:sp>
              <p:sp>
                <p:nvSpPr>
                  <p:cNvPr id="201" name="TextBox 200">
                    <a:extLst>
                      <a:ext uri="{FF2B5EF4-FFF2-40B4-BE49-F238E27FC236}">
                        <a16:creationId xmlns:a16="http://schemas.microsoft.com/office/drawing/2014/main" id="{9CE84A79-284E-6C9B-DE87-7CF023E91A5E}"/>
                      </a:ext>
                    </a:extLst>
                  </p:cNvPr>
                  <p:cNvSpPr txBox="1"/>
                  <p:nvPr/>
                </p:nvSpPr>
                <p:spPr>
                  <a:xfrm>
                    <a:off x="10520508" y="1458986"/>
                    <a:ext cx="704746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10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a</a:t>
                    </a:r>
                  </a:p>
                </p:txBody>
              </p:sp>
              <p:sp>
                <p:nvSpPr>
                  <p:cNvPr id="202" name="TextBox 201">
                    <a:extLst>
                      <a:ext uri="{FF2B5EF4-FFF2-40B4-BE49-F238E27FC236}">
                        <a16:creationId xmlns:a16="http://schemas.microsoft.com/office/drawing/2014/main" id="{2DD7BC7E-0550-4A35-6E14-4823A4224363}"/>
                      </a:ext>
                    </a:extLst>
                  </p:cNvPr>
                  <p:cNvSpPr txBox="1"/>
                  <p:nvPr/>
                </p:nvSpPr>
                <p:spPr>
                  <a:xfrm>
                    <a:off x="10520508" y="1562684"/>
                    <a:ext cx="704746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50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a</a:t>
                    </a:r>
                  </a:p>
                </p:txBody>
              </p:sp>
            </p:grpSp>
            <p:sp>
              <p:nvSpPr>
                <p:cNvPr id="191" name="Right Brace 190">
                  <a:extLst>
                    <a:ext uri="{FF2B5EF4-FFF2-40B4-BE49-F238E27FC236}">
                      <a16:creationId xmlns:a16="http://schemas.microsoft.com/office/drawing/2014/main" id="{964E0456-07E5-C2C4-C74F-9A9045333138}"/>
                    </a:ext>
                  </a:extLst>
                </p:cNvPr>
                <p:cNvSpPr/>
                <p:nvPr/>
              </p:nvSpPr>
              <p:spPr>
                <a:xfrm>
                  <a:off x="9153127" y="1720838"/>
                  <a:ext cx="45719" cy="88914"/>
                </a:xfrm>
                <a:prstGeom prst="rightBrace">
                  <a:avLst>
                    <a:gd name="adj1" fmla="val 25694"/>
                    <a:gd name="adj2" fmla="val 5000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B5C18D0C-E789-4B99-54E8-08FBB65B8955}"/>
                    </a:ext>
                  </a:extLst>
                </p:cNvPr>
                <p:cNvGrpSpPr/>
                <p:nvPr/>
              </p:nvGrpSpPr>
              <p:grpSpPr>
                <a:xfrm>
                  <a:off x="9140457" y="1877810"/>
                  <a:ext cx="390904" cy="200055"/>
                  <a:chOff x="9919918" y="1814310"/>
                  <a:chExt cx="390904" cy="200055"/>
                </a:xfrm>
              </p:grpSpPr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id="{2DB133EA-AAFC-EC6F-755D-A9705CB85651}"/>
                      </a:ext>
                    </a:extLst>
                  </p:cNvPr>
                  <p:cNvSpPr txBox="1"/>
                  <p:nvPr/>
                </p:nvSpPr>
                <p:spPr>
                  <a:xfrm>
                    <a:off x="9919918" y="1814310"/>
                    <a:ext cx="390904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endParaRPr 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6" name="Right Brace 195">
                    <a:extLst>
                      <a:ext uri="{FF2B5EF4-FFF2-40B4-BE49-F238E27FC236}">
                        <a16:creationId xmlns:a16="http://schemas.microsoft.com/office/drawing/2014/main" id="{A7F8E792-D0C9-2D5C-5993-632B0D403491}"/>
                      </a:ext>
                    </a:extLst>
                  </p:cNvPr>
                  <p:cNvSpPr/>
                  <p:nvPr/>
                </p:nvSpPr>
                <p:spPr>
                  <a:xfrm>
                    <a:off x="9945268" y="1873238"/>
                    <a:ext cx="45719" cy="88914"/>
                  </a:xfrm>
                  <a:prstGeom prst="rightBrace">
                    <a:avLst>
                      <a:gd name="adj1" fmla="val 25694"/>
                      <a:gd name="adj2" fmla="val 50000"/>
                    </a:avLst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1CBE9A8A-198E-B2BF-0863-2A78817BA0C7}"/>
                    </a:ext>
                  </a:extLst>
                </p:cNvPr>
                <p:cNvSpPr txBox="1"/>
                <p:nvPr/>
              </p:nvSpPr>
              <p:spPr>
                <a:xfrm>
                  <a:off x="9141633" y="1273059"/>
                  <a:ext cx="300363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</a:t>
                  </a:r>
                </a:p>
              </p:txBody>
            </p:sp>
            <p:sp>
              <p:nvSpPr>
                <p:cNvPr id="194" name="Right Brace 193">
                  <a:extLst>
                    <a:ext uri="{FF2B5EF4-FFF2-40B4-BE49-F238E27FC236}">
                      <a16:creationId xmlns:a16="http://schemas.microsoft.com/office/drawing/2014/main" id="{0E60864B-7CDB-81AC-954C-692C6369717B}"/>
                    </a:ext>
                  </a:extLst>
                </p:cNvPr>
                <p:cNvSpPr/>
                <p:nvPr/>
              </p:nvSpPr>
              <p:spPr>
                <a:xfrm>
                  <a:off x="9166983" y="1331987"/>
                  <a:ext cx="45719" cy="88914"/>
                </a:xfrm>
                <a:prstGeom prst="rightBrace">
                  <a:avLst>
                    <a:gd name="adj1" fmla="val 25694"/>
                    <a:gd name="adj2" fmla="val 5000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id="{83BBDE81-BC84-1286-DE62-F01B38443025}"/>
                </a:ext>
              </a:extLst>
            </p:cNvPr>
            <p:cNvGrpSpPr/>
            <p:nvPr/>
          </p:nvGrpSpPr>
          <p:grpSpPr>
            <a:xfrm>
              <a:off x="3410944" y="810606"/>
              <a:ext cx="2092325" cy="2249487"/>
              <a:chOff x="6925132" y="1363118"/>
              <a:chExt cx="2092325" cy="2249487"/>
            </a:xfrm>
          </p:grpSpPr>
          <p:graphicFrame>
            <p:nvGraphicFramePr>
              <p:cNvPr id="12" name="Object 11">
                <a:extLst>
                  <a:ext uri="{FF2B5EF4-FFF2-40B4-BE49-F238E27FC236}">
                    <a16:creationId xmlns:a16="http://schemas.microsoft.com/office/drawing/2014/main" id="{7634DAEE-160E-DF04-D6A8-BF6774A98AB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94625854"/>
                  </p:ext>
                </p:extLst>
              </p:nvPr>
            </p:nvGraphicFramePr>
            <p:xfrm>
              <a:off x="6925132" y="1363118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4" imgW="2092371" imgH="2249446" progId="SigmaPlotGraphicObject.12">
                      <p:embed/>
                    </p:oleObj>
                  </mc:Choice>
                  <mc:Fallback>
                    <p:oleObj name="SPW 13.0 Graph" r:id="rId4" imgW="2092371" imgH="2249446" progId="SigmaPlotGraphicObject.12">
                      <p:embed/>
                      <p:pic>
                        <p:nvPicPr>
                          <p:cNvPr id="12" name="Object 11">
                            <a:extLst>
                              <a:ext uri="{FF2B5EF4-FFF2-40B4-BE49-F238E27FC236}">
                                <a16:creationId xmlns:a16="http://schemas.microsoft.com/office/drawing/2014/main" id="{7634DAEE-160E-DF04-D6A8-BF6774A98AB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6925132" y="1363118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310F08C-2630-D303-B8B9-8A158D864DFA}"/>
                  </a:ext>
                </a:extLst>
              </p:cNvPr>
              <p:cNvSpPr txBox="1"/>
              <p:nvPr/>
            </p:nvSpPr>
            <p:spPr>
              <a:xfrm>
                <a:off x="7495753" y="1704909"/>
                <a:ext cx="19329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5D4951A4-8C1E-2F71-16CE-17FE4A1B819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667208" y="1991550"/>
                <a:ext cx="0" cy="11510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F0727A38-3DD6-8306-8FB9-D7DC6CDA347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844868" y="1994916"/>
                <a:ext cx="0" cy="11510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A416FFF2-82E1-3A6A-0E92-5C42EFC5355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083152" y="2015964"/>
                <a:ext cx="0" cy="11510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770DD68-91F2-10AF-211B-E83090BE90D9}"/>
                  </a:ext>
                </a:extLst>
              </p:cNvPr>
              <p:cNvSpPr txBox="1"/>
              <p:nvPr/>
            </p:nvSpPr>
            <p:spPr>
              <a:xfrm>
                <a:off x="7578569" y="2165077"/>
                <a:ext cx="56009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 mM PA</a:t>
                </a:r>
              </a:p>
            </p:txBody>
          </p: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4BA47EDA-8A0A-6BA0-3C23-4CB3B02BD7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04698" y="1753260"/>
                <a:ext cx="0" cy="11510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7D7A802-F40B-9244-4B8B-54E3FF8789F4}"/>
                  </a:ext>
                </a:extLst>
              </p:cNvPr>
              <p:cNvSpPr txBox="1"/>
              <p:nvPr/>
            </p:nvSpPr>
            <p:spPr>
              <a:xfrm>
                <a:off x="7296498" y="1496530"/>
                <a:ext cx="411906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 mM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</a:p>
            </p:txBody>
          </p:sp>
          <p:sp>
            <p:nvSpPr>
              <p:cNvPr id="29" name="Left Brace 28">
                <a:extLst>
                  <a:ext uri="{FF2B5EF4-FFF2-40B4-BE49-F238E27FC236}">
                    <a16:creationId xmlns:a16="http://schemas.microsoft.com/office/drawing/2014/main" id="{50037E8A-04AD-A42B-F229-BCB60F1FCD3E}"/>
                  </a:ext>
                </a:extLst>
              </p:cNvPr>
              <p:cNvSpPr/>
              <p:nvPr/>
            </p:nvSpPr>
            <p:spPr>
              <a:xfrm rot="16200000">
                <a:off x="7830499" y="1952570"/>
                <a:ext cx="64412" cy="440783"/>
              </a:xfrm>
              <a:prstGeom prst="leftBrace">
                <a:avLst>
                  <a:gd name="adj1" fmla="val 52333"/>
                  <a:gd name="adj2" fmla="val 5000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A2A8376-89E0-9D36-EC51-61B3452727B7}"/>
                  </a:ext>
                </a:extLst>
              </p:cNvPr>
              <p:cNvSpPr txBox="1"/>
              <p:nvPr/>
            </p:nvSpPr>
            <p:spPr>
              <a:xfrm>
                <a:off x="7909488" y="1522056"/>
                <a:ext cx="56009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Q (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31" name="Left Brace 30">
                <a:extLst>
                  <a:ext uri="{FF2B5EF4-FFF2-40B4-BE49-F238E27FC236}">
                    <a16:creationId xmlns:a16="http://schemas.microsoft.com/office/drawing/2014/main" id="{DFD48B86-80E0-F652-E079-C30F3CB485E4}"/>
                  </a:ext>
                </a:extLst>
              </p:cNvPr>
              <p:cNvSpPr/>
              <p:nvPr/>
            </p:nvSpPr>
            <p:spPr>
              <a:xfrm rot="5400000" flipV="1">
                <a:off x="8128016" y="1159029"/>
                <a:ext cx="67491" cy="1094090"/>
              </a:xfrm>
              <a:prstGeom prst="leftBrace">
                <a:avLst>
                  <a:gd name="adj1" fmla="val 52333"/>
                  <a:gd name="adj2" fmla="val 5000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41B00F99-9900-74FE-7701-ACC0FE940D77}"/>
                  </a:ext>
                </a:extLst>
              </p:cNvPr>
              <p:cNvSpPr txBox="1"/>
              <p:nvPr/>
            </p:nvSpPr>
            <p:spPr>
              <a:xfrm>
                <a:off x="7665835" y="1715855"/>
                <a:ext cx="19329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27E58BD-45B9-B31D-6255-DA6468257615}"/>
                  </a:ext>
                </a:extLst>
              </p:cNvPr>
              <p:cNvSpPr txBox="1"/>
              <p:nvPr/>
            </p:nvSpPr>
            <p:spPr>
              <a:xfrm>
                <a:off x="7846020" y="1731852"/>
                <a:ext cx="29011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BF5B8BA-01CF-A1BE-63B3-F03AA493E92C}"/>
                  </a:ext>
                </a:extLst>
              </p:cNvPr>
              <p:cNvSpPr txBox="1"/>
              <p:nvPr/>
            </p:nvSpPr>
            <p:spPr>
              <a:xfrm>
                <a:off x="8016102" y="1763006"/>
                <a:ext cx="314537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47FC844B-B22C-43C3-DDB1-102FC45E9782}"/>
                  </a:ext>
                </a:extLst>
              </p:cNvPr>
              <p:cNvSpPr txBox="1"/>
              <p:nvPr/>
            </p:nvSpPr>
            <p:spPr>
              <a:xfrm>
                <a:off x="8193762" y="1839627"/>
                <a:ext cx="3465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0F05C28F-1BA8-21B6-A4FB-A79C50FDBF7C}"/>
                  </a:ext>
                </a:extLst>
              </p:cNvPr>
              <p:cNvSpPr txBox="1"/>
              <p:nvPr/>
            </p:nvSpPr>
            <p:spPr>
              <a:xfrm>
                <a:off x="8444674" y="2082962"/>
                <a:ext cx="35326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379BAC03-133D-DBAC-A4F1-9349590CC330}"/>
                  </a:ext>
                </a:extLst>
              </p:cNvPr>
              <p:cNvSpPr txBox="1"/>
              <p:nvPr/>
            </p:nvSpPr>
            <p:spPr>
              <a:xfrm>
                <a:off x="8571814" y="2472803"/>
                <a:ext cx="44336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</a:p>
            </p:txBody>
          </p:sp>
        </p:grpSp>
        <p:grpSp>
          <p:nvGrpSpPr>
            <p:cNvPr id="227" name="Group 226">
              <a:extLst>
                <a:ext uri="{FF2B5EF4-FFF2-40B4-BE49-F238E27FC236}">
                  <a16:creationId xmlns:a16="http://schemas.microsoft.com/office/drawing/2014/main" id="{E68CAC58-4914-3FF6-95DD-D54DE064F209}"/>
                </a:ext>
              </a:extLst>
            </p:cNvPr>
            <p:cNvGrpSpPr/>
            <p:nvPr/>
          </p:nvGrpSpPr>
          <p:grpSpPr>
            <a:xfrm>
              <a:off x="7908664" y="820932"/>
              <a:ext cx="2957162" cy="2249487"/>
              <a:chOff x="5651417" y="1735572"/>
              <a:chExt cx="2957162" cy="2249487"/>
            </a:xfrm>
          </p:grpSpPr>
          <p:graphicFrame>
            <p:nvGraphicFramePr>
              <p:cNvPr id="228" name="Object 227">
                <a:extLst>
                  <a:ext uri="{FF2B5EF4-FFF2-40B4-BE49-F238E27FC236}">
                    <a16:creationId xmlns:a16="http://schemas.microsoft.com/office/drawing/2014/main" id="{7E51381F-9BB1-2DE6-F607-CC4504EF870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651417" y="1735572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6" imgW="2092371" imgH="2249446" progId="SigmaPlotGraphicObject.12">
                      <p:embed/>
                    </p:oleObj>
                  </mc:Choice>
                  <mc:Fallback>
                    <p:oleObj name="SPW 13.0 Graph" r:id="rId6" imgW="2092371" imgH="2249446" progId="SigmaPlotGraphicObject.12">
                      <p:embed/>
                      <p:pic>
                        <p:nvPicPr>
                          <p:cNvPr id="228" name="Object 227">
                            <a:extLst>
                              <a:ext uri="{FF2B5EF4-FFF2-40B4-BE49-F238E27FC236}">
                                <a16:creationId xmlns:a16="http://schemas.microsoft.com/office/drawing/2014/main" id="{7E51381F-9BB1-2DE6-F607-CC4504EF870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5651417" y="1735572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229" name="Straight Arrow Connector 228">
                <a:extLst>
                  <a:ext uri="{FF2B5EF4-FFF2-40B4-BE49-F238E27FC236}">
                    <a16:creationId xmlns:a16="http://schemas.microsoft.com/office/drawing/2014/main" id="{1072BF97-F3A1-F655-9612-DB4F4ED1EB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11156" y="2491006"/>
                <a:ext cx="0" cy="170379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B810886A-0B4D-B042-1D6F-EA495AFFEB71}"/>
                  </a:ext>
                </a:extLst>
              </p:cNvPr>
              <p:cNvSpPr txBox="1"/>
              <p:nvPr/>
            </p:nvSpPr>
            <p:spPr>
              <a:xfrm>
                <a:off x="7427168" y="2318749"/>
                <a:ext cx="694207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:10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23CE4EC6-786C-4EB4-1477-CA6B2336B013}"/>
                  </a:ext>
                </a:extLst>
              </p:cNvPr>
              <p:cNvSpPr txBox="1"/>
              <p:nvPr/>
            </p:nvSpPr>
            <p:spPr>
              <a:xfrm>
                <a:off x="6245030" y="3349476"/>
                <a:ext cx="98354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 mM NQ, 5 mM PA</a:t>
                </a:r>
              </a:p>
            </p:txBody>
          </p:sp>
          <p:sp>
            <p:nvSpPr>
              <p:cNvPr id="232" name="Right Brace 231">
                <a:extLst>
                  <a:ext uri="{FF2B5EF4-FFF2-40B4-BE49-F238E27FC236}">
                    <a16:creationId xmlns:a16="http://schemas.microsoft.com/office/drawing/2014/main" id="{EC18A4DA-5BD1-347A-379D-4551ED5EF1F8}"/>
                  </a:ext>
                </a:extLst>
              </p:cNvPr>
              <p:cNvSpPr/>
              <p:nvPr/>
            </p:nvSpPr>
            <p:spPr>
              <a:xfrm>
                <a:off x="8048976" y="2375476"/>
                <a:ext cx="59146" cy="323550"/>
              </a:xfrm>
              <a:prstGeom prst="rightBrace">
                <a:avLst>
                  <a:gd name="adj1" fmla="val 25694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82262D3D-1D96-3DBF-0B51-2BAB7DCA1EEC}"/>
                  </a:ext>
                </a:extLst>
              </p:cNvPr>
              <p:cNvSpPr txBox="1"/>
              <p:nvPr/>
            </p:nvSpPr>
            <p:spPr>
              <a:xfrm>
                <a:off x="6285366" y="2632174"/>
                <a:ext cx="41499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SH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759197DD-B197-AE55-6866-B44E1E635605}"/>
                  </a:ext>
                </a:extLst>
              </p:cNvPr>
              <p:cNvSpPr txBox="1"/>
              <p:nvPr/>
            </p:nvSpPr>
            <p:spPr>
              <a:xfrm>
                <a:off x="7363394" y="2438644"/>
                <a:ext cx="680676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00:50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52A1F92E-8AB0-59A7-82AD-398A87A9F13A}"/>
                  </a:ext>
                </a:extLst>
              </p:cNvPr>
              <p:cNvSpPr txBox="1"/>
              <p:nvPr/>
            </p:nvSpPr>
            <p:spPr>
              <a:xfrm>
                <a:off x="7365812" y="2551755"/>
                <a:ext cx="75114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38:1.38 mM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52741341-9D72-4DCD-55B7-D8514955FD5F}"/>
                  </a:ext>
                </a:extLst>
              </p:cNvPr>
              <p:cNvSpPr txBox="1"/>
              <p:nvPr/>
            </p:nvSpPr>
            <p:spPr>
              <a:xfrm>
                <a:off x="8011442" y="2390889"/>
                <a:ext cx="597137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Q+PA;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 h GSH</a:t>
                </a:r>
              </a:p>
            </p:txBody>
          </p:sp>
        </p:grpSp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3850C32B-187A-F423-C148-4E0B8571A1C9}"/>
                </a:ext>
              </a:extLst>
            </p:cNvPr>
            <p:cNvGrpSpPr/>
            <p:nvPr/>
          </p:nvGrpSpPr>
          <p:grpSpPr>
            <a:xfrm>
              <a:off x="480245" y="799190"/>
              <a:ext cx="3034890" cy="2249487"/>
              <a:chOff x="1749288" y="481614"/>
              <a:chExt cx="3034890" cy="2249487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F271D2B6-ED77-CE81-F149-94E09B2C8563}"/>
                  </a:ext>
                </a:extLst>
              </p:cNvPr>
              <p:cNvGrpSpPr/>
              <p:nvPr/>
            </p:nvGrpSpPr>
            <p:grpSpPr>
              <a:xfrm>
                <a:off x="1780063" y="481614"/>
                <a:ext cx="3004115" cy="2249487"/>
                <a:chOff x="4034699" y="1435558"/>
                <a:chExt cx="3004115" cy="2249487"/>
              </a:xfrm>
            </p:grpSpPr>
            <p:graphicFrame>
              <p:nvGraphicFramePr>
                <p:cNvPr id="2" name="Object 1">
                  <a:extLst>
                    <a:ext uri="{FF2B5EF4-FFF2-40B4-BE49-F238E27FC236}">
                      <a16:creationId xmlns:a16="http://schemas.microsoft.com/office/drawing/2014/main" id="{A815BB45-3BF3-B290-9D41-7AD850E4FDC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35081602"/>
                    </p:ext>
                  </p:extLst>
                </p:nvPr>
              </p:nvGraphicFramePr>
              <p:xfrm>
                <a:off x="4034699" y="1435558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2092371" imgH="2249446" progId="SigmaPlotGraphicObject.12">
                        <p:embed/>
                      </p:oleObj>
                    </mc:Choice>
                    <mc:Fallback>
                      <p:oleObj name="SPW 13.0 Graph" r:id="rId8" imgW="2092371" imgH="2249446" progId="SigmaPlotGraphicObject.12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A815BB45-3BF3-B290-9D41-7AD850E4FDC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034699" y="1435558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DB709AF9-7CE8-E471-1248-AF8D2703456C}"/>
                    </a:ext>
                  </a:extLst>
                </p:cNvPr>
                <p:cNvSpPr txBox="1"/>
                <p:nvPr/>
              </p:nvSpPr>
              <p:spPr>
                <a:xfrm>
                  <a:off x="5725978" y="2243096"/>
                  <a:ext cx="110877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 </a:t>
                  </a:r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Q, 5 mM PA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1196DC8C-8910-4EDB-7B85-E0536134AF80}"/>
                    </a:ext>
                  </a:extLst>
                </p:cNvPr>
                <p:cNvSpPr txBox="1"/>
                <p:nvPr/>
              </p:nvSpPr>
              <p:spPr>
                <a:xfrm>
                  <a:off x="5878378" y="1868554"/>
                  <a:ext cx="110877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mM NQ, 1 mM PA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E1CEF70-E24A-313B-7314-BE38530DB829}"/>
                    </a:ext>
                  </a:extLst>
                </p:cNvPr>
                <p:cNvSpPr txBox="1"/>
                <p:nvPr/>
              </p:nvSpPr>
              <p:spPr>
                <a:xfrm>
                  <a:off x="5844798" y="2059700"/>
                  <a:ext cx="110877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mM NQ, 2.5 mM PA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EAF4CC64-51E4-10A5-8E91-D7655A6D389A}"/>
                    </a:ext>
                  </a:extLst>
                </p:cNvPr>
                <p:cNvSpPr txBox="1"/>
                <p:nvPr/>
              </p:nvSpPr>
              <p:spPr>
                <a:xfrm>
                  <a:off x="5930039" y="2764873"/>
                  <a:ext cx="1108775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mM NQ, 5 mM PA</a:t>
                  </a:r>
                </a:p>
              </p:txBody>
            </p:sp>
          </p:grp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D06E062F-CFD3-6310-CF59-6A6AC99A76C4}"/>
                  </a:ext>
                </a:extLst>
              </p:cNvPr>
              <p:cNvSpPr txBox="1"/>
              <p:nvPr/>
            </p:nvSpPr>
            <p:spPr>
              <a:xfrm>
                <a:off x="1749288" y="574543"/>
                <a:ext cx="26946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446779A7-5747-AF98-070F-AF2DD3502751}"/>
                </a:ext>
              </a:extLst>
            </p:cNvPr>
            <p:cNvSpPr txBox="1"/>
            <p:nvPr/>
          </p:nvSpPr>
          <p:spPr>
            <a:xfrm>
              <a:off x="3558940" y="894249"/>
              <a:ext cx="2694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9072A93E-EE7A-13DC-E09E-766639E7D7D9}"/>
                </a:ext>
              </a:extLst>
            </p:cNvPr>
            <p:cNvSpPr txBox="1"/>
            <p:nvPr/>
          </p:nvSpPr>
          <p:spPr>
            <a:xfrm>
              <a:off x="7845786" y="900824"/>
              <a:ext cx="2694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36715DA-242C-2E4D-F756-F9B736464B82}"/>
                </a:ext>
              </a:extLst>
            </p:cNvPr>
            <p:cNvSpPr txBox="1"/>
            <p:nvPr/>
          </p:nvSpPr>
          <p:spPr>
            <a:xfrm>
              <a:off x="5519692" y="896808"/>
              <a:ext cx="2694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01B1250-1F81-C2C1-4EAA-2E411BE49946}"/>
              </a:ext>
            </a:extLst>
          </p:cNvPr>
          <p:cNvGrpSpPr/>
          <p:nvPr/>
        </p:nvGrpSpPr>
        <p:grpSpPr>
          <a:xfrm>
            <a:off x="1028934" y="3169336"/>
            <a:ext cx="2855096" cy="2249487"/>
            <a:chOff x="6402274" y="3163108"/>
            <a:chExt cx="2855096" cy="2249487"/>
          </a:xfrm>
        </p:grpSpPr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44552CC1-8A89-BE12-E838-86FD8FFBF94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402274" y="3163108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2092371" imgH="2249446" progId="SigmaPlotGraphicObject.12">
                    <p:embed/>
                  </p:oleObj>
                </mc:Choice>
                <mc:Fallback>
                  <p:oleObj name="SPW 13.0 Graph" r:id="rId10" imgW="2092371" imgH="2249446" progId="SigmaPlotGraphicObject.12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44552CC1-8A89-BE12-E838-86FD8FFBF94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402274" y="3163108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78AF7544-FDB1-0B40-C2E1-D3A7594831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65595" y="3919654"/>
              <a:ext cx="120122" cy="10498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4744B1-B666-4A45-B13C-14F98B9D6011}"/>
                </a:ext>
              </a:extLst>
            </p:cNvPr>
            <p:cNvSpPr txBox="1"/>
            <p:nvPr/>
          </p:nvSpPr>
          <p:spPr>
            <a:xfrm>
              <a:off x="8316230" y="4151728"/>
              <a:ext cx="66936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A+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C931876-11F1-70EB-EA33-CC0AA7FD02FF}"/>
                </a:ext>
              </a:extLst>
            </p:cNvPr>
            <p:cNvSpPr txBox="1"/>
            <p:nvPr/>
          </p:nvSpPr>
          <p:spPr>
            <a:xfrm>
              <a:off x="8332028" y="3774445"/>
              <a:ext cx="41331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E2B62BDC-248E-8A8D-3826-B25B5782468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253515" y="4157525"/>
              <a:ext cx="109900" cy="9108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B8A47DE-A426-EF7A-90A1-7BB894278C32}"/>
                </a:ext>
              </a:extLst>
            </p:cNvPr>
            <p:cNvSpPr txBox="1"/>
            <p:nvPr/>
          </p:nvSpPr>
          <p:spPr>
            <a:xfrm>
              <a:off x="8343178" y="4432367"/>
              <a:ext cx="61125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Q+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40148DB3-CCEF-711C-37EF-02EFBC41216A}"/>
                </a:ext>
              </a:extLst>
            </p:cNvPr>
            <p:cNvSpPr txBox="1"/>
            <p:nvPr/>
          </p:nvSpPr>
          <p:spPr>
            <a:xfrm>
              <a:off x="8414731" y="4662825"/>
              <a:ext cx="84263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Q+PA+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cxnSp>
          <p:nvCxnSpPr>
            <p:cNvPr id="225" name="Straight Arrow Connector 224">
              <a:extLst>
                <a:ext uri="{FF2B5EF4-FFF2-40B4-BE49-F238E27FC236}">
                  <a16:creationId xmlns:a16="http://schemas.microsoft.com/office/drawing/2014/main" id="{8A043920-2169-AC4B-545C-C296E0B3A6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89756" y="4568284"/>
              <a:ext cx="120122" cy="10498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Arrow Connector 237">
              <a:extLst>
                <a:ext uri="{FF2B5EF4-FFF2-40B4-BE49-F238E27FC236}">
                  <a16:creationId xmlns:a16="http://schemas.microsoft.com/office/drawing/2014/main" id="{324626B2-1B12-24AB-5894-31E957BC11A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286039" y="4747607"/>
              <a:ext cx="174948" cy="2232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9AE16F45-D0AF-22BF-0DA1-86C98831D7DC}"/>
                </a:ext>
              </a:extLst>
            </p:cNvPr>
            <p:cNvSpPr txBox="1"/>
            <p:nvPr/>
          </p:nvSpPr>
          <p:spPr>
            <a:xfrm>
              <a:off x="6917427" y="4642382"/>
              <a:ext cx="66013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Q+PA+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H+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cxnSp>
          <p:nvCxnSpPr>
            <p:cNvPr id="245" name="Straight Arrow Connector 244">
              <a:extLst>
                <a:ext uri="{FF2B5EF4-FFF2-40B4-BE49-F238E27FC236}">
                  <a16:creationId xmlns:a16="http://schemas.microsoft.com/office/drawing/2014/main" id="{487720C2-FA33-0791-EEF9-2559D9FD48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58575" y="4886069"/>
              <a:ext cx="19539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Arrow Connector 245">
              <a:extLst>
                <a:ext uri="{FF2B5EF4-FFF2-40B4-BE49-F238E27FC236}">
                  <a16:creationId xmlns:a16="http://schemas.microsoft.com/office/drawing/2014/main" id="{5DC2EB34-B1D9-8F39-0409-DF5107ACF166}"/>
                </a:ext>
              </a:extLst>
            </p:cNvPr>
            <p:cNvCxnSpPr>
              <a:cxnSpLocks/>
            </p:cNvCxnSpPr>
            <p:nvPr/>
          </p:nvCxnSpPr>
          <p:spPr>
            <a:xfrm>
              <a:off x="7503594" y="4885139"/>
              <a:ext cx="19539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705B1B5B-63A2-700E-55BD-F5B74D207387}"/>
                </a:ext>
              </a:extLst>
            </p:cNvPr>
            <p:cNvSpPr txBox="1"/>
            <p:nvPr/>
          </p:nvSpPr>
          <p:spPr>
            <a:xfrm>
              <a:off x="8023509" y="4781772"/>
              <a:ext cx="88074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Q+GSH+H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62F1C0E1-DFCA-EB61-0A84-BE3279974F32}"/>
              </a:ext>
            </a:extLst>
          </p:cNvPr>
          <p:cNvSpPr txBox="1"/>
          <p:nvPr/>
        </p:nvSpPr>
        <p:spPr>
          <a:xfrm>
            <a:off x="5221468" y="3132704"/>
            <a:ext cx="107174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5-06-2022 30uM NQ 1mM propylamine + 300uM H2s  1mM GSH O2 consumption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2C86C933-FAF7-BC9E-C9D8-DFCBA9F39219}"/>
              </a:ext>
            </a:extLst>
          </p:cNvPr>
          <p:cNvGrpSpPr/>
          <p:nvPr/>
        </p:nvGrpSpPr>
        <p:grpSpPr>
          <a:xfrm>
            <a:off x="3943227" y="3164853"/>
            <a:ext cx="2092325" cy="2249487"/>
            <a:chOff x="8493682" y="2259260"/>
            <a:chExt cx="2092325" cy="2249487"/>
          </a:xfrm>
        </p:grpSpPr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52C79050-ABED-44E3-124E-F1EDEE2060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01200" y="2994087"/>
              <a:ext cx="13837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8" name="Object 77">
              <a:extLst>
                <a:ext uri="{FF2B5EF4-FFF2-40B4-BE49-F238E27FC236}">
                  <a16:creationId xmlns:a16="http://schemas.microsoft.com/office/drawing/2014/main" id="{BE2E4000-4E92-03F5-52CC-A7CAAD7F259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3618251"/>
                </p:ext>
              </p:extLst>
            </p:nvPr>
          </p:nvGraphicFramePr>
          <p:xfrm>
            <a:off x="8493682" y="2259260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2" imgW="2092371" imgH="2249446" progId="SigmaPlotGraphicObject.12">
                    <p:embed/>
                  </p:oleObj>
                </mc:Choice>
                <mc:Fallback>
                  <p:oleObj name="SPW 13.0 Graph" r:id="rId12" imgW="2092371" imgH="2249446" progId="SigmaPlotGraphicObject.12">
                    <p:embed/>
                    <p:pic>
                      <p:nvPicPr>
                        <p:cNvPr id="78" name="Object 77">
                          <a:extLst>
                            <a:ext uri="{FF2B5EF4-FFF2-40B4-BE49-F238E27FC236}">
                              <a16:creationId xmlns:a16="http://schemas.microsoft.com/office/drawing/2014/main" id="{BE2E4000-4E92-03F5-52CC-A7CAAD7F259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493682" y="2259260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CD6C578-1A57-D0B0-632C-E4CC6187781E}"/>
                </a:ext>
              </a:extLst>
            </p:cNvPr>
            <p:cNvSpPr txBox="1"/>
            <p:nvPr/>
          </p:nvSpPr>
          <p:spPr>
            <a:xfrm>
              <a:off x="9666605" y="2895311"/>
              <a:ext cx="34656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Pa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5F24A63-09E8-F536-B9AF-9D0C3324BAAC}"/>
                </a:ext>
              </a:extLst>
            </p:cNvPr>
            <p:cNvSpPr txBox="1"/>
            <p:nvPr/>
          </p:nvSpPr>
          <p:spPr>
            <a:xfrm>
              <a:off x="9058203" y="2606193"/>
              <a:ext cx="5373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Q+/-Pa</a:t>
              </a:r>
            </a:p>
          </p:txBody>
        </p: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6A732F36-F71D-ECDA-CF1E-853FBC98E4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27041" y="2976163"/>
              <a:ext cx="0" cy="301931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43258E2-0A47-68E5-0462-A86C06781B28}"/>
                </a:ext>
              </a:extLst>
            </p:cNvPr>
            <p:cNvSpPr txBox="1"/>
            <p:nvPr/>
          </p:nvSpPr>
          <p:spPr>
            <a:xfrm>
              <a:off x="9099111" y="3246570"/>
              <a:ext cx="6046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+GSH</a:t>
              </a:r>
            </a:p>
          </p:txBody>
        </p:sp>
        <p:cxnSp>
          <p:nvCxnSpPr>
            <p:cNvPr id="84" name="Straight Arrow Connector 83">
              <a:extLst>
                <a:ext uri="{FF2B5EF4-FFF2-40B4-BE49-F238E27FC236}">
                  <a16:creationId xmlns:a16="http://schemas.microsoft.com/office/drawing/2014/main" id="{35B2EC1C-F69C-137E-778A-AF98334E93F4}"/>
                </a:ext>
              </a:extLst>
            </p:cNvPr>
            <p:cNvCxnSpPr>
              <a:cxnSpLocks/>
            </p:cNvCxnSpPr>
            <p:nvPr/>
          </p:nvCxnSpPr>
          <p:spPr>
            <a:xfrm>
              <a:off x="9552302" y="3603689"/>
              <a:ext cx="12306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stealth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52DB905D-C542-0CA3-6970-C47198AA121D}"/>
                </a:ext>
              </a:extLst>
            </p:cNvPr>
            <p:cNvSpPr txBox="1"/>
            <p:nvPr/>
          </p:nvSpPr>
          <p:spPr>
            <a:xfrm>
              <a:off x="9304568" y="3495132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Pa</a:t>
              </a:r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7E24E817-C5C6-9357-4C2F-2156D950CCAD}"/>
              </a:ext>
            </a:extLst>
          </p:cNvPr>
          <p:cNvSpPr txBox="1"/>
          <p:nvPr/>
        </p:nvSpPr>
        <p:spPr>
          <a:xfrm>
            <a:off x="1008649" y="3227956"/>
            <a:ext cx="2694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DAF0620-E187-5917-B43E-E8F21032DD6E}"/>
              </a:ext>
            </a:extLst>
          </p:cNvPr>
          <p:cNvSpPr txBox="1"/>
          <p:nvPr/>
        </p:nvSpPr>
        <p:spPr>
          <a:xfrm>
            <a:off x="3864603" y="3237411"/>
            <a:ext cx="2694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049157B-F558-F9AE-63CB-14FF068DC3C6}"/>
              </a:ext>
            </a:extLst>
          </p:cNvPr>
          <p:cNvSpPr txBox="1"/>
          <p:nvPr/>
        </p:nvSpPr>
        <p:spPr>
          <a:xfrm>
            <a:off x="1843629" y="3446801"/>
            <a:ext cx="107861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Q, H</a:t>
            </a:r>
            <a:r>
              <a:rPr lang="en-US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, GSH</a:t>
            </a:r>
          </a:p>
        </p:txBody>
      </p: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B68638FC-3977-96C6-70F4-57636985C02C}"/>
              </a:ext>
            </a:extLst>
          </p:cNvPr>
          <p:cNvCxnSpPr>
            <a:cxnSpLocks/>
          </p:cNvCxnSpPr>
          <p:nvPr/>
        </p:nvCxnSpPr>
        <p:spPr>
          <a:xfrm flipV="1">
            <a:off x="1743945" y="3643570"/>
            <a:ext cx="0" cy="369298"/>
          </a:xfrm>
          <a:prstGeom prst="straightConnector1">
            <a:avLst/>
          </a:prstGeom>
          <a:ln w="9525">
            <a:solidFill>
              <a:schemeClr val="tx1"/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6003BD00-249E-6F90-B38C-2868CAEB5F14}"/>
              </a:ext>
            </a:extLst>
          </p:cNvPr>
          <p:cNvSpPr txBox="1"/>
          <p:nvPr/>
        </p:nvSpPr>
        <p:spPr>
          <a:xfrm>
            <a:off x="1968435" y="1010208"/>
            <a:ext cx="56280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Q, PA </a:t>
            </a:r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AD03A1B7-1F8C-4F90-AE26-7787BC72C232}"/>
              </a:ext>
            </a:extLst>
          </p:cNvPr>
          <p:cNvCxnSpPr>
            <a:cxnSpLocks/>
          </p:cNvCxnSpPr>
          <p:nvPr/>
        </p:nvCxnSpPr>
        <p:spPr>
          <a:xfrm flipV="1">
            <a:off x="2249586" y="1197818"/>
            <a:ext cx="0" cy="369298"/>
          </a:xfrm>
          <a:prstGeom prst="straightConnector1">
            <a:avLst/>
          </a:prstGeom>
          <a:ln w="9525">
            <a:solidFill>
              <a:schemeClr val="tx1"/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310221A0-E1D5-DDCD-25C8-B64335AF2953}"/>
              </a:ext>
            </a:extLst>
          </p:cNvPr>
          <p:cNvCxnSpPr>
            <a:cxnSpLocks/>
          </p:cNvCxnSpPr>
          <p:nvPr/>
        </p:nvCxnSpPr>
        <p:spPr>
          <a:xfrm flipV="1">
            <a:off x="2392126" y="1219588"/>
            <a:ext cx="0" cy="123668"/>
          </a:xfrm>
          <a:prstGeom prst="straightConnector1">
            <a:avLst/>
          </a:prstGeom>
          <a:ln w="9525">
            <a:solidFill>
              <a:schemeClr val="tx1"/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517DEBE1-98B2-849C-1023-A0AC78657B84}"/>
              </a:ext>
            </a:extLst>
          </p:cNvPr>
          <p:cNvCxnSpPr>
            <a:cxnSpLocks/>
          </p:cNvCxnSpPr>
          <p:nvPr/>
        </p:nvCxnSpPr>
        <p:spPr>
          <a:xfrm flipV="1">
            <a:off x="1977714" y="3640984"/>
            <a:ext cx="0" cy="369298"/>
          </a:xfrm>
          <a:prstGeom prst="straightConnector1">
            <a:avLst/>
          </a:prstGeom>
          <a:ln w="9525">
            <a:solidFill>
              <a:schemeClr val="tx1"/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72FCE6FE-14F5-243A-F621-B4B774166DA3}"/>
              </a:ext>
            </a:extLst>
          </p:cNvPr>
          <p:cNvSpPr txBox="1"/>
          <p:nvPr/>
        </p:nvSpPr>
        <p:spPr>
          <a:xfrm>
            <a:off x="1577577" y="4002156"/>
            <a:ext cx="4333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E726C795-3112-CD7E-E59B-D21D38449DAD}"/>
              </a:ext>
            </a:extLst>
          </p:cNvPr>
          <p:cNvCxnSpPr>
            <a:cxnSpLocks/>
          </p:cNvCxnSpPr>
          <p:nvPr/>
        </p:nvCxnSpPr>
        <p:spPr>
          <a:xfrm flipV="1">
            <a:off x="4773932" y="3669705"/>
            <a:ext cx="0" cy="256716"/>
          </a:xfrm>
          <a:prstGeom prst="straightConnector1">
            <a:avLst/>
          </a:prstGeom>
          <a:ln w="9525">
            <a:solidFill>
              <a:schemeClr val="tx1"/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5512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150</TotalTime>
  <Words>2541</Words>
  <Application>Microsoft Office PowerPoint</Application>
  <PresentationFormat>Widescreen</PresentationFormat>
  <Paragraphs>791</Paragraphs>
  <Slides>1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SPW 13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 Olson</dc:creator>
  <cp:lastModifiedBy>K Olson</cp:lastModifiedBy>
  <cp:revision>445</cp:revision>
  <dcterms:created xsi:type="dcterms:W3CDTF">2022-02-05T13:57:38Z</dcterms:created>
  <dcterms:modified xsi:type="dcterms:W3CDTF">2023-04-02T13:42:07Z</dcterms:modified>
</cp:coreProperties>
</file>